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37A"/>
    <a:srgbClr val="FF0000"/>
    <a:srgbClr val="296DC0"/>
    <a:srgbClr val="004277"/>
    <a:srgbClr val="AA0065"/>
    <a:srgbClr val="0092F7"/>
    <a:srgbClr val="65AA00"/>
    <a:srgbClr val="0066B5"/>
    <a:srgbClr val="00447B"/>
    <a:srgbClr val="0044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79" autoAdjust="0"/>
    <p:restoredTop sz="94660"/>
  </p:normalViewPr>
  <p:slideViewPr>
    <p:cSldViewPr snapToGrid="0">
      <p:cViewPr varScale="1">
        <p:scale>
          <a:sx n="86" d="100"/>
          <a:sy n="86" d="100"/>
        </p:scale>
        <p:origin x="821" y="-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3/07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7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A00DEA2-7F51-4843-BB11-EEB5BA72E2A1}"/>
              </a:ext>
            </a:extLst>
          </p:cNvPr>
          <p:cNvGrpSpPr/>
          <p:nvPr/>
        </p:nvGrpSpPr>
        <p:grpSpPr>
          <a:xfrm>
            <a:off x="6031650" y="2987609"/>
            <a:ext cx="1944000" cy="1958216"/>
            <a:chOff x="6031650" y="2987609"/>
            <a:chExt cx="1944000" cy="1958216"/>
          </a:xfrm>
        </p:grpSpPr>
        <p:pic>
          <p:nvPicPr>
            <p:cNvPr id="33" name="Picture 32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F42F2876-0F4A-4547-9515-18A5E62BF324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74" t="13467" b="23684"/>
            <a:stretch/>
          </p:blipFill>
          <p:spPr>
            <a:xfrm>
              <a:off x="6031650" y="3449674"/>
              <a:ext cx="1944000" cy="1496151"/>
            </a:xfrm>
            <a:prstGeom prst="rect">
              <a:avLst/>
            </a:prstGeom>
            <a:noFill/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67227AF-8F53-864F-9709-D4265E699DD7}"/>
                </a:ext>
              </a:extLst>
            </p:cNvPr>
            <p:cNvSpPr txBox="1"/>
            <p:nvPr/>
          </p:nvSpPr>
          <p:spPr>
            <a:xfrm>
              <a:off x="6374547" y="2987609"/>
              <a:ext cx="1232838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H" sz="4000" b="1" dirty="0">
                  <a:solidFill>
                    <a:srgbClr val="FF0000"/>
                  </a:solidFill>
                </a:rPr>
                <a:t>PRES</a:t>
              </a:r>
            </a:p>
          </p:txBody>
        </p:sp>
      </p:grpSp>
      <p:sp>
        <p:nvSpPr>
          <p:cNvPr id="24" name="Title 1"/>
          <p:cNvSpPr txBox="1">
            <a:spLocks/>
          </p:cNvSpPr>
          <p:nvPr/>
        </p:nvSpPr>
        <p:spPr>
          <a:xfrm>
            <a:off x="0" y="41096"/>
            <a:ext cx="873303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800" kern="1800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Posterior reversible leukoencephalopathy syndrome associated with acute postinfectious glomerulonephritis: Systematic Review</a:t>
            </a:r>
            <a:endParaRPr lang="en-US" sz="1400" kern="1800" dirty="0">
              <a:solidFill>
                <a:schemeClr val="bg1"/>
              </a:solidFill>
              <a:latin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1189759"/>
            <a:ext cx="12282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WHAT’S KNOWN</a:t>
            </a:r>
            <a:r>
              <a:rPr lang="en-GB" dirty="0">
                <a:solidFill>
                  <a:schemeClr val="bg1"/>
                </a:solidFill>
              </a:rPr>
              <a:t>: Posterior reversible encephalopathy syndrome has been rarely reported in postinfectious  glomerulonephritis.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3847" y="1717067"/>
            <a:ext cx="12104638" cy="10205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GB" sz="1600" b="1" dirty="0">
                <a:solidFill>
                  <a:srgbClr val="0065AA"/>
                </a:solidFill>
              </a:rPr>
              <a:t>DESIGN AND OUTCOMES</a:t>
            </a:r>
          </a:p>
          <a:p>
            <a:pPr>
              <a:lnSpc>
                <a:spcPct val="80000"/>
              </a:lnSpc>
            </a:pPr>
            <a:endParaRPr lang="en-GB" sz="700" dirty="0">
              <a:solidFill>
                <a:srgbClr val="0065AA"/>
              </a:solidFill>
            </a:endParaRPr>
          </a:p>
          <a:p>
            <a:pPr>
              <a:lnSpc>
                <a:spcPct val="80000"/>
              </a:lnSpc>
            </a:pPr>
            <a:r>
              <a:rPr lang="en-GB" dirty="0">
                <a:solidFill>
                  <a:srgbClr val="0065AA"/>
                </a:solidFill>
              </a:rPr>
              <a:t>A systematic review found 52 cases (n = 50 ≤ 18 years of age) of acute postinfectious glomerulonephritis associate with posterior reversible leukoencephalopathy syndrome (PRES). </a:t>
            </a:r>
          </a:p>
          <a:p>
            <a:pPr>
              <a:lnSpc>
                <a:spcPct val="80000"/>
              </a:lnSpc>
            </a:pPr>
            <a:endParaRPr lang="en-GB" sz="1600" dirty="0">
              <a:solidFill>
                <a:srgbClr val="0065AA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3603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: </a:t>
            </a:r>
            <a:r>
              <a:rPr lang="en-GB" dirty="0">
                <a:solidFill>
                  <a:schemeClr val="bg1"/>
                </a:solidFill>
              </a:rPr>
              <a:t>The main factor associated with PRES in acute postinfectious glomerulonephritis is severe hypertension. The pattern of cerebral edema can vary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823DC057-18CD-2245-AB6D-30BD0CC4D60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097465" y="3218078"/>
            <a:ext cx="1260000" cy="103879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FD82A4F-9DFC-CD4A-B02E-934130D9926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315504" y="4205045"/>
            <a:ext cx="823922" cy="82392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126A1A5-0E04-1442-99E2-D8CF3F34E8C6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0933101" flipH="1">
            <a:off x="2357991" y="3196607"/>
            <a:ext cx="1584000" cy="185383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97C77E5-3DC8-9249-95AB-19B1CE173140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36640" y="2796244"/>
            <a:ext cx="1404000" cy="147479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83A706E-2C57-AA48-924A-043CABBC225D}"/>
              </a:ext>
            </a:extLst>
          </p:cNvPr>
          <p:cNvSpPr txBox="1"/>
          <p:nvPr/>
        </p:nvSpPr>
        <p:spPr>
          <a:xfrm>
            <a:off x="4649938" y="3992791"/>
            <a:ext cx="577402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H" sz="6600" b="1" dirty="0">
                <a:solidFill>
                  <a:srgbClr val="FF0000"/>
                </a:solidFill>
              </a:rPr>
              <a:t>?</a:t>
            </a:r>
          </a:p>
        </p:txBody>
      </p:sp>
      <p:sp>
        <p:nvSpPr>
          <p:cNvPr id="30" name="Down Arrow 29">
            <a:extLst>
              <a:ext uri="{FF2B5EF4-FFF2-40B4-BE49-F238E27FC236}">
                <a16:creationId xmlns:a16="http://schemas.microsoft.com/office/drawing/2014/main" id="{3241AB1A-5086-4B4F-9B6C-4BE237ABAD19}"/>
              </a:ext>
            </a:extLst>
          </p:cNvPr>
          <p:cNvSpPr/>
          <p:nvPr/>
        </p:nvSpPr>
        <p:spPr>
          <a:xfrm rot="16200000">
            <a:off x="2236814" y="3873707"/>
            <a:ext cx="504056" cy="499630"/>
          </a:xfrm>
          <a:prstGeom prst="downArrow">
            <a:avLst/>
          </a:prstGeom>
          <a:solidFill>
            <a:srgbClr val="0070C0">
              <a:alpha val="50000"/>
            </a:srgbClr>
          </a:solidFill>
          <a:ln w="285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31" name="Down Arrow 30">
            <a:extLst>
              <a:ext uri="{FF2B5EF4-FFF2-40B4-BE49-F238E27FC236}">
                <a16:creationId xmlns:a16="http://schemas.microsoft.com/office/drawing/2014/main" id="{0DB60149-602E-304B-90F5-57A309784A06}"/>
              </a:ext>
            </a:extLst>
          </p:cNvPr>
          <p:cNvSpPr/>
          <p:nvPr/>
        </p:nvSpPr>
        <p:spPr>
          <a:xfrm rot="18583740">
            <a:off x="3796820" y="4199707"/>
            <a:ext cx="504056" cy="736354"/>
          </a:xfrm>
          <a:prstGeom prst="downArrow">
            <a:avLst/>
          </a:prstGeom>
          <a:solidFill>
            <a:srgbClr val="0070C0">
              <a:alpha val="50000"/>
            </a:srgbClr>
          </a:solidFill>
          <a:ln w="285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32" name="Down Arrow 31">
            <a:extLst>
              <a:ext uri="{FF2B5EF4-FFF2-40B4-BE49-F238E27FC236}">
                <a16:creationId xmlns:a16="http://schemas.microsoft.com/office/drawing/2014/main" id="{21E5EB8A-FF6F-4844-9E8B-FADBDB1EA613}"/>
              </a:ext>
            </a:extLst>
          </p:cNvPr>
          <p:cNvSpPr/>
          <p:nvPr/>
        </p:nvSpPr>
        <p:spPr>
          <a:xfrm rot="13816260" flipH="1">
            <a:off x="3688820" y="2988709"/>
            <a:ext cx="504056" cy="736354"/>
          </a:xfrm>
          <a:prstGeom prst="downArrow">
            <a:avLst/>
          </a:prstGeom>
          <a:solidFill>
            <a:srgbClr val="0070C0">
              <a:alpha val="50000"/>
            </a:srgbClr>
          </a:solidFill>
          <a:ln w="285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34" name="Down Arrow 33">
            <a:extLst>
              <a:ext uri="{FF2B5EF4-FFF2-40B4-BE49-F238E27FC236}">
                <a16:creationId xmlns:a16="http://schemas.microsoft.com/office/drawing/2014/main" id="{22F0C963-0130-FB49-A80B-231D2B6F6E2D}"/>
              </a:ext>
            </a:extLst>
          </p:cNvPr>
          <p:cNvSpPr/>
          <p:nvPr/>
        </p:nvSpPr>
        <p:spPr>
          <a:xfrm rot="13816260" flipH="1">
            <a:off x="5707191" y="4214107"/>
            <a:ext cx="504056" cy="736354"/>
          </a:xfrm>
          <a:prstGeom prst="downArrow">
            <a:avLst/>
          </a:prstGeom>
          <a:solidFill>
            <a:srgbClr val="0070C0">
              <a:alpha val="50000"/>
            </a:srgbClr>
          </a:solidFill>
          <a:ln w="285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35" name="Down Arrow 34">
            <a:extLst>
              <a:ext uri="{FF2B5EF4-FFF2-40B4-BE49-F238E27FC236}">
                <a16:creationId xmlns:a16="http://schemas.microsoft.com/office/drawing/2014/main" id="{972728AB-7918-F34B-A847-184E0FBE8B09}"/>
              </a:ext>
            </a:extLst>
          </p:cNvPr>
          <p:cNvSpPr/>
          <p:nvPr/>
        </p:nvSpPr>
        <p:spPr>
          <a:xfrm rot="18583740">
            <a:off x="5707191" y="2988709"/>
            <a:ext cx="504056" cy="736354"/>
          </a:xfrm>
          <a:prstGeom prst="downArrow">
            <a:avLst/>
          </a:prstGeom>
          <a:solidFill>
            <a:srgbClr val="0070C0">
              <a:alpha val="50000"/>
            </a:srgbClr>
          </a:solidFill>
          <a:ln w="285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36" name="Freeform: Shape 46">
            <a:extLst>
              <a:ext uri="{FF2B5EF4-FFF2-40B4-BE49-F238E27FC236}">
                <a16:creationId xmlns:a16="http://schemas.microsoft.com/office/drawing/2014/main" id="{CF545E61-373A-4D4C-AA2E-EB91E4D80D38}"/>
              </a:ext>
            </a:extLst>
          </p:cNvPr>
          <p:cNvSpPr>
            <a:spLocks noChangeAspect="1"/>
          </p:cNvSpPr>
          <p:nvPr/>
        </p:nvSpPr>
        <p:spPr>
          <a:xfrm>
            <a:off x="284275" y="2995464"/>
            <a:ext cx="864000" cy="152304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1C5EEEC-0EC3-C242-A050-5A329453AC23}"/>
              </a:ext>
            </a:extLst>
          </p:cNvPr>
          <p:cNvSpPr txBox="1"/>
          <p:nvPr/>
        </p:nvSpPr>
        <p:spPr>
          <a:xfrm>
            <a:off x="18808" y="4611282"/>
            <a:ext cx="13949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H" sz="3600" b="1" dirty="0">
                <a:solidFill>
                  <a:srgbClr val="FF0000"/>
                </a:solidFill>
              </a:rPr>
              <a:t>N</a:t>
            </a:r>
            <a:r>
              <a:rPr lang="en-US" sz="3600" b="1" dirty="0">
                <a:solidFill>
                  <a:srgbClr val="FF0000"/>
                </a:solidFill>
              </a:rPr>
              <a:t> </a:t>
            </a:r>
            <a:r>
              <a:rPr lang="en-CH" sz="3600" b="1" dirty="0">
                <a:solidFill>
                  <a:srgbClr val="FF0000"/>
                </a:solidFill>
              </a:rPr>
              <a:t>=</a:t>
            </a:r>
            <a:r>
              <a:rPr lang="en-US" sz="3600" b="1" dirty="0">
                <a:solidFill>
                  <a:srgbClr val="FF0000"/>
                </a:solidFill>
              </a:rPr>
              <a:t> </a:t>
            </a:r>
            <a:r>
              <a:rPr lang="en-CH" sz="3600" b="1" dirty="0">
                <a:solidFill>
                  <a:srgbClr val="FF0000"/>
                </a:solidFill>
              </a:rPr>
              <a:t>5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287FC67-2FD4-C44D-B771-36C70A4DED5B}"/>
              </a:ext>
            </a:extLst>
          </p:cNvPr>
          <p:cNvSpPr txBox="1"/>
          <p:nvPr/>
        </p:nvSpPr>
        <p:spPr>
          <a:xfrm>
            <a:off x="4045608" y="2507132"/>
            <a:ext cx="17860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H" sz="2400" b="1" dirty="0">
                <a:solidFill>
                  <a:srgbClr val="FF0000"/>
                </a:solidFill>
              </a:rPr>
              <a:t>N</a:t>
            </a:r>
            <a:r>
              <a:rPr lang="en-US" sz="2400" b="1" dirty="0">
                <a:solidFill>
                  <a:srgbClr val="FF0000"/>
                </a:solidFill>
              </a:rPr>
              <a:t> </a:t>
            </a:r>
            <a:r>
              <a:rPr lang="en-CH" sz="2400" b="1" dirty="0">
                <a:solidFill>
                  <a:srgbClr val="FF0000"/>
                </a:solidFill>
              </a:rPr>
              <a:t>=</a:t>
            </a:r>
            <a:r>
              <a:rPr lang="en-US" sz="2400" b="1" dirty="0">
                <a:solidFill>
                  <a:srgbClr val="FF0000"/>
                </a:solidFill>
              </a:rPr>
              <a:t> </a:t>
            </a:r>
            <a:r>
              <a:rPr lang="en-CH" sz="2400" b="1" dirty="0">
                <a:solidFill>
                  <a:srgbClr val="FF0000"/>
                </a:solidFill>
              </a:rPr>
              <a:t>41 (79%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2356764-3812-FA49-8DDA-A169B02E67B8}"/>
              </a:ext>
            </a:extLst>
          </p:cNvPr>
          <p:cNvSpPr txBox="1"/>
          <p:nvPr/>
        </p:nvSpPr>
        <p:spPr>
          <a:xfrm>
            <a:off x="4045608" y="4786328"/>
            <a:ext cx="17860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H" sz="2400" b="1" dirty="0">
                <a:solidFill>
                  <a:srgbClr val="FF0000"/>
                </a:solidFill>
              </a:rPr>
              <a:t>N</a:t>
            </a:r>
            <a:r>
              <a:rPr lang="en-US" sz="2400" b="1" dirty="0">
                <a:solidFill>
                  <a:srgbClr val="FF0000"/>
                </a:solidFill>
              </a:rPr>
              <a:t> </a:t>
            </a:r>
            <a:r>
              <a:rPr lang="en-CH" sz="2400" b="1" dirty="0">
                <a:solidFill>
                  <a:srgbClr val="FF0000"/>
                </a:solidFill>
              </a:rPr>
              <a:t>=</a:t>
            </a:r>
            <a:r>
              <a:rPr lang="en-US" sz="2400" b="1" dirty="0">
                <a:solidFill>
                  <a:srgbClr val="FF0000"/>
                </a:solidFill>
              </a:rPr>
              <a:t> </a:t>
            </a:r>
            <a:r>
              <a:rPr lang="en-CH" sz="2400" b="1" dirty="0">
                <a:solidFill>
                  <a:srgbClr val="FF0000"/>
                </a:solidFill>
              </a:rPr>
              <a:t>11 (21%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A3ED725-F27A-1346-94A5-D8A12806528C}"/>
              </a:ext>
            </a:extLst>
          </p:cNvPr>
          <p:cNvSpPr txBox="1"/>
          <p:nvPr/>
        </p:nvSpPr>
        <p:spPr>
          <a:xfrm>
            <a:off x="8171179" y="2694892"/>
            <a:ext cx="34649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3200" b="1" dirty="0">
                <a:solidFill>
                  <a:srgbClr val="FF0000"/>
                </a:solidFill>
              </a:rPr>
              <a:t>E</a:t>
            </a:r>
            <a:r>
              <a:rPr lang="en-CH" sz="3200" b="1" dirty="0">
                <a:solidFill>
                  <a:srgbClr val="FF0000"/>
                </a:solidFill>
              </a:rPr>
              <a:t>dema Distribution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74A56D5-DA23-5344-AAF0-6DB3A45E192C}"/>
              </a:ext>
            </a:extLst>
          </p:cNvPr>
          <p:cNvSpPr txBox="1"/>
          <p:nvPr/>
        </p:nvSpPr>
        <p:spPr>
          <a:xfrm>
            <a:off x="7660919" y="4830881"/>
            <a:ext cx="1521570" cy="752514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CH" sz="2000" b="1" dirty="0">
                <a:solidFill>
                  <a:srgbClr val="FF0000"/>
                </a:solidFill>
              </a:rPr>
              <a:t>Posterior</a:t>
            </a:r>
          </a:p>
          <a:p>
            <a:pPr algn="ctr">
              <a:lnSpc>
                <a:spcPct val="110000"/>
              </a:lnSpc>
            </a:pPr>
            <a:r>
              <a:rPr lang="en-CH" sz="2000" b="1" dirty="0">
                <a:solidFill>
                  <a:srgbClr val="FF0000"/>
                </a:solidFill>
              </a:rPr>
              <a:t>N</a:t>
            </a:r>
            <a:r>
              <a:rPr lang="en-US" sz="2000" b="1" dirty="0">
                <a:solidFill>
                  <a:srgbClr val="FF0000"/>
                </a:solidFill>
              </a:rPr>
              <a:t> </a:t>
            </a:r>
            <a:r>
              <a:rPr lang="en-CH" sz="2000" b="1" dirty="0">
                <a:solidFill>
                  <a:srgbClr val="FF0000"/>
                </a:solidFill>
              </a:rPr>
              <a:t>=</a:t>
            </a:r>
            <a:r>
              <a:rPr lang="en-US" sz="2000" b="1" dirty="0">
                <a:solidFill>
                  <a:srgbClr val="FF0000"/>
                </a:solidFill>
              </a:rPr>
              <a:t> </a:t>
            </a:r>
            <a:r>
              <a:rPr lang="en-CH" sz="2000" b="1" dirty="0">
                <a:solidFill>
                  <a:srgbClr val="FF0000"/>
                </a:solidFill>
              </a:rPr>
              <a:t>28 (54%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3244BB2-1DCB-464B-8CFE-890418398327}"/>
              </a:ext>
            </a:extLst>
          </p:cNvPr>
          <p:cNvSpPr txBox="1"/>
          <p:nvPr/>
        </p:nvSpPr>
        <p:spPr>
          <a:xfrm>
            <a:off x="9163598" y="4830881"/>
            <a:ext cx="1521570" cy="752514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CH" sz="2000" b="1" dirty="0">
                <a:solidFill>
                  <a:srgbClr val="FF0000"/>
                </a:solidFill>
              </a:rPr>
              <a:t>Diffuse</a:t>
            </a:r>
          </a:p>
          <a:p>
            <a:pPr algn="ctr">
              <a:lnSpc>
                <a:spcPct val="110000"/>
              </a:lnSpc>
            </a:pPr>
            <a:r>
              <a:rPr lang="en-CH" sz="2000" b="1" dirty="0">
                <a:solidFill>
                  <a:srgbClr val="FF0000"/>
                </a:solidFill>
              </a:rPr>
              <a:t>N</a:t>
            </a:r>
            <a:r>
              <a:rPr lang="en-US" sz="2000" b="1" dirty="0">
                <a:solidFill>
                  <a:srgbClr val="FF0000"/>
                </a:solidFill>
              </a:rPr>
              <a:t> </a:t>
            </a:r>
            <a:r>
              <a:rPr lang="en-CH" sz="2000" b="1" dirty="0">
                <a:solidFill>
                  <a:srgbClr val="FF0000"/>
                </a:solidFill>
              </a:rPr>
              <a:t>=</a:t>
            </a:r>
            <a:r>
              <a:rPr lang="en-US" sz="2000" b="1" dirty="0">
                <a:solidFill>
                  <a:srgbClr val="FF0000"/>
                </a:solidFill>
              </a:rPr>
              <a:t> </a:t>
            </a:r>
            <a:r>
              <a:rPr lang="en-CH" sz="2000" b="1" dirty="0">
                <a:solidFill>
                  <a:srgbClr val="FF0000"/>
                </a:solidFill>
              </a:rPr>
              <a:t>23 (44%)</a:t>
            </a:r>
          </a:p>
        </p:txBody>
      </p:sp>
      <p:grpSp>
        <p:nvGrpSpPr>
          <p:cNvPr id="51" name="Gruppo 24">
            <a:extLst>
              <a:ext uri="{FF2B5EF4-FFF2-40B4-BE49-F238E27FC236}">
                <a16:creationId xmlns:a16="http://schemas.microsoft.com/office/drawing/2014/main" id="{9C27B99E-FF59-0E43-8657-50AC484CE79C}"/>
              </a:ext>
            </a:extLst>
          </p:cNvPr>
          <p:cNvGrpSpPr>
            <a:grpSpLocks noChangeAspect="1"/>
          </p:cNvGrpSpPr>
          <p:nvPr/>
        </p:nvGrpSpPr>
        <p:grpSpPr>
          <a:xfrm>
            <a:off x="7790394" y="3492347"/>
            <a:ext cx="1262623" cy="1332000"/>
            <a:chOff x="383909" y="265246"/>
            <a:chExt cx="2561715" cy="2702470"/>
          </a:xfrm>
        </p:grpSpPr>
        <p:pic>
          <p:nvPicPr>
            <p:cNvPr id="52" name="Immagine 3">
              <a:extLst>
                <a:ext uri="{FF2B5EF4-FFF2-40B4-BE49-F238E27FC236}">
                  <a16:creationId xmlns:a16="http://schemas.microsoft.com/office/drawing/2014/main" id="{17BA3F7D-0723-4B46-BC3B-754C957EB6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68" t="15664" r="32900" b="15160"/>
            <a:stretch/>
          </p:blipFill>
          <p:spPr>
            <a:xfrm>
              <a:off x="383909" y="265246"/>
              <a:ext cx="2561715" cy="2702470"/>
            </a:xfrm>
            <a:prstGeom prst="rect">
              <a:avLst/>
            </a:prstGeom>
          </p:spPr>
        </p:pic>
        <p:sp>
          <p:nvSpPr>
            <p:cNvPr id="53" name="Figura a mano libera 4">
              <a:extLst>
                <a:ext uri="{FF2B5EF4-FFF2-40B4-BE49-F238E27FC236}">
                  <a16:creationId xmlns:a16="http://schemas.microsoft.com/office/drawing/2014/main" id="{0F291FC5-A7B8-F145-9D97-48C65A2B7F74}"/>
                </a:ext>
              </a:extLst>
            </p:cNvPr>
            <p:cNvSpPr/>
            <p:nvPr/>
          </p:nvSpPr>
          <p:spPr>
            <a:xfrm>
              <a:off x="718680" y="1926522"/>
              <a:ext cx="875228" cy="628938"/>
            </a:xfrm>
            <a:custGeom>
              <a:avLst/>
              <a:gdLst>
                <a:gd name="connsiteX0" fmla="*/ 279482 w 875228"/>
                <a:gd name="connsiteY0" fmla="*/ 111683 h 628938"/>
                <a:gd name="connsiteX1" fmla="*/ 258541 w 875228"/>
                <a:gd name="connsiteY1" fmla="*/ 188464 h 628938"/>
                <a:gd name="connsiteX2" fmla="*/ 244581 w 875228"/>
                <a:gd name="connsiteY2" fmla="*/ 209405 h 628938"/>
                <a:gd name="connsiteX3" fmla="*/ 237601 w 875228"/>
                <a:gd name="connsiteY3" fmla="*/ 251286 h 628938"/>
                <a:gd name="connsiteX4" fmla="*/ 223641 w 875228"/>
                <a:gd name="connsiteY4" fmla="*/ 293167 h 628938"/>
                <a:gd name="connsiteX5" fmla="*/ 230621 w 875228"/>
                <a:gd name="connsiteY5" fmla="*/ 328067 h 628938"/>
                <a:gd name="connsiteX6" fmla="*/ 286462 w 875228"/>
                <a:gd name="connsiteY6" fmla="*/ 314107 h 628938"/>
                <a:gd name="connsiteX7" fmla="*/ 419085 w 875228"/>
                <a:gd name="connsiteY7" fmla="*/ 279206 h 628938"/>
                <a:gd name="connsiteX8" fmla="*/ 433045 w 875228"/>
                <a:gd name="connsiteY8" fmla="*/ 321087 h 628938"/>
                <a:gd name="connsiteX9" fmla="*/ 426065 w 875228"/>
                <a:gd name="connsiteY9" fmla="*/ 397869 h 628938"/>
                <a:gd name="connsiteX10" fmla="*/ 419085 w 875228"/>
                <a:gd name="connsiteY10" fmla="*/ 418809 h 628938"/>
                <a:gd name="connsiteX11" fmla="*/ 384184 w 875228"/>
                <a:gd name="connsiteY11" fmla="*/ 446730 h 628938"/>
                <a:gd name="connsiteX12" fmla="*/ 356264 w 875228"/>
                <a:gd name="connsiteY12" fmla="*/ 460690 h 628938"/>
                <a:gd name="connsiteX13" fmla="*/ 342303 w 875228"/>
                <a:gd name="connsiteY13" fmla="*/ 474651 h 628938"/>
                <a:gd name="connsiteX14" fmla="*/ 321363 w 875228"/>
                <a:gd name="connsiteY14" fmla="*/ 488611 h 628938"/>
                <a:gd name="connsiteX15" fmla="*/ 314383 w 875228"/>
                <a:gd name="connsiteY15" fmla="*/ 509551 h 628938"/>
                <a:gd name="connsiteX16" fmla="*/ 370224 w 875228"/>
                <a:gd name="connsiteY16" fmla="*/ 516531 h 628938"/>
                <a:gd name="connsiteX17" fmla="*/ 453986 w 875228"/>
                <a:gd name="connsiteY17" fmla="*/ 488611 h 628938"/>
                <a:gd name="connsiteX18" fmla="*/ 467946 w 875228"/>
                <a:gd name="connsiteY18" fmla="*/ 467670 h 628938"/>
                <a:gd name="connsiteX19" fmla="*/ 544728 w 875228"/>
                <a:gd name="connsiteY19" fmla="*/ 460690 h 628938"/>
                <a:gd name="connsiteX20" fmla="*/ 565668 w 875228"/>
                <a:gd name="connsiteY20" fmla="*/ 474651 h 628938"/>
                <a:gd name="connsiteX21" fmla="*/ 565668 w 875228"/>
                <a:gd name="connsiteY21" fmla="*/ 544452 h 628938"/>
                <a:gd name="connsiteX22" fmla="*/ 537747 w 875228"/>
                <a:gd name="connsiteY22" fmla="*/ 586333 h 628938"/>
                <a:gd name="connsiteX23" fmla="*/ 565668 w 875228"/>
                <a:gd name="connsiteY23" fmla="*/ 621234 h 628938"/>
                <a:gd name="connsiteX24" fmla="*/ 586609 w 875228"/>
                <a:gd name="connsiteY24" fmla="*/ 607273 h 628938"/>
                <a:gd name="connsiteX25" fmla="*/ 600569 w 875228"/>
                <a:gd name="connsiteY25" fmla="*/ 586333 h 628938"/>
                <a:gd name="connsiteX26" fmla="*/ 642450 w 875228"/>
                <a:gd name="connsiteY26" fmla="*/ 572373 h 628938"/>
                <a:gd name="connsiteX27" fmla="*/ 733192 w 875228"/>
                <a:gd name="connsiteY27" fmla="*/ 593313 h 628938"/>
                <a:gd name="connsiteX28" fmla="*/ 747152 w 875228"/>
                <a:gd name="connsiteY28" fmla="*/ 614254 h 628938"/>
                <a:gd name="connsiteX29" fmla="*/ 733192 w 875228"/>
                <a:gd name="connsiteY29" fmla="*/ 600293 h 628938"/>
                <a:gd name="connsiteX30" fmla="*/ 726212 w 875228"/>
                <a:gd name="connsiteY30" fmla="*/ 572373 h 628938"/>
                <a:gd name="connsiteX31" fmla="*/ 719231 w 875228"/>
                <a:gd name="connsiteY31" fmla="*/ 551432 h 628938"/>
                <a:gd name="connsiteX32" fmla="*/ 740172 w 875228"/>
                <a:gd name="connsiteY32" fmla="*/ 502571 h 628938"/>
                <a:gd name="connsiteX33" fmla="*/ 761112 w 875228"/>
                <a:gd name="connsiteY33" fmla="*/ 488611 h 628938"/>
                <a:gd name="connsiteX34" fmla="*/ 802993 w 875228"/>
                <a:gd name="connsiteY34" fmla="*/ 516531 h 628938"/>
                <a:gd name="connsiteX35" fmla="*/ 830914 w 875228"/>
                <a:gd name="connsiteY35" fmla="*/ 544452 h 628938"/>
                <a:gd name="connsiteX36" fmla="*/ 830914 w 875228"/>
                <a:gd name="connsiteY36" fmla="*/ 467670 h 628938"/>
                <a:gd name="connsiteX37" fmla="*/ 851854 w 875228"/>
                <a:gd name="connsiteY37" fmla="*/ 460690 h 628938"/>
                <a:gd name="connsiteX38" fmla="*/ 830914 w 875228"/>
                <a:gd name="connsiteY38" fmla="*/ 439750 h 628938"/>
                <a:gd name="connsiteX39" fmla="*/ 809973 w 875228"/>
                <a:gd name="connsiteY39" fmla="*/ 432770 h 628938"/>
                <a:gd name="connsiteX40" fmla="*/ 796013 w 875228"/>
                <a:gd name="connsiteY40" fmla="*/ 411829 h 628938"/>
                <a:gd name="connsiteX41" fmla="*/ 802993 w 875228"/>
                <a:gd name="connsiteY41" fmla="*/ 376928 h 628938"/>
                <a:gd name="connsiteX42" fmla="*/ 865815 w 875228"/>
                <a:gd name="connsiteY42" fmla="*/ 355988 h 628938"/>
                <a:gd name="connsiteX43" fmla="*/ 865815 w 875228"/>
                <a:gd name="connsiteY43" fmla="*/ 300147 h 628938"/>
                <a:gd name="connsiteX44" fmla="*/ 796013 w 875228"/>
                <a:gd name="connsiteY44" fmla="*/ 314107 h 628938"/>
                <a:gd name="connsiteX45" fmla="*/ 754132 w 875228"/>
                <a:gd name="connsiteY45" fmla="*/ 328067 h 628938"/>
                <a:gd name="connsiteX46" fmla="*/ 733192 w 875228"/>
                <a:gd name="connsiteY46" fmla="*/ 321087 h 628938"/>
                <a:gd name="connsiteX47" fmla="*/ 761112 w 875228"/>
                <a:gd name="connsiteY47" fmla="*/ 362968 h 628938"/>
                <a:gd name="connsiteX48" fmla="*/ 775073 w 875228"/>
                <a:gd name="connsiteY48" fmla="*/ 404849 h 628938"/>
                <a:gd name="connsiteX49" fmla="*/ 761112 w 875228"/>
                <a:gd name="connsiteY49" fmla="*/ 474651 h 628938"/>
                <a:gd name="connsiteX50" fmla="*/ 747152 w 875228"/>
                <a:gd name="connsiteY50" fmla="*/ 495591 h 628938"/>
                <a:gd name="connsiteX51" fmla="*/ 663390 w 875228"/>
                <a:gd name="connsiteY51" fmla="*/ 488611 h 628938"/>
                <a:gd name="connsiteX52" fmla="*/ 635470 w 875228"/>
                <a:gd name="connsiteY52" fmla="*/ 481631 h 628938"/>
                <a:gd name="connsiteX53" fmla="*/ 600569 w 875228"/>
                <a:gd name="connsiteY53" fmla="*/ 446730 h 628938"/>
                <a:gd name="connsiteX54" fmla="*/ 593589 w 875228"/>
                <a:gd name="connsiteY54" fmla="*/ 425789 h 628938"/>
                <a:gd name="connsiteX55" fmla="*/ 558688 w 875228"/>
                <a:gd name="connsiteY55" fmla="*/ 390889 h 628938"/>
                <a:gd name="connsiteX56" fmla="*/ 544728 w 875228"/>
                <a:gd name="connsiteY56" fmla="*/ 376928 h 628938"/>
                <a:gd name="connsiteX57" fmla="*/ 523787 w 875228"/>
                <a:gd name="connsiteY57" fmla="*/ 369948 h 628938"/>
                <a:gd name="connsiteX58" fmla="*/ 509827 w 875228"/>
                <a:gd name="connsiteY58" fmla="*/ 349008 h 628938"/>
                <a:gd name="connsiteX59" fmla="*/ 488886 w 875228"/>
                <a:gd name="connsiteY59" fmla="*/ 342028 h 628938"/>
                <a:gd name="connsiteX60" fmla="*/ 474926 w 875228"/>
                <a:gd name="connsiteY60" fmla="*/ 293167 h 628938"/>
                <a:gd name="connsiteX61" fmla="*/ 474926 w 875228"/>
                <a:gd name="connsiteY61" fmla="*/ 174504 h 628938"/>
                <a:gd name="connsiteX62" fmla="*/ 502847 w 875228"/>
                <a:gd name="connsiteY62" fmla="*/ 167524 h 628938"/>
                <a:gd name="connsiteX63" fmla="*/ 509827 w 875228"/>
                <a:gd name="connsiteY63" fmla="*/ 146583 h 628938"/>
                <a:gd name="connsiteX64" fmla="*/ 433045 w 875228"/>
                <a:gd name="connsiteY64" fmla="*/ 118663 h 628938"/>
                <a:gd name="connsiteX65" fmla="*/ 412105 w 875228"/>
                <a:gd name="connsiteY65" fmla="*/ 111683 h 628938"/>
                <a:gd name="connsiteX66" fmla="*/ 370224 w 875228"/>
                <a:gd name="connsiteY66" fmla="*/ 27921 h 628938"/>
                <a:gd name="connsiteX67" fmla="*/ 307402 w 875228"/>
                <a:gd name="connsiteY67" fmla="*/ 6980 h 628938"/>
                <a:gd name="connsiteX68" fmla="*/ 286462 w 875228"/>
                <a:gd name="connsiteY68" fmla="*/ 0 h 628938"/>
                <a:gd name="connsiteX69" fmla="*/ 265522 w 875228"/>
                <a:gd name="connsiteY69" fmla="*/ 6980 h 628938"/>
                <a:gd name="connsiteX70" fmla="*/ 244581 w 875228"/>
                <a:gd name="connsiteY70" fmla="*/ 20941 h 628938"/>
                <a:gd name="connsiteX71" fmla="*/ 202700 w 875228"/>
                <a:gd name="connsiteY71" fmla="*/ 34901 h 628938"/>
                <a:gd name="connsiteX72" fmla="*/ 181760 w 875228"/>
                <a:gd name="connsiteY72" fmla="*/ 55841 h 628938"/>
                <a:gd name="connsiteX73" fmla="*/ 160819 w 875228"/>
                <a:gd name="connsiteY73" fmla="*/ 62822 h 628938"/>
                <a:gd name="connsiteX74" fmla="*/ 139879 w 875228"/>
                <a:gd name="connsiteY74" fmla="*/ 76782 h 628938"/>
                <a:gd name="connsiteX75" fmla="*/ 56117 w 875228"/>
                <a:gd name="connsiteY75" fmla="*/ 55841 h 628938"/>
                <a:gd name="connsiteX76" fmla="*/ 35176 w 875228"/>
                <a:gd name="connsiteY76" fmla="*/ 48861 h 628938"/>
                <a:gd name="connsiteX77" fmla="*/ 276 w 875228"/>
                <a:gd name="connsiteY77" fmla="*/ 69802 h 628938"/>
                <a:gd name="connsiteX78" fmla="*/ 21216 w 875228"/>
                <a:gd name="connsiteY78" fmla="*/ 76782 h 628938"/>
                <a:gd name="connsiteX79" fmla="*/ 56117 w 875228"/>
                <a:gd name="connsiteY79" fmla="*/ 83762 h 628938"/>
                <a:gd name="connsiteX80" fmla="*/ 125918 w 875228"/>
                <a:gd name="connsiteY80" fmla="*/ 104702 h 628938"/>
                <a:gd name="connsiteX81" fmla="*/ 167799 w 875228"/>
                <a:gd name="connsiteY81" fmla="*/ 118663 h 628938"/>
                <a:gd name="connsiteX82" fmla="*/ 216660 w 875228"/>
                <a:gd name="connsiteY82" fmla="*/ 132623 h 628938"/>
                <a:gd name="connsiteX83" fmla="*/ 279482 w 875228"/>
                <a:gd name="connsiteY83" fmla="*/ 111683 h 6289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</a:cxnLst>
              <a:rect l="l" t="t" r="r" b="b"/>
              <a:pathLst>
                <a:path w="875228" h="628938">
                  <a:moveTo>
                    <a:pt x="279482" y="111683"/>
                  </a:moveTo>
                  <a:cubicBezTo>
                    <a:pt x="275735" y="130416"/>
                    <a:pt x="268664" y="173279"/>
                    <a:pt x="258541" y="188464"/>
                  </a:cubicBezTo>
                  <a:lnTo>
                    <a:pt x="244581" y="209405"/>
                  </a:lnTo>
                  <a:cubicBezTo>
                    <a:pt x="242254" y="223365"/>
                    <a:pt x="241034" y="237556"/>
                    <a:pt x="237601" y="251286"/>
                  </a:cubicBezTo>
                  <a:cubicBezTo>
                    <a:pt x="234032" y="265562"/>
                    <a:pt x="223641" y="293167"/>
                    <a:pt x="223641" y="293167"/>
                  </a:cubicBezTo>
                  <a:cubicBezTo>
                    <a:pt x="225968" y="304800"/>
                    <a:pt x="220750" y="321486"/>
                    <a:pt x="230621" y="328067"/>
                  </a:cubicBezTo>
                  <a:cubicBezTo>
                    <a:pt x="236237" y="331811"/>
                    <a:pt x="276902" y="317294"/>
                    <a:pt x="286462" y="314107"/>
                  </a:cubicBezTo>
                  <a:cubicBezTo>
                    <a:pt x="333786" y="243123"/>
                    <a:pt x="297642" y="271110"/>
                    <a:pt x="419085" y="279206"/>
                  </a:cubicBezTo>
                  <a:cubicBezTo>
                    <a:pt x="423738" y="293166"/>
                    <a:pt x="434377" y="306432"/>
                    <a:pt x="433045" y="321087"/>
                  </a:cubicBezTo>
                  <a:cubicBezTo>
                    <a:pt x="430718" y="346681"/>
                    <a:pt x="429699" y="372428"/>
                    <a:pt x="426065" y="397869"/>
                  </a:cubicBezTo>
                  <a:cubicBezTo>
                    <a:pt x="425025" y="405153"/>
                    <a:pt x="422870" y="412500"/>
                    <a:pt x="419085" y="418809"/>
                  </a:cubicBezTo>
                  <a:cubicBezTo>
                    <a:pt x="413102" y="428781"/>
                    <a:pt x="392871" y="441766"/>
                    <a:pt x="384184" y="446730"/>
                  </a:cubicBezTo>
                  <a:cubicBezTo>
                    <a:pt x="375150" y="451892"/>
                    <a:pt x="364922" y="454918"/>
                    <a:pt x="356264" y="460690"/>
                  </a:cubicBezTo>
                  <a:cubicBezTo>
                    <a:pt x="350788" y="464341"/>
                    <a:pt x="347442" y="470540"/>
                    <a:pt x="342303" y="474651"/>
                  </a:cubicBezTo>
                  <a:cubicBezTo>
                    <a:pt x="335752" y="479892"/>
                    <a:pt x="328343" y="483958"/>
                    <a:pt x="321363" y="488611"/>
                  </a:cubicBezTo>
                  <a:cubicBezTo>
                    <a:pt x="319036" y="495591"/>
                    <a:pt x="312940" y="502336"/>
                    <a:pt x="314383" y="509551"/>
                  </a:cubicBezTo>
                  <a:cubicBezTo>
                    <a:pt x="319759" y="536433"/>
                    <a:pt x="361833" y="518329"/>
                    <a:pt x="370224" y="516531"/>
                  </a:cubicBezTo>
                  <a:cubicBezTo>
                    <a:pt x="427920" y="504167"/>
                    <a:pt x="413373" y="508917"/>
                    <a:pt x="453986" y="488611"/>
                  </a:cubicBezTo>
                  <a:cubicBezTo>
                    <a:pt x="458639" y="481631"/>
                    <a:pt x="462014" y="473602"/>
                    <a:pt x="467946" y="467670"/>
                  </a:cubicBezTo>
                  <a:cubicBezTo>
                    <a:pt x="493664" y="441951"/>
                    <a:pt x="504779" y="455697"/>
                    <a:pt x="544728" y="460690"/>
                  </a:cubicBezTo>
                  <a:cubicBezTo>
                    <a:pt x="551708" y="465344"/>
                    <a:pt x="560427" y="468100"/>
                    <a:pt x="565668" y="474651"/>
                  </a:cubicBezTo>
                  <a:cubicBezTo>
                    <a:pt x="579289" y="491677"/>
                    <a:pt x="570473" y="531960"/>
                    <a:pt x="565668" y="544452"/>
                  </a:cubicBezTo>
                  <a:cubicBezTo>
                    <a:pt x="559645" y="560112"/>
                    <a:pt x="537747" y="586333"/>
                    <a:pt x="537747" y="586333"/>
                  </a:cubicBezTo>
                  <a:cubicBezTo>
                    <a:pt x="519312" y="641641"/>
                    <a:pt x="509272" y="630633"/>
                    <a:pt x="565668" y="621234"/>
                  </a:cubicBezTo>
                  <a:cubicBezTo>
                    <a:pt x="572648" y="616580"/>
                    <a:pt x="580677" y="613205"/>
                    <a:pt x="586609" y="607273"/>
                  </a:cubicBezTo>
                  <a:cubicBezTo>
                    <a:pt x="592541" y="601341"/>
                    <a:pt x="593455" y="590779"/>
                    <a:pt x="600569" y="586333"/>
                  </a:cubicBezTo>
                  <a:cubicBezTo>
                    <a:pt x="613048" y="578534"/>
                    <a:pt x="642450" y="572373"/>
                    <a:pt x="642450" y="572373"/>
                  </a:cubicBezTo>
                  <a:cubicBezTo>
                    <a:pt x="698713" y="577488"/>
                    <a:pt x="707991" y="561812"/>
                    <a:pt x="733192" y="593313"/>
                  </a:cubicBezTo>
                  <a:cubicBezTo>
                    <a:pt x="738433" y="599864"/>
                    <a:pt x="747152" y="605865"/>
                    <a:pt x="747152" y="614254"/>
                  </a:cubicBezTo>
                  <a:lnTo>
                    <a:pt x="733192" y="600293"/>
                  </a:lnTo>
                  <a:cubicBezTo>
                    <a:pt x="730865" y="590986"/>
                    <a:pt x="728848" y="581597"/>
                    <a:pt x="726212" y="572373"/>
                  </a:cubicBezTo>
                  <a:cubicBezTo>
                    <a:pt x="724191" y="565298"/>
                    <a:pt x="719231" y="558790"/>
                    <a:pt x="719231" y="551432"/>
                  </a:cubicBezTo>
                  <a:cubicBezTo>
                    <a:pt x="719231" y="535415"/>
                    <a:pt x="728775" y="513968"/>
                    <a:pt x="740172" y="502571"/>
                  </a:cubicBezTo>
                  <a:cubicBezTo>
                    <a:pt x="746104" y="496639"/>
                    <a:pt x="754132" y="493264"/>
                    <a:pt x="761112" y="488611"/>
                  </a:cubicBezTo>
                  <a:cubicBezTo>
                    <a:pt x="783066" y="495929"/>
                    <a:pt x="788055" y="494123"/>
                    <a:pt x="802993" y="516531"/>
                  </a:cubicBezTo>
                  <a:cubicBezTo>
                    <a:pt x="824266" y="548441"/>
                    <a:pt x="791027" y="531157"/>
                    <a:pt x="830914" y="544452"/>
                  </a:cubicBezTo>
                  <a:cubicBezTo>
                    <a:pt x="823995" y="516774"/>
                    <a:pt x="815630" y="498238"/>
                    <a:pt x="830914" y="467670"/>
                  </a:cubicBezTo>
                  <a:cubicBezTo>
                    <a:pt x="834204" y="461089"/>
                    <a:pt x="844874" y="463017"/>
                    <a:pt x="851854" y="460690"/>
                  </a:cubicBezTo>
                  <a:cubicBezTo>
                    <a:pt x="844874" y="453710"/>
                    <a:pt x="839127" y="445225"/>
                    <a:pt x="830914" y="439750"/>
                  </a:cubicBezTo>
                  <a:cubicBezTo>
                    <a:pt x="824792" y="435669"/>
                    <a:pt x="815719" y="437366"/>
                    <a:pt x="809973" y="432770"/>
                  </a:cubicBezTo>
                  <a:cubicBezTo>
                    <a:pt x="803422" y="427529"/>
                    <a:pt x="800666" y="418809"/>
                    <a:pt x="796013" y="411829"/>
                  </a:cubicBezTo>
                  <a:cubicBezTo>
                    <a:pt x="798340" y="400195"/>
                    <a:pt x="797107" y="387229"/>
                    <a:pt x="802993" y="376928"/>
                  </a:cubicBezTo>
                  <a:cubicBezTo>
                    <a:pt x="813324" y="358849"/>
                    <a:pt x="853425" y="358053"/>
                    <a:pt x="865815" y="355988"/>
                  </a:cubicBezTo>
                  <a:cubicBezTo>
                    <a:pt x="870069" y="343225"/>
                    <a:pt x="884682" y="310928"/>
                    <a:pt x="865815" y="300147"/>
                  </a:cubicBezTo>
                  <a:cubicBezTo>
                    <a:pt x="861485" y="297673"/>
                    <a:pt x="805796" y="311172"/>
                    <a:pt x="796013" y="314107"/>
                  </a:cubicBezTo>
                  <a:cubicBezTo>
                    <a:pt x="781918" y="318335"/>
                    <a:pt x="754132" y="328067"/>
                    <a:pt x="754132" y="328067"/>
                  </a:cubicBezTo>
                  <a:cubicBezTo>
                    <a:pt x="747152" y="325740"/>
                    <a:pt x="731749" y="313872"/>
                    <a:pt x="733192" y="321087"/>
                  </a:cubicBezTo>
                  <a:cubicBezTo>
                    <a:pt x="736482" y="337539"/>
                    <a:pt x="755806" y="347051"/>
                    <a:pt x="761112" y="362968"/>
                  </a:cubicBezTo>
                  <a:lnTo>
                    <a:pt x="775073" y="404849"/>
                  </a:lnTo>
                  <a:cubicBezTo>
                    <a:pt x="772500" y="422863"/>
                    <a:pt x="770860" y="455155"/>
                    <a:pt x="761112" y="474651"/>
                  </a:cubicBezTo>
                  <a:cubicBezTo>
                    <a:pt x="757360" y="482154"/>
                    <a:pt x="751805" y="488611"/>
                    <a:pt x="747152" y="495591"/>
                  </a:cubicBezTo>
                  <a:cubicBezTo>
                    <a:pt x="719231" y="493264"/>
                    <a:pt x="691191" y="492086"/>
                    <a:pt x="663390" y="488611"/>
                  </a:cubicBezTo>
                  <a:cubicBezTo>
                    <a:pt x="653871" y="487421"/>
                    <a:pt x="643452" y="486952"/>
                    <a:pt x="635470" y="481631"/>
                  </a:cubicBezTo>
                  <a:cubicBezTo>
                    <a:pt x="621781" y="472505"/>
                    <a:pt x="600569" y="446730"/>
                    <a:pt x="600569" y="446730"/>
                  </a:cubicBezTo>
                  <a:cubicBezTo>
                    <a:pt x="598242" y="439750"/>
                    <a:pt x="598004" y="431675"/>
                    <a:pt x="593589" y="425789"/>
                  </a:cubicBezTo>
                  <a:cubicBezTo>
                    <a:pt x="583718" y="412627"/>
                    <a:pt x="570322" y="402523"/>
                    <a:pt x="558688" y="390889"/>
                  </a:cubicBezTo>
                  <a:cubicBezTo>
                    <a:pt x="554034" y="386235"/>
                    <a:pt x="550971" y="379009"/>
                    <a:pt x="544728" y="376928"/>
                  </a:cubicBezTo>
                  <a:lnTo>
                    <a:pt x="523787" y="369948"/>
                  </a:lnTo>
                  <a:cubicBezTo>
                    <a:pt x="519134" y="362968"/>
                    <a:pt x="516378" y="354248"/>
                    <a:pt x="509827" y="349008"/>
                  </a:cubicBezTo>
                  <a:cubicBezTo>
                    <a:pt x="504081" y="344412"/>
                    <a:pt x="494089" y="347231"/>
                    <a:pt x="488886" y="342028"/>
                  </a:cubicBezTo>
                  <a:cubicBezTo>
                    <a:pt x="485549" y="338691"/>
                    <a:pt x="474986" y="293408"/>
                    <a:pt x="474926" y="293167"/>
                  </a:cubicBezTo>
                  <a:cubicBezTo>
                    <a:pt x="472060" y="267375"/>
                    <a:pt x="459825" y="201685"/>
                    <a:pt x="474926" y="174504"/>
                  </a:cubicBezTo>
                  <a:cubicBezTo>
                    <a:pt x="479585" y="166118"/>
                    <a:pt x="493540" y="169851"/>
                    <a:pt x="502847" y="167524"/>
                  </a:cubicBezTo>
                  <a:cubicBezTo>
                    <a:pt x="505174" y="160544"/>
                    <a:pt x="512154" y="153563"/>
                    <a:pt x="509827" y="146583"/>
                  </a:cubicBezTo>
                  <a:cubicBezTo>
                    <a:pt x="499417" y="115353"/>
                    <a:pt x="453464" y="121215"/>
                    <a:pt x="433045" y="118663"/>
                  </a:cubicBezTo>
                  <a:cubicBezTo>
                    <a:pt x="426065" y="116336"/>
                    <a:pt x="416382" y="117670"/>
                    <a:pt x="412105" y="111683"/>
                  </a:cubicBezTo>
                  <a:cubicBezTo>
                    <a:pt x="398555" y="92713"/>
                    <a:pt x="399789" y="37776"/>
                    <a:pt x="370224" y="27921"/>
                  </a:cubicBezTo>
                  <a:lnTo>
                    <a:pt x="307402" y="6980"/>
                  </a:lnTo>
                  <a:lnTo>
                    <a:pt x="286462" y="0"/>
                  </a:lnTo>
                  <a:cubicBezTo>
                    <a:pt x="279482" y="2327"/>
                    <a:pt x="272103" y="3690"/>
                    <a:pt x="265522" y="6980"/>
                  </a:cubicBezTo>
                  <a:cubicBezTo>
                    <a:pt x="258018" y="10732"/>
                    <a:pt x="252247" y="17534"/>
                    <a:pt x="244581" y="20941"/>
                  </a:cubicBezTo>
                  <a:cubicBezTo>
                    <a:pt x="231134" y="26918"/>
                    <a:pt x="202700" y="34901"/>
                    <a:pt x="202700" y="34901"/>
                  </a:cubicBezTo>
                  <a:cubicBezTo>
                    <a:pt x="195720" y="41881"/>
                    <a:pt x="189973" y="50365"/>
                    <a:pt x="181760" y="55841"/>
                  </a:cubicBezTo>
                  <a:cubicBezTo>
                    <a:pt x="175638" y="59923"/>
                    <a:pt x="167400" y="59531"/>
                    <a:pt x="160819" y="62822"/>
                  </a:cubicBezTo>
                  <a:cubicBezTo>
                    <a:pt x="153316" y="66574"/>
                    <a:pt x="146859" y="72129"/>
                    <a:pt x="139879" y="76782"/>
                  </a:cubicBezTo>
                  <a:cubicBezTo>
                    <a:pt x="83479" y="67382"/>
                    <a:pt x="111428" y="74278"/>
                    <a:pt x="56117" y="55841"/>
                  </a:cubicBezTo>
                  <a:lnTo>
                    <a:pt x="35176" y="48861"/>
                  </a:lnTo>
                  <a:cubicBezTo>
                    <a:pt x="33701" y="49353"/>
                    <a:pt x="-3557" y="58303"/>
                    <a:pt x="276" y="69802"/>
                  </a:cubicBezTo>
                  <a:cubicBezTo>
                    <a:pt x="2603" y="76782"/>
                    <a:pt x="14078" y="74998"/>
                    <a:pt x="21216" y="76782"/>
                  </a:cubicBezTo>
                  <a:cubicBezTo>
                    <a:pt x="32726" y="79659"/>
                    <a:pt x="44535" y="81188"/>
                    <a:pt x="56117" y="83762"/>
                  </a:cubicBezTo>
                  <a:cubicBezTo>
                    <a:pt x="87764" y="90794"/>
                    <a:pt x="91119" y="93102"/>
                    <a:pt x="125918" y="104702"/>
                  </a:cubicBezTo>
                  <a:lnTo>
                    <a:pt x="167799" y="118663"/>
                  </a:lnTo>
                  <a:cubicBezTo>
                    <a:pt x="181033" y="123074"/>
                    <a:pt x="203515" y="131163"/>
                    <a:pt x="216660" y="132623"/>
                  </a:cubicBezTo>
                  <a:cubicBezTo>
                    <a:pt x="228223" y="133908"/>
                    <a:pt x="239927" y="132623"/>
                    <a:pt x="279482" y="111683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Figura a mano libera 6">
              <a:extLst>
                <a:ext uri="{FF2B5EF4-FFF2-40B4-BE49-F238E27FC236}">
                  <a16:creationId xmlns:a16="http://schemas.microsoft.com/office/drawing/2014/main" id="{435DF122-D5D4-BE4B-9B3F-E3FCE56E797C}"/>
                </a:ext>
              </a:extLst>
            </p:cNvPr>
            <p:cNvSpPr/>
            <p:nvPr/>
          </p:nvSpPr>
          <p:spPr>
            <a:xfrm>
              <a:off x="1709351" y="2042203"/>
              <a:ext cx="866325" cy="554414"/>
            </a:xfrm>
            <a:custGeom>
              <a:avLst/>
              <a:gdLst>
                <a:gd name="connsiteX0" fmla="*/ 419596 w 866325"/>
                <a:gd name="connsiteY0" fmla="*/ 2982 h 554414"/>
                <a:gd name="connsiteX1" fmla="*/ 412615 w 866325"/>
                <a:gd name="connsiteY1" fmla="*/ 51843 h 554414"/>
                <a:gd name="connsiteX2" fmla="*/ 370734 w 866325"/>
                <a:gd name="connsiteY2" fmla="*/ 72783 h 554414"/>
                <a:gd name="connsiteX3" fmla="*/ 349794 w 866325"/>
                <a:gd name="connsiteY3" fmla="*/ 86744 h 554414"/>
                <a:gd name="connsiteX4" fmla="*/ 440536 w 866325"/>
                <a:gd name="connsiteY4" fmla="*/ 128624 h 554414"/>
                <a:gd name="connsiteX5" fmla="*/ 426576 w 866325"/>
                <a:gd name="connsiteY5" fmla="*/ 142585 h 554414"/>
                <a:gd name="connsiteX6" fmla="*/ 419596 w 866325"/>
                <a:gd name="connsiteY6" fmla="*/ 163525 h 554414"/>
                <a:gd name="connsiteX7" fmla="*/ 398655 w 866325"/>
                <a:gd name="connsiteY7" fmla="*/ 177486 h 554414"/>
                <a:gd name="connsiteX8" fmla="*/ 405635 w 866325"/>
                <a:gd name="connsiteY8" fmla="*/ 205406 h 554414"/>
                <a:gd name="connsiteX9" fmla="*/ 426576 w 866325"/>
                <a:gd name="connsiteY9" fmla="*/ 212386 h 554414"/>
                <a:gd name="connsiteX10" fmla="*/ 412615 w 866325"/>
                <a:gd name="connsiteY10" fmla="*/ 275208 h 554414"/>
                <a:gd name="connsiteX11" fmla="*/ 349794 w 866325"/>
                <a:gd name="connsiteY11" fmla="*/ 331049 h 554414"/>
                <a:gd name="connsiteX12" fmla="*/ 307913 w 866325"/>
                <a:gd name="connsiteY12" fmla="*/ 345009 h 554414"/>
                <a:gd name="connsiteX13" fmla="*/ 286973 w 866325"/>
                <a:gd name="connsiteY13" fmla="*/ 351989 h 554414"/>
                <a:gd name="connsiteX14" fmla="*/ 147370 w 866325"/>
                <a:gd name="connsiteY14" fmla="*/ 345009 h 554414"/>
                <a:gd name="connsiteX15" fmla="*/ 119449 w 866325"/>
                <a:gd name="connsiteY15" fmla="*/ 338029 h 554414"/>
                <a:gd name="connsiteX16" fmla="*/ 112469 w 866325"/>
                <a:gd name="connsiteY16" fmla="*/ 317089 h 554414"/>
                <a:gd name="connsiteX17" fmla="*/ 133409 w 866325"/>
                <a:gd name="connsiteY17" fmla="*/ 275208 h 554414"/>
                <a:gd name="connsiteX18" fmla="*/ 154350 w 866325"/>
                <a:gd name="connsiteY18" fmla="*/ 261247 h 554414"/>
                <a:gd name="connsiteX19" fmla="*/ 161330 w 866325"/>
                <a:gd name="connsiteY19" fmla="*/ 240307 h 554414"/>
                <a:gd name="connsiteX20" fmla="*/ 147370 w 866325"/>
                <a:gd name="connsiteY20" fmla="*/ 219366 h 554414"/>
                <a:gd name="connsiteX21" fmla="*/ 91528 w 866325"/>
                <a:gd name="connsiteY21" fmla="*/ 177486 h 554414"/>
                <a:gd name="connsiteX22" fmla="*/ 49647 w 866325"/>
                <a:gd name="connsiteY22" fmla="*/ 163525 h 554414"/>
                <a:gd name="connsiteX23" fmla="*/ 84548 w 866325"/>
                <a:gd name="connsiteY23" fmla="*/ 205406 h 554414"/>
                <a:gd name="connsiteX24" fmla="*/ 98509 w 866325"/>
                <a:gd name="connsiteY24" fmla="*/ 226347 h 554414"/>
                <a:gd name="connsiteX25" fmla="*/ 98509 w 866325"/>
                <a:gd name="connsiteY25" fmla="*/ 275208 h 554414"/>
                <a:gd name="connsiteX26" fmla="*/ 63608 w 866325"/>
                <a:gd name="connsiteY26" fmla="*/ 268228 h 554414"/>
                <a:gd name="connsiteX27" fmla="*/ 7767 w 866325"/>
                <a:gd name="connsiteY27" fmla="*/ 261247 h 554414"/>
                <a:gd name="connsiteX28" fmla="*/ 21727 w 866325"/>
                <a:gd name="connsiteY28" fmla="*/ 275208 h 554414"/>
                <a:gd name="connsiteX29" fmla="*/ 63608 w 866325"/>
                <a:gd name="connsiteY29" fmla="*/ 289168 h 554414"/>
                <a:gd name="connsiteX30" fmla="*/ 84548 w 866325"/>
                <a:gd name="connsiteY30" fmla="*/ 303128 h 554414"/>
                <a:gd name="connsiteX31" fmla="*/ 84548 w 866325"/>
                <a:gd name="connsiteY31" fmla="*/ 372930 h 554414"/>
                <a:gd name="connsiteX32" fmla="*/ 56628 w 866325"/>
                <a:gd name="connsiteY32" fmla="*/ 379910 h 554414"/>
                <a:gd name="connsiteX33" fmla="*/ 7767 w 866325"/>
                <a:gd name="connsiteY33" fmla="*/ 386890 h 554414"/>
                <a:gd name="connsiteX34" fmla="*/ 786 w 866325"/>
                <a:gd name="connsiteY34" fmla="*/ 407831 h 554414"/>
                <a:gd name="connsiteX35" fmla="*/ 21727 w 866325"/>
                <a:gd name="connsiteY35" fmla="*/ 414811 h 554414"/>
                <a:gd name="connsiteX36" fmla="*/ 126429 w 866325"/>
                <a:gd name="connsiteY36" fmla="*/ 407831 h 554414"/>
                <a:gd name="connsiteX37" fmla="*/ 154350 w 866325"/>
                <a:gd name="connsiteY37" fmla="*/ 435751 h 554414"/>
                <a:gd name="connsiteX38" fmla="*/ 140389 w 866325"/>
                <a:gd name="connsiteY38" fmla="*/ 449712 h 554414"/>
                <a:gd name="connsiteX39" fmla="*/ 112469 w 866325"/>
                <a:gd name="connsiteY39" fmla="*/ 491592 h 554414"/>
                <a:gd name="connsiteX40" fmla="*/ 70588 w 866325"/>
                <a:gd name="connsiteY40" fmla="*/ 519513 h 554414"/>
                <a:gd name="connsiteX41" fmla="*/ 77568 w 866325"/>
                <a:gd name="connsiteY41" fmla="*/ 540453 h 554414"/>
                <a:gd name="connsiteX42" fmla="*/ 119449 w 866325"/>
                <a:gd name="connsiteY42" fmla="*/ 554414 h 554414"/>
                <a:gd name="connsiteX43" fmla="*/ 147370 w 866325"/>
                <a:gd name="connsiteY43" fmla="*/ 547434 h 554414"/>
                <a:gd name="connsiteX44" fmla="*/ 175290 w 866325"/>
                <a:gd name="connsiteY44" fmla="*/ 512533 h 554414"/>
                <a:gd name="connsiteX45" fmla="*/ 210191 w 866325"/>
                <a:gd name="connsiteY45" fmla="*/ 456692 h 554414"/>
                <a:gd name="connsiteX46" fmla="*/ 259052 w 866325"/>
                <a:gd name="connsiteY46" fmla="*/ 477632 h 554414"/>
                <a:gd name="connsiteX47" fmla="*/ 273012 w 866325"/>
                <a:gd name="connsiteY47" fmla="*/ 519513 h 554414"/>
                <a:gd name="connsiteX48" fmla="*/ 279993 w 866325"/>
                <a:gd name="connsiteY48" fmla="*/ 540453 h 554414"/>
                <a:gd name="connsiteX49" fmla="*/ 286973 w 866325"/>
                <a:gd name="connsiteY49" fmla="*/ 512533 h 554414"/>
                <a:gd name="connsiteX50" fmla="*/ 293953 w 866325"/>
                <a:gd name="connsiteY50" fmla="*/ 435751 h 554414"/>
                <a:gd name="connsiteX51" fmla="*/ 335834 w 866325"/>
                <a:gd name="connsiteY51" fmla="*/ 421791 h 554414"/>
                <a:gd name="connsiteX52" fmla="*/ 377715 w 866325"/>
                <a:gd name="connsiteY52" fmla="*/ 442731 h 554414"/>
                <a:gd name="connsiteX53" fmla="*/ 391675 w 866325"/>
                <a:gd name="connsiteY53" fmla="*/ 540453 h 554414"/>
                <a:gd name="connsiteX54" fmla="*/ 405635 w 866325"/>
                <a:gd name="connsiteY54" fmla="*/ 554414 h 554414"/>
                <a:gd name="connsiteX55" fmla="*/ 405635 w 866325"/>
                <a:gd name="connsiteY55" fmla="*/ 512533 h 554414"/>
                <a:gd name="connsiteX56" fmla="*/ 412615 w 866325"/>
                <a:gd name="connsiteY56" fmla="*/ 338029 h 554414"/>
                <a:gd name="connsiteX57" fmla="*/ 426576 w 866325"/>
                <a:gd name="connsiteY57" fmla="*/ 351989 h 554414"/>
                <a:gd name="connsiteX58" fmla="*/ 468457 w 866325"/>
                <a:gd name="connsiteY58" fmla="*/ 379910 h 554414"/>
                <a:gd name="connsiteX59" fmla="*/ 482417 w 866325"/>
                <a:gd name="connsiteY59" fmla="*/ 421791 h 554414"/>
                <a:gd name="connsiteX60" fmla="*/ 496377 w 866325"/>
                <a:gd name="connsiteY60" fmla="*/ 470652 h 554414"/>
                <a:gd name="connsiteX61" fmla="*/ 510338 w 866325"/>
                <a:gd name="connsiteY61" fmla="*/ 484612 h 554414"/>
                <a:gd name="connsiteX62" fmla="*/ 517318 w 866325"/>
                <a:gd name="connsiteY62" fmla="*/ 505553 h 554414"/>
                <a:gd name="connsiteX63" fmla="*/ 524298 w 866325"/>
                <a:gd name="connsiteY63" fmla="*/ 484612 h 554414"/>
                <a:gd name="connsiteX64" fmla="*/ 517318 w 866325"/>
                <a:gd name="connsiteY64" fmla="*/ 414811 h 554414"/>
                <a:gd name="connsiteX65" fmla="*/ 503357 w 866325"/>
                <a:gd name="connsiteY65" fmla="*/ 372930 h 554414"/>
                <a:gd name="connsiteX66" fmla="*/ 482417 w 866325"/>
                <a:gd name="connsiteY66" fmla="*/ 331049 h 554414"/>
                <a:gd name="connsiteX67" fmla="*/ 482417 w 866325"/>
                <a:gd name="connsiteY67" fmla="*/ 219366 h 554414"/>
                <a:gd name="connsiteX68" fmla="*/ 496377 w 866325"/>
                <a:gd name="connsiteY68" fmla="*/ 198426 h 554414"/>
                <a:gd name="connsiteX69" fmla="*/ 552218 w 866325"/>
                <a:gd name="connsiteY69" fmla="*/ 170505 h 554414"/>
                <a:gd name="connsiteX70" fmla="*/ 587119 w 866325"/>
                <a:gd name="connsiteY70" fmla="*/ 205406 h 554414"/>
                <a:gd name="connsiteX71" fmla="*/ 615040 w 866325"/>
                <a:gd name="connsiteY71" fmla="*/ 233327 h 554414"/>
                <a:gd name="connsiteX72" fmla="*/ 656921 w 866325"/>
                <a:gd name="connsiteY72" fmla="*/ 268228 h 554414"/>
                <a:gd name="connsiteX73" fmla="*/ 684841 w 866325"/>
                <a:gd name="connsiteY73" fmla="*/ 282188 h 554414"/>
                <a:gd name="connsiteX74" fmla="*/ 726722 w 866325"/>
                <a:gd name="connsiteY74" fmla="*/ 296148 h 554414"/>
                <a:gd name="connsiteX75" fmla="*/ 740683 w 866325"/>
                <a:gd name="connsiteY75" fmla="*/ 282188 h 554414"/>
                <a:gd name="connsiteX76" fmla="*/ 733702 w 866325"/>
                <a:gd name="connsiteY76" fmla="*/ 254267 h 554414"/>
                <a:gd name="connsiteX77" fmla="*/ 677861 w 866325"/>
                <a:gd name="connsiteY77" fmla="*/ 205406 h 554414"/>
                <a:gd name="connsiteX78" fmla="*/ 656921 w 866325"/>
                <a:gd name="connsiteY78" fmla="*/ 184466 h 554414"/>
                <a:gd name="connsiteX79" fmla="*/ 629000 w 866325"/>
                <a:gd name="connsiteY79" fmla="*/ 142585 h 554414"/>
                <a:gd name="connsiteX80" fmla="*/ 642960 w 866325"/>
                <a:gd name="connsiteY80" fmla="*/ 128624 h 554414"/>
                <a:gd name="connsiteX81" fmla="*/ 698802 w 866325"/>
                <a:gd name="connsiteY81" fmla="*/ 149565 h 554414"/>
                <a:gd name="connsiteX82" fmla="*/ 712762 w 866325"/>
                <a:gd name="connsiteY82" fmla="*/ 170505 h 554414"/>
                <a:gd name="connsiteX83" fmla="*/ 768603 w 866325"/>
                <a:gd name="connsiteY83" fmla="*/ 219366 h 554414"/>
                <a:gd name="connsiteX84" fmla="*/ 782564 w 866325"/>
                <a:gd name="connsiteY84" fmla="*/ 205406 h 554414"/>
                <a:gd name="connsiteX85" fmla="*/ 761623 w 866325"/>
                <a:gd name="connsiteY85" fmla="*/ 149565 h 554414"/>
                <a:gd name="connsiteX86" fmla="*/ 866325 w 866325"/>
                <a:gd name="connsiteY86" fmla="*/ 128624 h 554414"/>
                <a:gd name="connsiteX87" fmla="*/ 838405 w 866325"/>
                <a:gd name="connsiteY87" fmla="*/ 93724 h 554414"/>
                <a:gd name="connsiteX88" fmla="*/ 796524 w 866325"/>
                <a:gd name="connsiteY88" fmla="*/ 107684 h 554414"/>
                <a:gd name="connsiteX89" fmla="*/ 684841 w 866325"/>
                <a:gd name="connsiteY89" fmla="*/ 100704 h 554414"/>
                <a:gd name="connsiteX90" fmla="*/ 663901 w 866325"/>
                <a:gd name="connsiteY90" fmla="*/ 86744 h 554414"/>
                <a:gd name="connsiteX91" fmla="*/ 635980 w 866325"/>
                <a:gd name="connsiteY91" fmla="*/ 58823 h 554414"/>
                <a:gd name="connsiteX92" fmla="*/ 615040 w 866325"/>
                <a:gd name="connsiteY92" fmla="*/ 44863 h 554414"/>
                <a:gd name="connsiteX93" fmla="*/ 587119 w 866325"/>
                <a:gd name="connsiteY93" fmla="*/ 16942 h 554414"/>
                <a:gd name="connsiteX94" fmla="*/ 566179 w 866325"/>
                <a:gd name="connsiteY94" fmla="*/ 9962 h 554414"/>
                <a:gd name="connsiteX95" fmla="*/ 419596 w 866325"/>
                <a:gd name="connsiteY95" fmla="*/ 2982 h 5544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</a:cxnLst>
              <a:rect l="l" t="t" r="r" b="b"/>
              <a:pathLst>
                <a:path w="866325" h="554414">
                  <a:moveTo>
                    <a:pt x="419596" y="2982"/>
                  </a:moveTo>
                  <a:cubicBezTo>
                    <a:pt x="394002" y="9962"/>
                    <a:pt x="419297" y="36809"/>
                    <a:pt x="412615" y="51843"/>
                  </a:cubicBezTo>
                  <a:cubicBezTo>
                    <a:pt x="407908" y="62433"/>
                    <a:pt x="380026" y="69686"/>
                    <a:pt x="370734" y="72783"/>
                  </a:cubicBezTo>
                  <a:cubicBezTo>
                    <a:pt x="363754" y="77437"/>
                    <a:pt x="352099" y="78678"/>
                    <a:pt x="349794" y="86744"/>
                  </a:cubicBezTo>
                  <a:cubicBezTo>
                    <a:pt x="332678" y="146652"/>
                    <a:pt x="414833" y="126482"/>
                    <a:pt x="440536" y="128624"/>
                  </a:cubicBezTo>
                  <a:cubicBezTo>
                    <a:pt x="435883" y="133278"/>
                    <a:pt x="429962" y="136942"/>
                    <a:pt x="426576" y="142585"/>
                  </a:cubicBezTo>
                  <a:cubicBezTo>
                    <a:pt x="422791" y="148894"/>
                    <a:pt x="424192" y="157780"/>
                    <a:pt x="419596" y="163525"/>
                  </a:cubicBezTo>
                  <a:cubicBezTo>
                    <a:pt x="414355" y="170076"/>
                    <a:pt x="405635" y="172832"/>
                    <a:pt x="398655" y="177486"/>
                  </a:cubicBezTo>
                  <a:cubicBezTo>
                    <a:pt x="400982" y="186793"/>
                    <a:pt x="399642" y="197915"/>
                    <a:pt x="405635" y="205406"/>
                  </a:cubicBezTo>
                  <a:cubicBezTo>
                    <a:pt x="410232" y="211151"/>
                    <a:pt x="424555" y="205311"/>
                    <a:pt x="426576" y="212386"/>
                  </a:cubicBezTo>
                  <a:cubicBezTo>
                    <a:pt x="426751" y="212999"/>
                    <a:pt x="419723" y="266069"/>
                    <a:pt x="412615" y="275208"/>
                  </a:cubicBezTo>
                  <a:cubicBezTo>
                    <a:pt x="404271" y="285936"/>
                    <a:pt x="370391" y="321895"/>
                    <a:pt x="349794" y="331049"/>
                  </a:cubicBezTo>
                  <a:cubicBezTo>
                    <a:pt x="336347" y="337025"/>
                    <a:pt x="321873" y="340356"/>
                    <a:pt x="307913" y="345009"/>
                  </a:cubicBezTo>
                  <a:lnTo>
                    <a:pt x="286973" y="351989"/>
                  </a:lnTo>
                  <a:cubicBezTo>
                    <a:pt x="240439" y="349662"/>
                    <a:pt x="193802" y="348878"/>
                    <a:pt x="147370" y="345009"/>
                  </a:cubicBezTo>
                  <a:cubicBezTo>
                    <a:pt x="137810" y="344212"/>
                    <a:pt x="126940" y="344022"/>
                    <a:pt x="119449" y="338029"/>
                  </a:cubicBezTo>
                  <a:cubicBezTo>
                    <a:pt x="113704" y="333433"/>
                    <a:pt x="114796" y="324069"/>
                    <a:pt x="112469" y="317089"/>
                  </a:cubicBezTo>
                  <a:cubicBezTo>
                    <a:pt x="118146" y="300057"/>
                    <a:pt x="119878" y="288739"/>
                    <a:pt x="133409" y="275208"/>
                  </a:cubicBezTo>
                  <a:cubicBezTo>
                    <a:pt x="139341" y="269276"/>
                    <a:pt x="147370" y="265901"/>
                    <a:pt x="154350" y="261247"/>
                  </a:cubicBezTo>
                  <a:cubicBezTo>
                    <a:pt x="156677" y="254267"/>
                    <a:pt x="162540" y="247564"/>
                    <a:pt x="161330" y="240307"/>
                  </a:cubicBezTo>
                  <a:cubicBezTo>
                    <a:pt x="159951" y="232032"/>
                    <a:pt x="152611" y="225917"/>
                    <a:pt x="147370" y="219366"/>
                  </a:cubicBezTo>
                  <a:cubicBezTo>
                    <a:pt x="135344" y="204334"/>
                    <a:pt x="103704" y="181545"/>
                    <a:pt x="91528" y="177486"/>
                  </a:cubicBezTo>
                  <a:lnTo>
                    <a:pt x="49647" y="163525"/>
                  </a:lnTo>
                  <a:cubicBezTo>
                    <a:pt x="84310" y="215519"/>
                    <a:pt x="39760" y="151660"/>
                    <a:pt x="84548" y="205406"/>
                  </a:cubicBezTo>
                  <a:cubicBezTo>
                    <a:pt x="89919" y="211851"/>
                    <a:pt x="93855" y="219367"/>
                    <a:pt x="98509" y="226347"/>
                  </a:cubicBezTo>
                  <a:cubicBezTo>
                    <a:pt x="101801" y="236222"/>
                    <a:pt x="116038" y="266443"/>
                    <a:pt x="98509" y="275208"/>
                  </a:cubicBezTo>
                  <a:cubicBezTo>
                    <a:pt x="87898" y="280514"/>
                    <a:pt x="75242" y="270555"/>
                    <a:pt x="63608" y="268228"/>
                  </a:cubicBezTo>
                  <a:cubicBezTo>
                    <a:pt x="47138" y="251758"/>
                    <a:pt x="40014" y="237060"/>
                    <a:pt x="7767" y="261247"/>
                  </a:cubicBezTo>
                  <a:cubicBezTo>
                    <a:pt x="2502" y="265196"/>
                    <a:pt x="15841" y="272265"/>
                    <a:pt x="21727" y="275208"/>
                  </a:cubicBezTo>
                  <a:cubicBezTo>
                    <a:pt x="34889" y="281789"/>
                    <a:pt x="63608" y="289168"/>
                    <a:pt x="63608" y="289168"/>
                  </a:cubicBezTo>
                  <a:cubicBezTo>
                    <a:pt x="70588" y="293821"/>
                    <a:pt x="80386" y="295844"/>
                    <a:pt x="84548" y="303128"/>
                  </a:cubicBezTo>
                  <a:cubicBezTo>
                    <a:pt x="92120" y="316378"/>
                    <a:pt x="95590" y="359680"/>
                    <a:pt x="84548" y="372930"/>
                  </a:cubicBezTo>
                  <a:cubicBezTo>
                    <a:pt x="78407" y="380300"/>
                    <a:pt x="66066" y="378194"/>
                    <a:pt x="56628" y="379910"/>
                  </a:cubicBezTo>
                  <a:cubicBezTo>
                    <a:pt x="40441" y="382853"/>
                    <a:pt x="24054" y="384563"/>
                    <a:pt x="7767" y="386890"/>
                  </a:cubicBezTo>
                  <a:cubicBezTo>
                    <a:pt x="5440" y="393870"/>
                    <a:pt x="-2504" y="401250"/>
                    <a:pt x="786" y="407831"/>
                  </a:cubicBezTo>
                  <a:cubicBezTo>
                    <a:pt x="4076" y="414412"/>
                    <a:pt x="14369" y="414811"/>
                    <a:pt x="21727" y="414811"/>
                  </a:cubicBezTo>
                  <a:cubicBezTo>
                    <a:pt x="56705" y="414811"/>
                    <a:pt x="91528" y="410158"/>
                    <a:pt x="126429" y="407831"/>
                  </a:cubicBezTo>
                  <a:cubicBezTo>
                    <a:pt x="140389" y="412484"/>
                    <a:pt x="159004" y="412484"/>
                    <a:pt x="154350" y="435751"/>
                  </a:cubicBezTo>
                  <a:cubicBezTo>
                    <a:pt x="153059" y="442204"/>
                    <a:pt x="144338" y="444447"/>
                    <a:pt x="140389" y="449712"/>
                  </a:cubicBezTo>
                  <a:cubicBezTo>
                    <a:pt x="130322" y="463134"/>
                    <a:pt x="126429" y="482285"/>
                    <a:pt x="112469" y="491592"/>
                  </a:cubicBezTo>
                  <a:lnTo>
                    <a:pt x="70588" y="519513"/>
                  </a:lnTo>
                  <a:cubicBezTo>
                    <a:pt x="72915" y="526493"/>
                    <a:pt x="71581" y="536176"/>
                    <a:pt x="77568" y="540453"/>
                  </a:cubicBezTo>
                  <a:cubicBezTo>
                    <a:pt x="89543" y="549006"/>
                    <a:pt x="119449" y="554414"/>
                    <a:pt x="119449" y="554414"/>
                  </a:cubicBezTo>
                  <a:cubicBezTo>
                    <a:pt x="128756" y="552087"/>
                    <a:pt x="138789" y="551724"/>
                    <a:pt x="147370" y="547434"/>
                  </a:cubicBezTo>
                  <a:cubicBezTo>
                    <a:pt x="157315" y="542462"/>
                    <a:pt x="170359" y="519929"/>
                    <a:pt x="175290" y="512533"/>
                  </a:cubicBezTo>
                  <a:cubicBezTo>
                    <a:pt x="191904" y="462694"/>
                    <a:pt x="177007" y="478815"/>
                    <a:pt x="210191" y="456692"/>
                  </a:cubicBezTo>
                  <a:cubicBezTo>
                    <a:pt x="223384" y="459990"/>
                    <a:pt x="250125" y="463349"/>
                    <a:pt x="259052" y="477632"/>
                  </a:cubicBezTo>
                  <a:cubicBezTo>
                    <a:pt x="266851" y="490111"/>
                    <a:pt x="268358" y="505553"/>
                    <a:pt x="273012" y="519513"/>
                  </a:cubicBezTo>
                  <a:lnTo>
                    <a:pt x="279993" y="540453"/>
                  </a:lnTo>
                  <a:cubicBezTo>
                    <a:pt x="282320" y="531146"/>
                    <a:pt x="285705" y="522042"/>
                    <a:pt x="286973" y="512533"/>
                  </a:cubicBezTo>
                  <a:cubicBezTo>
                    <a:pt x="290369" y="487059"/>
                    <a:pt x="281769" y="458379"/>
                    <a:pt x="293953" y="435751"/>
                  </a:cubicBezTo>
                  <a:cubicBezTo>
                    <a:pt x="300930" y="422794"/>
                    <a:pt x="335834" y="421791"/>
                    <a:pt x="335834" y="421791"/>
                  </a:cubicBezTo>
                  <a:cubicBezTo>
                    <a:pt x="345453" y="424196"/>
                    <a:pt x="373905" y="426222"/>
                    <a:pt x="377715" y="442731"/>
                  </a:cubicBezTo>
                  <a:cubicBezTo>
                    <a:pt x="378094" y="444374"/>
                    <a:pt x="378649" y="518742"/>
                    <a:pt x="391675" y="540453"/>
                  </a:cubicBezTo>
                  <a:cubicBezTo>
                    <a:pt x="395061" y="546096"/>
                    <a:pt x="400982" y="549760"/>
                    <a:pt x="405635" y="554414"/>
                  </a:cubicBezTo>
                  <a:cubicBezTo>
                    <a:pt x="424249" y="498570"/>
                    <a:pt x="405635" y="568375"/>
                    <a:pt x="405635" y="512533"/>
                  </a:cubicBezTo>
                  <a:cubicBezTo>
                    <a:pt x="405635" y="454318"/>
                    <a:pt x="410288" y="396197"/>
                    <a:pt x="412615" y="338029"/>
                  </a:cubicBezTo>
                  <a:cubicBezTo>
                    <a:pt x="417269" y="342682"/>
                    <a:pt x="421311" y="348040"/>
                    <a:pt x="426576" y="351989"/>
                  </a:cubicBezTo>
                  <a:cubicBezTo>
                    <a:pt x="439999" y="362056"/>
                    <a:pt x="468457" y="379910"/>
                    <a:pt x="468457" y="379910"/>
                  </a:cubicBezTo>
                  <a:cubicBezTo>
                    <a:pt x="473110" y="393870"/>
                    <a:pt x="478848" y="407515"/>
                    <a:pt x="482417" y="421791"/>
                  </a:cubicBezTo>
                  <a:cubicBezTo>
                    <a:pt x="483721" y="427006"/>
                    <a:pt x="492085" y="463499"/>
                    <a:pt x="496377" y="470652"/>
                  </a:cubicBezTo>
                  <a:cubicBezTo>
                    <a:pt x="499763" y="476295"/>
                    <a:pt x="505684" y="479959"/>
                    <a:pt x="510338" y="484612"/>
                  </a:cubicBezTo>
                  <a:cubicBezTo>
                    <a:pt x="512665" y="491592"/>
                    <a:pt x="509960" y="505553"/>
                    <a:pt x="517318" y="505553"/>
                  </a:cubicBezTo>
                  <a:cubicBezTo>
                    <a:pt x="524676" y="505553"/>
                    <a:pt x="524298" y="491970"/>
                    <a:pt x="524298" y="484612"/>
                  </a:cubicBezTo>
                  <a:cubicBezTo>
                    <a:pt x="524298" y="461229"/>
                    <a:pt x="521627" y="437794"/>
                    <a:pt x="517318" y="414811"/>
                  </a:cubicBezTo>
                  <a:cubicBezTo>
                    <a:pt x="514606" y="400348"/>
                    <a:pt x="508011" y="386890"/>
                    <a:pt x="503357" y="372930"/>
                  </a:cubicBezTo>
                  <a:cubicBezTo>
                    <a:pt x="493723" y="344029"/>
                    <a:pt x="500460" y="358113"/>
                    <a:pt x="482417" y="331049"/>
                  </a:cubicBezTo>
                  <a:cubicBezTo>
                    <a:pt x="467528" y="286378"/>
                    <a:pt x="467932" y="296621"/>
                    <a:pt x="482417" y="219366"/>
                  </a:cubicBezTo>
                  <a:cubicBezTo>
                    <a:pt x="483963" y="211121"/>
                    <a:pt x="491724" y="205406"/>
                    <a:pt x="496377" y="198426"/>
                  </a:cubicBezTo>
                  <a:cubicBezTo>
                    <a:pt x="503746" y="161582"/>
                    <a:pt x="495548" y="142170"/>
                    <a:pt x="552218" y="170505"/>
                  </a:cubicBezTo>
                  <a:cubicBezTo>
                    <a:pt x="566934" y="177863"/>
                    <a:pt x="575485" y="193772"/>
                    <a:pt x="587119" y="205406"/>
                  </a:cubicBezTo>
                  <a:lnTo>
                    <a:pt x="615040" y="233327"/>
                  </a:lnTo>
                  <a:cubicBezTo>
                    <a:pt x="634287" y="252575"/>
                    <a:pt x="634247" y="255271"/>
                    <a:pt x="656921" y="268228"/>
                  </a:cubicBezTo>
                  <a:cubicBezTo>
                    <a:pt x="665955" y="273390"/>
                    <a:pt x="675180" y="278324"/>
                    <a:pt x="684841" y="282188"/>
                  </a:cubicBezTo>
                  <a:cubicBezTo>
                    <a:pt x="698504" y="287653"/>
                    <a:pt x="726722" y="296148"/>
                    <a:pt x="726722" y="296148"/>
                  </a:cubicBezTo>
                  <a:cubicBezTo>
                    <a:pt x="731376" y="291495"/>
                    <a:pt x="739601" y="288680"/>
                    <a:pt x="740683" y="282188"/>
                  </a:cubicBezTo>
                  <a:cubicBezTo>
                    <a:pt x="742260" y="272725"/>
                    <a:pt x="737481" y="263085"/>
                    <a:pt x="733702" y="254267"/>
                  </a:cubicBezTo>
                  <a:cubicBezTo>
                    <a:pt x="718869" y="219657"/>
                    <a:pt x="709854" y="237399"/>
                    <a:pt x="677861" y="205406"/>
                  </a:cubicBezTo>
                  <a:cubicBezTo>
                    <a:pt x="670881" y="198426"/>
                    <a:pt x="662981" y="192258"/>
                    <a:pt x="656921" y="184466"/>
                  </a:cubicBezTo>
                  <a:cubicBezTo>
                    <a:pt x="646620" y="171222"/>
                    <a:pt x="629000" y="142585"/>
                    <a:pt x="629000" y="142585"/>
                  </a:cubicBezTo>
                  <a:cubicBezTo>
                    <a:pt x="633653" y="137931"/>
                    <a:pt x="636445" y="129555"/>
                    <a:pt x="642960" y="128624"/>
                  </a:cubicBezTo>
                  <a:cubicBezTo>
                    <a:pt x="667820" y="125073"/>
                    <a:pt x="680906" y="137635"/>
                    <a:pt x="698802" y="149565"/>
                  </a:cubicBezTo>
                  <a:cubicBezTo>
                    <a:pt x="703455" y="156545"/>
                    <a:pt x="707238" y="164192"/>
                    <a:pt x="712762" y="170505"/>
                  </a:cubicBezTo>
                  <a:cubicBezTo>
                    <a:pt x="741345" y="203171"/>
                    <a:pt x="740220" y="200444"/>
                    <a:pt x="768603" y="219366"/>
                  </a:cubicBezTo>
                  <a:cubicBezTo>
                    <a:pt x="773257" y="214713"/>
                    <a:pt x="781633" y="211921"/>
                    <a:pt x="782564" y="205406"/>
                  </a:cubicBezTo>
                  <a:cubicBezTo>
                    <a:pt x="786115" y="180546"/>
                    <a:pt x="773553" y="167460"/>
                    <a:pt x="761623" y="149565"/>
                  </a:cubicBezTo>
                  <a:cubicBezTo>
                    <a:pt x="823492" y="128942"/>
                    <a:pt x="788879" y="137230"/>
                    <a:pt x="866325" y="128624"/>
                  </a:cubicBezTo>
                  <a:cubicBezTo>
                    <a:pt x="861795" y="110504"/>
                    <a:pt x="865198" y="90747"/>
                    <a:pt x="838405" y="93724"/>
                  </a:cubicBezTo>
                  <a:cubicBezTo>
                    <a:pt x="823780" y="95349"/>
                    <a:pt x="796524" y="107684"/>
                    <a:pt x="796524" y="107684"/>
                  </a:cubicBezTo>
                  <a:cubicBezTo>
                    <a:pt x="759296" y="105357"/>
                    <a:pt x="721685" y="106521"/>
                    <a:pt x="684841" y="100704"/>
                  </a:cubicBezTo>
                  <a:cubicBezTo>
                    <a:pt x="676555" y="99396"/>
                    <a:pt x="670270" y="92203"/>
                    <a:pt x="663901" y="86744"/>
                  </a:cubicBezTo>
                  <a:cubicBezTo>
                    <a:pt x="653908" y="78178"/>
                    <a:pt x="646932" y="66124"/>
                    <a:pt x="635980" y="58823"/>
                  </a:cubicBezTo>
                  <a:cubicBezTo>
                    <a:pt x="629000" y="54170"/>
                    <a:pt x="621409" y="50322"/>
                    <a:pt x="615040" y="44863"/>
                  </a:cubicBezTo>
                  <a:cubicBezTo>
                    <a:pt x="605047" y="36297"/>
                    <a:pt x="599606" y="21104"/>
                    <a:pt x="587119" y="16942"/>
                  </a:cubicBezTo>
                  <a:cubicBezTo>
                    <a:pt x="580139" y="14615"/>
                    <a:pt x="573506" y="10628"/>
                    <a:pt x="566179" y="9962"/>
                  </a:cubicBezTo>
                  <a:cubicBezTo>
                    <a:pt x="484017" y="2493"/>
                    <a:pt x="445190" y="-3998"/>
                    <a:pt x="419596" y="2982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Gruppo 26">
            <a:extLst>
              <a:ext uri="{FF2B5EF4-FFF2-40B4-BE49-F238E27FC236}">
                <a16:creationId xmlns:a16="http://schemas.microsoft.com/office/drawing/2014/main" id="{A110FC99-3856-DA4A-98DE-CCC0C8C5C2B6}"/>
              </a:ext>
            </a:extLst>
          </p:cNvPr>
          <p:cNvGrpSpPr>
            <a:grpSpLocks noChangeAspect="1"/>
          </p:cNvGrpSpPr>
          <p:nvPr/>
        </p:nvGrpSpPr>
        <p:grpSpPr>
          <a:xfrm>
            <a:off x="9254343" y="3492347"/>
            <a:ext cx="1261682" cy="1332000"/>
            <a:chOff x="5766145" y="265247"/>
            <a:chExt cx="2501875" cy="2703492"/>
          </a:xfrm>
        </p:grpSpPr>
        <p:pic>
          <p:nvPicPr>
            <p:cNvPr id="56" name="Immagine 10">
              <a:extLst>
                <a:ext uri="{FF2B5EF4-FFF2-40B4-BE49-F238E27FC236}">
                  <a16:creationId xmlns:a16="http://schemas.microsoft.com/office/drawing/2014/main" id="{28830A96-6062-1E42-8E45-356C12C273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61" t="16083" r="34034" b="17400"/>
            <a:stretch/>
          </p:blipFill>
          <p:spPr>
            <a:xfrm>
              <a:off x="5766145" y="265247"/>
              <a:ext cx="2501875" cy="2703492"/>
            </a:xfrm>
            <a:prstGeom prst="rect">
              <a:avLst/>
            </a:prstGeom>
          </p:spPr>
        </p:pic>
        <p:sp>
          <p:nvSpPr>
            <p:cNvPr id="57" name="Figura a mano libera 11">
              <a:extLst>
                <a:ext uri="{FF2B5EF4-FFF2-40B4-BE49-F238E27FC236}">
                  <a16:creationId xmlns:a16="http://schemas.microsoft.com/office/drawing/2014/main" id="{F2945C9B-18C3-934C-8DFD-FD668285CFE7}"/>
                </a:ext>
              </a:extLst>
            </p:cNvPr>
            <p:cNvSpPr/>
            <p:nvPr/>
          </p:nvSpPr>
          <p:spPr>
            <a:xfrm>
              <a:off x="6145115" y="820574"/>
              <a:ext cx="813864" cy="1693381"/>
            </a:xfrm>
            <a:custGeom>
              <a:avLst/>
              <a:gdLst>
                <a:gd name="connsiteX0" fmla="*/ 611044 w 813864"/>
                <a:gd name="connsiteY0" fmla="*/ 89492 h 1693381"/>
                <a:gd name="connsiteX1" fmla="*/ 593710 w 813864"/>
                <a:gd name="connsiteY1" fmla="*/ 67824 h 1693381"/>
                <a:gd name="connsiteX2" fmla="*/ 572041 w 813864"/>
                <a:gd name="connsiteY2" fmla="*/ 33155 h 1693381"/>
                <a:gd name="connsiteX3" fmla="*/ 533039 w 813864"/>
                <a:gd name="connsiteY3" fmla="*/ 132829 h 1693381"/>
                <a:gd name="connsiteX4" fmla="*/ 511370 w 813864"/>
                <a:gd name="connsiteY4" fmla="*/ 154497 h 1693381"/>
                <a:gd name="connsiteX5" fmla="*/ 485368 w 813864"/>
                <a:gd name="connsiteY5" fmla="*/ 163164 h 1693381"/>
                <a:gd name="connsiteX6" fmla="*/ 433365 w 813864"/>
                <a:gd name="connsiteY6" fmla="*/ 158831 h 1693381"/>
                <a:gd name="connsiteX7" fmla="*/ 424697 w 813864"/>
                <a:gd name="connsiteY7" fmla="*/ 150163 h 1693381"/>
                <a:gd name="connsiteX8" fmla="*/ 398695 w 813864"/>
                <a:gd name="connsiteY8" fmla="*/ 141496 h 1693381"/>
                <a:gd name="connsiteX9" fmla="*/ 385694 w 813864"/>
                <a:gd name="connsiteY9" fmla="*/ 137162 h 1693381"/>
                <a:gd name="connsiteX10" fmla="*/ 372694 w 813864"/>
                <a:gd name="connsiteY10" fmla="*/ 85159 h 1693381"/>
                <a:gd name="connsiteX11" fmla="*/ 368360 w 813864"/>
                <a:gd name="connsiteY11" fmla="*/ 72158 h 1693381"/>
                <a:gd name="connsiteX12" fmla="*/ 351025 w 813864"/>
                <a:gd name="connsiteY12" fmla="*/ 67824 h 1693381"/>
                <a:gd name="connsiteX13" fmla="*/ 320690 w 813864"/>
                <a:gd name="connsiteY13" fmla="*/ 72158 h 1693381"/>
                <a:gd name="connsiteX14" fmla="*/ 299021 w 813864"/>
                <a:gd name="connsiteY14" fmla="*/ 89492 h 1693381"/>
                <a:gd name="connsiteX15" fmla="*/ 273020 w 813864"/>
                <a:gd name="connsiteY15" fmla="*/ 98160 h 1693381"/>
                <a:gd name="connsiteX16" fmla="*/ 268686 w 813864"/>
                <a:gd name="connsiteY16" fmla="*/ 111161 h 1693381"/>
                <a:gd name="connsiteX17" fmla="*/ 303355 w 813864"/>
                <a:gd name="connsiteY17" fmla="*/ 132829 h 1693381"/>
                <a:gd name="connsiteX18" fmla="*/ 316356 w 813864"/>
                <a:gd name="connsiteY18" fmla="*/ 141496 h 1693381"/>
                <a:gd name="connsiteX19" fmla="*/ 359693 w 813864"/>
                <a:gd name="connsiteY19" fmla="*/ 150163 h 1693381"/>
                <a:gd name="connsiteX20" fmla="*/ 372694 w 813864"/>
                <a:gd name="connsiteY20" fmla="*/ 154497 h 1693381"/>
                <a:gd name="connsiteX21" fmla="*/ 407363 w 813864"/>
                <a:gd name="connsiteY21" fmla="*/ 163164 h 1693381"/>
                <a:gd name="connsiteX22" fmla="*/ 424697 w 813864"/>
                <a:gd name="connsiteY22" fmla="*/ 171832 h 1693381"/>
                <a:gd name="connsiteX23" fmla="*/ 437698 w 813864"/>
                <a:gd name="connsiteY23" fmla="*/ 176165 h 1693381"/>
                <a:gd name="connsiteX24" fmla="*/ 459367 w 813864"/>
                <a:gd name="connsiteY24" fmla="*/ 193500 h 1693381"/>
                <a:gd name="connsiteX25" fmla="*/ 485368 w 813864"/>
                <a:gd name="connsiteY25" fmla="*/ 202167 h 1693381"/>
                <a:gd name="connsiteX26" fmla="*/ 498369 w 813864"/>
                <a:gd name="connsiteY26" fmla="*/ 206501 h 1693381"/>
                <a:gd name="connsiteX27" fmla="*/ 515704 w 813864"/>
                <a:gd name="connsiteY27" fmla="*/ 189166 h 1693381"/>
                <a:gd name="connsiteX28" fmla="*/ 528705 w 813864"/>
                <a:gd name="connsiteY28" fmla="*/ 176165 h 1693381"/>
                <a:gd name="connsiteX29" fmla="*/ 546040 w 813864"/>
                <a:gd name="connsiteY29" fmla="*/ 171832 h 1693381"/>
                <a:gd name="connsiteX30" fmla="*/ 572041 w 813864"/>
                <a:gd name="connsiteY30" fmla="*/ 189166 h 1693381"/>
                <a:gd name="connsiteX31" fmla="*/ 580709 w 813864"/>
                <a:gd name="connsiteY31" fmla="*/ 215168 h 1693381"/>
                <a:gd name="connsiteX32" fmla="*/ 572041 w 813864"/>
                <a:gd name="connsiteY32" fmla="*/ 262838 h 1693381"/>
                <a:gd name="connsiteX33" fmla="*/ 563374 w 813864"/>
                <a:gd name="connsiteY33" fmla="*/ 271506 h 1693381"/>
                <a:gd name="connsiteX34" fmla="*/ 546040 w 813864"/>
                <a:gd name="connsiteY34" fmla="*/ 297508 h 1693381"/>
                <a:gd name="connsiteX35" fmla="*/ 537372 w 813864"/>
                <a:gd name="connsiteY35" fmla="*/ 310508 h 1693381"/>
                <a:gd name="connsiteX36" fmla="*/ 498369 w 813864"/>
                <a:gd name="connsiteY36" fmla="*/ 306175 h 1693381"/>
                <a:gd name="connsiteX37" fmla="*/ 472367 w 813864"/>
                <a:gd name="connsiteY37" fmla="*/ 297508 h 1693381"/>
                <a:gd name="connsiteX38" fmla="*/ 459367 w 813864"/>
                <a:gd name="connsiteY38" fmla="*/ 293174 h 1693381"/>
                <a:gd name="connsiteX39" fmla="*/ 437698 w 813864"/>
                <a:gd name="connsiteY39" fmla="*/ 297508 h 1693381"/>
                <a:gd name="connsiteX40" fmla="*/ 433365 w 813864"/>
                <a:gd name="connsiteY40" fmla="*/ 310508 h 1693381"/>
                <a:gd name="connsiteX41" fmla="*/ 446366 w 813864"/>
                <a:gd name="connsiteY41" fmla="*/ 332177 h 1693381"/>
                <a:gd name="connsiteX42" fmla="*/ 463700 w 813864"/>
                <a:gd name="connsiteY42" fmla="*/ 336510 h 1693381"/>
                <a:gd name="connsiteX43" fmla="*/ 472367 w 813864"/>
                <a:gd name="connsiteY43" fmla="*/ 345178 h 1693381"/>
                <a:gd name="connsiteX44" fmla="*/ 498369 w 813864"/>
                <a:gd name="connsiteY44" fmla="*/ 362512 h 1693381"/>
                <a:gd name="connsiteX45" fmla="*/ 520038 w 813864"/>
                <a:gd name="connsiteY45" fmla="*/ 388514 h 1693381"/>
                <a:gd name="connsiteX46" fmla="*/ 515704 w 813864"/>
                <a:gd name="connsiteY46" fmla="*/ 457853 h 1693381"/>
                <a:gd name="connsiteX47" fmla="*/ 511370 w 813864"/>
                <a:gd name="connsiteY47" fmla="*/ 470853 h 1693381"/>
                <a:gd name="connsiteX48" fmla="*/ 502703 w 813864"/>
                <a:gd name="connsiteY48" fmla="*/ 479521 h 1693381"/>
                <a:gd name="connsiteX49" fmla="*/ 476701 w 813864"/>
                <a:gd name="connsiteY49" fmla="*/ 496855 h 1693381"/>
                <a:gd name="connsiteX50" fmla="*/ 468034 w 813864"/>
                <a:gd name="connsiteY50" fmla="*/ 505523 h 1693381"/>
                <a:gd name="connsiteX51" fmla="*/ 455033 w 813864"/>
                <a:gd name="connsiteY51" fmla="*/ 509856 h 1693381"/>
                <a:gd name="connsiteX52" fmla="*/ 416030 w 813864"/>
                <a:gd name="connsiteY52" fmla="*/ 518524 h 1693381"/>
                <a:gd name="connsiteX53" fmla="*/ 403029 w 813864"/>
                <a:gd name="connsiteY53" fmla="*/ 527191 h 1693381"/>
                <a:gd name="connsiteX54" fmla="*/ 377027 w 813864"/>
                <a:gd name="connsiteY54" fmla="*/ 535858 h 1693381"/>
                <a:gd name="connsiteX55" fmla="*/ 338024 w 813864"/>
                <a:gd name="connsiteY55" fmla="*/ 522857 h 1693381"/>
                <a:gd name="connsiteX56" fmla="*/ 325023 w 813864"/>
                <a:gd name="connsiteY56" fmla="*/ 496855 h 1693381"/>
                <a:gd name="connsiteX57" fmla="*/ 329357 w 813864"/>
                <a:gd name="connsiteY57" fmla="*/ 479521 h 1693381"/>
                <a:gd name="connsiteX58" fmla="*/ 372694 w 813864"/>
                <a:gd name="connsiteY58" fmla="*/ 453519 h 1693381"/>
                <a:gd name="connsiteX59" fmla="*/ 398695 w 813864"/>
                <a:gd name="connsiteY59" fmla="*/ 444852 h 1693381"/>
                <a:gd name="connsiteX60" fmla="*/ 411696 w 813864"/>
                <a:gd name="connsiteY60" fmla="*/ 440518 h 1693381"/>
                <a:gd name="connsiteX61" fmla="*/ 416030 w 813864"/>
                <a:gd name="connsiteY61" fmla="*/ 427517 h 1693381"/>
                <a:gd name="connsiteX62" fmla="*/ 390028 w 813864"/>
                <a:gd name="connsiteY62" fmla="*/ 410182 h 1693381"/>
                <a:gd name="connsiteX63" fmla="*/ 364026 w 813864"/>
                <a:gd name="connsiteY63" fmla="*/ 392848 h 1693381"/>
                <a:gd name="connsiteX64" fmla="*/ 351025 w 813864"/>
                <a:gd name="connsiteY64" fmla="*/ 375513 h 1693381"/>
                <a:gd name="connsiteX65" fmla="*/ 338024 w 813864"/>
                <a:gd name="connsiteY65" fmla="*/ 353845 h 1693381"/>
                <a:gd name="connsiteX66" fmla="*/ 329357 w 813864"/>
                <a:gd name="connsiteY66" fmla="*/ 327843 h 1693381"/>
                <a:gd name="connsiteX67" fmla="*/ 312022 w 813864"/>
                <a:gd name="connsiteY67" fmla="*/ 301841 h 1693381"/>
                <a:gd name="connsiteX68" fmla="*/ 316356 w 813864"/>
                <a:gd name="connsiteY68" fmla="*/ 284507 h 1693381"/>
                <a:gd name="connsiteX69" fmla="*/ 333691 w 813864"/>
                <a:gd name="connsiteY69" fmla="*/ 267172 h 1693381"/>
                <a:gd name="connsiteX70" fmla="*/ 329357 w 813864"/>
                <a:gd name="connsiteY70" fmla="*/ 241170 h 1693381"/>
                <a:gd name="connsiteX71" fmla="*/ 286021 w 813864"/>
                <a:gd name="connsiteY71" fmla="*/ 254171 h 1693381"/>
                <a:gd name="connsiteX72" fmla="*/ 251351 w 813864"/>
                <a:gd name="connsiteY72" fmla="*/ 280173 h 1693381"/>
                <a:gd name="connsiteX73" fmla="*/ 221016 w 813864"/>
                <a:gd name="connsiteY73" fmla="*/ 288840 h 1693381"/>
                <a:gd name="connsiteX74" fmla="*/ 208015 w 813864"/>
                <a:gd name="connsiteY74" fmla="*/ 293174 h 1693381"/>
                <a:gd name="connsiteX75" fmla="*/ 173346 w 813864"/>
                <a:gd name="connsiteY75" fmla="*/ 297508 h 1693381"/>
                <a:gd name="connsiteX76" fmla="*/ 147344 w 813864"/>
                <a:gd name="connsiteY76" fmla="*/ 301841 h 1693381"/>
                <a:gd name="connsiteX77" fmla="*/ 143010 w 813864"/>
                <a:gd name="connsiteY77" fmla="*/ 314842 h 1693381"/>
                <a:gd name="connsiteX78" fmla="*/ 156011 w 813864"/>
                <a:gd name="connsiteY78" fmla="*/ 323509 h 1693381"/>
                <a:gd name="connsiteX79" fmla="*/ 199348 w 813864"/>
                <a:gd name="connsiteY79" fmla="*/ 327843 h 1693381"/>
                <a:gd name="connsiteX80" fmla="*/ 238350 w 813864"/>
                <a:gd name="connsiteY80" fmla="*/ 332177 h 1693381"/>
                <a:gd name="connsiteX81" fmla="*/ 264352 w 813864"/>
                <a:gd name="connsiteY81" fmla="*/ 340844 h 1693381"/>
                <a:gd name="connsiteX82" fmla="*/ 277353 w 813864"/>
                <a:gd name="connsiteY82" fmla="*/ 345178 h 1693381"/>
                <a:gd name="connsiteX83" fmla="*/ 299021 w 813864"/>
                <a:gd name="connsiteY83" fmla="*/ 362512 h 1693381"/>
                <a:gd name="connsiteX84" fmla="*/ 307689 w 813864"/>
                <a:gd name="connsiteY84" fmla="*/ 371180 h 1693381"/>
                <a:gd name="connsiteX85" fmla="*/ 307689 w 813864"/>
                <a:gd name="connsiteY85" fmla="*/ 423183 h 1693381"/>
                <a:gd name="connsiteX86" fmla="*/ 294688 w 813864"/>
                <a:gd name="connsiteY86" fmla="*/ 444852 h 1693381"/>
                <a:gd name="connsiteX87" fmla="*/ 268686 w 813864"/>
                <a:gd name="connsiteY87" fmla="*/ 462186 h 1693381"/>
                <a:gd name="connsiteX88" fmla="*/ 242684 w 813864"/>
                <a:gd name="connsiteY88" fmla="*/ 470853 h 1693381"/>
                <a:gd name="connsiteX89" fmla="*/ 208015 w 813864"/>
                <a:gd name="connsiteY89" fmla="*/ 462186 h 1693381"/>
                <a:gd name="connsiteX90" fmla="*/ 182013 w 813864"/>
                <a:gd name="connsiteY90" fmla="*/ 444852 h 1693381"/>
                <a:gd name="connsiteX91" fmla="*/ 169012 w 813864"/>
                <a:gd name="connsiteY91" fmla="*/ 436184 h 1693381"/>
                <a:gd name="connsiteX92" fmla="*/ 156011 w 813864"/>
                <a:gd name="connsiteY92" fmla="*/ 431851 h 1693381"/>
                <a:gd name="connsiteX93" fmla="*/ 86673 w 813864"/>
                <a:gd name="connsiteY93" fmla="*/ 436184 h 1693381"/>
                <a:gd name="connsiteX94" fmla="*/ 95340 w 813864"/>
                <a:gd name="connsiteY94" fmla="*/ 444852 h 1693381"/>
                <a:gd name="connsiteX95" fmla="*/ 138676 w 813864"/>
                <a:gd name="connsiteY95" fmla="*/ 457853 h 1693381"/>
                <a:gd name="connsiteX96" fmla="*/ 186347 w 813864"/>
                <a:gd name="connsiteY96" fmla="*/ 470853 h 1693381"/>
                <a:gd name="connsiteX97" fmla="*/ 199348 w 813864"/>
                <a:gd name="connsiteY97" fmla="*/ 475187 h 1693381"/>
                <a:gd name="connsiteX98" fmla="*/ 212349 w 813864"/>
                <a:gd name="connsiteY98" fmla="*/ 479521 h 1693381"/>
                <a:gd name="connsiteX99" fmla="*/ 238350 w 813864"/>
                <a:gd name="connsiteY99" fmla="*/ 492522 h 1693381"/>
                <a:gd name="connsiteX100" fmla="*/ 264352 w 813864"/>
                <a:gd name="connsiteY100" fmla="*/ 509856 h 1693381"/>
                <a:gd name="connsiteX101" fmla="*/ 273020 w 813864"/>
                <a:gd name="connsiteY101" fmla="*/ 518524 h 1693381"/>
                <a:gd name="connsiteX102" fmla="*/ 264352 w 813864"/>
                <a:gd name="connsiteY102" fmla="*/ 557526 h 1693381"/>
                <a:gd name="connsiteX103" fmla="*/ 255685 w 813864"/>
                <a:gd name="connsiteY103" fmla="*/ 566194 h 1693381"/>
                <a:gd name="connsiteX104" fmla="*/ 195014 w 813864"/>
                <a:gd name="connsiteY104" fmla="*/ 557526 h 1693381"/>
                <a:gd name="connsiteX105" fmla="*/ 177679 w 813864"/>
                <a:gd name="connsiteY105" fmla="*/ 548859 h 1693381"/>
                <a:gd name="connsiteX106" fmla="*/ 164678 w 813864"/>
                <a:gd name="connsiteY106" fmla="*/ 553193 h 1693381"/>
                <a:gd name="connsiteX107" fmla="*/ 195014 w 813864"/>
                <a:gd name="connsiteY107" fmla="*/ 587862 h 1693381"/>
                <a:gd name="connsiteX108" fmla="*/ 208015 w 813864"/>
                <a:gd name="connsiteY108" fmla="*/ 600863 h 1693381"/>
                <a:gd name="connsiteX109" fmla="*/ 225349 w 813864"/>
                <a:gd name="connsiteY109" fmla="*/ 609530 h 1693381"/>
                <a:gd name="connsiteX110" fmla="*/ 238350 w 813864"/>
                <a:gd name="connsiteY110" fmla="*/ 618198 h 1693381"/>
                <a:gd name="connsiteX111" fmla="*/ 281687 w 813864"/>
                <a:gd name="connsiteY111" fmla="*/ 631199 h 1693381"/>
                <a:gd name="connsiteX112" fmla="*/ 307689 w 813864"/>
                <a:gd name="connsiteY112" fmla="*/ 635532 h 1693381"/>
                <a:gd name="connsiteX113" fmla="*/ 320690 w 813864"/>
                <a:gd name="connsiteY113" fmla="*/ 639866 h 1693381"/>
                <a:gd name="connsiteX114" fmla="*/ 333691 w 813864"/>
                <a:gd name="connsiteY114" fmla="*/ 648533 h 1693381"/>
                <a:gd name="connsiteX115" fmla="*/ 355359 w 813864"/>
                <a:gd name="connsiteY115" fmla="*/ 652867 h 1693381"/>
                <a:gd name="connsiteX116" fmla="*/ 372694 w 813864"/>
                <a:gd name="connsiteY116" fmla="*/ 657200 h 1693381"/>
                <a:gd name="connsiteX117" fmla="*/ 407363 w 813864"/>
                <a:gd name="connsiteY117" fmla="*/ 683202 h 1693381"/>
                <a:gd name="connsiteX118" fmla="*/ 411696 w 813864"/>
                <a:gd name="connsiteY118" fmla="*/ 696203 h 1693381"/>
                <a:gd name="connsiteX119" fmla="*/ 420364 w 813864"/>
                <a:gd name="connsiteY119" fmla="*/ 704871 h 1693381"/>
                <a:gd name="connsiteX120" fmla="*/ 437698 w 813864"/>
                <a:gd name="connsiteY120" fmla="*/ 743873 h 1693381"/>
                <a:gd name="connsiteX121" fmla="*/ 424697 w 813864"/>
                <a:gd name="connsiteY121" fmla="*/ 821879 h 1693381"/>
                <a:gd name="connsiteX122" fmla="*/ 411696 w 813864"/>
                <a:gd name="connsiteY122" fmla="*/ 834880 h 1693381"/>
                <a:gd name="connsiteX123" fmla="*/ 355359 w 813864"/>
                <a:gd name="connsiteY123" fmla="*/ 830546 h 1693381"/>
                <a:gd name="connsiteX124" fmla="*/ 342358 w 813864"/>
                <a:gd name="connsiteY124" fmla="*/ 826213 h 1693381"/>
                <a:gd name="connsiteX125" fmla="*/ 325023 w 813864"/>
                <a:gd name="connsiteY125" fmla="*/ 821879 h 1693381"/>
                <a:gd name="connsiteX126" fmla="*/ 286021 w 813864"/>
                <a:gd name="connsiteY126" fmla="*/ 800211 h 1693381"/>
                <a:gd name="connsiteX127" fmla="*/ 277353 w 813864"/>
                <a:gd name="connsiteY127" fmla="*/ 791544 h 1693381"/>
                <a:gd name="connsiteX128" fmla="*/ 251351 w 813864"/>
                <a:gd name="connsiteY128" fmla="*/ 774209 h 1693381"/>
                <a:gd name="connsiteX129" fmla="*/ 229683 w 813864"/>
                <a:gd name="connsiteY129" fmla="*/ 743873 h 1693381"/>
                <a:gd name="connsiteX130" fmla="*/ 208015 w 813864"/>
                <a:gd name="connsiteY130" fmla="*/ 717871 h 1693381"/>
                <a:gd name="connsiteX131" fmla="*/ 182013 w 813864"/>
                <a:gd name="connsiteY131" fmla="*/ 722205 h 1693381"/>
                <a:gd name="connsiteX132" fmla="*/ 169012 w 813864"/>
                <a:gd name="connsiteY132" fmla="*/ 748207 h 1693381"/>
                <a:gd name="connsiteX133" fmla="*/ 195014 w 813864"/>
                <a:gd name="connsiteY133" fmla="*/ 778543 h 1693381"/>
                <a:gd name="connsiteX134" fmla="*/ 208015 w 813864"/>
                <a:gd name="connsiteY134" fmla="*/ 787210 h 1693381"/>
                <a:gd name="connsiteX135" fmla="*/ 234017 w 813864"/>
                <a:gd name="connsiteY135" fmla="*/ 813212 h 1693381"/>
                <a:gd name="connsiteX136" fmla="*/ 234017 w 813864"/>
                <a:gd name="connsiteY136" fmla="*/ 860882 h 1693381"/>
                <a:gd name="connsiteX137" fmla="*/ 195014 w 813864"/>
                <a:gd name="connsiteY137" fmla="*/ 856548 h 1693381"/>
                <a:gd name="connsiteX138" fmla="*/ 156011 w 813864"/>
                <a:gd name="connsiteY138" fmla="*/ 839214 h 1693381"/>
                <a:gd name="connsiteX139" fmla="*/ 125676 w 813864"/>
                <a:gd name="connsiteY139" fmla="*/ 808878 h 1693381"/>
                <a:gd name="connsiteX140" fmla="*/ 117008 w 813864"/>
                <a:gd name="connsiteY140" fmla="*/ 800211 h 1693381"/>
                <a:gd name="connsiteX141" fmla="*/ 108341 w 813864"/>
                <a:gd name="connsiteY141" fmla="*/ 787210 h 1693381"/>
                <a:gd name="connsiteX142" fmla="*/ 95340 w 813864"/>
                <a:gd name="connsiteY142" fmla="*/ 782876 h 1693381"/>
                <a:gd name="connsiteX143" fmla="*/ 65004 w 813864"/>
                <a:gd name="connsiteY143" fmla="*/ 765542 h 1693381"/>
                <a:gd name="connsiteX144" fmla="*/ 52003 w 813864"/>
                <a:gd name="connsiteY144" fmla="*/ 761208 h 1693381"/>
                <a:gd name="connsiteX145" fmla="*/ 8667 w 813864"/>
                <a:gd name="connsiteY145" fmla="*/ 774209 h 1693381"/>
                <a:gd name="connsiteX146" fmla="*/ 0 w 813864"/>
                <a:gd name="connsiteY146" fmla="*/ 787210 h 1693381"/>
                <a:gd name="connsiteX147" fmla="*/ 4333 w 813864"/>
                <a:gd name="connsiteY147" fmla="*/ 800211 h 1693381"/>
                <a:gd name="connsiteX148" fmla="*/ 17334 w 813864"/>
                <a:gd name="connsiteY148" fmla="*/ 808878 h 1693381"/>
                <a:gd name="connsiteX149" fmla="*/ 60671 w 813864"/>
                <a:gd name="connsiteY149" fmla="*/ 821879 h 1693381"/>
                <a:gd name="connsiteX150" fmla="*/ 86673 w 813864"/>
                <a:gd name="connsiteY150" fmla="*/ 830546 h 1693381"/>
                <a:gd name="connsiteX151" fmla="*/ 121342 w 813864"/>
                <a:gd name="connsiteY151" fmla="*/ 839214 h 1693381"/>
                <a:gd name="connsiteX152" fmla="*/ 147344 w 813864"/>
                <a:gd name="connsiteY152" fmla="*/ 847881 h 1693381"/>
                <a:gd name="connsiteX153" fmla="*/ 160345 w 813864"/>
                <a:gd name="connsiteY153" fmla="*/ 852215 h 1693381"/>
                <a:gd name="connsiteX154" fmla="*/ 177679 w 813864"/>
                <a:gd name="connsiteY154" fmla="*/ 856548 h 1693381"/>
                <a:gd name="connsiteX155" fmla="*/ 190680 w 813864"/>
                <a:gd name="connsiteY155" fmla="*/ 860882 h 1693381"/>
                <a:gd name="connsiteX156" fmla="*/ 234017 w 813864"/>
                <a:gd name="connsiteY156" fmla="*/ 865216 h 1693381"/>
                <a:gd name="connsiteX157" fmla="*/ 264352 w 813864"/>
                <a:gd name="connsiteY157" fmla="*/ 869549 h 1693381"/>
                <a:gd name="connsiteX158" fmla="*/ 290354 w 813864"/>
                <a:gd name="connsiteY158" fmla="*/ 878217 h 1693381"/>
                <a:gd name="connsiteX159" fmla="*/ 303355 w 813864"/>
                <a:gd name="connsiteY159" fmla="*/ 882550 h 1693381"/>
                <a:gd name="connsiteX160" fmla="*/ 316356 w 813864"/>
                <a:gd name="connsiteY160" fmla="*/ 891217 h 1693381"/>
                <a:gd name="connsiteX161" fmla="*/ 333691 w 813864"/>
                <a:gd name="connsiteY161" fmla="*/ 912886 h 1693381"/>
                <a:gd name="connsiteX162" fmla="*/ 325023 w 813864"/>
                <a:gd name="connsiteY162" fmla="*/ 943221 h 1693381"/>
                <a:gd name="connsiteX163" fmla="*/ 307689 w 813864"/>
                <a:gd name="connsiteY163" fmla="*/ 977890 h 1693381"/>
                <a:gd name="connsiteX164" fmla="*/ 294688 w 813864"/>
                <a:gd name="connsiteY164" fmla="*/ 982224 h 1693381"/>
                <a:gd name="connsiteX165" fmla="*/ 281687 w 813864"/>
                <a:gd name="connsiteY165" fmla="*/ 990891 h 1693381"/>
                <a:gd name="connsiteX166" fmla="*/ 238350 w 813864"/>
                <a:gd name="connsiteY166" fmla="*/ 995225 h 1693381"/>
                <a:gd name="connsiteX167" fmla="*/ 390028 w 813864"/>
                <a:gd name="connsiteY167" fmla="*/ 1021227 h 1693381"/>
                <a:gd name="connsiteX168" fmla="*/ 403029 w 813864"/>
                <a:gd name="connsiteY168" fmla="*/ 1025561 h 1693381"/>
                <a:gd name="connsiteX169" fmla="*/ 429031 w 813864"/>
                <a:gd name="connsiteY169" fmla="*/ 1029894 h 1693381"/>
                <a:gd name="connsiteX170" fmla="*/ 442032 w 813864"/>
                <a:gd name="connsiteY170" fmla="*/ 1034228 h 1693381"/>
                <a:gd name="connsiteX171" fmla="*/ 459367 w 813864"/>
                <a:gd name="connsiteY171" fmla="*/ 1060230 h 1693381"/>
                <a:gd name="connsiteX172" fmla="*/ 446366 w 813864"/>
                <a:gd name="connsiteY172" fmla="*/ 1133902 h 1693381"/>
                <a:gd name="connsiteX173" fmla="*/ 433365 w 813864"/>
                <a:gd name="connsiteY173" fmla="*/ 1142569 h 1693381"/>
                <a:gd name="connsiteX174" fmla="*/ 424697 w 813864"/>
                <a:gd name="connsiteY174" fmla="*/ 1151236 h 1693381"/>
                <a:gd name="connsiteX175" fmla="*/ 398695 w 813864"/>
                <a:gd name="connsiteY175" fmla="*/ 1159904 h 1693381"/>
                <a:gd name="connsiteX176" fmla="*/ 372694 w 813864"/>
                <a:gd name="connsiteY176" fmla="*/ 1177238 h 1693381"/>
                <a:gd name="connsiteX177" fmla="*/ 359693 w 813864"/>
                <a:gd name="connsiteY177" fmla="*/ 1203240 h 1693381"/>
                <a:gd name="connsiteX178" fmla="*/ 377027 w 813864"/>
                <a:gd name="connsiteY178" fmla="*/ 1207574 h 1693381"/>
                <a:gd name="connsiteX179" fmla="*/ 390028 w 813864"/>
                <a:gd name="connsiteY179" fmla="*/ 1211908 h 1693381"/>
                <a:gd name="connsiteX180" fmla="*/ 429031 w 813864"/>
                <a:gd name="connsiteY180" fmla="*/ 1207574 h 1693381"/>
                <a:gd name="connsiteX181" fmla="*/ 459367 w 813864"/>
                <a:gd name="connsiteY181" fmla="*/ 1194573 h 1693381"/>
                <a:gd name="connsiteX182" fmla="*/ 485368 w 813864"/>
                <a:gd name="connsiteY182" fmla="*/ 1181572 h 1693381"/>
                <a:gd name="connsiteX183" fmla="*/ 520038 w 813864"/>
                <a:gd name="connsiteY183" fmla="*/ 1194573 h 1693381"/>
                <a:gd name="connsiteX184" fmla="*/ 528705 w 813864"/>
                <a:gd name="connsiteY184" fmla="*/ 1220575 h 1693381"/>
                <a:gd name="connsiteX185" fmla="*/ 533039 w 813864"/>
                <a:gd name="connsiteY185" fmla="*/ 1233576 h 1693381"/>
                <a:gd name="connsiteX186" fmla="*/ 528705 w 813864"/>
                <a:gd name="connsiteY186" fmla="*/ 1281246 h 1693381"/>
                <a:gd name="connsiteX187" fmla="*/ 502703 w 813864"/>
                <a:gd name="connsiteY187" fmla="*/ 1302914 h 1693381"/>
                <a:gd name="connsiteX188" fmla="*/ 476701 w 813864"/>
                <a:gd name="connsiteY188" fmla="*/ 1315915 h 1693381"/>
                <a:gd name="connsiteX189" fmla="*/ 446366 w 813864"/>
                <a:gd name="connsiteY189" fmla="*/ 1307248 h 1693381"/>
                <a:gd name="connsiteX190" fmla="*/ 437698 w 813864"/>
                <a:gd name="connsiteY190" fmla="*/ 1298581 h 1693381"/>
                <a:gd name="connsiteX191" fmla="*/ 424697 w 813864"/>
                <a:gd name="connsiteY191" fmla="*/ 1294247 h 1693381"/>
                <a:gd name="connsiteX192" fmla="*/ 385694 w 813864"/>
                <a:gd name="connsiteY192" fmla="*/ 1272579 h 1693381"/>
                <a:gd name="connsiteX193" fmla="*/ 346692 w 813864"/>
                <a:gd name="connsiteY193" fmla="*/ 1255244 h 1693381"/>
                <a:gd name="connsiteX194" fmla="*/ 320690 w 813864"/>
                <a:gd name="connsiteY194" fmla="*/ 1246577 h 1693381"/>
                <a:gd name="connsiteX195" fmla="*/ 307689 w 813864"/>
                <a:gd name="connsiteY195" fmla="*/ 1242243 h 1693381"/>
                <a:gd name="connsiteX196" fmla="*/ 277353 w 813864"/>
                <a:gd name="connsiteY196" fmla="*/ 1233576 h 1693381"/>
                <a:gd name="connsiteX197" fmla="*/ 264352 w 813864"/>
                <a:gd name="connsiteY197" fmla="*/ 1224908 h 1693381"/>
                <a:gd name="connsiteX198" fmla="*/ 260019 w 813864"/>
                <a:gd name="connsiteY198" fmla="*/ 1185906 h 1693381"/>
                <a:gd name="connsiteX199" fmla="*/ 273020 w 813864"/>
                <a:gd name="connsiteY199" fmla="*/ 1177238 h 1693381"/>
                <a:gd name="connsiteX200" fmla="*/ 299021 w 813864"/>
                <a:gd name="connsiteY200" fmla="*/ 1168571 h 1693381"/>
                <a:gd name="connsiteX201" fmla="*/ 307689 w 813864"/>
                <a:gd name="connsiteY201" fmla="*/ 1159904 h 1693381"/>
                <a:gd name="connsiteX202" fmla="*/ 333691 w 813864"/>
                <a:gd name="connsiteY202" fmla="*/ 1142569 h 1693381"/>
                <a:gd name="connsiteX203" fmla="*/ 342358 w 813864"/>
                <a:gd name="connsiteY203" fmla="*/ 1129568 h 1693381"/>
                <a:gd name="connsiteX204" fmla="*/ 329357 w 813864"/>
                <a:gd name="connsiteY204" fmla="*/ 1120901 h 1693381"/>
                <a:gd name="connsiteX205" fmla="*/ 307689 w 813864"/>
                <a:gd name="connsiteY205" fmla="*/ 1125235 h 1693381"/>
                <a:gd name="connsiteX206" fmla="*/ 294688 w 813864"/>
                <a:gd name="connsiteY206" fmla="*/ 1129568 h 1693381"/>
                <a:gd name="connsiteX207" fmla="*/ 277353 w 813864"/>
                <a:gd name="connsiteY207" fmla="*/ 1133902 h 1693381"/>
                <a:gd name="connsiteX208" fmla="*/ 247018 w 813864"/>
                <a:gd name="connsiteY208" fmla="*/ 1151236 h 1693381"/>
                <a:gd name="connsiteX209" fmla="*/ 234017 w 813864"/>
                <a:gd name="connsiteY209" fmla="*/ 1155570 h 1693381"/>
                <a:gd name="connsiteX210" fmla="*/ 195014 w 813864"/>
                <a:gd name="connsiteY210" fmla="*/ 1151236 h 1693381"/>
                <a:gd name="connsiteX211" fmla="*/ 173346 w 813864"/>
                <a:gd name="connsiteY211" fmla="*/ 1107900 h 1693381"/>
                <a:gd name="connsiteX212" fmla="*/ 164678 w 813864"/>
                <a:gd name="connsiteY212" fmla="*/ 1077564 h 1693381"/>
                <a:gd name="connsiteX213" fmla="*/ 156011 w 813864"/>
                <a:gd name="connsiteY213" fmla="*/ 1051562 h 1693381"/>
                <a:gd name="connsiteX214" fmla="*/ 143010 w 813864"/>
                <a:gd name="connsiteY214" fmla="*/ 1038562 h 1693381"/>
                <a:gd name="connsiteX215" fmla="*/ 138676 w 813864"/>
                <a:gd name="connsiteY215" fmla="*/ 1025561 h 1693381"/>
                <a:gd name="connsiteX216" fmla="*/ 130009 w 813864"/>
                <a:gd name="connsiteY216" fmla="*/ 1012560 h 1693381"/>
                <a:gd name="connsiteX217" fmla="*/ 134343 w 813864"/>
                <a:gd name="connsiteY217" fmla="*/ 990891 h 1693381"/>
                <a:gd name="connsiteX218" fmla="*/ 130009 w 813864"/>
                <a:gd name="connsiteY218" fmla="*/ 960556 h 1693381"/>
                <a:gd name="connsiteX219" fmla="*/ 117008 w 813864"/>
                <a:gd name="connsiteY219" fmla="*/ 956222 h 1693381"/>
                <a:gd name="connsiteX220" fmla="*/ 26002 w 813864"/>
                <a:gd name="connsiteY220" fmla="*/ 951889 h 1693381"/>
                <a:gd name="connsiteX221" fmla="*/ 65004 w 813864"/>
                <a:gd name="connsiteY221" fmla="*/ 973557 h 1693381"/>
                <a:gd name="connsiteX222" fmla="*/ 95340 w 813864"/>
                <a:gd name="connsiteY222" fmla="*/ 990891 h 1693381"/>
                <a:gd name="connsiteX223" fmla="*/ 108341 w 813864"/>
                <a:gd name="connsiteY223" fmla="*/ 999559 h 1693381"/>
                <a:gd name="connsiteX224" fmla="*/ 117008 w 813864"/>
                <a:gd name="connsiteY224" fmla="*/ 1012560 h 1693381"/>
                <a:gd name="connsiteX225" fmla="*/ 125676 w 813864"/>
                <a:gd name="connsiteY225" fmla="*/ 1038562 h 1693381"/>
                <a:gd name="connsiteX226" fmla="*/ 121342 w 813864"/>
                <a:gd name="connsiteY226" fmla="*/ 1073231 h 1693381"/>
                <a:gd name="connsiteX227" fmla="*/ 65004 w 813864"/>
                <a:gd name="connsiteY227" fmla="*/ 1064563 h 1693381"/>
                <a:gd name="connsiteX228" fmla="*/ 30335 w 813864"/>
                <a:gd name="connsiteY228" fmla="*/ 1081898 h 1693381"/>
                <a:gd name="connsiteX229" fmla="*/ 39003 w 813864"/>
                <a:gd name="connsiteY229" fmla="*/ 1094899 h 1693381"/>
                <a:gd name="connsiteX230" fmla="*/ 65004 w 813864"/>
                <a:gd name="connsiteY230" fmla="*/ 1103566 h 1693381"/>
                <a:gd name="connsiteX231" fmla="*/ 86673 w 813864"/>
                <a:gd name="connsiteY231" fmla="*/ 1116567 h 1693381"/>
                <a:gd name="connsiteX232" fmla="*/ 112675 w 813864"/>
                <a:gd name="connsiteY232" fmla="*/ 1133902 h 1693381"/>
                <a:gd name="connsiteX233" fmla="*/ 121342 w 813864"/>
                <a:gd name="connsiteY233" fmla="*/ 1146903 h 1693381"/>
                <a:gd name="connsiteX234" fmla="*/ 130009 w 813864"/>
                <a:gd name="connsiteY234" fmla="*/ 1172905 h 1693381"/>
                <a:gd name="connsiteX235" fmla="*/ 125676 w 813864"/>
                <a:gd name="connsiteY235" fmla="*/ 1185906 h 1693381"/>
                <a:gd name="connsiteX236" fmla="*/ 43336 w 813864"/>
                <a:gd name="connsiteY236" fmla="*/ 1190239 h 1693381"/>
                <a:gd name="connsiteX237" fmla="*/ 30335 w 813864"/>
                <a:gd name="connsiteY237" fmla="*/ 1194573 h 1693381"/>
                <a:gd name="connsiteX238" fmla="*/ 17334 w 813864"/>
                <a:gd name="connsiteY238" fmla="*/ 1220575 h 1693381"/>
                <a:gd name="connsiteX239" fmla="*/ 26002 w 813864"/>
                <a:gd name="connsiteY239" fmla="*/ 1229242 h 1693381"/>
                <a:gd name="connsiteX240" fmla="*/ 52003 w 813864"/>
                <a:gd name="connsiteY240" fmla="*/ 1242243 h 1693381"/>
                <a:gd name="connsiteX241" fmla="*/ 82339 w 813864"/>
                <a:gd name="connsiteY241" fmla="*/ 1233576 h 1693381"/>
                <a:gd name="connsiteX242" fmla="*/ 104007 w 813864"/>
                <a:gd name="connsiteY242" fmla="*/ 1220575 h 1693381"/>
                <a:gd name="connsiteX243" fmla="*/ 169012 w 813864"/>
                <a:gd name="connsiteY243" fmla="*/ 1224908 h 1693381"/>
                <a:gd name="connsiteX244" fmla="*/ 177679 w 813864"/>
                <a:gd name="connsiteY244" fmla="*/ 1259578 h 1693381"/>
                <a:gd name="connsiteX245" fmla="*/ 173346 w 813864"/>
                <a:gd name="connsiteY245" fmla="*/ 1272579 h 1693381"/>
                <a:gd name="connsiteX246" fmla="*/ 160345 w 813864"/>
                <a:gd name="connsiteY246" fmla="*/ 1276912 h 1693381"/>
                <a:gd name="connsiteX247" fmla="*/ 147344 w 813864"/>
                <a:gd name="connsiteY247" fmla="*/ 1285580 h 1693381"/>
                <a:gd name="connsiteX248" fmla="*/ 134343 w 813864"/>
                <a:gd name="connsiteY248" fmla="*/ 1289913 h 1693381"/>
                <a:gd name="connsiteX249" fmla="*/ 125676 w 813864"/>
                <a:gd name="connsiteY249" fmla="*/ 1302914 h 1693381"/>
                <a:gd name="connsiteX250" fmla="*/ 112675 w 813864"/>
                <a:gd name="connsiteY250" fmla="*/ 1311581 h 1693381"/>
                <a:gd name="connsiteX251" fmla="*/ 104007 w 813864"/>
                <a:gd name="connsiteY251" fmla="*/ 1324582 h 1693381"/>
                <a:gd name="connsiteX252" fmla="*/ 104007 w 813864"/>
                <a:gd name="connsiteY252" fmla="*/ 1363585 h 1693381"/>
                <a:gd name="connsiteX253" fmla="*/ 112675 w 813864"/>
                <a:gd name="connsiteY253" fmla="*/ 1376586 h 1693381"/>
                <a:gd name="connsiteX254" fmla="*/ 134343 w 813864"/>
                <a:gd name="connsiteY254" fmla="*/ 1367919 h 1693381"/>
                <a:gd name="connsiteX255" fmla="*/ 156011 w 813864"/>
                <a:gd name="connsiteY255" fmla="*/ 1341917 h 1693381"/>
                <a:gd name="connsiteX256" fmla="*/ 173346 w 813864"/>
                <a:gd name="connsiteY256" fmla="*/ 1333250 h 1693381"/>
                <a:gd name="connsiteX257" fmla="*/ 186347 w 813864"/>
                <a:gd name="connsiteY257" fmla="*/ 1324582 h 1693381"/>
                <a:gd name="connsiteX258" fmla="*/ 290354 w 813864"/>
                <a:gd name="connsiteY258" fmla="*/ 1307248 h 1693381"/>
                <a:gd name="connsiteX259" fmla="*/ 351025 w 813864"/>
                <a:gd name="connsiteY259" fmla="*/ 1311581 h 1693381"/>
                <a:gd name="connsiteX260" fmla="*/ 364026 w 813864"/>
                <a:gd name="connsiteY260" fmla="*/ 1320249 h 1693381"/>
                <a:gd name="connsiteX261" fmla="*/ 359693 w 813864"/>
                <a:gd name="connsiteY261" fmla="*/ 1376586 h 1693381"/>
                <a:gd name="connsiteX262" fmla="*/ 364026 w 813864"/>
                <a:gd name="connsiteY262" fmla="*/ 1424256 h 1693381"/>
                <a:gd name="connsiteX263" fmla="*/ 385694 w 813864"/>
                <a:gd name="connsiteY263" fmla="*/ 1415589 h 1693381"/>
                <a:gd name="connsiteX264" fmla="*/ 394362 w 813864"/>
                <a:gd name="connsiteY264" fmla="*/ 1389587 h 1693381"/>
                <a:gd name="connsiteX265" fmla="*/ 398695 w 813864"/>
                <a:gd name="connsiteY265" fmla="*/ 1376586 h 1693381"/>
                <a:gd name="connsiteX266" fmla="*/ 411696 w 813864"/>
                <a:gd name="connsiteY266" fmla="*/ 1372253 h 1693381"/>
                <a:gd name="connsiteX267" fmla="*/ 450699 w 813864"/>
                <a:gd name="connsiteY267" fmla="*/ 1380920 h 1693381"/>
                <a:gd name="connsiteX268" fmla="*/ 476701 w 813864"/>
                <a:gd name="connsiteY268" fmla="*/ 1398254 h 1693381"/>
                <a:gd name="connsiteX269" fmla="*/ 489702 w 813864"/>
                <a:gd name="connsiteY269" fmla="*/ 1424256 h 1693381"/>
                <a:gd name="connsiteX270" fmla="*/ 502703 w 813864"/>
                <a:gd name="connsiteY270" fmla="*/ 1419923 h 1693381"/>
                <a:gd name="connsiteX271" fmla="*/ 511370 w 813864"/>
                <a:gd name="connsiteY271" fmla="*/ 1411255 h 1693381"/>
                <a:gd name="connsiteX272" fmla="*/ 524371 w 813864"/>
                <a:gd name="connsiteY272" fmla="*/ 1393921 h 1693381"/>
                <a:gd name="connsiteX273" fmla="*/ 537372 w 813864"/>
                <a:gd name="connsiteY273" fmla="*/ 1389587 h 1693381"/>
                <a:gd name="connsiteX274" fmla="*/ 567708 w 813864"/>
                <a:gd name="connsiteY274" fmla="*/ 1380920 h 1693381"/>
                <a:gd name="connsiteX275" fmla="*/ 580709 w 813864"/>
                <a:gd name="connsiteY275" fmla="*/ 1393921 h 1693381"/>
                <a:gd name="connsiteX276" fmla="*/ 567708 w 813864"/>
                <a:gd name="connsiteY276" fmla="*/ 1523930 h 1693381"/>
                <a:gd name="connsiteX277" fmla="*/ 563374 w 813864"/>
                <a:gd name="connsiteY277" fmla="*/ 1541265 h 1693381"/>
                <a:gd name="connsiteX278" fmla="*/ 541706 w 813864"/>
                <a:gd name="connsiteY278" fmla="*/ 1567267 h 1693381"/>
                <a:gd name="connsiteX279" fmla="*/ 524371 w 813864"/>
                <a:gd name="connsiteY279" fmla="*/ 1588935 h 1693381"/>
                <a:gd name="connsiteX280" fmla="*/ 489702 w 813864"/>
                <a:gd name="connsiteY280" fmla="*/ 1584601 h 1693381"/>
                <a:gd name="connsiteX281" fmla="*/ 450699 w 813864"/>
                <a:gd name="connsiteY281" fmla="*/ 1567267 h 1693381"/>
                <a:gd name="connsiteX282" fmla="*/ 442032 w 813864"/>
                <a:gd name="connsiteY282" fmla="*/ 1558599 h 1693381"/>
                <a:gd name="connsiteX283" fmla="*/ 437698 w 813864"/>
                <a:gd name="connsiteY283" fmla="*/ 1536931 h 1693381"/>
                <a:gd name="connsiteX284" fmla="*/ 394362 w 813864"/>
                <a:gd name="connsiteY284" fmla="*/ 1541265 h 1693381"/>
                <a:gd name="connsiteX285" fmla="*/ 381361 w 813864"/>
                <a:gd name="connsiteY285" fmla="*/ 1549932 h 1693381"/>
                <a:gd name="connsiteX286" fmla="*/ 368360 w 813864"/>
                <a:gd name="connsiteY286" fmla="*/ 1554266 h 1693381"/>
                <a:gd name="connsiteX287" fmla="*/ 351025 w 813864"/>
                <a:gd name="connsiteY287" fmla="*/ 1562933 h 1693381"/>
                <a:gd name="connsiteX288" fmla="*/ 303355 w 813864"/>
                <a:gd name="connsiteY288" fmla="*/ 1554266 h 1693381"/>
                <a:gd name="connsiteX289" fmla="*/ 290354 w 813864"/>
                <a:gd name="connsiteY289" fmla="*/ 1545599 h 1693381"/>
                <a:gd name="connsiteX290" fmla="*/ 255685 w 813864"/>
                <a:gd name="connsiteY290" fmla="*/ 1554266 h 1693381"/>
                <a:gd name="connsiteX291" fmla="*/ 229683 w 813864"/>
                <a:gd name="connsiteY291" fmla="*/ 1575934 h 1693381"/>
                <a:gd name="connsiteX292" fmla="*/ 216682 w 813864"/>
                <a:gd name="connsiteY292" fmla="*/ 1584601 h 1693381"/>
                <a:gd name="connsiteX293" fmla="*/ 208015 w 813864"/>
                <a:gd name="connsiteY293" fmla="*/ 1597602 h 1693381"/>
                <a:gd name="connsiteX294" fmla="*/ 229683 w 813864"/>
                <a:gd name="connsiteY294" fmla="*/ 1593269 h 1693381"/>
                <a:gd name="connsiteX295" fmla="*/ 242684 w 813864"/>
                <a:gd name="connsiteY295" fmla="*/ 1588935 h 1693381"/>
                <a:gd name="connsiteX296" fmla="*/ 281687 w 813864"/>
                <a:gd name="connsiteY296" fmla="*/ 1580268 h 1693381"/>
                <a:gd name="connsiteX297" fmla="*/ 351025 w 813864"/>
                <a:gd name="connsiteY297" fmla="*/ 1593269 h 1693381"/>
                <a:gd name="connsiteX298" fmla="*/ 355359 w 813864"/>
                <a:gd name="connsiteY298" fmla="*/ 1606270 h 1693381"/>
                <a:gd name="connsiteX299" fmla="*/ 351025 w 813864"/>
                <a:gd name="connsiteY299" fmla="*/ 1645272 h 1693381"/>
                <a:gd name="connsiteX300" fmla="*/ 346692 w 813864"/>
                <a:gd name="connsiteY300" fmla="*/ 1658273 h 1693381"/>
                <a:gd name="connsiteX301" fmla="*/ 342358 w 813864"/>
                <a:gd name="connsiteY301" fmla="*/ 1675608 h 1693381"/>
                <a:gd name="connsiteX302" fmla="*/ 346692 w 813864"/>
                <a:gd name="connsiteY302" fmla="*/ 1692943 h 1693381"/>
                <a:gd name="connsiteX303" fmla="*/ 355359 w 813864"/>
                <a:gd name="connsiteY303" fmla="*/ 1684275 h 1693381"/>
                <a:gd name="connsiteX304" fmla="*/ 359693 w 813864"/>
                <a:gd name="connsiteY304" fmla="*/ 1653940 h 1693381"/>
                <a:gd name="connsiteX305" fmla="*/ 364026 w 813864"/>
                <a:gd name="connsiteY305" fmla="*/ 1619271 h 1693381"/>
                <a:gd name="connsiteX306" fmla="*/ 385694 w 813864"/>
                <a:gd name="connsiteY306" fmla="*/ 1588935 h 1693381"/>
                <a:gd name="connsiteX307" fmla="*/ 398695 w 813864"/>
                <a:gd name="connsiteY307" fmla="*/ 1584601 h 1693381"/>
                <a:gd name="connsiteX308" fmla="*/ 420364 w 813864"/>
                <a:gd name="connsiteY308" fmla="*/ 1588935 h 1693381"/>
                <a:gd name="connsiteX309" fmla="*/ 446366 w 813864"/>
                <a:gd name="connsiteY309" fmla="*/ 1597602 h 1693381"/>
                <a:gd name="connsiteX310" fmla="*/ 455033 w 813864"/>
                <a:gd name="connsiteY310" fmla="*/ 1606270 h 1693381"/>
                <a:gd name="connsiteX311" fmla="*/ 468034 w 813864"/>
                <a:gd name="connsiteY311" fmla="*/ 1632271 h 1693381"/>
                <a:gd name="connsiteX312" fmla="*/ 476701 w 813864"/>
                <a:gd name="connsiteY312" fmla="*/ 1640939 h 1693381"/>
                <a:gd name="connsiteX313" fmla="*/ 541706 w 813864"/>
                <a:gd name="connsiteY313" fmla="*/ 1645272 h 1693381"/>
                <a:gd name="connsiteX314" fmla="*/ 550373 w 813864"/>
                <a:gd name="connsiteY314" fmla="*/ 1653940 h 1693381"/>
                <a:gd name="connsiteX315" fmla="*/ 563374 w 813864"/>
                <a:gd name="connsiteY315" fmla="*/ 1658273 h 1693381"/>
                <a:gd name="connsiteX316" fmla="*/ 567708 w 813864"/>
                <a:gd name="connsiteY316" fmla="*/ 1671274 h 1693381"/>
                <a:gd name="connsiteX317" fmla="*/ 576375 w 813864"/>
                <a:gd name="connsiteY317" fmla="*/ 1684275 h 1693381"/>
                <a:gd name="connsiteX318" fmla="*/ 585042 w 813864"/>
                <a:gd name="connsiteY318" fmla="*/ 1666941 h 1693381"/>
                <a:gd name="connsiteX319" fmla="*/ 576375 w 813864"/>
                <a:gd name="connsiteY319" fmla="*/ 1614937 h 1693381"/>
                <a:gd name="connsiteX320" fmla="*/ 580709 w 813864"/>
                <a:gd name="connsiteY320" fmla="*/ 1562933 h 1693381"/>
                <a:gd name="connsiteX321" fmla="*/ 593710 w 813864"/>
                <a:gd name="connsiteY321" fmla="*/ 1558599 h 1693381"/>
                <a:gd name="connsiteX322" fmla="*/ 628379 w 813864"/>
                <a:gd name="connsiteY322" fmla="*/ 1562933 h 1693381"/>
                <a:gd name="connsiteX323" fmla="*/ 637046 w 813864"/>
                <a:gd name="connsiteY323" fmla="*/ 1575934 h 1693381"/>
                <a:gd name="connsiteX324" fmla="*/ 641380 w 813864"/>
                <a:gd name="connsiteY324" fmla="*/ 1593269 h 1693381"/>
                <a:gd name="connsiteX325" fmla="*/ 650047 w 813864"/>
                <a:gd name="connsiteY325" fmla="*/ 1619271 h 1693381"/>
                <a:gd name="connsiteX326" fmla="*/ 663048 w 813864"/>
                <a:gd name="connsiteY326" fmla="*/ 1649606 h 1693381"/>
                <a:gd name="connsiteX327" fmla="*/ 676049 w 813864"/>
                <a:gd name="connsiteY327" fmla="*/ 1653940 h 1693381"/>
                <a:gd name="connsiteX328" fmla="*/ 671715 w 813864"/>
                <a:gd name="connsiteY328" fmla="*/ 1610603 h 1693381"/>
                <a:gd name="connsiteX329" fmla="*/ 663048 w 813864"/>
                <a:gd name="connsiteY329" fmla="*/ 1580268 h 1693381"/>
                <a:gd name="connsiteX330" fmla="*/ 667382 w 813864"/>
                <a:gd name="connsiteY330" fmla="*/ 1532598 h 1693381"/>
                <a:gd name="connsiteX331" fmla="*/ 680383 w 813864"/>
                <a:gd name="connsiteY331" fmla="*/ 1523930 h 1693381"/>
                <a:gd name="connsiteX332" fmla="*/ 706385 w 813864"/>
                <a:gd name="connsiteY332" fmla="*/ 1536931 h 1693381"/>
                <a:gd name="connsiteX333" fmla="*/ 728053 w 813864"/>
                <a:gd name="connsiteY333" fmla="*/ 1562933 h 1693381"/>
                <a:gd name="connsiteX334" fmla="*/ 754055 w 813864"/>
                <a:gd name="connsiteY334" fmla="*/ 1597602 h 1693381"/>
                <a:gd name="connsiteX335" fmla="*/ 767056 w 813864"/>
                <a:gd name="connsiteY335" fmla="*/ 1593269 h 1693381"/>
                <a:gd name="connsiteX336" fmla="*/ 771389 w 813864"/>
                <a:gd name="connsiteY336" fmla="*/ 1549932 h 1693381"/>
                <a:gd name="connsiteX337" fmla="*/ 745387 w 813864"/>
                <a:gd name="connsiteY337" fmla="*/ 1532598 h 1693381"/>
                <a:gd name="connsiteX338" fmla="*/ 762722 w 813864"/>
                <a:gd name="connsiteY338" fmla="*/ 1445925 h 1693381"/>
                <a:gd name="connsiteX339" fmla="*/ 771389 w 813864"/>
                <a:gd name="connsiteY339" fmla="*/ 1437257 h 1693381"/>
                <a:gd name="connsiteX340" fmla="*/ 728053 w 813864"/>
                <a:gd name="connsiteY340" fmla="*/ 1424256 h 1693381"/>
                <a:gd name="connsiteX341" fmla="*/ 715052 w 813864"/>
                <a:gd name="connsiteY341" fmla="*/ 1415589 h 1693381"/>
                <a:gd name="connsiteX342" fmla="*/ 710718 w 813864"/>
                <a:gd name="connsiteY342" fmla="*/ 1402588 h 1693381"/>
                <a:gd name="connsiteX343" fmla="*/ 715052 w 813864"/>
                <a:gd name="connsiteY343" fmla="*/ 1376586 h 1693381"/>
                <a:gd name="connsiteX344" fmla="*/ 780057 w 813864"/>
                <a:gd name="connsiteY344" fmla="*/ 1363585 h 1693381"/>
                <a:gd name="connsiteX345" fmla="*/ 793058 w 813864"/>
                <a:gd name="connsiteY345" fmla="*/ 1359252 h 1693381"/>
                <a:gd name="connsiteX346" fmla="*/ 788724 w 813864"/>
                <a:gd name="connsiteY346" fmla="*/ 1337583 h 1693381"/>
                <a:gd name="connsiteX347" fmla="*/ 775723 w 813864"/>
                <a:gd name="connsiteY347" fmla="*/ 1333250 h 1693381"/>
                <a:gd name="connsiteX348" fmla="*/ 715052 w 813864"/>
                <a:gd name="connsiteY348" fmla="*/ 1324582 h 1693381"/>
                <a:gd name="connsiteX349" fmla="*/ 680383 w 813864"/>
                <a:gd name="connsiteY349" fmla="*/ 1315915 h 1693381"/>
                <a:gd name="connsiteX350" fmla="*/ 671715 w 813864"/>
                <a:gd name="connsiteY350" fmla="*/ 1307248 h 1693381"/>
                <a:gd name="connsiteX351" fmla="*/ 680383 w 813864"/>
                <a:gd name="connsiteY351" fmla="*/ 1285580 h 1693381"/>
                <a:gd name="connsiteX352" fmla="*/ 702051 w 813864"/>
                <a:gd name="connsiteY352" fmla="*/ 1272579 h 1693381"/>
                <a:gd name="connsiteX353" fmla="*/ 723719 w 813864"/>
                <a:gd name="connsiteY353" fmla="*/ 1268245 h 1693381"/>
                <a:gd name="connsiteX354" fmla="*/ 745387 w 813864"/>
                <a:gd name="connsiteY354" fmla="*/ 1250910 h 1693381"/>
                <a:gd name="connsiteX355" fmla="*/ 736720 w 813864"/>
                <a:gd name="connsiteY355" fmla="*/ 1237909 h 1693381"/>
                <a:gd name="connsiteX356" fmla="*/ 710718 w 813864"/>
                <a:gd name="connsiteY356" fmla="*/ 1224908 h 1693381"/>
                <a:gd name="connsiteX357" fmla="*/ 663048 w 813864"/>
                <a:gd name="connsiteY357" fmla="*/ 1229242 h 1693381"/>
                <a:gd name="connsiteX358" fmla="*/ 650047 w 813864"/>
                <a:gd name="connsiteY358" fmla="*/ 1233576 h 1693381"/>
                <a:gd name="connsiteX359" fmla="*/ 624045 w 813864"/>
                <a:gd name="connsiteY359" fmla="*/ 1224908 h 1693381"/>
                <a:gd name="connsiteX360" fmla="*/ 615378 w 813864"/>
                <a:gd name="connsiteY360" fmla="*/ 1211908 h 1693381"/>
                <a:gd name="connsiteX361" fmla="*/ 598043 w 813864"/>
                <a:gd name="connsiteY361" fmla="*/ 1194573 h 1693381"/>
                <a:gd name="connsiteX362" fmla="*/ 598043 w 813864"/>
                <a:gd name="connsiteY362" fmla="*/ 1155570 h 1693381"/>
                <a:gd name="connsiteX363" fmla="*/ 611044 w 813864"/>
                <a:gd name="connsiteY363" fmla="*/ 1151236 h 1693381"/>
                <a:gd name="connsiteX364" fmla="*/ 645713 w 813864"/>
                <a:gd name="connsiteY364" fmla="*/ 1138235 h 1693381"/>
                <a:gd name="connsiteX365" fmla="*/ 650047 w 813864"/>
                <a:gd name="connsiteY365" fmla="*/ 1125235 h 1693381"/>
                <a:gd name="connsiteX366" fmla="*/ 645713 w 813864"/>
                <a:gd name="connsiteY366" fmla="*/ 1112234 h 1693381"/>
                <a:gd name="connsiteX367" fmla="*/ 619712 w 813864"/>
                <a:gd name="connsiteY367" fmla="*/ 1103566 h 1693381"/>
                <a:gd name="connsiteX368" fmla="*/ 589376 w 813864"/>
                <a:gd name="connsiteY368" fmla="*/ 1090565 h 1693381"/>
                <a:gd name="connsiteX369" fmla="*/ 563374 w 813864"/>
                <a:gd name="connsiteY369" fmla="*/ 1081898 h 1693381"/>
                <a:gd name="connsiteX370" fmla="*/ 550373 w 813864"/>
                <a:gd name="connsiteY370" fmla="*/ 1077564 h 1693381"/>
                <a:gd name="connsiteX371" fmla="*/ 546040 w 813864"/>
                <a:gd name="connsiteY371" fmla="*/ 1051562 h 1693381"/>
                <a:gd name="connsiteX372" fmla="*/ 559040 w 813864"/>
                <a:gd name="connsiteY372" fmla="*/ 1047229 h 1693381"/>
                <a:gd name="connsiteX373" fmla="*/ 567708 w 813864"/>
                <a:gd name="connsiteY373" fmla="*/ 1038562 h 1693381"/>
                <a:gd name="connsiteX374" fmla="*/ 658714 w 813864"/>
                <a:gd name="connsiteY374" fmla="*/ 1042895 h 1693381"/>
                <a:gd name="connsiteX375" fmla="*/ 671715 w 813864"/>
                <a:gd name="connsiteY375" fmla="*/ 1047229 h 1693381"/>
                <a:gd name="connsiteX376" fmla="*/ 693384 w 813864"/>
                <a:gd name="connsiteY376" fmla="*/ 1051562 h 1693381"/>
                <a:gd name="connsiteX377" fmla="*/ 719385 w 813864"/>
                <a:gd name="connsiteY377" fmla="*/ 1047229 h 1693381"/>
                <a:gd name="connsiteX378" fmla="*/ 723719 w 813864"/>
                <a:gd name="connsiteY378" fmla="*/ 1029894 h 1693381"/>
                <a:gd name="connsiteX379" fmla="*/ 719385 w 813864"/>
                <a:gd name="connsiteY379" fmla="*/ 1012560 h 1693381"/>
                <a:gd name="connsiteX380" fmla="*/ 697717 w 813864"/>
                <a:gd name="connsiteY380" fmla="*/ 982224 h 1693381"/>
                <a:gd name="connsiteX381" fmla="*/ 684716 w 813864"/>
                <a:gd name="connsiteY381" fmla="*/ 977890 h 1693381"/>
                <a:gd name="connsiteX382" fmla="*/ 632712 w 813864"/>
                <a:gd name="connsiteY382" fmla="*/ 969223 h 1693381"/>
                <a:gd name="connsiteX383" fmla="*/ 606711 w 813864"/>
                <a:gd name="connsiteY383" fmla="*/ 960556 h 1693381"/>
                <a:gd name="connsiteX384" fmla="*/ 593710 w 813864"/>
                <a:gd name="connsiteY384" fmla="*/ 951889 h 1693381"/>
                <a:gd name="connsiteX385" fmla="*/ 585042 w 813864"/>
                <a:gd name="connsiteY385" fmla="*/ 938888 h 1693381"/>
                <a:gd name="connsiteX386" fmla="*/ 585042 w 813864"/>
                <a:gd name="connsiteY386" fmla="*/ 895551 h 1693381"/>
                <a:gd name="connsiteX387" fmla="*/ 589376 w 813864"/>
                <a:gd name="connsiteY387" fmla="*/ 882550 h 1693381"/>
                <a:gd name="connsiteX388" fmla="*/ 602377 w 813864"/>
                <a:gd name="connsiteY388" fmla="*/ 869549 h 1693381"/>
                <a:gd name="connsiteX389" fmla="*/ 702051 w 813864"/>
                <a:gd name="connsiteY389" fmla="*/ 869549 h 1693381"/>
                <a:gd name="connsiteX390" fmla="*/ 715052 w 813864"/>
                <a:gd name="connsiteY390" fmla="*/ 860882 h 1693381"/>
                <a:gd name="connsiteX391" fmla="*/ 728053 w 813864"/>
                <a:gd name="connsiteY391" fmla="*/ 856548 h 1693381"/>
                <a:gd name="connsiteX392" fmla="*/ 736720 w 813864"/>
                <a:gd name="connsiteY392" fmla="*/ 843547 h 1693381"/>
                <a:gd name="connsiteX393" fmla="*/ 715052 w 813864"/>
                <a:gd name="connsiteY393" fmla="*/ 808878 h 1693381"/>
                <a:gd name="connsiteX394" fmla="*/ 702051 w 813864"/>
                <a:gd name="connsiteY394" fmla="*/ 800211 h 1693381"/>
                <a:gd name="connsiteX395" fmla="*/ 658714 w 813864"/>
                <a:gd name="connsiteY395" fmla="*/ 791544 h 1693381"/>
                <a:gd name="connsiteX396" fmla="*/ 624045 w 813864"/>
                <a:gd name="connsiteY396" fmla="*/ 787210 h 1693381"/>
                <a:gd name="connsiteX397" fmla="*/ 593710 w 813864"/>
                <a:gd name="connsiteY397" fmla="*/ 765542 h 1693381"/>
                <a:gd name="connsiteX398" fmla="*/ 598043 w 813864"/>
                <a:gd name="connsiteY398" fmla="*/ 748207 h 1693381"/>
                <a:gd name="connsiteX399" fmla="*/ 611044 w 813864"/>
                <a:gd name="connsiteY399" fmla="*/ 743873 h 1693381"/>
                <a:gd name="connsiteX400" fmla="*/ 624045 w 813864"/>
                <a:gd name="connsiteY400" fmla="*/ 735206 h 1693381"/>
                <a:gd name="connsiteX401" fmla="*/ 749721 w 813864"/>
                <a:gd name="connsiteY401" fmla="*/ 739540 h 1693381"/>
                <a:gd name="connsiteX402" fmla="*/ 771389 w 813864"/>
                <a:gd name="connsiteY402" fmla="*/ 735206 h 1693381"/>
                <a:gd name="connsiteX403" fmla="*/ 758388 w 813864"/>
                <a:gd name="connsiteY403" fmla="*/ 700537 h 1693381"/>
                <a:gd name="connsiteX404" fmla="*/ 745387 w 813864"/>
                <a:gd name="connsiteY404" fmla="*/ 657200 h 1693381"/>
                <a:gd name="connsiteX405" fmla="*/ 754055 w 813864"/>
                <a:gd name="connsiteY405" fmla="*/ 605197 h 1693381"/>
                <a:gd name="connsiteX406" fmla="*/ 762722 w 813864"/>
                <a:gd name="connsiteY406" fmla="*/ 544526 h 1693381"/>
                <a:gd name="connsiteX407" fmla="*/ 771389 w 813864"/>
                <a:gd name="connsiteY407" fmla="*/ 557526 h 1693381"/>
                <a:gd name="connsiteX408" fmla="*/ 767056 w 813864"/>
                <a:gd name="connsiteY408" fmla="*/ 574861 h 1693381"/>
                <a:gd name="connsiteX409" fmla="*/ 754055 w 813864"/>
                <a:gd name="connsiteY409" fmla="*/ 583528 h 1693381"/>
                <a:gd name="connsiteX410" fmla="*/ 728053 w 813864"/>
                <a:gd name="connsiteY410" fmla="*/ 605197 h 1693381"/>
                <a:gd name="connsiteX411" fmla="*/ 702051 w 813864"/>
                <a:gd name="connsiteY411" fmla="*/ 613864 h 1693381"/>
                <a:gd name="connsiteX412" fmla="*/ 676049 w 813864"/>
                <a:gd name="connsiteY412" fmla="*/ 609530 h 1693381"/>
                <a:gd name="connsiteX413" fmla="*/ 645713 w 813864"/>
                <a:gd name="connsiteY413" fmla="*/ 592196 h 1693381"/>
                <a:gd name="connsiteX414" fmla="*/ 619712 w 813864"/>
                <a:gd name="connsiteY414" fmla="*/ 566194 h 1693381"/>
                <a:gd name="connsiteX415" fmla="*/ 611044 w 813864"/>
                <a:gd name="connsiteY415" fmla="*/ 557526 h 1693381"/>
                <a:gd name="connsiteX416" fmla="*/ 615378 w 813864"/>
                <a:gd name="connsiteY416" fmla="*/ 518524 h 1693381"/>
                <a:gd name="connsiteX417" fmla="*/ 637046 w 813864"/>
                <a:gd name="connsiteY417" fmla="*/ 496855 h 1693381"/>
                <a:gd name="connsiteX418" fmla="*/ 658714 w 813864"/>
                <a:gd name="connsiteY418" fmla="*/ 470853 h 1693381"/>
                <a:gd name="connsiteX419" fmla="*/ 654381 w 813864"/>
                <a:gd name="connsiteY419" fmla="*/ 431851 h 1693381"/>
                <a:gd name="connsiteX420" fmla="*/ 645713 w 813864"/>
                <a:gd name="connsiteY420" fmla="*/ 423183 h 1693381"/>
                <a:gd name="connsiteX421" fmla="*/ 637046 w 813864"/>
                <a:gd name="connsiteY421" fmla="*/ 405849 h 1693381"/>
                <a:gd name="connsiteX422" fmla="*/ 628379 w 813864"/>
                <a:gd name="connsiteY422" fmla="*/ 392848 h 1693381"/>
                <a:gd name="connsiteX423" fmla="*/ 619712 w 813864"/>
                <a:gd name="connsiteY423" fmla="*/ 371180 h 1693381"/>
                <a:gd name="connsiteX424" fmla="*/ 602377 w 813864"/>
                <a:gd name="connsiteY424" fmla="*/ 349511 h 1693381"/>
                <a:gd name="connsiteX425" fmla="*/ 598043 w 813864"/>
                <a:gd name="connsiteY425" fmla="*/ 332177 h 1693381"/>
                <a:gd name="connsiteX426" fmla="*/ 589376 w 813864"/>
                <a:gd name="connsiteY426" fmla="*/ 236836 h 1693381"/>
                <a:gd name="connsiteX427" fmla="*/ 585042 w 813864"/>
                <a:gd name="connsiteY427" fmla="*/ 210835 h 1693381"/>
                <a:gd name="connsiteX428" fmla="*/ 593710 w 813864"/>
                <a:gd name="connsiteY428" fmla="*/ 223835 h 1693381"/>
                <a:gd name="connsiteX429" fmla="*/ 598043 w 813864"/>
                <a:gd name="connsiteY429" fmla="*/ 236836 h 1693381"/>
                <a:gd name="connsiteX430" fmla="*/ 606711 w 813864"/>
                <a:gd name="connsiteY430" fmla="*/ 249837 h 1693381"/>
                <a:gd name="connsiteX431" fmla="*/ 611044 w 813864"/>
                <a:gd name="connsiteY431" fmla="*/ 275839 h 1693381"/>
                <a:gd name="connsiteX432" fmla="*/ 624045 w 813864"/>
                <a:gd name="connsiteY432" fmla="*/ 258505 h 1693381"/>
                <a:gd name="connsiteX433" fmla="*/ 632712 w 813864"/>
                <a:gd name="connsiteY433" fmla="*/ 245504 h 1693381"/>
                <a:gd name="connsiteX434" fmla="*/ 641380 w 813864"/>
                <a:gd name="connsiteY434" fmla="*/ 236836 h 1693381"/>
                <a:gd name="connsiteX435" fmla="*/ 663048 w 813864"/>
                <a:gd name="connsiteY435" fmla="*/ 206501 h 1693381"/>
                <a:gd name="connsiteX436" fmla="*/ 689050 w 813864"/>
                <a:gd name="connsiteY436" fmla="*/ 197834 h 1693381"/>
                <a:gd name="connsiteX437" fmla="*/ 702051 w 813864"/>
                <a:gd name="connsiteY437" fmla="*/ 193500 h 1693381"/>
                <a:gd name="connsiteX438" fmla="*/ 749721 w 813864"/>
                <a:gd name="connsiteY438" fmla="*/ 197834 h 1693381"/>
                <a:gd name="connsiteX439" fmla="*/ 762722 w 813864"/>
                <a:gd name="connsiteY439" fmla="*/ 206501 h 1693381"/>
                <a:gd name="connsiteX440" fmla="*/ 775723 w 813864"/>
                <a:gd name="connsiteY440" fmla="*/ 210835 h 1693381"/>
                <a:gd name="connsiteX441" fmla="*/ 810392 w 813864"/>
                <a:gd name="connsiteY441" fmla="*/ 206501 h 1693381"/>
                <a:gd name="connsiteX442" fmla="*/ 806058 w 813864"/>
                <a:gd name="connsiteY442" fmla="*/ 189166 h 1693381"/>
                <a:gd name="connsiteX443" fmla="*/ 758388 w 813864"/>
                <a:gd name="connsiteY443" fmla="*/ 184833 h 1693381"/>
                <a:gd name="connsiteX444" fmla="*/ 719385 w 813864"/>
                <a:gd name="connsiteY444" fmla="*/ 154497 h 1693381"/>
                <a:gd name="connsiteX445" fmla="*/ 719385 w 813864"/>
                <a:gd name="connsiteY445" fmla="*/ 128495 h 1693381"/>
                <a:gd name="connsiteX446" fmla="*/ 732386 w 813864"/>
                <a:gd name="connsiteY446" fmla="*/ 124162 h 1693381"/>
                <a:gd name="connsiteX447" fmla="*/ 762722 w 813864"/>
                <a:gd name="connsiteY447" fmla="*/ 89492 h 1693381"/>
                <a:gd name="connsiteX448" fmla="*/ 775723 w 813864"/>
                <a:gd name="connsiteY448" fmla="*/ 76491 h 1693381"/>
                <a:gd name="connsiteX449" fmla="*/ 801725 w 813864"/>
                <a:gd name="connsiteY449" fmla="*/ 59157 h 1693381"/>
                <a:gd name="connsiteX450" fmla="*/ 806058 w 813864"/>
                <a:gd name="connsiteY450" fmla="*/ 2819 h 1693381"/>
                <a:gd name="connsiteX451" fmla="*/ 762722 w 813864"/>
                <a:gd name="connsiteY451" fmla="*/ 7153 h 1693381"/>
                <a:gd name="connsiteX452" fmla="*/ 749721 w 813864"/>
                <a:gd name="connsiteY452" fmla="*/ 11487 h 1693381"/>
                <a:gd name="connsiteX453" fmla="*/ 715052 w 813864"/>
                <a:gd name="connsiteY453" fmla="*/ 50490 h 1693381"/>
                <a:gd name="connsiteX454" fmla="*/ 693384 w 813864"/>
                <a:gd name="connsiteY454" fmla="*/ 72158 h 1693381"/>
                <a:gd name="connsiteX455" fmla="*/ 684716 w 813864"/>
                <a:gd name="connsiteY455" fmla="*/ 80825 h 1693381"/>
                <a:gd name="connsiteX456" fmla="*/ 676049 w 813864"/>
                <a:gd name="connsiteY456" fmla="*/ 93826 h 1693381"/>
                <a:gd name="connsiteX457" fmla="*/ 650047 w 813864"/>
                <a:gd name="connsiteY457" fmla="*/ 119828 h 1693381"/>
                <a:gd name="connsiteX458" fmla="*/ 611044 w 813864"/>
                <a:gd name="connsiteY458" fmla="*/ 89492 h 16933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</a:cxnLst>
              <a:rect l="l" t="t" r="r" b="b"/>
              <a:pathLst>
                <a:path w="813864" h="1693381">
                  <a:moveTo>
                    <a:pt x="611044" y="89492"/>
                  </a:moveTo>
                  <a:cubicBezTo>
                    <a:pt x="601655" y="80825"/>
                    <a:pt x="598139" y="75944"/>
                    <a:pt x="593710" y="67824"/>
                  </a:cubicBezTo>
                  <a:cubicBezTo>
                    <a:pt x="573082" y="30006"/>
                    <a:pt x="598523" y="50809"/>
                    <a:pt x="572041" y="33155"/>
                  </a:cubicBezTo>
                  <a:cubicBezTo>
                    <a:pt x="502841" y="41806"/>
                    <a:pt x="545997" y="24843"/>
                    <a:pt x="533039" y="132829"/>
                  </a:cubicBezTo>
                  <a:cubicBezTo>
                    <a:pt x="531981" y="141645"/>
                    <a:pt x="518206" y="151459"/>
                    <a:pt x="511370" y="154497"/>
                  </a:cubicBezTo>
                  <a:cubicBezTo>
                    <a:pt x="503021" y="158207"/>
                    <a:pt x="485368" y="163164"/>
                    <a:pt x="485368" y="163164"/>
                  </a:cubicBezTo>
                  <a:cubicBezTo>
                    <a:pt x="468034" y="161720"/>
                    <a:pt x="450373" y="162476"/>
                    <a:pt x="433365" y="158831"/>
                  </a:cubicBezTo>
                  <a:cubicBezTo>
                    <a:pt x="429370" y="157975"/>
                    <a:pt x="428352" y="151990"/>
                    <a:pt x="424697" y="150163"/>
                  </a:cubicBezTo>
                  <a:cubicBezTo>
                    <a:pt x="416525" y="146077"/>
                    <a:pt x="407362" y="144385"/>
                    <a:pt x="398695" y="141496"/>
                  </a:cubicBezTo>
                  <a:lnTo>
                    <a:pt x="385694" y="137162"/>
                  </a:lnTo>
                  <a:cubicBezTo>
                    <a:pt x="368180" y="84619"/>
                    <a:pt x="384366" y="137683"/>
                    <a:pt x="372694" y="85159"/>
                  </a:cubicBezTo>
                  <a:cubicBezTo>
                    <a:pt x="371703" y="80700"/>
                    <a:pt x="371927" y="75012"/>
                    <a:pt x="368360" y="72158"/>
                  </a:cubicBezTo>
                  <a:cubicBezTo>
                    <a:pt x="363709" y="68437"/>
                    <a:pt x="356803" y="69269"/>
                    <a:pt x="351025" y="67824"/>
                  </a:cubicBezTo>
                  <a:cubicBezTo>
                    <a:pt x="340913" y="69269"/>
                    <a:pt x="330474" y="69223"/>
                    <a:pt x="320690" y="72158"/>
                  </a:cubicBezTo>
                  <a:cubicBezTo>
                    <a:pt x="295005" y="79864"/>
                    <a:pt x="318655" y="79675"/>
                    <a:pt x="299021" y="89492"/>
                  </a:cubicBezTo>
                  <a:cubicBezTo>
                    <a:pt x="290850" y="93578"/>
                    <a:pt x="273020" y="98160"/>
                    <a:pt x="273020" y="98160"/>
                  </a:cubicBezTo>
                  <a:cubicBezTo>
                    <a:pt x="271575" y="102494"/>
                    <a:pt x="267935" y="106655"/>
                    <a:pt x="268686" y="111161"/>
                  </a:cubicBezTo>
                  <a:cubicBezTo>
                    <a:pt x="271934" y="130653"/>
                    <a:pt x="290807" y="124464"/>
                    <a:pt x="303355" y="132829"/>
                  </a:cubicBezTo>
                  <a:cubicBezTo>
                    <a:pt x="307689" y="135718"/>
                    <a:pt x="311698" y="139167"/>
                    <a:pt x="316356" y="141496"/>
                  </a:cubicBezTo>
                  <a:cubicBezTo>
                    <a:pt x="328460" y="147548"/>
                    <a:pt x="348508" y="148565"/>
                    <a:pt x="359693" y="150163"/>
                  </a:cubicBezTo>
                  <a:cubicBezTo>
                    <a:pt x="364027" y="151608"/>
                    <a:pt x="368287" y="153295"/>
                    <a:pt x="372694" y="154497"/>
                  </a:cubicBezTo>
                  <a:cubicBezTo>
                    <a:pt x="384186" y="157631"/>
                    <a:pt x="407363" y="163164"/>
                    <a:pt x="407363" y="163164"/>
                  </a:cubicBezTo>
                  <a:cubicBezTo>
                    <a:pt x="413141" y="166053"/>
                    <a:pt x="418759" y="169287"/>
                    <a:pt x="424697" y="171832"/>
                  </a:cubicBezTo>
                  <a:cubicBezTo>
                    <a:pt x="428896" y="173631"/>
                    <a:pt x="433781" y="173815"/>
                    <a:pt x="437698" y="176165"/>
                  </a:cubicBezTo>
                  <a:cubicBezTo>
                    <a:pt x="463431" y="191604"/>
                    <a:pt x="425909" y="178630"/>
                    <a:pt x="459367" y="193500"/>
                  </a:cubicBezTo>
                  <a:cubicBezTo>
                    <a:pt x="467715" y="197210"/>
                    <a:pt x="476701" y="199278"/>
                    <a:pt x="485368" y="202167"/>
                  </a:cubicBezTo>
                  <a:lnTo>
                    <a:pt x="498369" y="206501"/>
                  </a:lnTo>
                  <a:lnTo>
                    <a:pt x="515704" y="189166"/>
                  </a:lnTo>
                  <a:cubicBezTo>
                    <a:pt x="520038" y="184832"/>
                    <a:pt x="522759" y="177651"/>
                    <a:pt x="528705" y="176165"/>
                  </a:cubicBezTo>
                  <a:lnTo>
                    <a:pt x="546040" y="171832"/>
                  </a:lnTo>
                  <a:cubicBezTo>
                    <a:pt x="563294" y="176145"/>
                    <a:pt x="564559" y="172331"/>
                    <a:pt x="572041" y="189166"/>
                  </a:cubicBezTo>
                  <a:cubicBezTo>
                    <a:pt x="575752" y="197515"/>
                    <a:pt x="580709" y="215168"/>
                    <a:pt x="580709" y="215168"/>
                  </a:cubicBezTo>
                  <a:cubicBezTo>
                    <a:pt x="580111" y="219952"/>
                    <a:pt x="578370" y="252289"/>
                    <a:pt x="572041" y="262838"/>
                  </a:cubicBezTo>
                  <a:cubicBezTo>
                    <a:pt x="569939" y="266342"/>
                    <a:pt x="565825" y="268237"/>
                    <a:pt x="563374" y="271506"/>
                  </a:cubicBezTo>
                  <a:cubicBezTo>
                    <a:pt x="557124" y="279840"/>
                    <a:pt x="551818" y="288841"/>
                    <a:pt x="546040" y="297508"/>
                  </a:cubicBezTo>
                  <a:lnTo>
                    <a:pt x="537372" y="310508"/>
                  </a:lnTo>
                  <a:cubicBezTo>
                    <a:pt x="524371" y="309064"/>
                    <a:pt x="511196" y="308740"/>
                    <a:pt x="498369" y="306175"/>
                  </a:cubicBezTo>
                  <a:cubicBezTo>
                    <a:pt x="489410" y="304383"/>
                    <a:pt x="481034" y="300397"/>
                    <a:pt x="472367" y="297508"/>
                  </a:cubicBezTo>
                  <a:lnTo>
                    <a:pt x="459367" y="293174"/>
                  </a:lnTo>
                  <a:cubicBezTo>
                    <a:pt x="452144" y="294619"/>
                    <a:pt x="443827" y="293422"/>
                    <a:pt x="437698" y="297508"/>
                  </a:cubicBezTo>
                  <a:cubicBezTo>
                    <a:pt x="433897" y="300042"/>
                    <a:pt x="433365" y="305940"/>
                    <a:pt x="433365" y="310508"/>
                  </a:cubicBezTo>
                  <a:cubicBezTo>
                    <a:pt x="433365" y="317922"/>
                    <a:pt x="439500" y="328744"/>
                    <a:pt x="446366" y="332177"/>
                  </a:cubicBezTo>
                  <a:cubicBezTo>
                    <a:pt x="451693" y="334841"/>
                    <a:pt x="457922" y="335066"/>
                    <a:pt x="463700" y="336510"/>
                  </a:cubicBezTo>
                  <a:cubicBezTo>
                    <a:pt x="466589" y="339399"/>
                    <a:pt x="469098" y="342726"/>
                    <a:pt x="472367" y="345178"/>
                  </a:cubicBezTo>
                  <a:cubicBezTo>
                    <a:pt x="480700" y="351428"/>
                    <a:pt x="491003" y="355146"/>
                    <a:pt x="498369" y="362512"/>
                  </a:cubicBezTo>
                  <a:cubicBezTo>
                    <a:pt x="512144" y="376287"/>
                    <a:pt x="504585" y="367911"/>
                    <a:pt x="520038" y="388514"/>
                  </a:cubicBezTo>
                  <a:cubicBezTo>
                    <a:pt x="518593" y="411627"/>
                    <a:pt x="518129" y="434822"/>
                    <a:pt x="515704" y="457853"/>
                  </a:cubicBezTo>
                  <a:cubicBezTo>
                    <a:pt x="515226" y="462396"/>
                    <a:pt x="513720" y="466936"/>
                    <a:pt x="511370" y="470853"/>
                  </a:cubicBezTo>
                  <a:cubicBezTo>
                    <a:pt x="509268" y="474357"/>
                    <a:pt x="505972" y="477069"/>
                    <a:pt x="502703" y="479521"/>
                  </a:cubicBezTo>
                  <a:cubicBezTo>
                    <a:pt x="494370" y="485771"/>
                    <a:pt x="484066" y="489489"/>
                    <a:pt x="476701" y="496855"/>
                  </a:cubicBezTo>
                  <a:cubicBezTo>
                    <a:pt x="473812" y="499744"/>
                    <a:pt x="471538" y="503421"/>
                    <a:pt x="468034" y="505523"/>
                  </a:cubicBezTo>
                  <a:cubicBezTo>
                    <a:pt x="464117" y="507873"/>
                    <a:pt x="459492" y="508865"/>
                    <a:pt x="455033" y="509856"/>
                  </a:cubicBezTo>
                  <a:cubicBezTo>
                    <a:pt x="443047" y="512520"/>
                    <a:pt x="427738" y="512670"/>
                    <a:pt x="416030" y="518524"/>
                  </a:cubicBezTo>
                  <a:cubicBezTo>
                    <a:pt x="411372" y="520853"/>
                    <a:pt x="407788" y="525076"/>
                    <a:pt x="403029" y="527191"/>
                  </a:cubicBezTo>
                  <a:cubicBezTo>
                    <a:pt x="394680" y="530901"/>
                    <a:pt x="377027" y="535858"/>
                    <a:pt x="377027" y="535858"/>
                  </a:cubicBezTo>
                  <a:cubicBezTo>
                    <a:pt x="363378" y="533129"/>
                    <a:pt x="349357" y="532302"/>
                    <a:pt x="338024" y="522857"/>
                  </a:cubicBezTo>
                  <a:cubicBezTo>
                    <a:pt x="330270" y="516395"/>
                    <a:pt x="327981" y="505728"/>
                    <a:pt x="325023" y="496855"/>
                  </a:cubicBezTo>
                  <a:cubicBezTo>
                    <a:pt x="326468" y="491077"/>
                    <a:pt x="326200" y="484572"/>
                    <a:pt x="329357" y="479521"/>
                  </a:cubicBezTo>
                  <a:cubicBezTo>
                    <a:pt x="341882" y="459482"/>
                    <a:pt x="351540" y="460571"/>
                    <a:pt x="372694" y="453519"/>
                  </a:cubicBezTo>
                  <a:lnTo>
                    <a:pt x="398695" y="444852"/>
                  </a:lnTo>
                  <a:lnTo>
                    <a:pt x="411696" y="440518"/>
                  </a:lnTo>
                  <a:cubicBezTo>
                    <a:pt x="413141" y="436184"/>
                    <a:pt x="417475" y="431851"/>
                    <a:pt x="416030" y="427517"/>
                  </a:cubicBezTo>
                  <a:cubicBezTo>
                    <a:pt x="410785" y="411780"/>
                    <a:pt x="400655" y="416086"/>
                    <a:pt x="390028" y="410182"/>
                  </a:cubicBezTo>
                  <a:cubicBezTo>
                    <a:pt x="380922" y="405123"/>
                    <a:pt x="364026" y="392848"/>
                    <a:pt x="364026" y="392848"/>
                  </a:cubicBezTo>
                  <a:cubicBezTo>
                    <a:pt x="359692" y="387070"/>
                    <a:pt x="354608" y="381784"/>
                    <a:pt x="351025" y="375513"/>
                  </a:cubicBezTo>
                  <a:cubicBezTo>
                    <a:pt x="336025" y="349262"/>
                    <a:pt x="358308" y="374127"/>
                    <a:pt x="338024" y="353845"/>
                  </a:cubicBezTo>
                  <a:cubicBezTo>
                    <a:pt x="335135" y="345178"/>
                    <a:pt x="334425" y="335445"/>
                    <a:pt x="329357" y="327843"/>
                  </a:cubicBezTo>
                  <a:lnTo>
                    <a:pt x="312022" y="301841"/>
                  </a:lnTo>
                  <a:cubicBezTo>
                    <a:pt x="313467" y="296063"/>
                    <a:pt x="313199" y="289558"/>
                    <a:pt x="316356" y="284507"/>
                  </a:cubicBezTo>
                  <a:cubicBezTo>
                    <a:pt x="320687" y="277577"/>
                    <a:pt x="333691" y="267172"/>
                    <a:pt x="333691" y="267172"/>
                  </a:cubicBezTo>
                  <a:cubicBezTo>
                    <a:pt x="332246" y="258505"/>
                    <a:pt x="336808" y="245827"/>
                    <a:pt x="329357" y="241170"/>
                  </a:cubicBezTo>
                  <a:cubicBezTo>
                    <a:pt x="316934" y="233406"/>
                    <a:pt x="295758" y="246382"/>
                    <a:pt x="286021" y="254171"/>
                  </a:cubicBezTo>
                  <a:cubicBezTo>
                    <a:pt x="271355" y="265903"/>
                    <a:pt x="277263" y="271535"/>
                    <a:pt x="251351" y="280173"/>
                  </a:cubicBezTo>
                  <a:cubicBezTo>
                    <a:pt x="220179" y="290565"/>
                    <a:pt x="259107" y="277957"/>
                    <a:pt x="221016" y="288840"/>
                  </a:cubicBezTo>
                  <a:cubicBezTo>
                    <a:pt x="216624" y="290095"/>
                    <a:pt x="212509" y="292357"/>
                    <a:pt x="208015" y="293174"/>
                  </a:cubicBezTo>
                  <a:cubicBezTo>
                    <a:pt x="196557" y="295258"/>
                    <a:pt x="184875" y="295861"/>
                    <a:pt x="173346" y="297508"/>
                  </a:cubicBezTo>
                  <a:cubicBezTo>
                    <a:pt x="164647" y="298751"/>
                    <a:pt x="156011" y="300397"/>
                    <a:pt x="147344" y="301841"/>
                  </a:cubicBezTo>
                  <a:cubicBezTo>
                    <a:pt x="145899" y="306175"/>
                    <a:pt x="141313" y="310601"/>
                    <a:pt x="143010" y="314842"/>
                  </a:cubicBezTo>
                  <a:cubicBezTo>
                    <a:pt x="144944" y="319678"/>
                    <a:pt x="150936" y="322338"/>
                    <a:pt x="156011" y="323509"/>
                  </a:cubicBezTo>
                  <a:cubicBezTo>
                    <a:pt x="170157" y="326773"/>
                    <a:pt x="184910" y="326323"/>
                    <a:pt x="199348" y="327843"/>
                  </a:cubicBezTo>
                  <a:lnTo>
                    <a:pt x="238350" y="332177"/>
                  </a:lnTo>
                  <a:lnTo>
                    <a:pt x="264352" y="340844"/>
                  </a:lnTo>
                  <a:lnTo>
                    <a:pt x="277353" y="345178"/>
                  </a:lnTo>
                  <a:cubicBezTo>
                    <a:pt x="298287" y="366110"/>
                    <a:pt x="271680" y="340639"/>
                    <a:pt x="299021" y="362512"/>
                  </a:cubicBezTo>
                  <a:cubicBezTo>
                    <a:pt x="302212" y="365065"/>
                    <a:pt x="304800" y="368291"/>
                    <a:pt x="307689" y="371180"/>
                  </a:cubicBezTo>
                  <a:cubicBezTo>
                    <a:pt x="315595" y="394901"/>
                    <a:pt x="314139" y="384480"/>
                    <a:pt x="307689" y="423183"/>
                  </a:cubicBezTo>
                  <a:cubicBezTo>
                    <a:pt x="305912" y="433847"/>
                    <a:pt x="303142" y="438511"/>
                    <a:pt x="294688" y="444852"/>
                  </a:cubicBezTo>
                  <a:cubicBezTo>
                    <a:pt x="286355" y="451102"/>
                    <a:pt x="278568" y="458892"/>
                    <a:pt x="268686" y="462186"/>
                  </a:cubicBezTo>
                  <a:lnTo>
                    <a:pt x="242684" y="470853"/>
                  </a:lnTo>
                  <a:cubicBezTo>
                    <a:pt x="236676" y="469652"/>
                    <a:pt x="215513" y="466352"/>
                    <a:pt x="208015" y="462186"/>
                  </a:cubicBezTo>
                  <a:cubicBezTo>
                    <a:pt x="198909" y="457127"/>
                    <a:pt x="190680" y="450630"/>
                    <a:pt x="182013" y="444852"/>
                  </a:cubicBezTo>
                  <a:cubicBezTo>
                    <a:pt x="177679" y="441963"/>
                    <a:pt x="173953" y="437831"/>
                    <a:pt x="169012" y="436184"/>
                  </a:cubicBezTo>
                  <a:lnTo>
                    <a:pt x="156011" y="431851"/>
                  </a:lnTo>
                  <a:cubicBezTo>
                    <a:pt x="132898" y="433295"/>
                    <a:pt x="109317" y="431332"/>
                    <a:pt x="86673" y="436184"/>
                  </a:cubicBezTo>
                  <a:cubicBezTo>
                    <a:pt x="82678" y="437040"/>
                    <a:pt x="91685" y="443025"/>
                    <a:pt x="95340" y="444852"/>
                  </a:cubicBezTo>
                  <a:cubicBezTo>
                    <a:pt x="103976" y="449170"/>
                    <a:pt x="127483" y="455366"/>
                    <a:pt x="138676" y="457853"/>
                  </a:cubicBezTo>
                  <a:cubicBezTo>
                    <a:pt x="175434" y="466021"/>
                    <a:pt x="145754" y="457322"/>
                    <a:pt x="186347" y="470853"/>
                  </a:cubicBezTo>
                  <a:lnTo>
                    <a:pt x="199348" y="475187"/>
                  </a:lnTo>
                  <a:cubicBezTo>
                    <a:pt x="203682" y="476632"/>
                    <a:pt x="208548" y="476987"/>
                    <a:pt x="212349" y="479521"/>
                  </a:cubicBezTo>
                  <a:cubicBezTo>
                    <a:pt x="229150" y="490722"/>
                    <a:pt x="220408" y="486541"/>
                    <a:pt x="238350" y="492522"/>
                  </a:cubicBezTo>
                  <a:cubicBezTo>
                    <a:pt x="258227" y="512396"/>
                    <a:pt x="232864" y="488864"/>
                    <a:pt x="264352" y="509856"/>
                  </a:cubicBezTo>
                  <a:cubicBezTo>
                    <a:pt x="267752" y="512123"/>
                    <a:pt x="270131" y="515635"/>
                    <a:pt x="273020" y="518524"/>
                  </a:cubicBezTo>
                  <a:cubicBezTo>
                    <a:pt x="272144" y="523778"/>
                    <a:pt x="269277" y="549318"/>
                    <a:pt x="264352" y="557526"/>
                  </a:cubicBezTo>
                  <a:cubicBezTo>
                    <a:pt x="262250" y="561030"/>
                    <a:pt x="258574" y="563305"/>
                    <a:pt x="255685" y="566194"/>
                  </a:cubicBezTo>
                  <a:cubicBezTo>
                    <a:pt x="231178" y="563966"/>
                    <a:pt x="215218" y="566185"/>
                    <a:pt x="195014" y="557526"/>
                  </a:cubicBezTo>
                  <a:cubicBezTo>
                    <a:pt x="189076" y="554981"/>
                    <a:pt x="183457" y="551748"/>
                    <a:pt x="177679" y="548859"/>
                  </a:cubicBezTo>
                  <a:cubicBezTo>
                    <a:pt x="173345" y="550304"/>
                    <a:pt x="166375" y="548952"/>
                    <a:pt x="164678" y="553193"/>
                  </a:cubicBezTo>
                  <a:cubicBezTo>
                    <a:pt x="157113" y="572107"/>
                    <a:pt x="189288" y="582136"/>
                    <a:pt x="195014" y="587862"/>
                  </a:cubicBezTo>
                  <a:cubicBezTo>
                    <a:pt x="199348" y="592196"/>
                    <a:pt x="203028" y="597301"/>
                    <a:pt x="208015" y="600863"/>
                  </a:cubicBezTo>
                  <a:cubicBezTo>
                    <a:pt x="213272" y="604618"/>
                    <a:pt x="219740" y="606325"/>
                    <a:pt x="225349" y="609530"/>
                  </a:cubicBezTo>
                  <a:cubicBezTo>
                    <a:pt x="229871" y="612114"/>
                    <a:pt x="233590" y="616083"/>
                    <a:pt x="238350" y="618198"/>
                  </a:cubicBezTo>
                  <a:cubicBezTo>
                    <a:pt x="247390" y="622216"/>
                    <a:pt x="270230" y="628908"/>
                    <a:pt x="281687" y="631199"/>
                  </a:cubicBezTo>
                  <a:cubicBezTo>
                    <a:pt x="290303" y="632922"/>
                    <a:pt x="299022" y="634088"/>
                    <a:pt x="307689" y="635532"/>
                  </a:cubicBezTo>
                  <a:cubicBezTo>
                    <a:pt x="312023" y="636977"/>
                    <a:pt x="316604" y="637823"/>
                    <a:pt x="320690" y="639866"/>
                  </a:cubicBezTo>
                  <a:cubicBezTo>
                    <a:pt x="325348" y="642195"/>
                    <a:pt x="328814" y="646704"/>
                    <a:pt x="333691" y="648533"/>
                  </a:cubicBezTo>
                  <a:cubicBezTo>
                    <a:pt x="340588" y="651119"/>
                    <a:pt x="348169" y="651269"/>
                    <a:pt x="355359" y="652867"/>
                  </a:cubicBezTo>
                  <a:cubicBezTo>
                    <a:pt x="361173" y="654159"/>
                    <a:pt x="366916" y="655756"/>
                    <a:pt x="372694" y="657200"/>
                  </a:cubicBezTo>
                  <a:cubicBezTo>
                    <a:pt x="402095" y="676802"/>
                    <a:pt x="391329" y="667170"/>
                    <a:pt x="407363" y="683202"/>
                  </a:cubicBezTo>
                  <a:cubicBezTo>
                    <a:pt x="408807" y="687536"/>
                    <a:pt x="409346" y="692286"/>
                    <a:pt x="411696" y="696203"/>
                  </a:cubicBezTo>
                  <a:cubicBezTo>
                    <a:pt x="413798" y="699707"/>
                    <a:pt x="418537" y="701216"/>
                    <a:pt x="420364" y="704871"/>
                  </a:cubicBezTo>
                  <a:cubicBezTo>
                    <a:pt x="451312" y="766765"/>
                    <a:pt x="412200" y="705625"/>
                    <a:pt x="437698" y="743873"/>
                  </a:cubicBezTo>
                  <a:cubicBezTo>
                    <a:pt x="434895" y="785919"/>
                    <a:pt x="444962" y="797562"/>
                    <a:pt x="424697" y="821879"/>
                  </a:cubicBezTo>
                  <a:cubicBezTo>
                    <a:pt x="420773" y="826587"/>
                    <a:pt x="416030" y="830546"/>
                    <a:pt x="411696" y="834880"/>
                  </a:cubicBezTo>
                  <a:cubicBezTo>
                    <a:pt x="392917" y="833435"/>
                    <a:pt x="374048" y="832882"/>
                    <a:pt x="355359" y="830546"/>
                  </a:cubicBezTo>
                  <a:cubicBezTo>
                    <a:pt x="350826" y="829979"/>
                    <a:pt x="346750" y="827468"/>
                    <a:pt x="342358" y="826213"/>
                  </a:cubicBezTo>
                  <a:cubicBezTo>
                    <a:pt x="336631" y="824577"/>
                    <a:pt x="330801" y="823324"/>
                    <a:pt x="325023" y="821879"/>
                  </a:cubicBezTo>
                  <a:cubicBezTo>
                    <a:pt x="295220" y="802010"/>
                    <a:pt x="308903" y="807838"/>
                    <a:pt x="286021" y="800211"/>
                  </a:cubicBezTo>
                  <a:cubicBezTo>
                    <a:pt x="283132" y="797322"/>
                    <a:pt x="280622" y="793996"/>
                    <a:pt x="277353" y="791544"/>
                  </a:cubicBezTo>
                  <a:cubicBezTo>
                    <a:pt x="269019" y="785294"/>
                    <a:pt x="251351" y="774209"/>
                    <a:pt x="251351" y="774209"/>
                  </a:cubicBezTo>
                  <a:cubicBezTo>
                    <a:pt x="244491" y="763919"/>
                    <a:pt x="237746" y="753280"/>
                    <a:pt x="229683" y="743873"/>
                  </a:cubicBezTo>
                  <a:cubicBezTo>
                    <a:pt x="204658" y="714676"/>
                    <a:pt x="227170" y="746605"/>
                    <a:pt x="208015" y="717871"/>
                  </a:cubicBezTo>
                  <a:cubicBezTo>
                    <a:pt x="199348" y="719316"/>
                    <a:pt x="189872" y="718275"/>
                    <a:pt x="182013" y="722205"/>
                  </a:cubicBezTo>
                  <a:cubicBezTo>
                    <a:pt x="175293" y="725565"/>
                    <a:pt x="171063" y="742055"/>
                    <a:pt x="169012" y="748207"/>
                  </a:cubicBezTo>
                  <a:cubicBezTo>
                    <a:pt x="176854" y="759970"/>
                    <a:pt x="182403" y="770136"/>
                    <a:pt x="195014" y="778543"/>
                  </a:cubicBezTo>
                  <a:cubicBezTo>
                    <a:pt x="199348" y="781432"/>
                    <a:pt x="204122" y="783750"/>
                    <a:pt x="208015" y="787210"/>
                  </a:cubicBezTo>
                  <a:cubicBezTo>
                    <a:pt x="217176" y="795353"/>
                    <a:pt x="234017" y="813212"/>
                    <a:pt x="234017" y="813212"/>
                  </a:cubicBezTo>
                  <a:cubicBezTo>
                    <a:pt x="238241" y="825885"/>
                    <a:pt x="248583" y="850686"/>
                    <a:pt x="234017" y="860882"/>
                  </a:cubicBezTo>
                  <a:cubicBezTo>
                    <a:pt x="223301" y="868383"/>
                    <a:pt x="208015" y="857993"/>
                    <a:pt x="195014" y="856548"/>
                  </a:cubicBezTo>
                  <a:cubicBezTo>
                    <a:pt x="177214" y="850615"/>
                    <a:pt x="169121" y="850451"/>
                    <a:pt x="156011" y="839214"/>
                  </a:cubicBezTo>
                  <a:cubicBezTo>
                    <a:pt x="155998" y="839202"/>
                    <a:pt x="128214" y="811416"/>
                    <a:pt x="125676" y="808878"/>
                  </a:cubicBezTo>
                  <a:cubicBezTo>
                    <a:pt x="122787" y="805989"/>
                    <a:pt x="119274" y="803611"/>
                    <a:pt x="117008" y="800211"/>
                  </a:cubicBezTo>
                  <a:cubicBezTo>
                    <a:pt x="114119" y="795877"/>
                    <a:pt x="112408" y="790464"/>
                    <a:pt x="108341" y="787210"/>
                  </a:cubicBezTo>
                  <a:cubicBezTo>
                    <a:pt x="104774" y="784356"/>
                    <a:pt x="99539" y="784675"/>
                    <a:pt x="95340" y="782876"/>
                  </a:cubicBezTo>
                  <a:cubicBezTo>
                    <a:pt x="42158" y="760084"/>
                    <a:pt x="108525" y="787302"/>
                    <a:pt x="65004" y="765542"/>
                  </a:cubicBezTo>
                  <a:cubicBezTo>
                    <a:pt x="60918" y="763499"/>
                    <a:pt x="56337" y="762653"/>
                    <a:pt x="52003" y="761208"/>
                  </a:cubicBezTo>
                  <a:cubicBezTo>
                    <a:pt x="32911" y="763936"/>
                    <a:pt x="21805" y="761071"/>
                    <a:pt x="8667" y="774209"/>
                  </a:cubicBezTo>
                  <a:cubicBezTo>
                    <a:pt x="4984" y="777892"/>
                    <a:pt x="2889" y="782876"/>
                    <a:pt x="0" y="787210"/>
                  </a:cubicBezTo>
                  <a:cubicBezTo>
                    <a:pt x="1444" y="791544"/>
                    <a:pt x="1479" y="796644"/>
                    <a:pt x="4333" y="800211"/>
                  </a:cubicBezTo>
                  <a:cubicBezTo>
                    <a:pt x="7587" y="804278"/>
                    <a:pt x="12575" y="806763"/>
                    <a:pt x="17334" y="808878"/>
                  </a:cubicBezTo>
                  <a:cubicBezTo>
                    <a:pt x="38544" y="818304"/>
                    <a:pt x="41281" y="816062"/>
                    <a:pt x="60671" y="821879"/>
                  </a:cubicBezTo>
                  <a:cubicBezTo>
                    <a:pt x="69422" y="824504"/>
                    <a:pt x="77810" y="828330"/>
                    <a:pt x="86673" y="830546"/>
                  </a:cubicBezTo>
                  <a:cubicBezTo>
                    <a:pt x="98229" y="833435"/>
                    <a:pt x="110041" y="835447"/>
                    <a:pt x="121342" y="839214"/>
                  </a:cubicBezTo>
                  <a:lnTo>
                    <a:pt x="147344" y="847881"/>
                  </a:lnTo>
                  <a:cubicBezTo>
                    <a:pt x="151678" y="849326"/>
                    <a:pt x="155913" y="851107"/>
                    <a:pt x="160345" y="852215"/>
                  </a:cubicBezTo>
                  <a:cubicBezTo>
                    <a:pt x="166123" y="853659"/>
                    <a:pt x="171952" y="854912"/>
                    <a:pt x="177679" y="856548"/>
                  </a:cubicBezTo>
                  <a:cubicBezTo>
                    <a:pt x="182071" y="857803"/>
                    <a:pt x="186165" y="860187"/>
                    <a:pt x="190680" y="860882"/>
                  </a:cubicBezTo>
                  <a:cubicBezTo>
                    <a:pt x="205029" y="863090"/>
                    <a:pt x="219599" y="863520"/>
                    <a:pt x="234017" y="865216"/>
                  </a:cubicBezTo>
                  <a:cubicBezTo>
                    <a:pt x="244161" y="866409"/>
                    <a:pt x="254240" y="868105"/>
                    <a:pt x="264352" y="869549"/>
                  </a:cubicBezTo>
                  <a:lnTo>
                    <a:pt x="290354" y="878217"/>
                  </a:lnTo>
                  <a:lnTo>
                    <a:pt x="303355" y="882550"/>
                  </a:lnTo>
                  <a:cubicBezTo>
                    <a:pt x="307689" y="885439"/>
                    <a:pt x="312289" y="887963"/>
                    <a:pt x="316356" y="891217"/>
                  </a:cubicBezTo>
                  <a:cubicBezTo>
                    <a:pt x="325175" y="898272"/>
                    <a:pt x="327257" y="903236"/>
                    <a:pt x="333691" y="912886"/>
                  </a:cubicBezTo>
                  <a:cubicBezTo>
                    <a:pt x="331852" y="920243"/>
                    <a:pt x="328477" y="935621"/>
                    <a:pt x="325023" y="943221"/>
                  </a:cubicBezTo>
                  <a:cubicBezTo>
                    <a:pt x="319677" y="954983"/>
                    <a:pt x="319946" y="973804"/>
                    <a:pt x="307689" y="977890"/>
                  </a:cubicBezTo>
                  <a:cubicBezTo>
                    <a:pt x="303355" y="979335"/>
                    <a:pt x="298774" y="980181"/>
                    <a:pt x="294688" y="982224"/>
                  </a:cubicBezTo>
                  <a:cubicBezTo>
                    <a:pt x="290030" y="984553"/>
                    <a:pt x="286762" y="989720"/>
                    <a:pt x="281687" y="990891"/>
                  </a:cubicBezTo>
                  <a:cubicBezTo>
                    <a:pt x="267541" y="994155"/>
                    <a:pt x="252796" y="993780"/>
                    <a:pt x="238350" y="995225"/>
                  </a:cubicBezTo>
                  <a:cubicBezTo>
                    <a:pt x="252437" y="1065652"/>
                    <a:pt x="234551" y="1012822"/>
                    <a:pt x="390028" y="1021227"/>
                  </a:cubicBezTo>
                  <a:cubicBezTo>
                    <a:pt x="394589" y="1021474"/>
                    <a:pt x="398570" y="1024570"/>
                    <a:pt x="403029" y="1025561"/>
                  </a:cubicBezTo>
                  <a:cubicBezTo>
                    <a:pt x="411607" y="1027467"/>
                    <a:pt x="420364" y="1028450"/>
                    <a:pt x="429031" y="1029894"/>
                  </a:cubicBezTo>
                  <a:cubicBezTo>
                    <a:pt x="433365" y="1031339"/>
                    <a:pt x="438231" y="1031694"/>
                    <a:pt x="442032" y="1034228"/>
                  </a:cubicBezTo>
                  <a:cubicBezTo>
                    <a:pt x="455944" y="1043503"/>
                    <a:pt x="454823" y="1046600"/>
                    <a:pt x="459367" y="1060230"/>
                  </a:cubicBezTo>
                  <a:cubicBezTo>
                    <a:pt x="457644" y="1084350"/>
                    <a:pt x="465513" y="1114755"/>
                    <a:pt x="446366" y="1133902"/>
                  </a:cubicBezTo>
                  <a:cubicBezTo>
                    <a:pt x="442683" y="1137585"/>
                    <a:pt x="437432" y="1139316"/>
                    <a:pt x="433365" y="1142569"/>
                  </a:cubicBezTo>
                  <a:cubicBezTo>
                    <a:pt x="430174" y="1145121"/>
                    <a:pt x="428352" y="1149409"/>
                    <a:pt x="424697" y="1151236"/>
                  </a:cubicBezTo>
                  <a:cubicBezTo>
                    <a:pt x="416525" y="1155322"/>
                    <a:pt x="406297" y="1154836"/>
                    <a:pt x="398695" y="1159904"/>
                  </a:cubicBezTo>
                  <a:lnTo>
                    <a:pt x="372694" y="1177238"/>
                  </a:lnTo>
                  <a:cubicBezTo>
                    <a:pt x="371922" y="1178397"/>
                    <a:pt x="356526" y="1199017"/>
                    <a:pt x="359693" y="1203240"/>
                  </a:cubicBezTo>
                  <a:cubicBezTo>
                    <a:pt x="363266" y="1208005"/>
                    <a:pt x="371300" y="1205938"/>
                    <a:pt x="377027" y="1207574"/>
                  </a:cubicBezTo>
                  <a:cubicBezTo>
                    <a:pt x="381419" y="1208829"/>
                    <a:pt x="385694" y="1210463"/>
                    <a:pt x="390028" y="1211908"/>
                  </a:cubicBezTo>
                  <a:cubicBezTo>
                    <a:pt x="403029" y="1210463"/>
                    <a:pt x="416128" y="1209725"/>
                    <a:pt x="429031" y="1207574"/>
                  </a:cubicBezTo>
                  <a:cubicBezTo>
                    <a:pt x="440115" y="1205727"/>
                    <a:pt x="449325" y="1198877"/>
                    <a:pt x="459367" y="1194573"/>
                  </a:cubicBezTo>
                  <a:cubicBezTo>
                    <a:pt x="484482" y="1183809"/>
                    <a:pt x="460386" y="1198226"/>
                    <a:pt x="485368" y="1181572"/>
                  </a:cubicBezTo>
                  <a:cubicBezTo>
                    <a:pt x="497942" y="1183668"/>
                    <a:pt x="513274" y="1181046"/>
                    <a:pt x="520038" y="1194573"/>
                  </a:cubicBezTo>
                  <a:cubicBezTo>
                    <a:pt x="524124" y="1202745"/>
                    <a:pt x="525816" y="1211908"/>
                    <a:pt x="528705" y="1220575"/>
                  </a:cubicBezTo>
                  <a:lnTo>
                    <a:pt x="533039" y="1233576"/>
                  </a:lnTo>
                  <a:cubicBezTo>
                    <a:pt x="531594" y="1249466"/>
                    <a:pt x="532048" y="1265645"/>
                    <a:pt x="528705" y="1281246"/>
                  </a:cubicBezTo>
                  <a:cubicBezTo>
                    <a:pt x="525618" y="1295653"/>
                    <a:pt x="513331" y="1296841"/>
                    <a:pt x="502703" y="1302914"/>
                  </a:cubicBezTo>
                  <a:cubicBezTo>
                    <a:pt x="479179" y="1316356"/>
                    <a:pt x="500539" y="1307968"/>
                    <a:pt x="476701" y="1315915"/>
                  </a:cubicBezTo>
                  <a:cubicBezTo>
                    <a:pt x="473467" y="1315107"/>
                    <a:pt x="450804" y="1309910"/>
                    <a:pt x="446366" y="1307248"/>
                  </a:cubicBezTo>
                  <a:cubicBezTo>
                    <a:pt x="442862" y="1305146"/>
                    <a:pt x="441202" y="1300683"/>
                    <a:pt x="437698" y="1298581"/>
                  </a:cubicBezTo>
                  <a:cubicBezTo>
                    <a:pt x="433781" y="1296231"/>
                    <a:pt x="428690" y="1296466"/>
                    <a:pt x="424697" y="1294247"/>
                  </a:cubicBezTo>
                  <a:cubicBezTo>
                    <a:pt x="379998" y="1269413"/>
                    <a:pt x="415110" y="1282383"/>
                    <a:pt x="385694" y="1272579"/>
                  </a:cubicBezTo>
                  <a:cubicBezTo>
                    <a:pt x="365092" y="1258842"/>
                    <a:pt x="377636" y="1265559"/>
                    <a:pt x="346692" y="1255244"/>
                  </a:cubicBezTo>
                  <a:lnTo>
                    <a:pt x="320690" y="1246577"/>
                  </a:lnTo>
                  <a:cubicBezTo>
                    <a:pt x="316356" y="1245132"/>
                    <a:pt x="312121" y="1243351"/>
                    <a:pt x="307689" y="1242243"/>
                  </a:cubicBezTo>
                  <a:cubicBezTo>
                    <a:pt x="285922" y="1236801"/>
                    <a:pt x="296005" y="1239792"/>
                    <a:pt x="277353" y="1233576"/>
                  </a:cubicBezTo>
                  <a:cubicBezTo>
                    <a:pt x="273019" y="1230687"/>
                    <a:pt x="268035" y="1228591"/>
                    <a:pt x="264352" y="1224908"/>
                  </a:cubicBezTo>
                  <a:cubicBezTo>
                    <a:pt x="252655" y="1213211"/>
                    <a:pt x="251716" y="1202511"/>
                    <a:pt x="260019" y="1185906"/>
                  </a:cubicBezTo>
                  <a:cubicBezTo>
                    <a:pt x="262348" y="1181247"/>
                    <a:pt x="268260" y="1179353"/>
                    <a:pt x="273020" y="1177238"/>
                  </a:cubicBezTo>
                  <a:cubicBezTo>
                    <a:pt x="281368" y="1173527"/>
                    <a:pt x="299021" y="1168571"/>
                    <a:pt x="299021" y="1168571"/>
                  </a:cubicBezTo>
                  <a:cubicBezTo>
                    <a:pt x="301910" y="1165682"/>
                    <a:pt x="304420" y="1162356"/>
                    <a:pt x="307689" y="1159904"/>
                  </a:cubicBezTo>
                  <a:cubicBezTo>
                    <a:pt x="316023" y="1153654"/>
                    <a:pt x="333691" y="1142569"/>
                    <a:pt x="333691" y="1142569"/>
                  </a:cubicBezTo>
                  <a:cubicBezTo>
                    <a:pt x="336580" y="1138235"/>
                    <a:pt x="343380" y="1134675"/>
                    <a:pt x="342358" y="1129568"/>
                  </a:cubicBezTo>
                  <a:cubicBezTo>
                    <a:pt x="341336" y="1124461"/>
                    <a:pt x="334525" y="1121547"/>
                    <a:pt x="329357" y="1120901"/>
                  </a:cubicBezTo>
                  <a:cubicBezTo>
                    <a:pt x="322048" y="1119988"/>
                    <a:pt x="314835" y="1123449"/>
                    <a:pt x="307689" y="1125235"/>
                  </a:cubicBezTo>
                  <a:cubicBezTo>
                    <a:pt x="303257" y="1126343"/>
                    <a:pt x="299080" y="1128313"/>
                    <a:pt x="294688" y="1129568"/>
                  </a:cubicBezTo>
                  <a:cubicBezTo>
                    <a:pt x="288961" y="1131204"/>
                    <a:pt x="283131" y="1132457"/>
                    <a:pt x="277353" y="1133902"/>
                  </a:cubicBezTo>
                  <a:cubicBezTo>
                    <a:pt x="264296" y="1142606"/>
                    <a:pt x="262413" y="1144638"/>
                    <a:pt x="247018" y="1151236"/>
                  </a:cubicBezTo>
                  <a:cubicBezTo>
                    <a:pt x="242819" y="1153036"/>
                    <a:pt x="238351" y="1154125"/>
                    <a:pt x="234017" y="1155570"/>
                  </a:cubicBezTo>
                  <a:cubicBezTo>
                    <a:pt x="221016" y="1154125"/>
                    <a:pt x="207089" y="1156267"/>
                    <a:pt x="195014" y="1151236"/>
                  </a:cubicBezTo>
                  <a:cubicBezTo>
                    <a:pt x="183089" y="1146267"/>
                    <a:pt x="176002" y="1115868"/>
                    <a:pt x="173346" y="1107900"/>
                  </a:cubicBezTo>
                  <a:cubicBezTo>
                    <a:pt x="158780" y="1064203"/>
                    <a:pt x="181005" y="1131986"/>
                    <a:pt x="164678" y="1077564"/>
                  </a:cubicBezTo>
                  <a:cubicBezTo>
                    <a:pt x="162053" y="1068813"/>
                    <a:pt x="162471" y="1058022"/>
                    <a:pt x="156011" y="1051562"/>
                  </a:cubicBezTo>
                  <a:lnTo>
                    <a:pt x="143010" y="1038562"/>
                  </a:lnTo>
                  <a:cubicBezTo>
                    <a:pt x="141565" y="1034228"/>
                    <a:pt x="140719" y="1029647"/>
                    <a:pt x="138676" y="1025561"/>
                  </a:cubicBezTo>
                  <a:cubicBezTo>
                    <a:pt x="136347" y="1020903"/>
                    <a:pt x="130655" y="1017728"/>
                    <a:pt x="130009" y="1012560"/>
                  </a:cubicBezTo>
                  <a:cubicBezTo>
                    <a:pt x="129096" y="1005251"/>
                    <a:pt x="132898" y="998114"/>
                    <a:pt x="134343" y="990891"/>
                  </a:cubicBezTo>
                  <a:cubicBezTo>
                    <a:pt x="132898" y="980779"/>
                    <a:pt x="134577" y="969692"/>
                    <a:pt x="130009" y="960556"/>
                  </a:cubicBezTo>
                  <a:cubicBezTo>
                    <a:pt x="127966" y="956470"/>
                    <a:pt x="121560" y="956601"/>
                    <a:pt x="117008" y="956222"/>
                  </a:cubicBezTo>
                  <a:cubicBezTo>
                    <a:pt x="86743" y="953700"/>
                    <a:pt x="56337" y="953333"/>
                    <a:pt x="26002" y="951889"/>
                  </a:cubicBezTo>
                  <a:cubicBezTo>
                    <a:pt x="66803" y="992690"/>
                    <a:pt x="1378" y="931142"/>
                    <a:pt x="65004" y="973557"/>
                  </a:cubicBezTo>
                  <a:cubicBezTo>
                    <a:pt x="96689" y="994680"/>
                    <a:pt x="56838" y="968890"/>
                    <a:pt x="95340" y="990891"/>
                  </a:cubicBezTo>
                  <a:cubicBezTo>
                    <a:pt x="99862" y="993475"/>
                    <a:pt x="104007" y="996670"/>
                    <a:pt x="108341" y="999559"/>
                  </a:cubicBezTo>
                  <a:cubicBezTo>
                    <a:pt x="111230" y="1003893"/>
                    <a:pt x="114893" y="1007801"/>
                    <a:pt x="117008" y="1012560"/>
                  </a:cubicBezTo>
                  <a:cubicBezTo>
                    <a:pt x="120719" y="1020909"/>
                    <a:pt x="125676" y="1038562"/>
                    <a:pt x="125676" y="1038562"/>
                  </a:cubicBezTo>
                  <a:cubicBezTo>
                    <a:pt x="124231" y="1050118"/>
                    <a:pt x="130535" y="1066081"/>
                    <a:pt x="121342" y="1073231"/>
                  </a:cubicBezTo>
                  <a:cubicBezTo>
                    <a:pt x="118122" y="1075735"/>
                    <a:pt x="73579" y="1066278"/>
                    <a:pt x="65004" y="1064563"/>
                  </a:cubicBezTo>
                  <a:cubicBezTo>
                    <a:pt x="54927" y="1066003"/>
                    <a:pt x="26817" y="1060790"/>
                    <a:pt x="30335" y="1081898"/>
                  </a:cubicBezTo>
                  <a:cubicBezTo>
                    <a:pt x="31191" y="1087036"/>
                    <a:pt x="34586" y="1092138"/>
                    <a:pt x="39003" y="1094899"/>
                  </a:cubicBezTo>
                  <a:cubicBezTo>
                    <a:pt x="46750" y="1099741"/>
                    <a:pt x="65004" y="1103566"/>
                    <a:pt x="65004" y="1103566"/>
                  </a:cubicBezTo>
                  <a:cubicBezTo>
                    <a:pt x="84452" y="1123014"/>
                    <a:pt x="61355" y="1102502"/>
                    <a:pt x="86673" y="1116567"/>
                  </a:cubicBezTo>
                  <a:cubicBezTo>
                    <a:pt x="95779" y="1121626"/>
                    <a:pt x="112675" y="1133902"/>
                    <a:pt x="112675" y="1133902"/>
                  </a:cubicBezTo>
                  <a:cubicBezTo>
                    <a:pt x="115564" y="1138236"/>
                    <a:pt x="119227" y="1142144"/>
                    <a:pt x="121342" y="1146903"/>
                  </a:cubicBezTo>
                  <a:cubicBezTo>
                    <a:pt x="125052" y="1155252"/>
                    <a:pt x="130009" y="1172905"/>
                    <a:pt x="130009" y="1172905"/>
                  </a:cubicBezTo>
                  <a:cubicBezTo>
                    <a:pt x="128565" y="1177239"/>
                    <a:pt x="130155" y="1185010"/>
                    <a:pt x="125676" y="1185906"/>
                  </a:cubicBezTo>
                  <a:cubicBezTo>
                    <a:pt x="98725" y="1191296"/>
                    <a:pt x="70708" y="1187751"/>
                    <a:pt x="43336" y="1190239"/>
                  </a:cubicBezTo>
                  <a:cubicBezTo>
                    <a:pt x="38787" y="1190653"/>
                    <a:pt x="34669" y="1193128"/>
                    <a:pt x="30335" y="1194573"/>
                  </a:cubicBezTo>
                  <a:cubicBezTo>
                    <a:pt x="27527" y="1198785"/>
                    <a:pt x="15954" y="1213675"/>
                    <a:pt x="17334" y="1220575"/>
                  </a:cubicBezTo>
                  <a:cubicBezTo>
                    <a:pt x="18135" y="1224582"/>
                    <a:pt x="22811" y="1226690"/>
                    <a:pt x="26002" y="1229242"/>
                  </a:cubicBezTo>
                  <a:cubicBezTo>
                    <a:pt x="38003" y="1238842"/>
                    <a:pt x="38272" y="1237665"/>
                    <a:pt x="52003" y="1242243"/>
                  </a:cubicBezTo>
                  <a:cubicBezTo>
                    <a:pt x="55236" y="1241435"/>
                    <a:pt x="77902" y="1236238"/>
                    <a:pt x="82339" y="1233576"/>
                  </a:cubicBezTo>
                  <a:cubicBezTo>
                    <a:pt x="112082" y="1215730"/>
                    <a:pt x="67178" y="1232849"/>
                    <a:pt x="104007" y="1220575"/>
                  </a:cubicBezTo>
                  <a:cubicBezTo>
                    <a:pt x="125675" y="1222019"/>
                    <a:pt x="147813" y="1220197"/>
                    <a:pt x="169012" y="1224908"/>
                  </a:cubicBezTo>
                  <a:cubicBezTo>
                    <a:pt x="189485" y="1229457"/>
                    <a:pt x="180494" y="1248317"/>
                    <a:pt x="177679" y="1259578"/>
                  </a:cubicBezTo>
                  <a:cubicBezTo>
                    <a:pt x="176571" y="1264010"/>
                    <a:pt x="176576" y="1269349"/>
                    <a:pt x="173346" y="1272579"/>
                  </a:cubicBezTo>
                  <a:cubicBezTo>
                    <a:pt x="170116" y="1275809"/>
                    <a:pt x="164679" y="1275468"/>
                    <a:pt x="160345" y="1276912"/>
                  </a:cubicBezTo>
                  <a:cubicBezTo>
                    <a:pt x="156011" y="1279801"/>
                    <a:pt x="152003" y="1283251"/>
                    <a:pt x="147344" y="1285580"/>
                  </a:cubicBezTo>
                  <a:cubicBezTo>
                    <a:pt x="143258" y="1287623"/>
                    <a:pt x="137910" y="1287059"/>
                    <a:pt x="134343" y="1289913"/>
                  </a:cubicBezTo>
                  <a:cubicBezTo>
                    <a:pt x="130276" y="1293167"/>
                    <a:pt x="129359" y="1299231"/>
                    <a:pt x="125676" y="1302914"/>
                  </a:cubicBezTo>
                  <a:cubicBezTo>
                    <a:pt x="121993" y="1306597"/>
                    <a:pt x="117009" y="1308692"/>
                    <a:pt x="112675" y="1311581"/>
                  </a:cubicBezTo>
                  <a:cubicBezTo>
                    <a:pt x="109786" y="1315915"/>
                    <a:pt x="106336" y="1319923"/>
                    <a:pt x="104007" y="1324582"/>
                  </a:cubicBezTo>
                  <a:cubicBezTo>
                    <a:pt x="97059" y="1338478"/>
                    <a:pt x="98609" y="1347391"/>
                    <a:pt x="104007" y="1363585"/>
                  </a:cubicBezTo>
                  <a:cubicBezTo>
                    <a:pt x="105654" y="1368526"/>
                    <a:pt x="109786" y="1372252"/>
                    <a:pt x="112675" y="1376586"/>
                  </a:cubicBezTo>
                  <a:cubicBezTo>
                    <a:pt x="119898" y="1373697"/>
                    <a:pt x="127746" y="1372042"/>
                    <a:pt x="134343" y="1367919"/>
                  </a:cubicBezTo>
                  <a:cubicBezTo>
                    <a:pt x="166437" y="1347860"/>
                    <a:pt x="130848" y="1362886"/>
                    <a:pt x="156011" y="1341917"/>
                  </a:cubicBezTo>
                  <a:cubicBezTo>
                    <a:pt x="160974" y="1337781"/>
                    <a:pt x="167737" y="1336455"/>
                    <a:pt x="173346" y="1333250"/>
                  </a:cubicBezTo>
                  <a:cubicBezTo>
                    <a:pt x="177868" y="1330666"/>
                    <a:pt x="181587" y="1326697"/>
                    <a:pt x="186347" y="1324582"/>
                  </a:cubicBezTo>
                  <a:cubicBezTo>
                    <a:pt x="218914" y="1310107"/>
                    <a:pt x="255659" y="1310139"/>
                    <a:pt x="290354" y="1307248"/>
                  </a:cubicBezTo>
                  <a:cubicBezTo>
                    <a:pt x="310578" y="1308692"/>
                    <a:pt x="331058" y="1308057"/>
                    <a:pt x="351025" y="1311581"/>
                  </a:cubicBezTo>
                  <a:cubicBezTo>
                    <a:pt x="356154" y="1312486"/>
                    <a:pt x="363338" y="1315086"/>
                    <a:pt x="364026" y="1320249"/>
                  </a:cubicBezTo>
                  <a:cubicBezTo>
                    <a:pt x="366515" y="1338918"/>
                    <a:pt x="361137" y="1357807"/>
                    <a:pt x="359693" y="1376586"/>
                  </a:cubicBezTo>
                  <a:cubicBezTo>
                    <a:pt x="361137" y="1392476"/>
                    <a:pt x="355176" y="1410980"/>
                    <a:pt x="364026" y="1424256"/>
                  </a:cubicBezTo>
                  <a:cubicBezTo>
                    <a:pt x="368341" y="1430729"/>
                    <a:pt x="380571" y="1421443"/>
                    <a:pt x="385694" y="1415589"/>
                  </a:cubicBezTo>
                  <a:cubicBezTo>
                    <a:pt x="391710" y="1408713"/>
                    <a:pt x="391473" y="1398254"/>
                    <a:pt x="394362" y="1389587"/>
                  </a:cubicBezTo>
                  <a:cubicBezTo>
                    <a:pt x="395807" y="1385253"/>
                    <a:pt x="394361" y="1378030"/>
                    <a:pt x="398695" y="1376586"/>
                  </a:cubicBezTo>
                  <a:lnTo>
                    <a:pt x="411696" y="1372253"/>
                  </a:lnTo>
                  <a:cubicBezTo>
                    <a:pt x="418756" y="1373430"/>
                    <a:pt x="441552" y="1375839"/>
                    <a:pt x="450699" y="1380920"/>
                  </a:cubicBezTo>
                  <a:cubicBezTo>
                    <a:pt x="459805" y="1385979"/>
                    <a:pt x="476701" y="1398254"/>
                    <a:pt x="476701" y="1398254"/>
                  </a:cubicBezTo>
                  <a:cubicBezTo>
                    <a:pt x="478525" y="1403727"/>
                    <a:pt x="483241" y="1421671"/>
                    <a:pt x="489702" y="1424256"/>
                  </a:cubicBezTo>
                  <a:cubicBezTo>
                    <a:pt x="493943" y="1425953"/>
                    <a:pt x="498369" y="1421367"/>
                    <a:pt x="502703" y="1419923"/>
                  </a:cubicBezTo>
                  <a:cubicBezTo>
                    <a:pt x="505592" y="1417034"/>
                    <a:pt x="508754" y="1414394"/>
                    <a:pt x="511370" y="1411255"/>
                  </a:cubicBezTo>
                  <a:cubicBezTo>
                    <a:pt x="515994" y="1405706"/>
                    <a:pt x="518822" y="1398545"/>
                    <a:pt x="524371" y="1393921"/>
                  </a:cubicBezTo>
                  <a:cubicBezTo>
                    <a:pt x="527880" y="1390997"/>
                    <a:pt x="532980" y="1390842"/>
                    <a:pt x="537372" y="1389587"/>
                  </a:cubicBezTo>
                  <a:cubicBezTo>
                    <a:pt x="575490" y="1378696"/>
                    <a:pt x="536516" y="1391316"/>
                    <a:pt x="567708" y="1380920"/>
                  </a:cubicBezTo>
                  <a:cubicBezTo>
                    <a:pt x="572042" y="1385254"/>
                    <a:pt x="580301" y="1387806"/>
                    <a:pt x="580709" y="1393921"/>
                  </a:cubicBezTo>
                  <a:cubicBezTo>
                    <a:pt x="587704" y="1498850"/>
                    <a:pt x="596486" y="1480761"/>
                    <a:pt x="567708" y="1523930"/>
                  </a:cubicBezTo>
                  <a:cubicBezTo>
                    <a:pt x="566263" y="1529708"/>
                    <a:pt x="565720" y="1535790"/>
                    <a:pt x="563374" y="1541265"/>
                  </a:cubicBezTo>
                  <a:cubicBezTo>
                    <a:pt x="557677" y="1554558"/>
                    <a:pt x="550895" y="1556241"/>
                    <a:pt x="541706" y="1567267"/>
                  </a:cubicBezTo>
                  <a:cubicBezTo>
                    <a:pt x="514381" y="1600057"/>
                    <a:pt x="549581" y="1563728"/>
                    <a:pt x="524371" y="1588935"/>
                  </a:cubicBezTo>
                  <a:cubicBezTo>
                    <a:pt x="512815" y="1587490"/>
                    <a:pt x="501090" y="1587041"/>
                    <a:pt x="489702" y="1584601"/>
                  </a:cubicBezTo>
                  <a:cubicBezTo>
                    <a:pt x="473277" y="1581081"/>
                    <a:pt x="463025" y="1577128"/>
                    <a:pt x="450699" y="1567267"/>
                  </a:cubicBezTo>
                  <a:cubicBezTo>
                    <a:pt x="447508" y="1564715"/>
                    <a:pt x="444921" y="1561488"/>
                    <a:pt x="442032" y="1558599"/>
                  </a:cubicBezTo>
                  <a:cubicBezTo>
                    <a:pt x="440587" y="1551376"/>
                    <a:pt x="441784" y="1543060"/>
                    <a:pt x="437698" y="1536931"/>
                  </a:cubicBezTo>
                  <a:cubicBezTo>
                    <a:pt x="429733" y="1524984"/>
                    <a:pt x="394528" y="1541217"/>
                    <a:pt x="394362" y="1541265"/>
                  </a:cubicBezTo>
                  <a:cubicBezTo>
                    <a:pt x="390028" y="1544154"/>
                    <a:pt x="386019" y="1547603"/>
                    <a:pt x="381361" y="1549932"/>
                  </a:cubicBezTo>
                  <a:cubicBezTo>
                    <a:pt x="377275" y="1551975"/>
                    <a:pt x="372559" y="1552467"/>
                    <a:pt x="368360" y="1554266"/>
                  </a:cubicBezTo>
                  <a:cubicBezTo>
                    <a:pt x="362422" y="1556811"/>
                    <a:pt x="356803" y="1560044"/>
                    <a:pt x="351025" y="1562933"/>
                  </a:cubicBezTo>
                  <a:cubicBezTo>
                    <a:pt x="339080" y="1561440"/>
                    <a:pt x="316714" y="1560945"/>
                    <a:pt x="303355" y="1554266"/>
                  </a:cubicBezTo>
                  <a:cubicBezTo>
                    <a:pt x="298696" y="1551937"/>
                    <a:pt x="294688" y="1548488"/>
                    <a:pt x="290354" y="1545599"/>
                  </a:cubicBezTo>
                  <a:cubicBezTo>
                    <a:pt x="282108" y="1547248"/>
                    <a:pt x="264572" y="1549823"/>
                    <a:pt x="255685" y="1554266"/>
                  </a:cubicBezTo>
                  <a:cubicBezTo>
                    <a:pt x="239544" y="1562337"/>
                    <a:pt x="244061" y="1563952"/>
                    <a:pt x="229683" y="1575934"/>
                  </a:cubicBezTo>
                  <a:cubicBezTo>
                    <a:pt x="225682" y="1579268"/>
                    <a:pt x="221016" y="1581712"/>
                    <a:pt x="216682" y="1584601"/>
                  </a:cubicBezTo>
                  <a:cubicBezTo>
                    <a:pt x="213793" y="1588935"/>
                    <a:pt x="203681" y="1594713"/>
                    <a:pt x="208015" y="1597602"/>
                  </a:cubicBezTo>
                  <a:cubicBezTo>
                    <a:pt x="214143" y="1601688"/>
                    <a:pt x="222537" y="1595055"/>
                    <a:pt x="229683" y="1593269"/>
                  </a:cubicBezTo>
                  <a:cubicBezTo>
                    <a:pt x="234115" y="1592161"/>
                    <a:pt x="238225" y="1589926"/>
                    <a:pt x="242684" y="1588935"/>
                  </a:cubicBezTo>
                  <a:cubicBezTo>
                    <a:pt x="288456" y="1578763"/>
                    <a:pt x="252414" y="1590024"/>
                    <a:pt x="281687" y="1580268"/>
                  </a:cubicBezTo>
                  <a:cubicBezTo>
                    <a:pt x="291665" y="1581035"/>
                    <a:pt x="336610" y="1575249"/>
                    <a:pt x="351025" y="1593269"/>
                  </a:cubicBezTo>
                  <a:cubicBezTo>
                    <a:pt x="353879" y="1596836"/>
                    <a:pt x="353914" y="1601936"/>
                    <a:pt x="355359" y="1606270"/>
                  </a:cubicBezTo>
                  <a:cubicBezTo>
                    <a:pt x="353914" y="1619271"/>
                    <a:pt x="353175" y="1632369"/>
                    <a:pt x="351025" y="1645272"/>
                  </a:cubicBezTo>
                  <a:cubicBezTo>
                    <a:pt x="350274" y="1649778"/>
                    <a:pt x="347947" y="1653881"/>
                    <a:pt x="346692" y="1658273"/>
                  </a:cubicBezTo>
                  <a:cubicBezTo>
                    <a:pt x="345056" y="1664000"/>
                    <a:pt x="343803" y="1669830"/>
                    <a:pt x="342358" y="1675608"/>
                  </a:cubicBezTo>
                  <a:cubicBezTo>
                    <a:pt x="343803" y="1681386"/>
                    <a:pt x="341736" y="1689639"/>
                    <a:pt x="346692" y="1692943"/>
                  </a:cubicBezTo>
                  <a:cubicBezTo>
                    <a:pt x="350092" y="1695209"/>
                    <a:pt x="354067" y="1688151"/>
                    <a:pt x="355359" y="1684275"/>
                  </a:cubicBezTo>
                  <a:cubicBezTo>
                    <a:pt x="358589" y="1674585"/>
                    <a:pt x="358343" y="1664065"/>
                    <a:pt x="359693" y="1653940"/>
                  </a:cubicBezTo>
                  <a:cubicBezTo>
                    <a:pt x="361232" y="1642396"/>
                    <a:pt x="361201" y="1630570"/>
                    <a:pt x="364026" y="1619271"/>
                  </a:cubicBezTo>
                  <a:cubicBezTo>
                    <a:pt x="366737" y="1608427"/>
                    <a:pt x="376377" y="1595147"/>
                    <a:pt x="385694" y="1588935"/>
                  </a:cubicBezTo>
                  <a:cubicBezTo>
                    <a:pt x="389495" y="1586401"/>
                    <a:pt x="394361" y="1586046"/>
                    <a:pt x="398695" y="1584601"/>
                  </a:cubicBezTo>
                  <a:cubicBezTo>
                    <a:pt x="405918" y="1586046"/>
                    <a:pt x="413257" y="1586997"/>
                    <a:pt x="420364" y="1588935"/>
                  </a:cubicBezTo>
                  <a:cubicBezTo>
                    <a:pt x="429178" y="1591339"/>
                    <a:pt x="446366" y="1597602"/>
                    <a:pt x="446366" y="1597602"/>
                  </a:cubicBezTo>
                  <a:cubicBezTo>
                    <a:pt x="449255" y="1600491"/>
                    <a:pt x="452931" y="1602766"/>
                    <a:pt x="455033" y="1606270"/>
                  </a:cubicBezTo>
                  <a:cubicBezTo>
                    <a:pt x="474256" y="1638309"/>
                    <a:pt x="441736" y="1599398"/>
                    <a:pt x="468034" y="1632271"/>
                  </a:cubicBezTo>
                  <a:cubicBezTo>
                    <a:pt x="470586" y="1635462"/>
                    <a:pt x="472677" y="1640229"/>
                    <a:pt x="476701" y="1640939"/>
                  </a:cubicBezTo>
                  <a:cubicBezTo>
                    <a:pt x="498087" y="1644713"/>
                    <a:pt x="520038" y="1643828"/>
                    <a:pt x="541706" y="1645272"/>
                  </a:cubicBezTo>
                  <a:cubicBezTo>
                    <a:pt x="544595" y="1648161"/>
                    <a:pt x="546869" y="1651838"/>
                    <a:pt x="550373" y="1653940"/>
                  </a:cubicBezTo>
                  <a:cubicBezTo>
                    <a:pt x="554290" y="1656290"/>
                    <a:pt x="560144" y="1655043"/>
                    <a:pt x="563374" y="1658273"/>
                  </a:cubicBezTo>
                  <a:cubicBezTo>
                    <a:pt x="566604" y="1661503"/>
                    <a:pt x="565665" y="1667188"/>
                    <a:pt x="567708" y="1671274"/>
                  </a:cubicBezTo>
                  <a:cubicBezTo>
                    <a:pt x="570037" y="1675932"/>
                    <a:pt x="573486" y="1679941"/>
                    <a:pt x="576375" y="1684275"/>
                  </a:cubicBezTo>
                  <a:cubicBezTo>
                    <a:pt x="579264" y="1678497"/>
                    <a:pt x="584546" y="1673382"/>
                    <a:pt x="585042" y="1666941"/>
                  </a:cubicBezTo>
                  <a:cubicBezTo>
                    <a:pt x="586857" y="1643352"/>
                    <a:pt x="582523" y="1633379"/>
                    <a:pt x="576375" y="1614937"/>
                  </a:cubicBezTo>
                  <a:cubicBezTo>
                    <a:pt x="577820" y="1597602"/>
                    <a:pt x="575593" y="1579559"/>
                    <a:pt x="580709" y="1562933"/>
                  </a:cubicBezTo>
                  <a:cubicBezTo>
                    <a:pt x="582052" y="1558567"/>
                    <a:pt x="589142" y="1558599"/>
                    <a:pt x="593710" y="1558599"/>
                  </a:cubicBezTo>
                  <a:cubicBezTo>
                    <a:pt x="605356" y="1558599"/>
                    <a:pt x="616823" y="1561488"/>
                    <a:pt x="628379" y="1562933"/>
                  </a:cubicBezTo>
                  <a:cubicBezTo>
                    <a:pt x="631268" y="1567267"/>
                    <a:pt x="634994" y="1571147"/>
                    <a:pt x="637046" y="1575934"/>
                  </a:cubicBezTo>
                  <a:cubicBezTo>
                    <a:pt x="639392" y="1581409"/>
                    <a:pt x="639669" y="1587564"/>
                    <a:pt x="641380" y="1593269"/>
                  </a:cubicBezTo>
                  <a:cubicBezTo>
                    <a:pt x="644005" y="1602020"/>
                    <a:pt x="647831" y="1610408"/>
                    <a:pt x="650047" y="1619271"/>
                  </a:cubicBezTo>
                  <a:cubicBezTo>
                    <a:pt x="652649" y="1629679"/>
                    <a:pt x="653696" y="1642125"/>
                    <a:pt x="663048" y="1649606"/>
                  </a:cubicBezTo>
                  <a:cubicBezTo>
                    <a:pt x="666615" y="1652460"/>
                    <a:pt x="671715" y="1652495"/>
                    <a:pt x="676049" y="1653940"/>
                  </a:cubicBezTo>
                  <a:cubicBezTo>
                    <a:pt x="674604" y="1639494"/>
                    <a:pt x="673768" y="1624975"/>
                    <a:pt x="671715" y="1610603"/>
                  </a:cubicBezTo>
                  <a:cubicBezTo>
                    <a:pt x="670354" y="1601076"/>
                    <a:pt x="666136" y="1589532"/>
                    <a:pt x="663048" y="1580268"/>
                  </a:cubicBezTo>
                  <a:cubicBezTo>
                    <a:pt x="664493" y="1564378"/>
                    <a:pt x="662690" y="1547848"/>
                    <a:pt x="667382" y="1532598"/>
                  </a:cubicBezTo>
                  <a:cubicBezTo>
                    <a:pt x="668914" y="1527620"/>
                    <a:pt x="675245" y="1524786"/>
                    <a:pt x="680383" y="1523930"/>
                  </a:cubicBezTo>
                  <a:cubicBezTo>
                    <a:pt x="687559" y="1522734"/>
                    <a:pt x="701858" y="1533913"/>
                    <a:pt x="706385" y="1536931"/>
                  </a:cubicBezTo>
                  <a:cubicBezTo>
                    <a:pt x="737355" y="1583388"/>
                    <a:pt x="689125" y="1512881"/>
                    <a:pt x="728053" y="1562933"/>
                  </a:cubicBezTo>
                  <a:cubicBezTo>
                    <a:pt x="762348" y="1607028"/>
                    <a:pt x="732257" y="1575806"/>
                    <a:pt x="754055" y="1597602"/>
                  </a:cubicBezTo>
                  <a:cubicBezTo>
                    <a:pt x="758389" y="1596158"/>
                    <a:pt x="763489" y="1596123"/>
                    <a:pt x="767056" y="1593269"/>
                  </a:cubicBezTo>
                  <a:cubicBezTo>
                    <a:pt x="779702" y="1583152"/>
                    <a:pt x="779768" y="1563098"/>
                    <a:pt x="771389" y="1549932"/>
                  </a:cubicBezTo>
                  <a:cubicBezTo>
                    <a:pt x="765796" y="1541144"/>
                    <a:pt x="745387" y="1532598"/>
                    <a:pt x="745387" y="1532598"/>
                  </a:cubicBezTo>
                  <a:cubicBezTo>
                    <a:pt x="751354" y="1425193"/>
                    <a:pt x="727784" y="1473877"/>
                    <a:pt x="762722" y="1445925"/>
                  </a:cubicBezTo>
                  <a:cubicBezTo>
                    <a:pt x="765913" y="1443373"/>
                    <a:pt x="768500" y="1440146"/>
                    <a:pt x="771389" y="1437257"/>
                  </a:cubicBezTo>
                  <a:cubicBezTo>
                    <a:pt x="761696" y="1434834"/>
                    <a:pt x="734388" y="1428479"/>
                    <a:pt x="728053" y="1424256"/>
                  </a:cubicBezTo>
                  <a:lnTo>
                    <a:pt x="715052" y="1415589"/>
                  </a:lnTo>
                  <a:cubicBezTo>
                    <a:pt x="713607" y="1411255"/>
                    <a:pt x="710718" y="1407156"/>
                    <a:pt x="710718" y="1402588"/>
                  </a:cubicBezTo>
                  <a:cubicBezTo>
                    <a:pt x="710718" y="1393801"/>
                    <a:pt x="709266" y="1383199"/>
                    <a:pt x="715052" y="1376586"/>
                  </a:cubicBezTo>
                  <a:cubicBezTo>
                    <a:pt x="723325" y="1367132"/>
                    <a:pt x="775126" y="1364133"/>
                    <a:pt x="780057" y="1363585"/>
                  </a:cubicBezTo>
                  <a:cubicBezTo>
                    <a:pt x="784391" y="1362141"/>
                    <a:pt x="789828" y="1362482"/>
                    <a:pt x="793058" y="1359252"/>
                  </a:cubicBezTo>
                  <a:cubicBezTo>
                    <a:pt x="802390" y="1349920"/>
                    <a:pt x="797305" y="1342732"/>
                    <a:pt x="788724" y="1337583"/>
                  </a:cubicBezTo>
                  <a:cubicBezTo>
                    <a:pt x="784807" y="1335233"/>
                    <a:pt x="780115" y="1334505"/>
                    <a:pt x="775723" y="1333250"/>
                  </a:cubicBezTo>
                  <a:cubicBezTo>
                    <a:pt x="747243" y="1325113"/>
                    <a:pt x="757152" y="1330195"/>
                    <a:pt x="715052" y="1324582"/>
                  </a:cubicBezTo>
                  <a:cubicBezTo>
                    <a:pt x="697616" y="1322257"/>
                    <a:pt x="694969" y="1320777"/>
                    <a:pt x="680383" y="1315915"/>
                  </a:cubicBezTo>
                  <a:cubicBezTo>
                    <a:pt x="677494" y="1313026"/>
                    <a:pt x="671715" y="1311334"/>
                    <a:pt x="671715" y="1307248"/>
                  </a:cubicBezTo>
                  <a:cubicBezTo>
                    <a:pt x="671715" y="1299469"/>
                    <a:pt x="676523" y="1292334"/>
                    <a:pt x="680383" y="1285580"/>
                  </a:cubicBezTo>
                  <a:cubicBezTo>
                    <a:pt x="685494" y="1276635"/>
                    <a:pt x="692760" y="1274902"/>
                    <a:pt x="702051" y="1272579"/>
                  </a:cubicBezTo>
                  <a:cubicBezTo>
                    <a:pt x="709197" y="1270793"/>
                    <a:pt x="716496" y="1269690"/>
                    <a:pt x="723719" y="1268245"/>
                  </a:cubicBezTo>
                  <a:cubicBezTo>
                    <a:pt x="724377" y="1267806"/>
                    <a:pt x="745387" y="1255028"/>
                    <a:pt x="745387" y="1250910"/>
                  </a:cubicBezTo>
                  <a:cubicBezTo>
                    <a:pt x="745387" y="1245702"/>
                    <a:pt x="740403" y="1241592"/>
                    <a:pt x="736720" y="1237909"/>
                  </a:cubicBezTo>
                  <a:cubicBezTo>
                    <a:pt x="728320" y="1229509"/>
                    <a:pt x="721291" y="1228433"/>
                    <a:pt x="710718" y="1224908"/>
                  </a:cubicBezTo>
                  <a:cubicBezTo>
                    <a:pt x="694828" y="1226353"/>
                    <a:pt x="678843" y="1226985"/>
                    <a:pt x="663048" y="1229242"/>
                  </a:cubicBezTo>
                  <a:cubicBezTo>
                    <a:pt x="658526" y="1229888"/>
                    <a:pt x="654587" y="1234081"/>
                    <a:pt x="650047" y="1233576"/>
                  </a:cubicBezTo>
                  <a:cubicBezTo>
                    <a:pt x="640967" y="1232567"/>
                    <a:pt x="624045" y="1224908"/>
                    <a:pt x="624045" y="1224908"/>
                  </a:cubicBezTo>
                  <a:cubicBezTo>
                    <a:pt x="621156" y="1220575"/>
                    <a:pt x="618767" y="1215862"/>
                    <a:pt x="615378" y="1211908"/>
                  </a:cubicBezTo>
                  <a:cubicBezTo>
                    <a:pt x="610060" y="1205704"/>
                    <a:pt x="598043" y="1194573"/>
                    <a:pt x="598043" y="1194573"/>
                  </a:cubicBezTo>
                  <a:cubicBezTo>
                    <a:pt x="594755" y="1181417"/>
                    <a:pt x="589041" y="1169073"/>
                    <a:pt x="598043" y="1155570"/>
                  </a:cubicBezTo>
                  <a:cubicBezTo>
                    <a:pt x="600577" y="1151769"/>
                    <a:pt x="606710" y="1152681"/>
                    <a:pt x="611044" y="1151236"/>
                  </a:cubicBezTo>
                  <a:cubicBezTo>
                    <a:pt x="639117" y="1123166"/>
                    <a:pt x="587314" y="1171605"/>
                    <a:pt x="645713" y="1138235"/>
                  </a:cubicBezTo>
                  <a:cubicBezTo>
                    <a:pt x="649679" y="1135969"/>
                    <a:pt x="648602" y="1129568"/>
                    <a:pt x="650047" y="1125235"/>
                  </a:cubicBezTo>
                  <a:cubicBezTo>
                    <a:pt x="648602" y="1120901"/>
                    <a:pt x="649430" y="1114889"/>
                    <a:pt x="645713" y="1112234"/>
                  </a:cubicBezTo>
                  <a:cubicBezTo>
                    <a:pt x="638279" y="1106924"/>
                    <a:pt x="627314" y="1108634"/>
                    <a:pt x="619712" y="1103566"/>
                  </a:cubicBezTo>
                  <a:cubicBezTo>
                    <a:pt x="599086" y="1089816"/>
                    <a:pt x="614816" y="1098197"/>
                    <a:pt x="589376" y="1090565"/>
                  </a:cubicBezTo>
                  <a:cubicBezTo>
                    <a:pt x="580625" y="1087940"/>
                    <a:pt x="572041" y="1084787"/>
                    <a:pt x="563374" y="1081898"/>
                  </a:cubicBezTo>
                  <a:lnTo>
                    <a:pt x="550373" y="1077564"/>
                  </a:lnTo>
                  <a:cubicBezTo>
                    <a:pt x="544627" y="1068945"/>
                    <a:pt x="535275" y="1062327"/>
                    <a:pt x="546040" y="1051562"/>
                  </a:cubicBezTo>
                  <a:cubicBezTo>
                    <a:pt x="549270" y="1048332"/>
                    <a:pt x="554707" y="1048673"/>
                    <a:pt x="559040" y="1047229"/>
                  </a:cubicBezTo>
                  <a:cubicBezTo>
                    <a:pt x="561929" y="1044340"/>
                    <a:pt x="563626" y="1038739"/>
                    <a:pt x="567708" y="1038562"/>
                  </a:cubicBezTo>
                  <a:cubicBezTo>
                    <a:pt x="598049" y="1037243"/>
                    <a:pt x="628449" y="1040373"/>
                    <a:pt x="658714" y="1042895"/>
                  </a:cubicBezTo>
                  <a:cubicBezTo>
                    <a:pt x="663266" y="1043274"/>
                    <a:pt x="667283" y="1046121"/>
                    <a:pt x="671715" y="1047229"/>
                  </a:cubicBezTo>
                  <a:cubicBezTo>
                    <a:pt x="678861" y="1049015"/>
                    <a:pt x="686161" y="1050118"/>
                    <a:pt x="693384" y="1051562"/>
                  </a:cubicBezTo>
                  <a:cubicBezTo>
                    <a:pt x="702051" y="1050118"/>
                    <a:pt x="712235" y="1052336"/>
                    <a:pt x="719385" y="1047229"/>
                  </a:cubicBezTo>
                  <a:cubicBezTo>
                    <a:pt x="724232" y="1043767"/>
                    <a:pt x="723719" y="1035850"/>
                    <a:pt x="723719" y="1029894"/>
                  </a:cubicBezTo>
                  <a:cubicBezTo>
                    <a:pt x="723719" y="1023938"/>
                    <a:pt x="721021" y="1018287"/>
                    <a:pt x="719385" y="1012560"/>
                  </a:cubicBezTo>
                  <a:cubicBezTo>
                    <a:pt x="715979" y="1000641"/>
                    <a:pt x="712001" y="986986"/>
                    <a:pt x="697717" y="982224"/>
                  </a:cubicBezTo>
                  <a:cubicBezTo>
                    <a:pt x="693383" y="980779"/>
                    <a:pt x="689195" y="978786"/>
                    <a:pt x="684716" y="977890"/>
                  </a:cubicBezTo>
                  <a:cubicBezTo>
                    <a:pt x="667484" y="974444"/>
                    <a:pt x="649384" y="974780"/>
                    <a:pt x="632712" y="969223"/>
                  </a:cubicBezTo>
                  <a:cubicBezTo>
                    <a:pt x="624045" y="966334"/>
                    <a:pt x="614313" y="965624"/>
                    <a:pt x="606711" y="960556"/>
                  </a:cubicBezTo>
                  <a:lnTo>
                    <a:pt x="593710" y="951889"/>
                  </a:lnTo>
                  <a:cubicBezTo>
                    <a:pt x="590821" y="947555"/>
                    <a:pt x="587371" y="943547"/>
                    <a:pt x="585042" y="938888"/>
                  </a:cubicBezTo>
                  <a:cubicBezTo>
                    <a:pt x="577035" y="922874"/>
                    <a:pt x="581057" y="915478"/>
                    <a:pt x="585042" y="895551"/>
                  </a:cubicBezTo>
                  <a:cubicBezTo>
                    <a:pt x="585938" y="891072"/>
                    <a:pt x="586842" y="886351"/>
                    <a:pt x="589376" y="882550"/>
                  </a:cubicBezTo>
                  <a:cubicBezTo>
                    <a:pt x="592776" y="877451"/>
                    <a:pt x="598043" y="873883"/>
                    <a:pt x="602377" y="869549"/>
                  </a:cubicBezTo>
                  <a:cubicBezTo>
                    <a:pt x="644160" y="874192"/>
                    <a:pt x="655257" y="877807"/>
                    <a:pt x="702051" y="869549"/>
                  </a:cubicBezTo>
                  <a:cubicBezTo>
                    <a:pt x="707180" y="868644"/>
                    <a:pt x="710394" y="863211"/>
                    <a:pt x="715052" y="860882"/>
                  </a:cubicBezTo>
                  <a:cubicBezTo>
                    <a:pt x="719138" y="858839"/>
                    <a:pt x="723719" y="857993"/>
                    <a:pt x="728053" y="856548"/>
                  </a:cubicBezTo>
                  <a:cubicBezTo>
                    <a:pt x="730942" y="852214"/>
                    <a:pt x="736074" y="848715"/>
                    <a:pt x="736720" y="843547"/>
                  </a:cubicBezTo>
                  <a:cubicBezTo>
                    <a:pt x="739450" y="821701"/>
                    <a:pt x="729962" y="819528"/>
                    <a:pt x="715052" y="808878"/>
                  </a:cubicBezTo>
                  <a:cubicBezTo>
                    <a:pt x="710814" y="805851"/>
                    <a:pt x="706709" y="802540"/>
                    <a:pt x="702051" y="800211"/>
                  </a:cubicBezTo>
                  <a:cubicBezTo>
                    <a:pt x="690076" y="794224"/>
                    <a:pt x="669609" y="792997"/>
                    <a:pt x="658714" y="791544"/>
                  </a:cubicBezTo>
                  <a:lnTo>
                    <a:pt x="624045" y="787210"/>
                  </a:lnTo>
                  <a:cubicBezTo>
                    <a:pt x="593709" y="777099"/>
                    <a:pt x="600932" y="787210"/>
                    <a:pt x="593710" y="765542"/>
                  </a:cubicBezTo>
                  <a:cubicBezTo>
                    <a:pt x="595154" y="759764"/>
                    <a:pt x="594322" y="752858"/>
                    <a:pt x="598043" y="748207"/>
                  </a:cubicBezTo>
                  <a:cubicBezTo>
                    <a:pt x="600897" y="744640"/>
                    <a:pt x="606958" y="745916"/>
                    <a:pt x="611044" y="743873"/>
                  </a:cubicBezTo>
                  <a:cubicBezTo>
                    <a:pt x="615702" y="741544"/>
                    <a:pt x="619711" y="738095"/>
                    <a:pt x="624045" y="735206"/>
                  </a:cubicBezTo>
                  <a:cubicBezTo>
                    <a:pt x="665937" y="736651"/>
                    <a:pt x="707804" y="739540"/>
                    <a:pt x="749721" y="739540"/>
                  </a:cubicBezTo>
                  <a:cubicBezTo>
                    <a:pt x="757087" y="739540"/>
                    <a:pt x="767735" y="741601"/>
                    <a:pt x="771389" y="735206"/>
                  </a:cubicBezTo>
                  <a:cubicBezTo>
                    <a:pt x="780491" y="719278"/>
                    <a:pt x="766710" y="708858"/>
                    <a:pt x="758388" y="700537"/>
                  </a:cubicBezTo>
                  <a:cubicBezTo>
                    <a:pt x="747838" y="668884"/>
                    <a:pt x="751937" y="683398"/>
                    <a:pt x="745387" y="657200"/>
                  </a:cubicBezTo>
                  <a:cubicBezTo>
                    <a:pt x="754011" y="631330"/>
                    <a:pt x="748778" y="650055"/>
                    <a:pt x="754055" y="605197"/>
                  </a:cubicBezTo>
                  <a:cubicBezTo>
                    <a:pt x="758396" y="568298"/>
                    <a:pt x="757289" y="577119"/>
                    <a:pt x="762722" y="544526"/>
                  </a:cubicBezTo>
                  <a:cubicBezTo>
                    <a:pt x="765611" y="548859"/>
                    <a:pt x="770652" y="552370"/>
                    <a:pt x="771389" y="557526"/>
                  </a:cubicBezTo>
                  <a:cubicBezTo>
                    <a:pt x="772231" y="563422"/>
                    <a:pt x="770360" y="569905"/>
                    <a:pt x="767056" y="574861"/>
                  </a:cubicBezTo>
                  <a:cubicBezTo>
                    <a:pt x="764167" y="579195"/>
                    <a:pt x="758122" y="580274"/>
                    <a:pt x="754055" y="583528"/>
                  </a:cubicBezTo>
                  <a:cubicBezTo>
                    <a:pt x="740810" y="594124"/>
                    <a:pt x="747718" y="595364"/>
                    <a:pt x="728053" y="605197"/>
                  </a:cubicBezTo>
                  <a:cubicBezTo>
                    <a:pt x="719881" y="609283"/>
                    <a:pt x="702051" y="613864"/>
                    <a:pt x="702051" y="613864"/>
                  </a:cubicBezTo>
                  <a:cubicBezTo>
                    <a:pt x="693384" y="612419"/>
                    <a:pt x="684465" y="612055"/>
                    <a:pt x="676049" y="609530"/>
                  </a:cubicBezTo>
                  <a:cubicBezTo>
                    <a:pt x="670126" y="607753"/>
                    <a:pt x="651133" y="597014"/>
                    <a:pt x="645713" y="592196"/>
                  </a:cubicBezTo>
                  <a:cubicBezTo>
                    <a:pt x="636552" y="584053"/>
                    <a:pt x="628379" y="574861"/>
                    <a:pt x="619712" y="566194"/>
                  </a:cubicBezTo>
                  <a:lnTo>
                    <a:pt x="611044" y="557526"/>
                  </a:lnTo>
                  <a:cubicBezTo>
                    <a:pt x="605402" y="540598"/>
                    <a:pt x="602107" y="539379"/>
                    <a:pt x="615378" y="518524"/>
                  </a:cubicBezTo>
                  <a:cubicBezTo>
                    <a:pt x="620862" y="509906"/>
                    <a:pt x="632478" y="505991"/>
                    <a:pt x="637046" y="496855"/>
                  </a:cubicBezTo>
                  <a:cubicBezTo>
                    <a:pt x="648042" y="474862"/>
                    <a:pt x="640338" y="483105"/>
                    <a:pt x="658714" y="470853"/>
                  </a:cubicBezTo>
                  <a:cubicBezTo>
                    <a:pt x="657270" y="457852"/>
                    <a:pt x="657823" y="444471"/>
                    <a:pt x="654381" y="431851"/>
                  </a:cubicBezTo>
                  <a:cubicBezTo>
                    <a:pt x="653306" y="427909"/>
                    <a:pt x="647980" y="426583"/>
                    <a:pt x="645713" y="423183"/>
                  </a:cubicBezTo>
                  <a:cubicBezTo>
                    <a:pt x="642130" y="417808"/>
                    <a:pt x="640251" y="411458"/>
                    <a:pt x="637046" y="405849"/>
                  </a:cubicBezTo>
                  <a:cubicBezTo>
                    <a:pt x="634462" y="401327"/>
                    <a:pt x="630708" y="397507"/>
                    <a:pt x="628379" y="392848"/>
                  </a:cubicBezTo>
                  <a:cubicBezTo>
                    <a:pt x="624900" y="385890"/>
                    <a:pt x="623191" y="378138"/>
                    <a:pt x="619712" y="371180"/>
                  </a:cubicBezTo>
                  <a:cubicBezTo>
                    <a:pt x="614246" y="360249"/>
                    <a:pt x="610437" y="357572"/>
                    <a:pt x="602377" y="349511"/>
                  </a:cubicBezTo>
                  <a:cubicBezTo>
                    <a:pt x="600932" y="343733"/>
                    <a:pt x="598949" y="338064"/>
                    <a:pt x="598043" y="332177"/>
                  </a:cubicBezTo>
                  <a:cubicBezTo>
                    <a:pt x="592653" y="297139"/>
                    <a:pt x="593241" y="273554"/>
                    <a:pt x="589376" y="236836"/>
                  </a:cubicBezTo>
                  <a:cubicBezTo>
                    <a:pt x="588456" y="228098"/>
                    <a:pt x="582263" y="219171"/>
                    <a:pt x="585042" y="210835"/>
                  </a:cubicBezTo>
                  <a:cubicBezTo>
                    <a:pt x="586689" y="205894"/>
                    <a:pt x="590821" y="219502"/>
                    <a:pt x="593710" y="223835"/>
                  </a:cubicBezTo>
                  <a:cubicBezTo>
                    <a:pt x="595154" y="228169"/>
                    <a:pt x="596000" y="232750"/>
                    <a:pt x="598043" y="236836"/>
                  </a:cubicBezTo>
                  <a:cubicBezTo>
                    <a:pt x="600372" y="241495"/>
                    <a:pt x="605064" y="244896"/>
                    <a:pt x="606711" y="249837"/>
                  </a:cubicBezTo>
                  <a:cubicBezTo>
                    <a:pt x="609490" y="258173"/>
                    <a:pt x="609600" y="267172"/>
                    <a:pt x="611044" y="275839"/>
                  </a:cubicBezTo>
                  <a:cubicBezTo>
                    <a:pt x="615378" y="270061"/>
                    <a:pt x="619847" y="264382"/>
                    <a:pt x="624045" y="258505"/>
                  </a:cubicBezTo>
                  <a:cubicBezTo>
                    <a:pt x="627072" y="254267"/>
                    <a:pt x="629458" y="249571"/>
                    <a:pt x="632712" y="245504"/>
                  </a:cubicBezTo>
                  <a:cubicBezTo>
                    <a:pt x="635265" y="242313"/>
                    <a:pt x="639113" y="240236"/>
                    <a:pt x="641380" y="236836"/>
                  </a:cubicBezTo>
                  <a:cubicBezTo>
                    <a:pt x="650113" y="223737"/>
                    <a:pt x="648017" y="214851"/>
                    <a:pt x="663048" y="206501"/>
                  </a:cubicBezTo>
                  <a:cubicBezTo>
                    <a:pt x="671034" y="202064"/>
                    <a:pt x="680383" y="200723"/>
                    <a:pt x="689050" y="197834"/>
                  </a:cubicBezTo>
                  <a:lnTo>
                    <a:pt x="702051" y="193500"/>
                  </a:lnTo>
                  <a:cubicBezTo>
                    <a:pt x="717941" y="194945"/>
                    <a:pt x="734120" y="194491"/>
                    <a:pt x="749721" y="197834"/>
                  </a:cubicBezTo>
                  <a:cubicBezTo>
                    <a:pt x="754814" y="198925"/>
                    <a:pt x="758064" y="204172"/>
                    <a:pt x="762722" y="206501"/>
                  </a:cubicBezTo>
                  <a:cubicBezTo>
                    <a:pt x="766808" y="208544"/>
                    <a:pt x="771389" y="209390"/>
                    <a:pt x="775723" y="210835"/>
                  </a:cubicBezTo>
                  <a:cubicBezTo>
                    <a:pt x="787279" y="209390"/>
                    <a:pt x="800915" y="213271"/>
                    <a:pt x="810392" y="206501"/>
                  </a:cubicBezTo>
                  <a:cubicBezTo>
                    <a:pt x="815239" y="203039"/>
                    <a:pt x="811556" y="191457"/>
                    <a:pt x="806058" y="189166"/>
                  </a:cubicBezTo>
                  <a:cubicBezTo>
                    <a:pt x="791330" y="183029"/>
                    <a:pt x="774278" y="186277"/>
                    <a:pt x="758388" y="184833"/>
                  </a:cubicBezTo>
                  <a:cubicBezTo>
                    <a:pt x="727287" y="164098"/>
                    <a:pt x="739752" y="174864"/>
                    <a:pt x="719385" y="154497"/>
                  </a:cubicBezTo>
                  <a:cubicBezTo>
                    <a:pt x="716497" y="145831"/>
                    <a:pt x="710719" y="137161"/>
                    <a:pt x="719385" y="128495"/>
                  </a:cubicBezTo>
                  <a:cubicBezTo>
                    <a:pt x="722615" y="125265"/>
                    <a:pt x="728052" y="125606"/>
                    <a:pt x="732386" y="124162"/>
                  </a:cubicBezTo>
                  <a:cubicBezTo>
                    <a:pt x="746720" y="102663"/>
                    <a:pt x="737372" y="114843"/>
                    <a:pt x="762722" y="89492"/>
                  </a:cubicBezTo>
                  <a:cubicBezTo>
                    <a:pt x="767056" y="85158"/>
                    <a:pt x="770624" y="79891"/>
                    <a:pt x="775723" y="76491"/>
                  </a:cubicBezTo>
                  <a:lnTo>
                    <a:pt x="801725" y="59157"/>
                  </a:lnTo>
                  <a:cubicBezTo>
                    <a:pt x="806408" y="47448"/>
                    <a:pt x="823797" y="14108"/>
                    <a:pt x="806058" y="2819"/>
                  </a:cubicBezTo>
                  <a:cubicBezTo>
                    <a:pt x="793810" y="-4975"/>
                    <a:pt x="777167" y="5708"/>
                    <a:pt x="762722" y="7153"/>
                  </a:cubicBezTo>
                  <a:cubicBezTo>
                    <a:pt x="758388" y="8598"/>
                    <a:pt x="753327" y="8682"/>
                    <a:pt x="749721" y="11487"/>
                  </a:cubicBezTo>
                  <a:cubicBezTo>
                    <a:pt x="702494" y="48220"/>
                    <a:pt x="737972" y="24295"/>
                    <a:pt x="715052" y="50490"/>
                  </a:cubicBezTo>
                  <a:cubicBezTo>
                    <a:pt x="708326" y="58177"/>
                    <a:pt x="700607" y="64935"/>
                    <a:pt x="693384" y="72158"/>
                  </a:cubicBezTo>
                  <a:cubicBezTo>
                    <a:pt x="690495" y="75047"/>
                    <a:pt x="686982" y="77425"/>
                    <a:pt x="684716" y="80825"/>
                  </a:cubicBezTo>
                  <a:cubicBezTo>
                    <a:pt x="681827" y="85159"/>
                    <a:pt x="679509" y="89933"/>
                    <a:pt x="676049" y="93826"/>
                  </a:cubicBezTo>
                  <a:cubicBezTo>
                    <a:pt x="667906" y="102987"/>
                    <a:pt x="650047" y="119828"/>
                    <a:pt x="650047" y="119828"/>
                  </a:cubicBezTo>
                  <a:cubicBezTo>
                    <a:pt x="622030" y="115158"/>
                    <a:pt x="620433" y="98159"/>
                    <a:pt x="611044" y="89492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Figura a mano libera 12">
              <a:extLst>
                <a:ext uri="{FF2B5EF4-FFF2-40B4-BE49-F238E27FC236}">
                  <a16:creationId xmlns:a16="http://schemas.microsoft.com/office/drawing/2014/main" id="{D9BD0184-3490-FE4F-B7D9-0336799C3F5A}"/>
                </a:ext>
              </a:extLst>
            </p:cNvPr>
            <p:cNvSpPr/>
            <p:nvPr/>
          </p:nvSpPr>
          <p:spPr>
            <a:xfrm>
              <a:off x="7063848" y="665408"/>
              <a:ext cx="811632" cy="1830828"/>
            </a:xfrm>
            <a:custGeom>
              <a:avLst/>
              <a:gdLst>
                <a:gd name="connsiteX0" fmla="*/ 78006 w 811632"/>
                <a:gd name="connsiteY0" fmla="*/ 1974 h 1830828"/>
                <a:gd name="connsiteX1" fmla="*/ 56338 w 811632"/>
                <a:gd name="connsiteY1" fmla="*/ 10641 h 1830828"/>
                <a:gd name="connsiteX2" fmla="*/ 47670 w 811632"/>
                <a:gd name="connsiteY2" fmla="*/ 19309 h 1830828"/>
                <a:gd name="connsiteX3" fmla="*/ 52004 w 811632"/>
                <a:gd name="connsiteY3" fmla="*/ 75646 h 1830828"/>
                <a:gd name="connsiteX4" fmla="*/ 65005 w 811632"/>
                <a:gd name="connsiteY4" fmla="*/ 101648 h 1830828"/>
                <a:gd name="connsiteX5" fmla="*/ 78006 w 811632"/>
                <a:gd name="connsiteY5" fmla="*/ 110315 h 1830828"/>
                <a:gd name="connsiteX6" fmla="*/ 108342 w 811632"/>
                <a:gd name="connsiteY6" fmla="*/ 136317 h 1830828"/>
                <a:gd name="connsiteX7" fmla="*/ 117009 w 811632"/>
                <a:gd name="connsiteY7" fmla="*/ 149318 h 1830828"/>
                <a:gd name="connsiteX8" fmla="*/ 130010 w 811632"/>
                <a:gd name="connsiteY8" fmla="*/ 162319 h 1830828"/>
                <a:gd name="connsiteX9" fmla="*/ 134343 w 811632"/>
                <a:gd name="connsiteY9" fmla="*/ 175320 h 1830828"/>
                <a:gd name="connsiteX10" fmla="*/ 130010 w 811632"/>
                <a:gd name="connsiteY10" fmla="*/ 192655 h 1830828"/>
                <a:gd name="connsiteX11" fmla="*/ 117009 w 811632"/>
                <a:gd name="connsiteY11" fmla="*/ 201322 h 1830828"/>
                <a:gd name="connsiteX12" fmla="*/ 134343 w 811632"/>
                <a:gd name="connsiteY12" fmla="*/ 205656 h 1830828"/>
                <a:gd name="connsiteX13" fmla="*/ 164679 w 811632"/>
                <a:gd name="connsiteY13" fmla="*/ 209989 h 1830828"/>
                <a:gd name="connsiteX14" fmla="*/ 164679 w 811632"/>
                <a:gd name="connsiteY14" fmla="*/ 305329 h 1830828"/>
                <a:gd name="connsiteX15" fmla="*/ 151678 w 811632"/>
                <a:gd name="connsiteY15" fmla="*/ 309663 h 1830828"/>
                <a:gd name="connsiteX16" fmla="*/ 60671 w 811632"/>
                <a:gd name="connsiteY16" fmla="*/ 305329 h 1830828"/>
                <a:gd name="connsiteX17" fmla="*/ 65005 w 811632"/>
                <a:gd name="connsiteY17" fmla="*/ 318330 h 1830828"/>
                <a:gd name="connsiteX18" fmla="*/ 91007 w 811632"/>
                <a:gd name="connsiteY18" fmla="*/ 331331 h 1830828"/>
                <a:gd name="connsiteX19" fmla="*/ 125676 w 811632"/>
                <a:gd name="connsiteY19" fmla="*/ 339999 h 1830828"/>
                <a:gd name="connsiteX20" fmla="*/ 138677 w 811632"/>
                <a:gd name="connsiteY20" fmla="*/ 348666 h 1830828"/>
                <a:gd name="connsiteX21" fmla="*/ 134343 w 811632"/>
                <a:gd name="connsiteY21" fmla="*/ 366001 h 1830828"/>
                <a:gd name="connsiteX22" fmla="*/ 121343 w 811632"/>
                <a:gd name="connsiteY22" fmla="*/ 387669 h 1830828"/>
                <a:gd name="connsiteX23" fmla="*/ 99674 w 811632"/>
                <a:gd name="connsiteY23" fmla="*/ 413671 h 1830828"/>
                <a:gd name="connsiteX24" fmla="*/ 86673 w 811632"/>
                <a:gd name="connsiteY24" fmla="*/ 418004 h 1830828"/>
                <a:gd name="connsiteX25" fmla="*/ 78006 w 811632"/>
                <a:gd name="connsiteY25" fmla="*/ 426672 h 1830828"/>
                <a:gd name="connsiteX26" fmla="*/ 52004 w 811632"/>
                <a:gd name="connsiteY26" fmla="*/ 444006 h 1830828"/>
                <a:gd name="connsiteX27" fmla="*/ 43337 w 811632"/>
                <a:gd name="connsiteY27" fmla="*/ 452674 h 1830828"/>
                <a:gd name="connsiteX28" fmla="*/ 17335 w 811632"/>
                <a:gd name="connsiteY28" fmla="*/ 470008 h 1830828"/>
                <a:gd name="connsiteX29" fmla="*/ 34670 w 811632"/>
                <a:gd name="connsiteY29" fmla="*/ 509011 h 1830828"/>
                <a:gd name="connsiteX30" fmla="*/ 47670 w 811632"/>
                <a:gd name="connsiteY30" fmla="*/ 504677 h 1830828"/>
                <a:gd name="connsiteX31" fmla="*/ 56338 w 811632"/>
                <a:gd name="connsiteY31" fmla="*/ 496010 h 1830828"/>
                <a:gd name="connsiteX32" fmla="*/ 65005 w 811632"/>
                <a:gd name="connsiteY32" fmla="*/ 483009 h 1830828"/>
                <a:gd name="connsiteX33" fmla="*/ 78006 w 811632"/>
                <a:gd name="connsiteY33" fmla="*/ 478675 h 1830828"/>
                <a:gd name="connsiteX34" fmla="*/ 108342 w 811632"/>
                <a:gd name="connsiteY34" fmla="*/ 470008 h 1830828"/>
                <a:gd name="connsiteX35" fmla="*/ 147344 w 811632"/>
                <a:gd name="connsiteY35" fmla="*/ 474342 h 1830828"/>
                <a:gd name="connsiteX36" fmla="*/ 160345 w 811632"/>
                <a:gd name="connsiteY36" fmla="*/ 496010 h 1830828"/>
                <a:gd name="connsiteX37" fmla="*/ 173346 w 811632"/>
                <a:gd name="connsiteY37" fmla="*/ 526346 h 1830828"/>
                <a:gd name="connsiteX38" fmla="*/ 164679 w 811632"/>
                <a:gd name="connsiteY38" fmla="*/ 626019 h 1830828"/>
                <a:gd name="connsiteX39" fmla="*/ 160345 w 811632"/>
                <a:gd name="connsiteY39" fmla="*/ 643354 h 1830828"/>
                <a:gd name="connsiteX40" fmla="*/ 151678 w 811632"/>
                <a:gd name="connsiteY40" fmla="*/ 656355 h 1830828"/>
                <a:gd name="connsiteX41" fmla="*/ 134343 w 811632"/>
                <a:gd name="connsiteY41" fmla="*/ 682357 h 1830828"/>
                <a:gd name="connsiteX42" fmla="*/ 130010 w 811632"/>
                <a:gd name="connsiteY42" fmla="*/ 695358 h 1830828"/>
                <a:gd name="connsiteX43" fmla="*/ 104008 w 811632"/>
                <a:gd name="connsiteY43" fmla="*/ 704025 h 1830828"/>
                <a:gd name="connsiteX44" fmla="*/ 82340 w 811632"/>
                <a:gd name="connsiteY44" fmla="*/ 699692 h 1830828"/>
                <a:gd name="connsiteX45" fmla="*/ 60671 w 811632"/>
                <a:gd name="connsiteY45" fmla="*/ 682357 h 1830828"/>
                <a:gd name="connsiteX46" fmla="*/ 52004 w 811632"/>
                <a:gd name="connsiteY46" fmla="*/ 669356 h 1830828"/>
                <a:gd name="connsiteX47" fmla="*/ 39003 w 811632"/>
                <a:gd name="connsiteY47" fmla="*/ 656355 h 1830828"/>
                <a:gd name="connsiteX48" fmla="*/ 21669 w 811632"/>
                <a:gd name="connsiteY48" fmla="*/ 660689 h 1830828"/>
                <a:gd name="connsiteX49" fmla="*/ 0 w 811632"/>
                <a:gd name="connsiteY49" fmla="*/ 678023 h 1830828"/>
                <a:gd name="connsiteX50" fmla="*/ 4334 w 811632"/>
                <a:gd name="connsiteY50" fmla="*/ 704025 h 1830828"/>
                <a:gd name="connsiteX51" fmla="*/ 13001 w 811632"/>
                <a:gd name="connsiteY51" fmla="*/ 717026 h 1830828"/>
                <a:gd name="connsiteX52" fmla="*/ 34670 w 811632"/>
                <a:gd name="connsiteY52" fmla="*/ 730027 h 1830828"/>
                <a:gd name="connsiteX53" fmla="*/ 91007 w 811632"/>
                <a:gd name="connsiteY53" fmla="*/ 738694 h 1830828"/>
                <a:gd name="connsiteX54" fmla="*/ 104008 w 811632"/>
                <a:gd name="connsiteY54" fmla="*/ 743028 h 1830828"/>
                <a:gd name="connsiteX55" fmla="*/ 143011 w 811632"/>
                <a:gd name="connsiteY55" fmla="*/ 751695 h 1830828"/>
                <a:gd name="connsiteX56" fmla="*/ 156012 w 811632"/>
                <a:gd name="connsiteY56" fmla="*/ 760363 h 1830828"/>
                <a:gd name="connsiteX57" fmla="*/ 164679 w 811632"/>
                <a:gd name="connsiteY57" fmla="*/ 773364 h 1830828"/>
                <a:gd name="connsiteX58" fmla="*/ 182014 w 811632"/>
                <a:gd name="connsiteY58" fmla="*/ 816700 h 1830828"/>
                <a:gd name="connsiteX59" fmla="*/ 186347 w 811632"/>
                <a:gd name="connsiteY59" fmla="*/ 829701 h 1830828"/>
                <a:gd name="connsiteX60" fmla="*/ 190681 w 811632"/>
                <a:gd name="connsiteY60" fmla="*/ 842702 h 1830828"/>
                <a:gd name="connsiteX61" fmla="*/ 195015 w 811632"/>
                <a:gd name="connsiteY61" fmla="*/ 868704 h 1830828"/>
                <a:gd name="connsiteX62" fmla="*/ 190681 w 811632"/>
                <a:gd name="connsiteY62" fmla="*/ 925041 h 1830828"/>
                <a:gd name="connsiteX63" fmla="*/ 186347 w 811632"/>
                <a:gd name="connsiteY63" fmla="*/ 938042 h 1830828"/>
                <a:gd name="connsiteX64" fmla="*/ 173346 w 811632"/>
                <a:gd name="connsiteY64" fmla="*/ 942376 h 1830828"/>
                <a:gd name="connsiteX65" fmla="*/ 130010 w 811632"/>
                <a:gd name="connsiteY65" fmla="*/ 946710 h 1830828"/>
                <a:gd name="connsiteX66" fmla="*/ 121343 w 811632"/>
                <a:gd name="connsiteY66" fmla="*/ 959710 h 1830828"/>
                <a:gd name="connsiteX67" fmla="*/ 147344 w 811632"/>
                <a:gd name="connsiteY67" fmla="*/ 964044 h 1830828"/>
                <a:gd name="connsiteX68" fmla="*/ 160345 w 811632"/>
                <a:gd name="connsiteY68" fmla="*/ 968378 h 1830828"/>
                <a:gd name="connsiteX69" fmla="*/ 208016 w 811632"/>
                <a:gd name="connsiteY69" fmla="*/ 977045 h 1830828"/>
                <a:gd name="connsiteX70" fmla="*/ 234017 w 811632"/>
                <a:gd name="connsiteY70" fmla="*/ 985712 h 1830828"/>
                <a:gd name="connsiteX71" fmla="*/ 247018 w 811632"/>
                <a:gd name="connsiteY71" fmla="*/ 990046 h 1830828"/>
                <a:gd name="connsiteX72" fmla="*/ 255686 w 811632"/>
                <a:gd name="connsiteY72" fmla="*/ 998713 h 1830828"/>
                <a:gd name="connsiteX73" fmla="*/ 268687 w 811632"/>
                <a:gd name="connsiteY73" fmla="*/ 1003047 h 1830828"/>
                <a:gd name="connsiteX74" fmla="*/ 273020 w 811632"/>
                <a:gd name="connsiteY74" fmla="*/ 1042050 h 1830828"/>
                <a:gd name="connsiteX75" fmla="*/ 268687 w 811632"/>
                <a:gd name="connsiteY75" fmla="*/ 1189394 h 1830828"/>
                <a:gd name="connsiteX76" fmla="*/ 255686 w 811632"/>
                <a:gd name="connsiteY76" fmla="*/ 1193728 h 1830828"/>
                <a:gd name="connsiteX77" fmla="*/ 182014 w 811632"/>
                <a:gd name="connsiteY77" fmla="*/ 1189394 h 1830828"/>
                <a:gd name="connsiteX78" fmla="*/ 91007 w 811632"/>
                <a:gd name="connsiteY78" fmla="*/ 1193728 h 1830828"/>
                <a:gd name="connsiteX79" fmla="*/ 82340 w 811632"/>
                <a:gd name="connsiteY79" fmla="*/ 1228397 h 1830828"/>
                <a:gd name="connsiteX80" fmla="*/ 95341 w 811632"/>
                <a:gd name="connsiteY80" fmla="*/ 1237064 h 1830828"/>
                <a:gd name="connsiteX81" fmla="*/ 121343 w 811632"/>
                <a:gd name="connsiteY81" fmla="*/ 1241398 h 1830828"/>
                <a:gd name="connsiteX82" fmla="*/ 203682 w 811632"/>
                <a:gd name="connsiteY82" fmla="*/ 1250065 h 1830828"/>
                <a:gd name="connsiteX83" fmla="*/ 216683 w 811632"/>
                <a:gd name="connsiteY83" fmla="*/ 1254399 h 1830828"/>
                <a:gd name="connsiteX84" fmla="*/ 242685 w 811632"/>
                <a:gd name="connsiteY84" fmla="*/ 1271733 h 1830828"/>
                <a:gd name="connsiteX85" fmla="*/ 247018 w 811632"/>
                <a:gd name="connsiteY85" fmla="*/ 1284734 h 1830828"/>
                <a:gd name="connsiteX86" fmla="*/ 247018 w 811632"/>
                <a:gd name="connsiteY86" fmla="*/ 1484082 h 1830828"/>
                <a:gd name="connsiteX87" fmla="*/ 238351 w 811632"/>
                <a:gd name="connsiteY87" fmla="*/ 1497083 h 1830828"/>
                <a:gd name="connsiteX88" fmla="*/ 208016 w 811632"/>
                <a:gd name="connsiteY88" fmla="*/ 1492749 h 1830828"/>
                <a:gd name="connsiteX89" fmla="*/ 195015 w 811632"/>
                <a:gd name="connsiteY89" fmla="*/ 1488416 h 1830828"/>
                <a:gd name="connsiteX90" fmla="*/ 164679 w 811632"/>
                <a:gd name="connsiteY90" fmla="*/ 1479748 h 1830828"/>
                <a:gd name="connsiteX91" fmla="*/ 56338 w 811632"/>
                <a:gd name="connsiteY91" fmla="*/ 1484082 h 1830828"/>
                <a:gd name="connsiteX92" fmla="*/ 60671 w 811632"/>
                <a:gd name="connsiteY92" fmla="*/ 1501417 h 1830828"/>
                <a:gd name="connsiteX93" fmla="*/ 173346 w 811632"/>
                <a:gd name="connsiteY93" fmla="*/ 1505750 h 1830828"/>
                <a:gd name="connsiteX94" fmla="*/ 208016 w 811632"/>
                <a:gd name="connsiteY94" fmla="*/ 1514418 h 1830828"/>
                <a:gd name="connsiteX95" fmla="*/ 229684 w 811632"/>
                <a:gd name="connsiteY95" fmla="*/ 1531752 h 1830828"/>
                <a:gd name="connsiteX96" fmla="*/ 225350 w 811632"/>
                <a:gd name="connsiteY96" fmla="*/ 1614092 h 1830828"/>
                <a:gd name="connsiteX97" fmla="*/ 216683 w 811632"/>
                <a:gd name="connsiteY97" fmla="*/ 1644427 h 1830828"/>
                <a:gd name="connsiteX98" fmla="*/ 212349 w 811632"/>
                <a:gd name="connsiteY98" fmla="*/ 1661762 h 1830828"/>
                <a:gd name="connsiteX99" fmla="*/ 199348 w 811632"/>
                <a:gd name="connsiteY99" fmla="*/ 1679096 h 1830828"/>
                <a:gd name="connsiteX100" fmla="*/ 190681 w 811632"/>
                <a:gd name="connsiteY100" fmla="*/ 1696431 h 1830828"/>
                <a:gd name="connsiteX101" fmla="*/ 173346 w 811632"/>
                <a:gd name="connsiteY101" fmla="*/ 1722433 h 1830828"/>
                <a:gd name="connsiteX102" fmla="*/ 164679 w 811632"/>
                <a:gd name="connsiteY102" fmla="*/ 1752768 h 1830828"/>
                <a:gd name="connsiteX103" fmla="*/ 156012 w 811632"/>
                <a:gd name="connsiteY103" fmla="*/ 1778770 h 1830828"/>
                <a:gd name="connsiteX104" fmla="*/ 151678 w 811632"/>
                <a:gd name="connsiteY104" fmla="*/ 1791771 h 1830828"/>
                <a:gd name="connsiteX105" fmla="*/ 138677 w 811632"/>
                <a:gd name="connsiteY105" fmla="*/ 1817773 h 1830828"/>
                <a:gd name="connsiteX106" fmla="*/ 147344 w 811632"/>
                <a:gd name="connsiteY106" fmla="*/ 1830774 h 1830828"/>
                <a:gd name="connsiteX107" fmla="*/ 164679 w 811632"/>
                <a:gd name="connsiteY107" fmla="*/ 1813439 h 1830828"/>
                <a:gd name="connsiteX108" fmla="*/ 177680 w 811632"/>
                <a:gd name="connsiteY108" fmla="*/ 1800438 h 1830828"/>
                <a:gd name="connsiteX109" fmla="*/ 195015 w 811632"/>
                <a:gd name="connsiteY109" fmla="*/ 1778770 h 1830828"/>
                <a:gd name="connsiteX110" fmla="*/ 212349 w 811632"/>
                <a:gd name="connsiteY110" fmla="*/ 1739767 h 1830828"/>
                <a:gd name="connsiteX111" fmla="*/ 225350 w 811632"/>
                <a:gd name="connsiteY111" fmla="*/ 1731100 h 1830828"/>
                <a:gd name="connsiteX112" fmla="*/ 251352 w 811632"/>
                <a:gd name="connsiteY112" fmla="*/ 1726766 h 1830828"/>
                <a:gd name="connsiteX113" fmla="*/ 260019 w 811632"/>
                <a:gd name="connsiteY113" fmla="*/ 1644427 h 1830828"/>
                <a:gd name="connsiteX114" fmla="*/ 281688 w 811632"/>
                <a:gd name="connsiteY114" fmla="*/ 1618425 h 1830828"/>
                <a:gd name="connsiteX115" fmla="*/ 290355 w 811632"/>
                <a:gd name="connsiteY115" fmla="*/ 1605424 h 1830828"/>
                <a:gd name="connsiteX116" fmla="*/ 303356 w 811632"/>
                <a:gd name="connsiteY116" fmla="*/ 1601091 h 1830828"/>
                <a:gd name="connsiteX117" fmla="*/ 316357 w 811632"/>
                <a:gd name="connsiteY117" fmla="*/ 1592423 h 1830828"/>
                <a:gd name="connsiteX118" fmla="*/ 333691 w 811632"/>
                <a:gd name="connsiteY118" fmla="*/ 1588090 h 1830828"/>
                <a:gd name="connsiteX119" fmla="*/ 342359 w 811632"/>
                <a:gd name="connsiteY119" fmla="*/ 1579422 h 1830828"/>
                <a:gd name="connsiteX120" fmla="*/ 355360 w 811632"/>
                <a:gd name="connsiteY120" fmla="*/ 1575089 h 1830828"/>
                <a:gd name="connsiteX121" fmla="*/ 420364 w 811632"/>
                <a:gd name="connsiteY121" fmla="*/ 1579422 h 1830828"/>
                <a:gd name="connsiteX122" fmla="*/ 437699 w 811632"/>
                <a:gd name="connsiteY122" fmla="*/ 1601091 h 1830828"/>
                <a:gd name="connsiteX123" fmla="*/ 446366 w 811632"/>
                <a:gd name="connsiteY123" fmla="*/ 1618425 h 1830828"/>
                <a:gd name="connsiteX124" fmla="*/ 450700 w 811632"/>
                <a:gd name="connsiteY124" fmla="*/ 1640093 h 1830828"/>
                <a:gd name="connsiteX125" fmla="*/ 442033 w 811632"/>
                <a:gd name="connsiteY125" fmla="*/ 1748435 h 1830828"/>
                <a:gd name="connsiteX126" fmla="*/ 437699 w 811632"/>
                <a:gd name="connsiteY126" fmla="*/ 1761436 h 1830828"/>
                <a:gd name="connsiteX127" fmla="*/ 442033 w 811632"/>
                <a:gd name="connsiteY127" fmla="*/ 1787437 h 1830828"/>
                <a:gd name="connsiteX128" fmla="*/ 455034 w 811632"/>
                <a:gd name="connsiteY128" fmla="*/ 1783104 h 1830828"/>
                <a:gd name="connsiteX129" fmla="*/ 468034 w 811632"/>
                <a:gd name="connsiteY129" fmla="*/ 1770103 h 1830828"/>
                <a:gd name="connsiteX130" fmla="*/ 481035 w 811632"/>
                <a:gd name="connsiteY130" fmla="*/ 1744101 h 1830828"/>
                <a:gd name="connsiteX131" fmla="*/ 485369 w 811632"/>
                <a:gd name="connsiteY131" fmla="*/ 1731100 h 1830828"/>
                <a:gd name="connsiteX132" fmla="*/ 502704 w 811632"/>
                <a:gd name="connsiteY132" fmla="*/ 1709432 h 1830828"/>
                <a:gd name="connsiteX133" fmla="*/ 528706 w 811632"/>
                <a:gd name="connsiteY133" fmla="*/ 1722433 h 1830828"/>
                <a:gd name="connsiteX134" fmla="*/ 550374 w 811632"/>
                <a:gd name="connsiteY134" fmla="*/ 1748435 h 1830828"/>
                <a:gd name="connsiteX135" fmla="*/ 563375 w 811632"/>
                <a:gd name="connsiteY135" fmla="*/ 1757102 h 1830828"/>
                <a:gd name="connsiteX136" fmla="*/ 567708 w 811632"/>
                <a:gd name="connsiteY136" fmla="*/ 1744101 h 1830828"/>
                <a:gd name="connsiteX137" fmla="*/ 546040 w 811632"/>
                <a:gd name="connsiteY137" fmla="*/ 1713765 h 1830828"/>
                <a:gd name="connsiteX138" fmla="*/ 537373 w 811632"/>
                <a:gd name="connsiteY138" fmla="*/ 1700765 h 1830828"/>
                <a:gd name="connsiteX139" fmla="*/ 520038 w 811632"/>
                <a:gd name="connsiteY139" fmla="*/ 1683430 h 1830828"/>
                <a:gd name="connsiteX140" fmla="*/ 511371 w 811632"/>
                <a:gd name="connsiteY140" fmla="*/ 1657428 h 1830828"/>
                <a:gd name="connsiteX141" fmla="*/ 507037 w 811632"/>
                <a:gd name="connsiteY141" fmla="*/ 1640093 h 1830828"/>
                <a:gd name="connsiteX142" fmla="*/ 498370 w 811632"/>
                <a:gd name="connsiteY142" fmla="*/ 1622759 h 1830828"/>
                <a:gd name="connsiteX143" fmla="*/ 494036 w 811632"/>
                <a:gd name="connsiteY143" fmla="*/ 1605424 h 1830828"/>
                <a:gd name="connsiteX144" fmla="*/ 481035 w 811632"/>
                <a:gd name="connsiteY144" fmla="*/ 1592423 h 1830828"/>
                <a:gd name="connsiteX145" fmla="*/ 476702 w 811632"/>
                <a:gd name="connsiteY145" fmla="*/ 1579422 h 1830828"/>
                <a:gd name="connsiteX146" fmla="*/ 455034 w 811632"/>
                <a:gd name="connsiteY146" fmla="*/ 1557754 h 1830828"/>
                <a:gd name="connsiteX147" fmla="*/ 450700 w 811632"/>
                <a:gd name="connsiteY147" fmla="*/ 1544753 h 1830828"/>
                <a:gd name="connsiteX148" fmla="*/ 442033 w 811632"/>
                <a:gd name="connsiteY148" fmla="*/ 1531752 h 1830828"/>
                <a:gd name="connsiteX149" fmla="*/ 450700 w 811632"/>
                <a:gd name="connsiteY149" fmla="*/ 1505750 h 1830828"/>
                <a:gd name="connsiteX150" fmla="*/ 476702 w 811632"/>
                <a:gd name="connsiteY150" fmla="*/ 1514418 h 1830828"/>
                <a:gd name="connsiteX151" fmla="*/ 489703 w 811632"/>
                <a:gd name="connsiteY151" fmla="*/ 1527419 h 1830828"/>
                <a:gd name="connsiteX152" fmla="*/ 511371 w 811632"/>
                <a:gd name="connsiteY152" fmla="*/ 1536086 h 1830828"/>
                <a:gd name="connsiteX153" fmla="*/ 546040 w 811632"/>
                <a:gd name="connsiteY153" fmla="*/ 1562088 h 1830828"/>
                <a:gd name="connsiteX154" fmla="*/ 559041 w 811632"/>
                <a:gd name="connsiteY154" fmla="*/ 1570755 h 1830828"/>
                <a:gd name="connsiteX155" fmla="*/ 580709 w 811632"/>
                <a:gd name="connsiteY155" fmla="*/ 1592423 h 1830828"/>
                <a:gd name="connsiteX156" fmla="*/ 602378 w 811632"/>
                <a:gd name="connsiteY156" fmla="*/ 1605424 h 1830828"/>
                <a:gd name="connsiteX157" fmla="*/ 611045 w 811632"/>
                <a:gd name="connsiteY157" fmla="*/ 1614092 h 1830828"/>
                <a:gd name="connsiteX158" fmla="*/ 619712 w 811632"/>
                <a:gd name="connsiteY158" fmla="*/ 1605424 h 1830828"/>
                <a:gd name="connsiteX159" fmla="*/ 606711 w 811632"/>
                <a:gd name="connsiteY159" fmla="*/ 1596757 h 1830828"/>
                <a:gd name="connsiteX160" fmla="*/ 563375 w 811632"/>
                <a:gd name="connsiteY160" fmla="*/ 1544753 h 1830828"/>
                <a:gd name="connsiteX161" fmla="*/ 559041 w 811632"/>
                <a:gd name="connsiteY161" fmla="*/ 1531752 h 1830828"/>
                <a:gd name="connsiteX162" fmla="*/ 563375 w 811632"/>
                <a:gd name="connsiteY162" fmla="*/ 1510084 h 1830828"/>
                <a:gd name="connsiteX163" fmla="*/ 615379 w 811632"/>
                <a:gd name="connsiteY163" fmla="*/ 1501417 h 1830828"/>
                <a:gd name="connsiteX164" fmla="*/ 645714 w 811632"/>
                <a:gd name="connsiteY164" fmla="*/ 1518751 h 1830828"/>
                <a:gd name="connsiteX165" fmla="*/ 654381 w 811632"/>
                <a:gd name="connsiteY165" fmla="*/ 1527419 h 1830828"/>
                <a:gd name="connsiteX166" fmla="*/ 671716 w 811632"/>
                <a:gd name="connsiteY166" fmla="*/ 1536086 h 1830828"/>
                <a:gd name="connsiteX167" fmla="*/ 697718 w 811632"/>
                <a:gd name="connsiteY167" fmla="*/ 1553420 h 1830828"/>
                <a:gd name="connsiteX168" fmla="*/ 706385 w 811632"/>
                <a:gd name="connsiteY168" fmla="*/ 1562088 h 1830828"/>
                <a:gd name="connsiteX169" fmla="*/ 719386 w 811632"/>
                <a:gd name="connsiteY169" fmla="*/ 1566421 h 1830828"/>
                <a:gd name="connsiteX170" fmla="*/ 715052 w 811632"/>
                <a:gd name="connsiteY170" fmla="*/ 1549087 h 1830828"/>
                <a:gd name="connsiteX171" fmla="*/ 697718 w 811632"/>
                <a:gd name="connsiteY171" fmla="*/ 1540419 h 1830828"/>
                <a:gd name="connsiteX172" fmla="*/ 684717 w 811632"/>
                <a:gd name="connsiteY172" fmla="*/ 1531752 h 1830828"/>
                <a:gd name="connsiteX173" fmla="*/ 676050 w 811632"/>
                <a:gd name="connsiteY173" fmla="*/ 1518751 h 1830828"/>
                <a:gd name="connsiteX174" fmla="*/ 645714 w 811632"/>
                <a:gd name="connsiteY174" fmla="*/ 1492749 h 1830828"/>
                <a:gd name="connsiteX175" fmla="*/ 628379 w 811632"/>
                <a:gd name="connsiteY175" fmla="*/ 1466747 h 1830828"/>
                <a:gd name="connsiteX176" fmla="*/ 624046 w 811632"/>
                <a:gd name="connsiteY176" fmla="*/ 1453747 h 1830828"/>
                <a:gd name="connsiteX177" fmla="*/ 606711 w 811632"/>
                <a:gd name="connsiteY177" fmla="*/ 1432078 h 1830828"/>
                <a:gd name="connsiteX178" fmla="*/ 611045 w 811632"/>
                <a:gd name="connsiteY178" fmla="*/ 1388742 h 1830828"/>
                <a:gd name="connsiteX179" fmla="*/ 632713 w 811632"/>
                <a:gd name="connsiteY179" fmla="*/ 1393075 h 1830828"/>
                <a:gd name="connsiteX180" fmla="*/ 658715 w 811632"/>
                <a:gd name="connsiteY180" fmla="*/ 1406076 h 1830828"/>
                <a:gd name="connsiteX181" fmla="*/ 671716 w 811632"/>
                <a:gd name="connsiteY181" fmla="*/ 1410410 h 1830828"/>
                <a:gd name="connsiteX182" fmla="*/ 684717 w 811632"/>
                <a:gd name="connsiteY182" fmla="*/ 1419077 h 1830828"/>
                <a:gd name="connsiteX183" fmla="*/ 715052 w 811632"/>
                <a:gd name="connsiteY183" fmla="*/ 1427745 h 1830828"/>
                <a:gd name="connsiteX184" fmla="*/ 788725 w 811632"/>
                <a:gd name="connsiteY184" fmla="*/ 1414744 h 1830828"/>
                <a:gd name="connsiteX185" fmla="*/ 797392 w 811632"/>
                <a:gd name="connsiteY185" fmla="*/ 1406076 h 1830828"/>
                <a:gd name="connsiteX186" fmla="*/ 806059 w 811632"/>
                <a:gd name="connsiteY186" fmla="*/ 1380074 h 1830828"/>
                <a:gd name="connsiteX187" fmla="*/ 810393 w 811632"/>
                <a:gd name="connsiteY187" fmla="*/ 1367074 h 1830828"/>
                <a:gd name="connsiteX188" fmla="*/ 806059 w 811632"/>
                <a:gd name="connsiteY188" fmla="*/ 1302069 h 1830828"/>
                <a:gd name="connsiteX189" fmla="*/ 780057 w 811632"/>
                <a:gd name="connsiteY189" fmla="*/ 1310736 h 1830828"/>
                <a:gd name="connsiteX190" fmla="*/ 754055 w 811632"/>
                <a:gd name="connsiteY190" fmla="*/ 1336738 h 1830828"/>
                <a:gd name="connsiteX191" fmla="*/ 741054 w 811632"/>
                <a:gd name="connsiteY191" fmla="*/ 1349739 h 1830828"/>
                <a:gd name="connsiteX192" fmla="*/ 732387 w 811632"/>
                <a:gd name="connsiteY192" fmla="*/ 1362740 h 1830828"/>
                <a:gd name="connsiteX193" fmla="*/ 719386 w 811632"/>
                <a:gd name="connsiteY193" fmla="*/ 1367074 h 1830828"/>
                <a:gd name="connsiteX194" fmla="*/ 693384 w 811632"/>
                <a:gd name="connsiteY194" fmla="*/ 1362740 h 1830828"/>
                <a:gd name="connsiteX195" fmla="*/ 667382 w 811632"/>
                <a:gd name="connsiteY195" fmla="*/ 1354073 h 1830828"/>
                <a:gd name="connsiteX196" fmla="*/ 619712 w 811632"/>
                <a:gd name="connsiteY196" fmla="*/ 1362740 h 1830828"/>
                <a:gd name="connsiteX197" fmla="*/ 606711 w 811632"/>
                <a:gd name="connsiteY197" fmla="*/ 1371407 h 1830828"/>
                <a:gd name="connsiteX198" fmla="*/ 572042 w 811632"/>
                <a:gd name="connsiteY198" fmla="*/ 1380074 h 1830828"/>
                <a:gd name="connsiteX199" fmla="*/ 559041 w 811632"/>
                <a:gd name="connsiteY199" fmla="*/ 1388742 h 1830828"/>
                <a:gd name="connsiteX200" fmla="*/ 533039 w 811632"/>
                <a:gd name="connsiteY200" fmla="*/ 1401743 h 1830828"/>
                <a:gd name="connsiteX201" fmla="*/ 533039 w 811632"/>
                <a:gd name="connsiteY201" fmla="*/ 1449413 h 1830828"/>
                <a:gd name="connsiteX202" fmla="*/ 528706 w 811632"/>
                <a:gd name="connsiteY202" fmla="*/ 1466747 h 1830828"/>
                <a:gd name="connsiteX203" fmla="*/ 502704 w 811632"/>
                <a:gd name="connsiteY203" fmla="*/ 1475415 h 1830828"/>
                <a:gd name="connsiteX204" fmla="*/ 429032 w 811632"/>
                <a:gd name="connsiteY204" fmla="*/ 1471081 h 1830828"/>
                <a:gd name="connsiteX205" fmla="*/ 385695 w 811632"/>
                <a:gd name="connsiteY205" fmla="*/ 1458080 h 1830828"/>
                <a:gd name="connsiteX206" fmla="*/ 355360 w 811632"/>
                <a:gd name="connsiteY206" fmla="*/ 1449413 h 1830828"/>
                <a:gd name="connsiteX207" fmla="*/ 346692 w 811632"/>
                <a:gd name="connsiteY207" fmla="*/ 1440746 h 1830828"/>
                <a:gd name="connsiteX208" fmla="*/ 333691 w 811632"/>
                <a:gd name="connsiteY208" fmla="*/ 1432078 h 1830828"/>
                <a:gd name="connsiteX209" fmla="*/ 325024 w 811632"/>
                <a:gd name="connsiteY209" fmla="*/ 1419077 h 1830828"/>
                <a:gd name="connsiteX210" fmla="*/ 329358 w 811632"/>
                <a:gd name="connsiteY210" fmla="*/ 1371407 h 1830828"/>
                <a:gd name="connsiteX211" fmla="*/ 342359 w 811632"/>
                <a:gd name="connsiteY211" fmla="*/ 1358406 h 1830828"/>
                <a:gd name="connsiteX212" fmla="*/ 355360 w 811632"/>
                <a:gd name="connsiteY212" fmla="*/ 1349739 h 1830828"/>
                <a:gd name="connsiteX213" fmla="*/ 424698 w 811632"/>
                <a:gd name="connsiteY213" fmla="*/ 1341072 h 1830828"/>
                <a:gd name="connsiteX214" fmla="*/ 407363 w 811632"/>
                <a:gd name="connsiteY214" fmla="*/ 1315070 h 1830828"/>
                <a:gd name="connsiteX215" fmla="*/ 398696 w 811632"/>
                <a:gd name="connsiteY215" fmla="*/ 1302069 h 1830828"/>
                <a:gd name="connsiteX216" fmla="*/ 390029 w 811632"/>
                <a:gd name="connsiteY216" fmla="*/ 1293401 h 1830828"/>
                <a:gd name="connsiteX217" fmla="*/ 394362 w 811632"/>
                <a:gd name="connsiteY217" fmla="*/ 1271733 h 1830828"/>
                <a:gd name="connsiteX218" fmla="*/ 420364 w 811632"/>
                <a:gd name="connsiteY218" fmla="*/ 1263066 h 1830828"/>
                <a:gd name="connsiteX219" fmla="*/ 494036 w 811632"/>
                <a:gd name="connsiteY219" fmla="*/ 1254399 h 1830828"/>
                <a:gd name="connsiteX220" fmla="*/ 494036 w 811632"/>
                <a:gd name="connsiteY220" fmla="*/ 1172059 h 1830828"/>
                <a:gd name="connsiteX221" fmla="*/ 502704 w 811632"/>
                <a:gd name="connsiteY221" fmla="*/ 1163392 h 1830828"/>
                <a:gd name="connsiteX222" fmla="*/ 520038 w 811632"/>
                <a:gd name="connsiteY222" fmla="*/ 1159058 h 1830828"/>
                <a:gd name="connsiteX223" fmla="*/ 667382 w 811632"/>
                <a:gd name="connsiteY223" fmla="*/ 1163392 h 1830828"/>
                <a:gd name="connsiteX224" fmla="*/ 663049 w 811632"/>
                <a:gd name="connsiteY224" fmla="*/ 1150391 h 1830828"/>
                <a:gd name="connsiteX225" fmla="*/ 637047 w 811632"/>
                <a:gd name="connsiteY225" fmla="*/ 1137390 h 1830828"/>
                <a:gd name="connsiteX226" fmla="*/ 606711 w 811632"/>
                <a:gd name="connsiteY226" fmla="*/ 1124389 h 1830828"/>
                <a:gd name="connsiteX227" fmla="*/ 468034 w 811632"/>
                <a:gd name="connsiteY227" fmla="*/ 1111388 h 1830828"/>
                <a:gd name="connsiteX228" fmla="*/ 437699 w 811632"/>
                <a:gd name="connsiteY228" fmla="*/ 1102721 h 1830828"/>
                <a:gd name="connsiteX229" fmla="*/ 424698 w 811632"/>
                <a:gd name="connsiteY229" fmla="*/ 1094054 h 1830828"/>
                <a:gd name="connsiteX230" fmla="*/ 407363 w 811632"/>
                <a:gd name="connsiteY230" fmla="*/ 1076719 h 1830828"/>
                <a:gd name="connsiteX231" fmla="*/ 407363 w 811632"/>
                <a:gd name="connsiteY231" fmla="*/ 1033383 h 1830828"/>
                <a:gd name="connsiteX232" fmla="*/ 416031 w 811632"/>
                <a:gd name="connsiteY232" fmla="*/ 1024715 h 1830828"/>
                <a:gd name="connsiteX233" fmla="*/ 667382 w 811632"/>
                <a:gd name="connsiteY233" fmla="*/ 1020382 h 1830828"/>
                <a:gd name="connsiteX234" fmla="*/ 715052 w 811632"/>
                <a:gd name="connsiteY234" fmla="*/ 1007381 h 1830828"/>
                <a:gd name="connsiteX235" fmla="*/ 728053 w 811632"/>
                <a:gd name="connsiteY235" fmla="*/ 1003047 h 1830828"/>
                <a:gd name="connsiteX236" fmla="*/ 741054 w 811632"/>
                <a:gd name="connsiteY236" fmla="*/ 994380 h 1830828"/>
                <a:gd name="connsiteX237" fmla="*/ 745388 w 811632"/>
                <a:gd name="connsiteY237" fmla="*/ 981379 h 1830828"/>
                <a:gd name="connsiteX238" fmla="*/ 723720 w 811632"/>
                <a:gd name="connsiteY238" fmla="*/ 968378 h 1830828"/>
                <a:gd name="connsiteX239" fmla="*/ 671716 w 811632"/>
                <a:gd name="connsiteY239" fmla="*/ 972711 h 1830828"/>
                <a:gd name="connsiteX240" fmla="*/ 658715 w 811632"/>
                <a:gd name="connsiteY240" fmla="*/ 977045 h 1830828"/>
                <a:gd name="connsiteX241" fmla="*/ 637047 w 811632"/>
                <a:gd name="connsiteY241" fmla="*/ 981379 h 1830828"/>
                <a:gd name="connsiteX242" fmla="*/ 624046 w 811632"/>
                <a:gd name="connsiteY242" fmla="*/ 985712 h 1830828"/>
                <a:gd name="connsiteX243" fmla="*/ 589377 w 811632"/>
                <a:gd name="connsiteY243" fmla="*/ 990046 h 1830828"/>
                <a:gd name="connsiteX244" fmla="*/ 489703 w 811632"/>
                <a:gd name="connsiteY244" fmla="*/ 998713 h 1830828"/>
                <a:gd name="connsiteX245" fmla="*/ 455034 w 811632"/>
                <a:gd name="connsiteY245" fmla="*/ 994380 h 1830828"/>
                <a:gd name="connsiteX246" fmla="*/ 429032 w 811632"/>
                <a:gd name="connsiteY246" fmla="*/ 985712 h 1830828"/>
                <a:gd name="connsiteX247" fmla="*/ 398696 w 811632"/>
                <a:gd name="connsiteY247" fmla="*/ 951043 h 1830828"/>
                <a:gd name="connsiteX248" fmla="*/ 394362 w 811632"/>
                <a:gd name="connsiteY248" fmla="*/ 938042 h 1830828"/>
                <a:gd name="connsiteX249" fmla="*/ 385695 w 811632"/>
                <a:gd name="connsiteY249" fmla="*/ 925041 h 1830828"/>
                <a:gd name="connsiteX250" fmla="*/ 377028 w 811632"/>
                <a:gd name="connsiteY250" fmla="*/ 899039 h 1830828"/>
                <a:gd name="connsiteX251" fmla="*/ 372694 w 811632"/>
                <a:gd name="connsiteY251" fmla="*/ 886038 h 1830828"/>
                <a:gd name="connsiteX252" fmla="*/ 377028 w 811632"/>
                <a:gd name="connsiteY252" fmla="*/ 873037 h 1830828"/>
                <a:gd name="connsiteX253" fmla="*/ 390029 w 811632"/>
                <a:gd name="connsiteY253" fmla="*/ 864370 h 1830828"/>
                <a:gd name="connsiteX254" fmla="*/ 433365 w 811632"/>
                <a:gd name="connsiteY254" fmla="*/ 855703 h 1830828"/>
                <a:gd name="connsiteX255" fmla="*/ 446366 w 811632"/>
                <a:gd name="connsiteY255" fmla="*/ 777697 h 1830828"/>
                <a:gd name="connsiteX256" fmla="*/ 476702 w 811632"/>
                <a:gd name="connsiteY256" fmla="*/ 747362 h 1830828"/>
                <a:gd name="connsiteX257" fmla="*/ 498370 w 811632"/>
                <a:gd name="connsiteY257" fmla="*/ 743028 h 1830828"/>
                <a:gd name="connsiteX258" fmla="*/ 524372 w 811632"/>
                <a:gd name="connsiteY258" fmla="*/ 734361 h 1830828"/>
                <a:gd name="connsiteX259" fmla="*/ 541707 w 811632"/>
                <a:gd name="connsiteY259" fmla="*/ 730027 h 1830828"/>
                <a:gd name="connsiteX260" fmla="*/ 567708 w 811632"/>
                <a:gd name="connsiteY260" fmla="*/ 717026 h 1830828"/>
                <a:gd name="connsiteX261" fmla="*/ 593710 w 811632"/>
                <a:gd name="connsiteY261" fmla="*/ 704025 h 1830828"/>
                <a:gd name="connsiteX262" fmla="*/ 602378 w 811632"/>
                <a:gd name="connsiteY262" fmla="*/ 695358 h 1830828"/>
                <a:gd name="connsiteX263" fmla="*/ 619712 w 811632"/>
                <a:gd name="connsiteY263" fmla="*/ 669356 h 1830828"/>
                <a:gd name="connsiteX264" fmla="*/ 632713 w 811632"/>
                <a:gd name="connsiteY264" fmla="*/ 660689 h 1830828"/>
                <a:gd name="connsiteX265" fmla="*/ 667382 w 811632"/>
                <a:gd name="connsiteY265" fmla="*/ 643354 h 1830828"/>
                <a:gd name="connsiteX266" fmla="*/ 676050 w 811632"/>
                <a:gd name="connsiteY266" fmla="*/ 634687 h 1830828"/>
                <a:gd name="connsiteX267" fmla="*/ 680383 w 811632"/>
                <a:gd name="connsiteY267" fmla="*/ 621686 h 1830828"/>
                <a:gd name="connsiteX268" fmla="*/ 611045 w 811632"/>
                <a:gd name="connsiteY268" fmla="*/ 600018 h 1830828"/>
                <a:gd name="connsiteX269" fmla="*/ 585043 w 811632"/>
                <a:gd name="connsiteY269" fmla="*/ 613019 h 1830828"/>
                <a:gd name="connsiteX270" fmla="*/ 567708 w 811632"/>
                <a:gd name="connsiteY270" fmla="*/ 621686 h 1830828"/>
                <a:gd name="connsiteX271" fmla="*/ 533039 w 811632"/>
                <a:gd name="connsiteY271" fmla="*/ 639020 h 1830828"/>
                <a:gd name="connsiteX272" fmla="*/ 507037 w 811632"/>
                <a:gd name="connsiteY272" fmla="*/ 656355 h 1830828"/>
                <a:gd name="connsiteX273" fmla="*/ 494036 w 811632"/>
                <a:gd name="connsiteY273" fmla="*/ 660689 h 1830828"/>
                <a:gd name="connsiteX274" fmla="*/ 481035 w 811632"/>
                <a:gd name="connsiteY274" fmla="*/ 669356 h 1830828"/>
                <a:gd name="connsiteX275" fmla="*/ 455034 w 811632"/>
                <a:gd name="connsiteY275" fmla="*/ 673690 h 1830828"/>
                <a:gd name="connsiteX276" fmla="*/ 403030 w 811632"/>
                <a:gd name="connsiteY276" fmla="*/ 656355 h 1830828"/>
                <a:gd name="connsiteX277" fmla="*/ 394362 w 811632"/>
                <a:gd name="connsiteY277" fmla="*/ 643354 h 1830828"/>
                <a:gd name="connsiteX278" fmla="*/ 390029 w 811632"/>
                <a:gd name="connsiteY278" fmla="*/ 630353 h 1830828"/>
                <a:gd name="connsiteX279" fmla="*/ 394362 w 811632"/>
                <a:gd name="connsiteY279" fmla="*/ 587017 h 1830828"/>
                <a:gd name="connsiteX280" fmla="*/ 416031 w 811632"/>
                <a:gd name="connsiteY280" fmla="*/ 565348 h 1830828"/>
                <a:gd name="connsiteX281" fmla="*/ 442033 w 811632"/>
                <a:gd name="connsiteY281" fmla="*/ 548014 h 1830828"/>
                <a:gd name="connsiteX282" fmla="*/ 455034 w 811632"/>
                <a:gd name="connsiteY282" fmla="*/ 539347 h 1830828"/>
                <a:gd name="connsiteX283" fmla="*/ 485369 w 811632"/>
                <a:gd name="connsiteY283" fmla="*/ 526346 h 1830828"/>
                <a:gd name="connsiteX284" fmla="*/ 498370 w 811632"/>
                <a:gd name="connsiteY284" fmla="*/ 522012 h 1830828"/>
                <a:gd name="connsiteX285" fmla="*/ 524372 w 811632"/>
                <a:gd name="connsiteY285" fmla="*/ 504677 h 1830828"/>
                <a:gd name="connsiteX286" fmla="*/ 550374 w 811632"/>
                <a:gd name="connsiteY286" fmla="*/ 483009 h 1830828"/>
                <a:gd name="connsiteX287" fmla="*/ 554707 w 811632"/>
                <a:gd name="connsiteY287" fmla="*/ 470008 h 1830828"/>
                <a:gd name="connsiteX288" fmla="*/ 563375 w 811632"/>
                <a:gd name="connsiteY288" fmla="*/ 461341 h 1830828"/>
                <a:gd name="connsiteX289" fmla="*/ 650048 w 811632"/>
                <a:gd name="connsiteY289" fmla="*/ 448340 h 1830828"/>
                <a:gd name="connsiteX290" fmla="*/ 676050 w 811632"/>
                <a:gd name="connsiteY290" fmla="*/ 444006 h 1830828"/>
                <a:gd name="connsiteX291" fmla="*/ 689051 w 811632"/>
                <a:gd name="connsiteY291" fmla="*/ 435339 h 1830828"/>
                <a:gd name="connsiteX292" fmla="*/ 702052 w 811632"/>
                <a:gd name="connsiteY292" fmla="*/ 431005 h 1830828"/>
                <a:gd name="connsiteX293" fmla="*/ 693384 w 811632"/>
                <a:gd name="connsiteY293" fmla="*/ 422338 h 1830828"/>
                <a:gd name="connsiteX294" fmla="*/ 628379 w 811632"/>
                <a:gd name="connsiteY294" fmla="*/ 409337 h 1830828"/>
                <a:gd name="connsiteX295" fmla="*/ 598044 w 811632"/>
                <a:gd name="connsiteY295" fmla="*/ 400670 h 1830828"/>
                <a:gd name="connsiteX296" fmla="*/ 593710 w 811632"/>
                <a:gd name="connsiteY296" fmla="*/ 387669 h 1830828"/>
                <a:gd name="connsiteX297" fmla="*/ 585043 w 811632"/>
                <a:gd name="connsiteY297" fmla="*/ 374668 h 1830828"/>
                <a:gd name="connsiteX298" fmla="*/ 580709 w 811632"/>
                <a:gd name="connsiteY298" fmla="*/ 344332 h 1830828"/>
                <a:gd name="connsiteX299" fmla="*/ 567708 w 811632"/>
                <a:gd name="connsiteY299" fmla="*/ 353000 h 1830828"/>
                <a:gd name="connsiteX300" fmla="*/ 554707 w 811632"/>
                <a:gd name="connsiteY300" fmla="*/ 366001 h 1830828"/>
                <a:gd name="connsiteX301" fmla="*/ 502704 w 811632"/>
                <a:gd name="connsiteY301" fmla="*/ 370334 h 1830828"/>
                <a:gd name="connsiteX302" fmla="*/ 485369 w 811632"/>
                <a:gd name="connsiteY302" fmla="*/ 387669 h 1830828"/>
                <a:gd name="connsiteX303" fmla="*/ 511371 w 811632"/>
                <a:gd name="connsiteY303" fmla="*/ 405003 h 1830828"/>
                <a:gd name="connsiteX304" fmla="*/ 524372 w 811632"/>
                <a:gd name="connsiteY304" fmla="*/ 413671 h 1830828"/>
                <a:gd name="connsiteX305" fmla="*/ 528706 w 811632"/>
                <a:gd name="connsiteY305" fmla="*/ 426672 h 1830828"/>
                <a:gd name="connsiteX306" fmla="*/ 515705 w 811632"/>
                <a:gd name="connsiteY306" fmla="*/ 461341 h 1830828"/>
                <a:gd name="connsiteX307" fmla="*/ 502704 w 811632"/>
                <a:gd name="connsiteY307" fmla="*/ 470008 h 1830828"/>
                <a:gd name="connsiteX308" fmla="*/ 485369 w 811632"/>
                <a:gd name="connsiteY308" fmla="*/ 487343 h 1830828"/>
                <a:gd name="connsiteX309" fmla="*/ 468034 w 811632"/>
                <a:gd name="connsiteY309" fmla="*/ 491676 h 1830828"/>
                <a:gd name="connsiteX310" fmla="*/ 442033 w 811632"/>
                <a:gd name="connsiteY310" fmla="*/ 500344 h 1830828"/>
                <a:gd name="connsiteX311" fmla="*/ 416031 w 811632"/>
                <a:gd name="connsiteY311" fmla="*/ 509011 h 1830828"/>
                <a:gd name="connsiteX312" fmla="*/ 403030 w 811632"/>
                <a:gd name="connsiteY312" fmla="*/ 513345 h 1830828"/>
                <a:gd name="connsiteX313" fmla="*/ 368361 w 811632"/>
                <a:gd name="connsiteY313" fmla="*/ 522012 h 1830828"/>
                <a:gd name="connsiteX314" fmla="*/ 346692 w 811632"/>
                <a:gd name="connsiteY314" fmla="*/ 530679 h 1830828"/>
                <a:gd name="connsiteX315" fmla="*/ 333691 w 811632"/>
                <a:gd name="connsiteY315" fmla="*/ 535013 h 1830828"/>
                <a:gd name="connsiteX316" fmla="*/ 294688 w 811632"/>
                <a:gd name="connsiteY316" fmla="*/ 556681 h 1830828"/>
                <a:gd name="connsiteX317" fmla="*/ 294688 w 811632"/>
                <a:gd name="connsiteY317" fmla="*/ 474342 h 1830828"/>
                <a:gd name="connsiteX318" fmla="*/ 307689 w 811632"/>
                <a:gd name="connsiteY318" fmla="*/ 444006 h 1830828"/>
                <a:gd name="connsiteX319" fmla="*/ 316357 w 811632"/>
                <a:gd name="connsiteY319" fmla="*/ 435339 h 1830828"/>
                <a:gd name="connsiteX320" fmla="*/ 333691 w 811632"/>
                <a:gd name="connsiteY320" fmla="*/ 409337 h 1830828"/>
                <a:gd name="connsiteX321" fmla="*/ 342359 w 811632"/>
                <a:gd name="connsiteY321" fmla="*/ 396336 h 1830828"/>
                <a:gd name="connsiteX322" fmla="*/ 338025 w 811632"/>
                <a:gd name="connsiteY322" fmla="*/ 379001 h 1830828"/>
                <a:gd name="connsiteX323" fmla="*/ 333691 w 811632"/>
                <a:gd name="connsiteY323" fmla="*/ 366001 h 1830828"/>
                <a:gd name="connsiteX324" fmla="*/ 338025 w 811632"/>
                <a:gd name="connsiteY324" fmla="*/ 331331 h 1830828"/>
                <a:gd name="connsiteX325" fmla="*/ 351026 w 811632"/>
                <a:gd name="connsiteY325" fmla="*/ 322664 h 1830828"/>
                <a:gd name="connsiteX326" fmla="*/ 377028 w 811632"/>
                <a:gd name="connsiteY326" fmla="*/ 292328 h 1830828"/>
                <a:gd name="connsiteX327" fmla="*/ 407363 w 811632"/>
                <a:gd name="connsiteY327" fmla="*/ 274994 h 1830828"/>
                <a:gd name="connsiteX328" fmla="*/ 398696 w 811632"/>
                <a:gd name="connsiteY328" fmla="*/ 248992 h 1830828"/>
                <a:gd name="connsiteX329" fmla="*/ 394362 w 811632"/>
                <a:gd name="connsiteY329" fmla="*/ 235991 h 1830828"/>
                <a:gd name="connsiteX330" fmla="*/ 398696 w 811632"/>
                <a:gd name="connsiteY330" fmla="*/ 131983 h 1830828"/>
                <a:gd name="connsiteX331" fmla="*/ 411697 w 811632"/>
                <a:gd name="connsiteY331" fmla="*/ 97314 h 1830828"/>
                <a:gd name="connsiteX332" fmla="*/ 437699 w 811632"/>
                <a:gd name="connsiteY332" fmla="*/ 79980 h 1830828"/>
                <a:gd name="connsiteX333" fmla="*/ 459367 w 811632"/>
                <a:gd name="connsiteY333" fmla="*/ 66979 h 1830828"/>
                <a:gd name="connsiteX334" fmla="*/ 455034 w 811632"/>
                <a:gd name="connsiteY334" fmla="*/ 49644 h 1830828"/>
                <a:gd name="connsiteX335" fmla="*/ 437699 w 811632"/>
                <a:gd name="connsiteY335" fmla="*/ 58311 h 1830828"/>
                <a:gd name="connsiteX336" fmla="*/ 407363 w 811632"/>
                <a:gd name="connsiteY336" fmla="*/ 88647 h 1830828"/>
                <a:gd name="connsiteX337" fmla="*/ 394362 w 811632"/>
                <a:gd name="connsiteY337" fmla="*/ 101648 h 1830828"/>
                <a:gd name="connsiteX338" fmla="*/ 368361 w 811632"/>
                <a:gd name="connsiteY338" fmla="*/ 110315 h 1830828"/>
                <a:gd name="connsiteX339" fmla="*/ 342359 w 811632"/>
                <a:gd name="connsiteY339" fmla="*/ 105982 h 1830828"/>
                <a:gd name="connsiteX340" fmla="*/ 316357 w 811632"/>
                <a:gd name="connsiteY340" fmla="*/ 97314 h 1830828"/>
                <a:gd name="connsiteX341" fmla="*/ 273020 w 811632"/>
                <a:gd name="connsiteY341" fmla="*/ 101648 h 1830828"/>
                <a:gd name="connsiteX342" fmla="*/ 277354 w 811632"/>
                <a:gd name="connsiteY342" fmla="*/ 114649 h 1830828"/>
                <a:gd name="connsiteX343" fmla="*/ 290355 w 811632"/>
                <a:gd name="connsiteY343" fmla="*/ 123316 h 1830828"/>
                <a:gd name="connsiteX344" fmla="*/ 307689 w 811632"/>
                <a:gd name="connsiteY344" fmla="*/ 136317 h 1830828"/>
                <a:gd name="connsiteX345" fmla="*/ 320690 w 811632"/>
                <a:gd name="connsiteY345" fmla="*/ 140651 h 1830828"/>
                <a:gd name="connsiteX346" fmla="*/ 342359 w 811632"/>
                <a:gd name="connsiteY346" fmla="*/ 157985 h 1830828"/>
                <a:gd name="connsiteX347" fmla="*/ 351026 w 811632"/>
                <a:gd name="connsiteY347" fmla="*/ 183987 h 1830828"/>
                <a:gd name="connsiteX348" fmla="*/ 346692 w 811632"/>
                <a:gd name="connsiteY348" fmla="*/ 235991 h 1830828"/>
                <a:gd name="connsiteX349" fmla="*/ 342359 w 811632"/>
                <a:gd name="connsiteY349" fmla="*/ 253326 h 1830828"/>
                <a:gd name="connsiteX350" fmla="*/ 325024 w 811632"/>
                <a:gd name="connsiteY350" fmla="*/ 279328 h 1830828"/>
                <a:gd name="connsiteX351" fmla="*/ 316357 w 811632"/>
                <a:gd name="connsiteY351" fmla="*/ 292328 h 1830828"/>
                <a:gd name="connsiteX352" fmla="*/ 294688 w 811632"/>
                <a:gd name="connsiteY352" fmla="*/ 313997 h 1830828"/>
                <a:gd name="connsiteX353" fmla="*/ 281688 w 811632"/>
                <a:gd name="connsiteY353" fmla="*/ 326998 h 1830828"/>
                <a:gd name="connsiteX354" fmla="*/ 255686 w 811632"/>
                <a:gd name="connsiteY354" fmla="*/ 335665 h 1830828"/>
                <a:gd name="connsiteX355" fmla="*/ 242685 w 811632"/>
                <a:gd name="connsiteY355" fmla="*/ 326998 h 1830828"/>
                <a:gd name="connsiteX356" fmla="*/ 234017 w 811632"/>
                <a:gd name="connsiteY356" fmla="*/ 300996 h 1830828"/>
                <a:gd name="connsiteX357" fmla="*/ 225350 w 811632"/>
                <a:gd name="connsiteY357" fmla="*/ 270660 h 1830828"/>
                <a:gd name="connsiteX358" fmla="*/ 212349 w 811632"/>
                <a:gd name="connsiteY358" fmla="*/ 201322 h 1830828"/>
                <a:gd name="connsiteX359" fmla="*/ 199348 w 811632"/>
                <a:gd name="connsiteY359" fmla="*/ 188321 h 1830828"/>
                <a:gd name="connsiteX360" fmla="*/ 182014 w 811632"/>
                <a:gd name="connsiteY360" fmla="*/ 162319 h 1830828"/>
                <a:gd name="connsiteX361" fmla="*/ 164679 w 811632"/>
                <a:gd name="connsiteY361" fmla="*/ 144984 h 1830828"/>
                <a:gd name="connsiteX362" fmla="*/ 160345 w 811632"/>
                <a:gd name="connsiteY362" fmla="*/ 131983 h 1830828"/>
                <a:gd name="connsiteX363" fmla="*/ 143011 w 811632"/>
                <a:gd name="connsiteY363" fmla="*/ 110315 h 1830828"/>
                <a:gd name="connsiteX364" fmla="*/ 125676 w 811632"/>
                <a:gd name="connsiteY364" fmla="*/ 71312 h 1830828"/>
                <a:gd name="connsiteX365" fmla="*/ 112675 w 811632"/>
                <a:gd name="connsiteY365" fmla="*/ 49644 h 1830828"/>
                <a:gd name="connsiteX366" fmla="*/ 78006 w 811632"/>
                <a:gd name="connsiteY366" fmla="*/ 1974 h 18308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</a:cxnLst>
              <a:rect l="l" t="t" r="r" b="b"/>
              <a:pathLst>
                <a:path w="811632" h="1830828">
                  <a:moveTo>
                    <a:pt x="78006" y="1974"/>
                  </a:moveTo>
                  <a:cubicBezTo>
                    <a:pt x="68617" y="-4526"/>
                    <a:pt x="63092" y="6781"/>
                    <a:pt x="56338" y="10641"/>
                  </a:cubicBezTo>
                  <a:cubicBezTo>
                    <a:pt x="52790" y="12668"/>
                    <a:pt x="47942" y="15232"/>
                    <a:pt x="47670" y="19309"/>
                  </a:cubicBezTo>
                  <a:cubicBezTo>
                    <a:pt x="46417" y="38102"/>
                    <a:pt x="49668" y="56957"/>
                    <a:pt x="52004" y="75646"/>
                  </a:cubicBezTo>
                  <a:cubicBezTo>
                    <a:pt x="53011" y="83701"/>
                    <a:pt x="59475" y="96118"/>
                    <a:pt x="65005" y="101648"/>
                  </a:cubicBezTo>
                  <a:cubicBezTo>
                    <a:pt x="68688" y="105331"/>
                    <a:pt x="74052" y="106925"/>
                    <a:pt x="78006" y="110315"/>
                  </a:cubicBezTo>
                  <a:cubicBezTo>
                    <a:pt x="114787" y="141841"/>
                    <a:pt x="78495" y="116420"/>
                    <a:pt x="108342" y="136317"/>
                  </a:cubicBezTo>
                  <a:cubicBezTo>
                    <a:pt x="111231" y="140651"/>
                    <a:pt x="113675" y="145317"/>
                    <a:pt x="117009" y="149318"/>
                  </a:cubicBezTo>
                  <a:cubicBezTo>
                    <a:pt x="120932" y="154026"/>
                    <a:pt x="126610" y="157220"/>
                    <a:pt x="130010" y="162319"/>
                  </a:cubicBezTo>
                  <a:cubicBezTo>
                    <a:pt x="132544" y="166120"/>
                    <a:pt x="132899" y="170986"/>
                    <a:pt x="134343" y="175320"/>
                  </a:cubicBezTo>
                  <a:cubicBezTo>
                    <a:pt x="132899" y="181098"/>
                    <a:pt x="133314" y="187699"/>
                    <a:pt x="130010" y="192655"/>
                  </a:cubicBezTo>
                  <a:cubicBezTo>
                    <a:pt x="127121" y="196989"/>
                    <a:pt x="115362" y="196381"/>
                    <a:pt x="117009" y="201322"/>
                  </a:cubicBezTo>
                  <a:cubicBezTo>
                    <a:pt x="118892" y="206972"/>
                    <a:pt x="128483" y="204591"/>
                    <a:pt x="134343" y="205656"/>
                  </a:cubicBezTo>
                  <a:cubicBezTo>
                    <a:pt x="144393" y="207483"/>
                    <a:pt x="154567" y="208545"/>
                    <a:pt x="164679" y="209989"/>
                  </a:cubicBezTo>
                  <a:cubicBezTo>
                    <a:pt x="176375" y="245073"/>
                    <a:pt x="177257" y="242439"/>
                    <a:pt x="164679" y="305329"/>
                  </a:cubicBezTo>
                  <a:cubicBezTo>
                    <a:pt x="163783" y="309808"/>
                    <a:pt x="156012" y="308218"/>
                    <a:pt x="151678" y="309663"/>
                  </a:cubicBezTo>
                  <a:cubicBezTo>
                    <a:pt x="105074" y="294129"/>
                    <a:pt x="134792" y="300388"/>
                    <a:pt x="60671" y="305329"/>
                  </a:cubicBezTo>
                  <a:cubicBezTo>
                    <a:pt x="62116" y="309663"/>
                    <a:pt x="62151" y="314763"/>
                    <a:pt x="65005" y="318330"/>
                  </a:cubicBezTo>
                  <a:cubicBezTo>
                    <a:pt x="70511" y="325213"/>
                    <a:pt x="82971" y="329139"/>
                    <a:pt x="91007" y="331331"/>
                  </a:cubicBezTo>
                  <a:cubicBezTo>
                    <a:pt x="102499" y="334465"/>
                    <a:pt x="125676" y="339999"/>
                    <a:pt x="125676" y="339999"/>
                  </a:cubicBezTo>
                  <a:cubicBezTo>
                    <a:pt x="130010" y="342888"/>
                    <a:pt x="137030" y="343725"/>
                    <a:pt x="138677" y="348666"/>
                  </a:cubicBezTo>
                  <a:cubicBezTo>
                    <a:pt x="140560" y="354317"/>
                    <a:pt x="135979" y="360274"/>
                    <a:pt x="134343" y="366001"/>
                  </a:cubicBezTo>
                  <a:cubicBezTo>
                    <a:pt x="128490" y="386485"/>
                    <a:pt x="133443" y="372544"/>
                    <a:pt x="121343" y="387669"/>
                  </a:cubicBezTo>
                  <a:cubicBezTo>
                    <a:pt x="112209" y="399087"/>
                    <a:pt x="112906" y="404850"/>
                    <a:pt x="99674" y="413671"/>
                  </a:cubicBezTo>
                  <a:cubicBezTo>
                    <a:pt x="95873" y="416205"/>
                    <a:pt x="91007" y="416560"/>
                    <a:pt x="86673" y="418004"/>
                  </a:cubicBezTo>
                  <a:cubicBezTo>
                    <a:pt x="83784" y="420893"/>
                    <a:pt x="81275" y="424220"/>
                    <a:pt x="78006" y="426672"/>
                  </a:cubicBezTo>
                  <a:cubicBezTo>
                    <a:pt x="69673" y="432922"/>
                    <a:pt x="59369" y="436640"/>
                    <a:pt x="52004" y="444006"/>
                  </a:cubicBezTo>
                  <a:cubicBezTo>
                    <a:pt x="49115" y="446895"/>
                    <a:pt x="46606" y="450222"/>
                    <a:pt x="43337" y="452674"/>
                  </a:cubicBezTo>
                  <a:cubicBezTo>
                    <a:pt x="35004" y="458924"/>
                    <a:pt x="17335" y="470008"/>
                    <a:pt x="17335" y="470008"/>
                  </a:cubicBezTo>
                  <a:cubicBezTo>
                    <a:pt x="19681" y="488770"/>
                    <a:pt x="11623" y="509011"/>
                    <a:pt x="34670" y="509011"/>
                  </a:cubicBezTo>
                  <a:cubicBezTo>
                    <a:pt x="39238" y="509011"/>
                    <a:pt x="43337" y="506122"/>
                    <a:pt x="47670" y="504677"/>
                  </a:cubicBezTo>
                  <a:cubicBezTo>
                    <a:pt x="50559" y="501788"/>
                    <a:pt x="53786" y="499201"/>
                    <a:pt x="56338" y="496010"/>
                  </a:cubicBezTo>
                  <a:cubicBezTo>
                    <a:pt x="59592" y="491943"/>
                    <a:pt x="60938" y="486263"/>
                    <a:pt x="65005" y="483009"/>
                  </a:cubicBezTo>
                  <a:cubicBezTo>
                    <a:pt x="68572" y="480155"/>
                    <a:pt x="73614" y="479930"/>
                    <a:pt x="78006" y="478675"/>
                  </a:cubicBezTo>
                  <a:cubicBezTo>
                    <a:pt x="116098" y="467792"/>
                    <a:pt x="77170" y="480399"/>
                    <a:pt x="108342" y="470008"/>
                  </a:cubicBezTo>
                  <a:cubicBezTo>
                    <a:pt x="121343" y="471453"/>
                    <a:pt x="134724" y="470900"/>
                    <a:pt x="147344" y="474342"/>
                  </a:cubicBezTo>
                  <a:cubicBezTo>
                    <a:pt x="156672" y="476886"/>
                    <a:pt x="157593" y="489589"/>
                    <a:pt x="160345" y="496010"/>
                  </a:cubicBezTo>
                  <a:cubicBezTo>
                    <a:pt x="176410" y="533496"/>
                    <a:pt x="163184" y="495857"/>
                    <a:pt x="173346" y="526346"/>
                  </a:cubicBezTo>
                  <a:cubicBezTo>
                    <a:pt x="166197" y="669338"/>
                    <a:pt x="178570" y="577404"/>
                    <a:pt x="164679" y="626019"/>
                  </a:cubicBezTo>
                  <a:cubicBezTo>
                    <a:pt x="163043" y="631746"/>
                    <a:pt x="162691" y="637879"/>
                    <a:pt x="160345" y="643354"/>
                  </a:cubicBezTo>
                  <a:cubicBezTo>
                    <a:pt x="158293" y="648141"/>
                    <a:pt x="154007" y="651697"/>
                    <a:pt x="151678" y="656355"/>
                  </a:cubicBezTo>
                  <a:cubicBezTo>
                    <a:pt x="139135" y="681441"/>
                    <a:pt x="158987" y="657713"/>
                    <a:pt x="134343" y="682357"/>
                  </a:cubicBezTo>
                  <a:cubicBezTo>
                    <a:pt x="132899" y="686691"/>
                    <a:pt x="133727" y="692703"/>
                    <a:pt x="130010" y="695358"/>
                  </a:cubicBezTo>
                  <a:cubicBezTo>
                    <a:pt x="122576" y="700668"/>
                    <a:pt x="104008" y="704025"/>
                    <a:pt x="104008" y="704025"/>
                  </a:cubicBezTo>
                  <a:cubicBezTo>
                    <a:pt x="96785" y="702581"/>
                    <a:pt x="89237" y="702278"/>
                    <a:pt x="82340" y="699692"/>
                  </a:cubicBezTo>
                  <a:cubicBezTo>
                    <a:pt x="75908" y="697280"/>
                    <a:pt x="65203" y="688021"/>
                    <a:pt x="60671" y="682357"/>
                  </a:cubicBezTo>
                  <a:cubicBezTo>
                    <a:pt x="57417" y="678290"/>
                    <a:pt x="55338" y="673357"/>
                    <a:pt x="52004" y="669356"/>
                  </a:cubicBezTo>
                  <a:cubicBezTo>
                    <a:pt x="48081" y="664648"/>
                    <a:pt x="43337" y="660689"/>
                    <a:pt x="39003" y="656355"/>
                  </a:cubicBezTo>
                  <a:cubicBezTo>
                    <a:pt x="33225" y="657800"/>
                    <a:pt x="27143" y="658343"/>
                    <a:pt x="21669" y="660689"/>
                  </a:cubicBezTo>
                  <a:cubicBezTo>
                    <a:pt x="12102" y="664789"/>
                    <a:pt x="6990" y="671034"/>
                    <a:pt x="0" y="678023"/>
                  </a:cubicBezTo>
                  <a:cubicBezTo>
                    <a:pt x="1445" y="686690"/>
                    <a:pt x="1555" y="695689"/>
                    <a:pt x="4334" y="704025"/>
                  </a:cubicBezTo>
                  <a:cubicBezTo>
                    <a:pt x="5981" y="708966"/>
                    <a:pt x="9747" y="712959"/>
                    <a:pt x="13001" y="717026"/>
                  </a:cubicBezTo>
                  <a:cubicBezTo>
                    <a:pt x="21068" y="727109"/>
                    <a:pt x="22076" y="726428"/>
                    <a:pt x="34670" y="730027"/>
                  </a:cubicBezTo>
                  <a:cubicBezTo>
                    <a:pt x="58555" y="736852"/>
                    <a:pt x="59569" y="735201"/>
                    <a:pt x="91007" y="738694"/>
                  </a:cubicBezTo>
                  <a:cubicBezTo>
                    <a:pt x="95341" y="740139"/>
                    <a:pt x="99616" y="741773"/>
                    <a:pt x="104008" y="743028"/>
                  </a:cubicBezTo>
                  <a:cubicBezTo>
                    <a:pt x="118293" y="747110"/>
                    <a:pt x="128111" y="748715"/>
                    <a:pt x="143011" y="751695"/>
                  </a:cubicBezTo>
                  <a:cubicBezTo>
                    <a:pt x="147345" y="754584"/>
                    <a:pt x="152329" y="756680"/>
                    <a:pt x="156012" y="760363"/>
                  </a:cubicBezTo>
                  <a:cubicBezTo>
                    <a:pt x="159695" y="764046"/>
                    <a:pt x="162095" y="768842"/>
                    <a:pt x="164679" y="773364"/>
                  </a:cubicBezTo>
                  <a:cubicBezTo>
                    <a:pt x="174880" y="791216"/>
                    <a:pt x="174912" y="795394"/>
                    <a:pt x="182014" y="816700"/>
                  </a:cubicBezTo>
                  <a:lnTo>
                    <a:pt x="186347" y="829701"/>
                  </a:lnTo>
                  <a:cubicBezTo>
                    <a:pt x="187792" y="834035"/>
                    <a:pt x="189930" y="838196"/>
                    <a:pt x="190681" y="842702"/>
                  </a:cubicBezTo>
                  <a:lnTo>
                    <a:pt x="195015" y="868704"/>
                  </a:lnTo>
                  <a:cubicBezTo>
                    <a:pt x="193570" y="887483"/>
                    <a:pt x="193017" y="906352"/>
                    <a:pt x="190681" y="925041"/>
                  </a:cubicBezTo>
                  <a:cubicBezTo>
                    <a:pt x="190114" y="929574"/>
                    <a:pt x="189577" y="934812"/>
                    <a:pt x="186347" y="938042"/>
                  </a:cubicBezTo>
                  <a:cubicBezTo>
                    <a:pt x="183117" y="941272"/>
                    <a:pt x="177861" y="941681"/>
                    <a:pt x="173346" y="942376"/>
                  </a:cubicBezTo>
                  <a:cubicBezTo>
                    <a:pt x="158997" y="944584"/>
                    <a:pt x="144455" y="945265"/>
                    <a:pt x="130010" y="946710"/>
                  </a:cubicBezTo>
                  <a:cubicBezTo>
                    <a:pt x="127121" y="951043"/>
                    <a:pt x="117660" y="956027"/>
                    <a:pt x="121343" y="959710"/>
                  </a:cubicBezTo>
                  <a:cubicBezTo>
                    <a:pt x="127556" y="965923"/>
                    <a:pt x="138767" y="962138"/>
                    <a:pt x="147344" y="964044"/>
                  </a:cubicBezTo>
                  <a:cubicBezTo>
                    <a:pt x="151803" y="965035"/>
                    <a:pt x="155866" y="967482"/>
                    <a:pt x="160345" y="968378"/>
                  </a:cubicBezTo>
                  <a:cubicBezTo>
                    <a:pt x="193930" y="975095"/>
                    <a:pt x="182315" y="969335"/>
                    <a:pt x="208016" y="977045"/>
                  </a:cubicBezTo>
                  <a:cubicBezTo>
                    <a:pt x="216767" y="979670"/>
                    <a:pt x="225350" y="982823"/>
                    <a:pt x="234017" y="985712"/>
                  </a:cubicBezTo>
                  <a:lnTo>
                    <a:pt x="247018" y="990046"/>
                  </a:lnTo>
                  <a:cubicBezTo>
                    <a:pt x="249907" y="992935"/>
                    <a:pt x="252182" y="996611"/>
                    <a:pt x="255686" y="998713"/>
                  </a:cubicBezTo>
                  <a:cubicBezTo>
                    <a:pt x="259603" y="1001063"/>
                    <a:pt x="266991" y="998806"/>
                    <a:pt x="268687" y="1003047"/>
                  </a:cubicBezTo>
                  <a:cubicBezTo>
                    <a:pt x="273545" y="1015192"/>
                    <a:pt x="271576" y="1029049"/>
                    <a:pt x="273020" y="1042050"/>
                  </a:cubicBezTo>
                  <a:cubicBezTo>
                    <a:pt x="271576" y="1091165"/>
                    <a:pt x="274266" y="1140576"/>
                    <a:pt x="268687" y="1189394"/>
                  </a:cubicBezTo>
                  <a:cubicBezTo>
                    <a:pt x="268168" y="1193933"/>
                    <a:pt x="260254" y="1193728"/>
                    <a:pt x="255686" y="1193728"/>
                  </a:cubicBezTo>
                  <a:cubicBezTo>
                    <a:pt x="231086" y="1193728"/>
                    <a:pt x="206571" y="1190839"/>
                    <a:pt x="182014" y="1189394"/>
                  </a:cubicBezTo>
                  <a:cubicBezTo>
                    <a:pt x="151678" y="1190839"/>
                    <a:pt x="121143" y="1189961"/>
                    <a:pt x="91007" y="1193728"/>
                  </a:cubicBezTo>
                  <a:cubicBezTo>
                    <a:pt x="71308" y="1196190"/>
                    <a:pt x="76115" y="1215948"/>
                    <a:pt x="82340" y="1228397"/>
                  </a:cubicBezTo>
                  <a:cubicBezTo>
                    <a:pt x="84669" y="1233055"/>
                    <a:pt x="90400" y="1235417"/>
                    <a:pt x="95341" y="1237064"/>
                  </a:cubicBezTo>
                  <a:cubicBezTo>
                    <a:pt x="103677" y="1239843"/>
                    <a:pt x="112658" y="1240062"/>
                    <a:pt x="121343" y="1241398"/>
                  </a:cubicBezTo>
                  <a:cubicBezTo>
                    <a:pt x="161476" y="1247572"/>
                    <a:pt x="154139" y="1245936"/>
                    <a:pt x="203682" y="1250065"/>
                  </a:cubicBezTo>
                  <a:cubicBezTo>
                    <a:pt x="208016" y="1251510"/>
                    <a:pt x="212690" y="1252181"/>
                    <a:pt x="216683" y="1254399"/>
                  </a:cubicBezTo>
                  <a:cubicBezTo>
                    <a:pt x="225789" y="1259458"/>
                    <a:pt x="242685" y="1271733"/>
                    <a:pt x="242685" y="1271733"/>
                  </a:cubicBezTo>
                  <a:cubicBezTo>
                    <a:pt x="244129" y="1276067"/>
                    <a:pt x="245763" y="1280342"/>
                    <a:pt x="247018" y="1284734"/>
                  </a:cubicBezTo>
                  <a:cubicBezTo>
                    <a:pt x="265945" y="1350983"/>
                    <a:pt x="252782" y="1397617"/>
                    <a:pt x="247018" y="1484082"/>
                  </a:cubicBezTo>
                  <a:cubicBezTo>
                    <a:pt x="246672" y="1489279"/>
                    <a:pt x="241240" y="1492749"/>
                    <a:pt x="238351" y="1497083"/>
                  </a:cubicBezTo>
                  <a:cubicBezTo>
                    <a:pt x="228239" y="1495638"/>
                    <a:pt x="218032" y="1494752"/>
                    <a:pt x="208016" y="1492749"/>
                  </a:cubicBezTo>
                  <a:cubicBezTo>
                    <a:pt x="203537" y="1491853"/>
                    <a:pt x="199407" y="1489671"/>
                    <a:pt x="195015" y="1488416"/>
                  </a:cubicBezTo>
                  <a:cubicBezTo>
                    <a:pt x="156950" y="1477541"/>
                    <a:pt x="195831" y="1490133"/>
                    <a:pt x="164679" y="1479748"/>
                  </a:cubicBezTo>
                  <a:lnTo>
                    <a:pt x="56338" y="1484082"/>
                  </a:lnTo>
                  <a:cubicBezTo>
                    <a:pt x="50507" y="1485297"/>
                    <a:pt x="54814" y="1500332"/>
                    <a:pt x="60671" y="1501417"/>
                  </a:cubicBezTo>
                  <a:cubicBezTo>
                    <a:pt x="97629" y="1508261"/>
                    <a:pt x="135788" y="1504306"/>
                    <a:pt x="173346" y="1505750"/>
                  </a:cubicBezTo>
                  <a:cubicBezTo>
                    <a:pt x="181589" y="1507399"/>
                    <a:pt x="199131" y="1509975"/>
                    <a:pt x="208016" y="1514418"/>
                  </a:cubicBezTo>
                  <a:cubicBezTo>
                    <a:pt x="218947" y="1519884"/>
                    <a:pt x="221623" y="1523692"/>
                    <a:pt x="229684" y="1531752"/>
                  </a:cubicBezTo>
                  <a:cubicBezTo>
                    <a:pt x="228239" y="1559199"/>
                    <a:pt x="227731" y="1586711"/>
                    <a:pt x="225350" y="1614092"/>
                  </a:cubicBezTo>
                  <a:cubicBezTo>
                    <a:pt x="224504" y="1623821"/>
                    <a:pt x="219374" y="1635008"/>
                    <a:pt x="216683" y="1644427"/>
                  </a:cubicBezTo>
                  <a:cubicBezTo>
                    <a:pt x="215047" y="1650154"/>
                    <a:pt x="215013" y="1656435"/>
                    <a:pt x="212349" y="1661762"/>
                  </a:cubicBezTo>
                  <a:cubicBezTo>
                    <a:pt x="209119" y="1668222"/>
                    <a:pt x="203176" y="1672971"/>
                    <a:pt x="199348" y="1679096"/>
                  </a:cubicBezTo>
                  <a:cubicBezTo>
                    <a:pt x="195924" y="1684574"/>
                    <a:pt x="194005" y="1690891"/>
                    <a:pt x="190681" y="1696431"/>
                  </a:cubicBezTo>
                  <a:cubicBezTo>
                    <a:pt x="185322" y="1705363"/>
                    <a:pt x="173346" y="1722433"/>
                    <a:pt x="173346" y="1722433"/>
                  </a:cubicBezTo>
                  <a:cubicBezTo>
                    <a:pt x="158774" y="1766155"/>
                    <a:pt x="181015" y="1698315"/>
                    <a:pt x="164679" y="1752768"/>
                  </a:cubicBezTo>
                  <a:cubicBezTo>
                    <a:pt x="162054" y="1761519"/>
                    <a:pt x="158901" y="1770103"/>
                    <a:pt x="156012" y="1778770"/>
                  </a:cubicBezTo>
                  <a:cubicBezTo>
                    <a:pt x="154567" y="1783104"/>
                    <a:pt x="154212" y="1787970"/>
                    <a:pt x="151678" y="1791771"/>
                  </a:cubicBezTo>
                  <a:cubicBezTo>
                    <a:pt x="140477" y="1808573"/>
                    <a:pt x="144658" y="1799831"/>
                    <a:pt x="138677" y="1817773"/>
                  </a:cubicBezTo>
                  <a:cubicBezTo>
                    <a:pt x="141566" y="1822107"/>
                    <a:pt x="142207" y="1831630"/>
                    <a:pt x="147344" y="1830774"/>
                  </a:cubicBezTo>
                  <a:cubicBezTo>
                    <a:pt x="155405" y="1829430"/>
                    <a:pt x="158901" y="1819217"/>
                    <a:pt x="164679" y="1813439"/>
                  </a:cubicBezTo>
                  <a:cubicBezTo>
                    <a:pt x="169013" y="1809105"/>
                    <a:pt x="174280" y="1805537"/>
                    <a:pt x="177680" y="1800438"/>
                  </a:cubicBezTo>
                  <a:cubicBezTo>
                    <a:pt x="188613" y="1784037"/>
                    <a:pt x="182664" y="1791120"/>
                    <a:pt x="195015" y="1778770"/>
                  </a:cubicBezTo>
                  <a:cubicBezTo>
                    <a:pt x="199306" y="1765898"/>
                    <a:pt x="202048" y="1750068"/>
                    <a:pt x="212349" y="1739767"/>
                  </a:cubicBezTo>
                  <a:cubicBezTo>
                    <a:pt x="216032" y="1736084"/>
                    <a:pt x="220409" y="1732747"/>
                    <a:pt x="225350" y="1731100"/>
                  </a:cubicBezTo>
                  <a:cubicBezTo>
                    <a:pt x="233686" y="1728321"/>
                    <a:pt x="242685" y="1728211"/>
                    <a:pt x="251352" y="1726766"/>
                  </a:cubicBezTo>
                  <a:cubicBezTo>
                    <a:pt x="265652" y="1683870"/>
                    <a:pt x="242007" y="1758505"/>
                    <a:pt x="260019" y="1644427"/>
                  </a:cubicBezTo>
                  <a:cubicBezTo>
                    <a:pt x="261276" y="1636463"/>
                    <a:pt x="277724" y="1623182"/>
                    <a:pt x="281688" y="1618425"/>
                  </a:cubicBezTo>
                  <a:cubicBezTo>
                    <a:pt x="285022" y="1614424"/>
                    <a:pt x="286288" y="1608678"/>
                    <a:pt x="290355" y="1605424"/>
                  </a:cubicBezTo>
                  <a:cubicBezTo>
                    <a:pt x="293922" y="1602570"/>
                    <a:pt x="299022" y="1602535"/>
                    <a:pt x="303356" y="1601091"/>
                  </a:cubicBezTo>
                  <a:cubicBezTo>
                    <a:pt x="307690" y="1598202"/>
                    <a:pt x="311570" y="1594475"/>
                    <a:pt x="316357" y="1592423"/>
                  </a:cubicBezTo>
                  <a:cubicBezTo>
                    <a:pt x="321831" y="1590077"/>
                    <a:pt x="328364" y="1590754"/>
                    <a:pt x="333691" y="1588090"/>
                  </a:cubicBezTo>
                  <a:cubicBezTo>
                    <a:pt x="337346" y="1586263"/>
                    <a:pt x="338855" y="1581524"/>
                    <a:pt x="342359" y="1579422"/>
                  </a:cubicBezTo>
                  <a:cubicBezTo>
                    <a:pt x="346276" y="1577072"/>
                    <a:pt x="351026" y="1576533"/>
                    <a:pt x="355360" y="1575089"/>
                  </a:cubicBezTo>
                  <a:cubicBezTo>
                    <a:pt x="377028" y="1576533"/>
                    <a:pt x="398943" y="1575852"/>
                    <a:pt x="420364" y="1579422"/>
                  </a:cubicBezTo>
                  <a:cubicBezTo>
                    <a:pt x="435386" y="1581926"/>
                    <a:pt x="433279" y="1590778"/>
                    <a:pt x="437699" y="1601091"/>
                  </a:cubicBezTo>
                  <a:cubicBezTo>
                    <a:pt x="440244" y="1607029"/>
                    <a:pt x="443477" y="1612647"/>
                    <a:pt x="446366" y="1618425"/>
                  </a:cubicBezTo>
                  <a:cubicBezTo>
                    <a:pt x="447811" y="1625648"/>
                    <a:pt x="450700" y="1632727"/>
                    <a:pt x="450700" y="1640093"/>
                  </a:cubicBezTo>
                  <a:cubicBezTo>
                    <a:pt x="450700" y="1691034"/>
                    <a:pt x="452825" y="1710661"/>
                    <a:pt x="442033" y="1748435"/>
                  </a:cubicBezTo>
                  <a:cubicBezTo>
                    <a:pt x="440778" y="1752827"/>
                    <a:pt x="439144" y="1757102"/>
                    <a:pt x="437699" y="1761436"/>
                  </a:cubicBezTo>
                  <a:cubicBezTo>
                    <a:pt x="439144" y="1770103"/>
                    <a:pt x="436544" y="1780576"/>
                    <a:pt x="442033" y="1787437"/>
                  </a:cubicBezTo>
                  <a:cubicBezTo>
                    <a:pt x="444887" y="1791004"/>
                    <a:pt x="451233" y="1785638"/>
                    <a:pt x="455034" y="1783104"/>
                  </a:cubicBezTo>
                  <a:cubicBezTo>
                    <a:pt x="460133" y="1779705"/>
                    <a:pt x="463701" y="1774437"/>
                    <a:pt x="468034" y="1770103"/>
                  </a:cubicBezTo>
                  <a:cubicBezTo>
                    <a:pt x="478928" y="1737424"/>
                    <a:pt x="464233" y="1777705"/>
                    <a:pt x="481035" y="1744101"/>
                  </a:cubicBezTo>
                  <a:cubicBezTo>
                    <a:pt x="483078" y="1740015"/>
                    <a:pt x="483326" y="1735186"/>
                    <a:pt x="485369" y="1731100"/>
                  </a:cubicBezTo>
                  <a:cubicBezTo>
                    <a:pt x="490837" y="1720164"/>
                    <a:pt x="494640" y="1717495"/>
                    <a:pt x="502704" y="1709432"/>
                  </a:cubicBezTo>
                  <a:cubicBezTo>
                    <a:pt x="515736" y="1713775"/>
                    <a:pt x="517503" y="1713097"/>
                    <a:pt x="528706" y="1722433"/>
                  </a:cubicBezTo>
                  <a:cubicBezTo>
                    <a:pt x="571314" y="1757941"/>
                    <a:pt x="516277" y="1714338"/>
                    <a:pt x="550374" y="1748435"/>
                  </a:cubicBezTo>
                  <a:cubicBezTo>
                    <a:pt x="554057" y="1752118"/>
                    <a:pt x="559041" y="1754213"/>
                    <a:pt x="563375" y="1757102"/>
                  </a:cubicBezTo>
                  <a:cubicBezTo>
                    <a:pt x="564819" y="1752768"/>
                    <a:pt x="567708" y="1748669"/>
                    <a:pt x="567708" y="1744101"/>
                  </a:cubicBezTo>
                  <a:cubicBezTo>
                    <a:pt x="567708" y="1727975"/>
                    <a:pt x="554232" y="1726052"/>
                    <a:pt x="546040" y="1713765"/>
                  </a:cubicBezTo>
                  <a:cubicBezTo>
                    <a:pt x="543151" y="1709432"/>
                    <a:pt x="540762" y="1704719"/>
                    <a:pt x="537373" y="1700765"/>
                  </a:cubicBezTo>
                  <a:cubicBezTo>
                    <a:pt x="532055" y="1694561"/>
                    <a:pt x="520038" y="1683430"/>
                    <a:pt x="520038" y="1683430"/>
                  </a:cubicBezTo>
                  <a:cubicBezTo>
                    <a:pt x="517149" y="1674763"/>
                    <a:pt x="513587" y="1666291"/>
                    <a:pt x="511371" y="1657428"/>
                  </a:cubicBezTo>
                  <a:cubicBezTo>
                    <a:pt x="509926" y="1651650"/>
                    <a:pt x="509128" y="1645670"/>
                    <a:pt x="507037" y="1640093"/>
                  </a:cubicBezTo>
                  <a:cubicBezTo>
                    <a:pt x="504769" y="1634044"/>
                    <a:pt x="500638" y="1628808"/>
                    <a:pt x="498370" y="1622759"/>
                  </a:cubicBezTo>
                  <a:cubicBezTo>
                    <a:pt x="496279" y="1617182"/>
                    <a:pt x="496991" y="1610595"/>
                    <a:pt x="494036" y="1605424"/>
                  </a:cubicBezTo>
                  <a:cubicBezTo>
                    <a:pt x="490995" y="1600103"/>
                    <a:pt x="485369" y="1596757"/>
                    <a:pt x="481035" y="1592423"/>
                  </a:cubicBezTo>
                  <a:cubicBezTo>
                    <a:pt x="479591" y="1588089"/>
                    <a:pt x="479443" y="1583076"/>
                    <a:pt x="476702" y="1579422"/>
                  </a:cubicBezTo>
                  <a:cubicBezTo>
                    <a:pt x="470573" y="1571250"/>
                    <a:pt x="455034" y="1557754"/>
                    <a:pt x="455034" y="1557754"/>
                  </a:cubicBezTo>
                  <a:cubicBezTo>
                    <a:pt x="453589" y="1553420"/>
                    <a:pt x="452743" y="1548839"/>
                    <a:pt x="450700" y="1544753"/>
                  </a:cubicBezTo>
                  <a:cubicBezTo>
                    <a:pt x="448371" y="1540095"/>
                    <a:pt x="442033" y="1536960"/>
                    <a:pt x="442033" y="1531752"/>
                  </a:cubicBezTo>
                  <a:cubicBezTo>
                    <a:pt x="442033" y="1522616"/>
                    <a:pt x="447811" y="1514417"/>
                    <a:pt x="450700" y="1505750"/>
                  </a:cubicBezTo>
                  <a:cubicBezTo>
                    <a:pt x="459367" y="1508639"/>
                    <a:pt x="470242" y="1507958"/>
                    <a:pt x="476702" y="1514418"/>
                  </a:cubicBezTo>
                  <a:cubicBezTo>
                    <a:pt x="481036" y="1518752"/>
                    <a:pt x="484506" y="1524171"/>
                    <a:pt x="489703" y="1527419"/>
                  </a:cubicBezTo>
                  <a:cubicBezTo>
                    <a:pt x="496300" y="1531542"/>
                    <a:pt x="504542" y="1532361"/>
                    <a:pt x="511371" y="1536086"/>
                  </a:cubicBezTo>
                  <a:cubicBezTo>
                    <a:pt x="558898" y="1562009"/>
                    <a:pt x="522898" y="1543574"/>
                    <a:pt x="546040" y="1562088"/>
                  </a:cubicBezTo>
                  <a:cubicBezTo>
                    <a:pt x="550107" y="1565342"/>
                    <a:pt x="554707" y="1567866"/>
                    <a:pt x="559041" y="1570755"/>
                  </a:cubicBezTo>
                  <a:cubicBezTo>
                    <a:pt x="573899" y="1593043"/>
                    <a:pt x="560072" y="1575914"/>
                    <a:pt x="580709" y="1592423"/>
                  </a:cubicBezTo>
                  <a:cubicBezTo>
                    <a:pt x="597706" y="1606020"/>
                    <a:pt x="579800" y="1597899"/>
                    <a:pt x="602378" y="1605424"/>
                  </a:cubicBezTo>
                  <a:cubicBezTo>
                    <a:pt x="605267" y="1608313"/>
                    <a:pt x="607541" y="1611990"/>
                    <a:pt x="611045" y="1614092"/>
                  </a:cubicBezTo>
                  <a:cubicBezTo>
                    <a:pt x="619937" y="1619427"/>
                    <a:pt x="633934" y="1623201"/>
                    <a:pt x="619712" y="1605424"/>
                  </a:cubicBezTo>
                  <a:cubicBezTo>
                    <a:pt x="616458" y="1601357"/>
                    <a:pt x="610604" y="1600217"/>
                    <a:pt x="606711" y="1596757"/>
                  </a:cubicBezTo>
                  <a:cubicBezTo>
                    <a:pt x="595275" y="1586592"/>
                    <a:pt x="568870" y="1561236"/>
                    <a:pt x="563375" y="1544753"/>
                  </a:cubicBezTo>
                  <a:lnTo>
                    <a:pt x="559041" y="1531752"/>
                  </a:lnTo>
                  <a:cubicBezTo>
                    <a:pt x="560486" y="1524529"/>
                    <a:pt x="560789" y="1516981"/>
                    <a:pt x="563375" y="1510084"/>
                  </a:cubicBezTo>
                  <a:cubicBezTo>
                    <a:pt x="573045" y="1484298"/>
                    <a:pt x="586511" y="1498530"/>
                    <a:pt x="615379" y="1501417"/>
                  </a:cubicBezTo>
                  <a:cubicBezTo>
                    <a:pt x="627239" y="1507347"/>
                    <a:pt x="635508" y="1510586"/>
                    <a:pt x="645714" y="1518751"/>
                  </a:cubicBezTo>
                  <a:cubicBezTo>
                    <a:pt x="648905" y="1521303"/>
                    <a:pt x="650981" y="1525153"/>
                    <a:pt x="654381" y="1527419"/>
                  </a:cubicBezTo>
                  <a:cubicBezTo>
                    <a:pt x="659756" y="1531003"/>
                    <a:pt x="666176" y="1532762"/>
                    <a:pt x="671716" y="1536086"/>
                  </a:cubicBezTo>
                  <a:cubicBezTo>
                    <a:pt x="680648" y="1541445"/>
                    <a:pt x="690353" y="1546054"/>
                    <a:pt x="697718" y="1553420"/>
                  </a:cubicBezTo>
                  <a:cubicBezTo>
                    <a:pt x="700607" y="1556309"/>
                    <a:pt x="702881" y="1559986"/>
                    <a:pt x="706385" y="1562088"/>
                  </a:cubicBezTo>
                  <a:cubicBezTo>
                    <a:pt x="710302" y="1564438"/>
                    <a:pt x="715052" y="1564977"/>
                    <a:pt x="719386" y="1566421"/>
                  </a:cubicBezTo>
                  <a:cubicBezTo>
                    <a:pt x="717941" y="1560643"/>
                    <a:pt x="718865" y="1553662"/>
                    <a:pt x="715052" y="1549087"/>
                  </a:cubicBezTo>
                  <a:cubicBezTo>
                    <a:pt x="710916" y="1544124"/>
                    <a:pt x="703327" y="1543624"/>
                    <a:pt x="697718" y="1540419"/>
                  </a:cubicBezTo>
                  <a:cubicBezTo>
                    <a:pt x="693196" y="1537835"/>
                    <a:pt x="689051" y="1534641"/>
                    <a:pt x="684717" y="1531752"/>
                  </a:cubicBezTo>
                  <a:cubicBezTo>
                    <a:pt x="681828" y="1527418"/>
                    <a:pt x="679733" y="1522434"/>
                    <a:pt x="676050" y="1518751"/>
                  </a:cubicBezTo>
                  <a:cubicBezTo>
                    <a:pt x="656443" y="1499144"/>
                    <a:pt x="666428" y="1523819"/>
                    <a:pt x="645714" y="1492749"/>
                  </a:cubicBezTo>
                  <a:lnTo>
                    <a:pt x="628379" y="1466747"/>
                  </a:lnTo>
                  <a:cubicBezTo>
                    <a:pt x="626935" y="1462414"/>
                    <a:pt x="626089" y="1457833"/>
                    <a:pt x="624046" y="1453747"/>
                  </a:cubicBezTo>
                  <a:cubicBezTo>
                    <a:pt x="618579" y="1442813"/>
                    <a:pt x="614773" y="1440140"/>
                    <a:pt x="606711" y="1432078"/>
                  </a:cubicBezTo>
                  <a:cubicBezTo>
                    <a:pt x="608156" y="1417633"/>
                    <a:pt x="602992" y="1400821"/>
                    <a:pt x="611045" y="1388742"/>
                  </a:cubicBezTo>
                  <a:cubicBezTo>
                    <a:pt x="615131" y="1382613"/>
                    <a:pt x="625567" y="1391289"/>
                    <a:pt x="632713" y="1393075"/>
                  </a:cubicBezTo>
                  <a:cubicBezTo>
                    <a:pt x="654495" y="1398520"/>
                    <a:pt x="637535" y="1395486"/>
                    <a:pt x="658715" y="1406076"/>
                  </a:cubicBezTo>
                  <a:cubicBezTo>
                    <a:pt x="662801" y="1408119"/>
                    <a:pt x="667630" y="1408367"/>
                    <a:pt x="671716" y="1410410"/>
                  </a:cubicBezTo>
                  <a:cubicBezTo>
                    <a:pt x="676374" y="1412739"/>
                    <a:pt x="680059" y="1416748"/>
                    <a:pt x="684717" y="1419077"/>
                  </a:cubicBezTo>
                  <a:cubicBezTo>
                    <a:pt x="690935" y="1422186"/>
                    <a:pt x="709497" y="1426356"/>
                    <a:pt x="715052" y="1427745"/>
                  </a:cubicBezTo>
                  <a:cubicBezTo>
                    <a:pt x="759630" y="1424561"/>
                    <a:pt x="764322" y="1434267"/>
                    <a:pt x="788725" y="1414744"/>
                  </a:cubicBezTo>
                  <a:cubicBezTo>
                    <a:pt x="791916" y="1412192"/>
                    <a:pt x="794503" y="1408965"/>
                    <a:pt x="797392" y="1406076"/>
                  </a:cubicBezTo>
                  <a:lnTo>
                    <a:pt x="806059" y="1380074"/>
                  </a:lnTo>
                  <a:lnTo>
                    <a:pt x="810393" y="1367074"/>
                  </a:lnTo>
                  <a:cubicBezTo>
                    <a:pt x="808948" y="1345406"/>
                    <a:pt x="816355" y="1321190"/>
                    <a:pt x="806059" y="1302069"/>
                  </a:cubicBezTo>
                  <a:cubicBezTo>
                    <a:pt x="801728" y="1294025"/>
                    <a:pt x="780057" y="1310736"/>
                    <a:pt x="780057" y="1310736"/>
                  </a:cubicBezTo>
                  <a:cubicBezTo>
                    <a:pt x="755143" y="1343955"/>
                    <a:pt x="779403" y="1315615"/>
                    <a:pt x="754055" y="1336738"/>
                  </a:cubicBezTo>
                  <a:cubicBezTo>
                    <a:pt x="749347" y="1340661"/>
                    <a:pt x="744977" y="1345031"/>
                    <a:pt x="741054" y="1349739"/>
                  </a:cubicBezTo>
                  <a:cubicBezTo>
                    <a:pt x="737720" y="1353740"/>
                    <a:pt x="736454" y="1359486"/>
                    <a:pt x="732387" y="1362740"/>
                  </a:cubicBezTo>
                  <a:cubicBezTo>
                    <a:pt x="728820" y="1365594"/>
                    <a:pt x="723720" y="1365629"/>
                    <a:pt x="719386" y="1367074"/>
                  </a:cubicBezTo>
                  <a:cubicBezTo>
                    <a:pt x="710719" y="1365629"/>
                    <a:pt x="701909" y="1364871"/>
                    <a:pt x="693384" y="1362740"/>
                  </a:cubicBezTo>
                  <a:cubicBezTo>
                    <a:pt x="684521" y="1360524"/>
                    <a:pt x="667382" y="1354073"/>
                    <a:pt x="667382" y="1354073"/>
                  </a:cubicBezTo>
                  <a:cubicBezTo>
                    <a:pt x="660347" y="1355078"/>
                    <a:pt x="629931" y="1358360"/>
                    <a:pt x="619712" y="1362740"/>
                  </a:cubicBezTo>
                  <a:cubicBezTo>
                    <a:pt x="614925" y="1364792"/>
                    <a:pt x="611606" y="1369627"/>
                    <a:pt x="606711" y="1371407"/>
                  </a:cubicBezTo>
                  <a:cubicBezTo>
                    <a:pt x="595516" y="1375478"/>
                    <a:pt x="572042" y="1380074"/>
                    <a:pt x="572042" y="1380074"/>
                  </a:cubicBezTo>
                  <a:cubicBezTo>
                    <a:pt x="567708" y="1382963"/>
                    <a:pt x="563828" y="1386690"/>
                    <a:pt x="559041" y="1388742"/>
                  </a:cubicBezTo>
                  <a:cubicBezTo>
                    <a:pt x="531086" y="1400723"/>
                    <a:pt x="550486" y="1384296"/>
                    <a:pt x="533039" y="1401743"/>
                  </a:cubicBezTo>
                  <a:cubicBezTo>
                    <a:pt x="523102" y="1431559"/>
                    <a:pt x="533039" y="1395510"/>
                    <a:pt x="533039" y="1449413"/>
                  </a:cubicBezTo>
                  <a:cubicBezTo>
                    <a:pt x="533039" y="1455369"/>
                    <a:pt x="533228" y="1462871"/>
                    <a:pt x="528706" y="1466747"/>
                  </a:cubicBezTo>
                  <a:cubicBezTo>
                    <a:pt x="521769" y="1472693"/>
                    <a:pt x="502704" y="1475415"/>
                    <a:pt x="502704" y="1475415"/>
                  </a:cubicBezTo>
                  <a:cubicBezTo>
                    <a:pt x="478147" y="1473970"/>
                    <a:pt x="453521" y="1473413"/>
                    <a:pt x="429032" y="1471081"/>
                  </a:cubicBezTo>
                  <a:cubicBezTo>
                    <a:pt x="417923" y="1470023"/>
                    <a:pt x="394202" y="1460206"/>
                    <a:pt x="385695" y="1458080"/>
                  </a:cubicBezTo>
                  <a:cubicBezTo>
                    <a:pt x="363929" y="1452639"/>
                    <a:pt x="374011" y="1455631"/>
                    <a:pt x="355360" y="1449413"/>
                  </a:cubicBezTo>
                  <a:cubicBezTo>
                    <a:pt x="352471" y="1446524"/>
                    <a:pt x="349883" y="1443298"/>
                    <a:pt x="346692" y="1440746"/>
                  </a:cubicBezTo>
                  <a:cubicBezTo>
                    <a:pt x="342625" y="1437492"/>
                    <a:pt x="337374" y="1435761"/>
                    <a:pt x="333691" y="1432078"/>
                  </a:cubicBezTo>
                  <a:cubicBezTo>
                    <a:pt x="330008" y="1428395"/>
                    <a:pt x="327913" y="1423411"/>
                    <a:pt x="325024" y="1419077"/>
                  </a:cubicBezTo>
                  <a:cubicBezTo>
                    <a:pt x="326469" y="1403187"/>
                    <a:pt x="324975" y="1386749"/>
                    <a:pt x="329358" y="1371407"/>
                  </a:cubicBezTo>
                  <a:cubicBezTo>
                    <a:pt x="331042" y="1365514"/>
                    <a:pt x="337651" y="1362329"/>
                    <a:pt x="342359" y="1358406"/>
                  </a:cubicBezTo>
                  <a:cubicBezTo>
                    <a:pt x="346360" y="1355072"/>
                    <a:pt x="350702" y="1352068"/>
                    <a:pt x="355360" y="1349739"/>
                  </a:cubicBezTo>
                  <a:cubicBezTo>
                    <a:pt x="374071" y="1340384"/>
                    <a:pt x="413935" y="1341900"/>
                    <a:pt x="424698" y="1341072"/>
                  </a:cubicBezTo>
                  <a:lnTo>
                    <a:pt x="407363" y="1315070"/>
                  </a:lnTo>
                  <a:cubicBezTo>
                    <a:pt x="404474" y="1310736"/>
                    <a:pt x="402379" y="1305752"/>
                    <a:pt x="398696" y="1302069"/>
                  </a:cubicBezTo>
                  <a:lnTo>
                    <a:pt x="390029" y="1293401"/>
                  </a:lnTo>
                  <a:cubicBezTo>
                    <a:pt x="391473" y="1286178"/>
                    <a:pt x="389154" y="1276941"/>
                    <a:pt x="394362" y="1271733"/>
                  </a:cubicBezTo>
                  <a:cubicBezTo>
                    <a:pt x="400822" y="1265273"/>
                    <a:pt x="411405" y="1264858"/>
                    <a:pt x="420364" y="1263066"/>
                  </a:cubicBezTo>
                  <a:cubicBezTo>
                    <a:pt x="459090" y="1255321"/>
                    <a:pt x="434692" y="1259344"/>
                    <a:pt x="494036" y="1254399"/>
                  </a:cubicBezTo>
                  <a:cubicBezTo>
                    <a:pt x="491465" y="1226109"/>
                    <a:pt x="485669" y="1199949"/>
                    <a:pt x="494036" y="1172059"/>
                  </a:cubicBezTo>
                  <a:cubicBezTo>
                    <a:pt x="495210" y="1168145"/>
                    <a:pt x="499049" y="1165219"/>
                    <a:pt x="502704" y="1163392"/>
                  </a:cubicBezTo>
                  <a:cubicBezTo>
                    <a:pt x="508031" y="1160728"/>
                    <a:pt x="514260" y="1160503"/>
                    <a:pt x="520038" y="1159058"/>
                  </a:cubicBezTo>
                  <a:cubicBezTo>
                    <a:pt x="569153" y="1160503"/>
                    <a:pt x="618336" y="1166364"/>
                    <a:pt x="667382" y="1163392"/>
                  </a:cubicBezTo>
                  <a:cubicBezTo>
                    <a:pt x="671942" y="1163116"/>
                    <a:pt x="665903" y="1153958"/>
                    <a:pt x="663049" y="1150391"/>
                  </a:cubicBezTo>
                  <a:cubicBezTo>
                    <a:pt x="654771" y="1140043"/>
                    <a:pt x="647513" y="1142623"/>
                    <a:pt x="637047" y="1137390"/>
                  </a:cubicBezTo>
                  <a:cubicBezTo>
                    <a:pt x="599236" y="1118484"/>
                    <a:pt x="651804" y="1137917"/>
                    <a:pt x="606711" y="1124389"/>
                  </a:cubicBezTo>
                  <a:cubicBezTo>
                    <a:pt x="537195" y="1103534"/>
                    <a:pt x="622159" y="1117316"/>
                    <a:pt x="468034" y="1111388"/>
                  </a:cubicBezTo>
                  <a:cubicBezTo>
                    <a:pt x="462475" y="1109998"/>
                    <a:pt x="443919" y="1105831"/>
                    <a:pt x="437699" y="1102721"/>
                  </a:cubicBezTo>
                  <a:cubicBezTo>
                    <a:pt x="433041" y="1100392"/>
                    <a:pt x="428652" y="1097444"/>
                    <a:pt x="424698" y="1094054"/>
                  </a:cubicBezTo>
                  <a:cubicBezTo>
                    <a:pt x="418493" y="1088736"/>
                    <a:pt x="407363" y="1076719"/>
                    <a:pt x="407363" y="1076719"/>
                  </a:cubicBezTo>
                  <a:cubicBezTo>
                    <a:pt x="401285" y="1058482"/>
                    <a:pt x="399064" y="1058279"/>
                    <a:pt x="407363" y="1033383"/>
                  </a:cubicBezTo>
                  <a:cubicBezTo>
                    <a:pt x="408655" y="1029507"/>
                    <a:pt x="411950" y="1024919"/>
                    <a:pt x="416031" y="1024715"/>
                  </a:cubicBezTo>
                  <a:cubicBezTo>
                    <a:pt x="499723" y="1020530"/>
                    <a:pt x="583598" y="1021826"/>
                    <a:pt x="667382" y="1020382"/>
                  </a:cubicBezTo>
                  <a:cubicBezTo>
                    <a:pt x="698008" y="1014257"/>
                    <a:pt x="682065" y="1018377"/>
                    <a:pt x="715052" y="1007381"/>
                  </a:cubicBezTo>
                  <a:cubicBezTo>
                    <a:pt x="719386" y="1005936"/>
                    <a:pt x="724252" y="1005581"/>
                    <a:pt x="728053" y="1003047"/>
                  </a:cubicBezTo>
                  <a:lnTo>
                    <a:pt x="741054" y="994380"/>
                  </a:lnTo>
                  <a:cubicBezTo>
                    <a:pt x="742499" y="990046"/>
                    <a:pt x="746284" y="985858"/>
                    <a:pt x="745388" y="981379"/>
                  </a:cubicBezTo>
                  <a:cubicBezTo>
                    <a:pt x="743688" y="972879"/>
                    <a:pt x="729197" y="970203"/>
                    <a:pt x="723720" y="968378"/>
                  </a:cubicBezTo>
                  <a:cubicBezTo>
                    <a:pt x="706385" y="969822"/>
                    <a:pt x="688958" y="970412"/>
                    <a:pt x="671716" y="972711"/>
                  </a:cubicBezTo>
                  <a:cubicBezTo>
                    <a:pt x="667188" y="973315"/>
                    <a:pt x="663147" y="975937"/>
                    <a:pt x="658715" y="977045"/>
                  </a:cubicBezTo>
                  <a:cubicBezTo>
                    <a:pt x="651569" y="978832"/>
                    <a:pt x="644193" y="979593"/>
                    <a:pt x="637047" y="981379"/>
                  </a:cubicBezTo>
                  <a:cubicBezTo>
                    <a:pt x="632615" y="982487"/>
                    <a:pt x="628540" y="984895"/>
                    <a:pt x="624046" y="985712"/>
                  </a:cubicBezTo>
                  <a:cubicBezTo>
                    <a:pt x="612588" y="987795"/>
                    <a:pt x="600906" y="988399"/>
                    <a:pt x="589377" y="990046"/>
                  </a:cubicBezTo>
                  <a:cubicBezTo>
                    <a:pt x="524871" y="999262"/>
                    <a:pt x="612011" y="991519"/>
                    <a:pt x="489703" y="998713"/>
                  </a:cubicBezTo>
                  <a:cubicBezTo>
                    <a:pt x="478147" y="997269"/>
                    <a:pt x="466422" y="996820"/>
                    <a:pt x="455034" y="994380"/>
                  </a:cubicBezTo>
                  <a:cubicBezTo>
                    <a:pt x="446101" y="992466"/>
                    <a:pt x="429032" y="985712"/>
                    <a:pt x="429032" y="985712"/>
                  </a:cubicBezTo>
                  <a:cubicBezTo>
                    <a:pt x="417733" y="974413"/>
                    <a:pt x="405864" y="965378"/>
                    <a:pt x="398696" y="951043"/>
                  </a:cubicBezTo>
                  <a:cubicBezTo>
                    <a:pt x="396653" y="946957"/>
                    <a:pt x="396405" y="942128"/>
                    <a:pt x="394362" y="938042"/>
                  </a:cubicBezTo>
                  <a:cubicBezTo>
                    <a:pt x="392033" y="933384"/>
                    <a:pt x="387810" y="929800"/>
                    <a:pt x="385695" y="925041"/>
                  </a:cubicBezTo>
                  <a:cubicBezTo>
                    <a:pt x="381985" y="916692"/>
                    <a:pt x="379917" y="907706"/>
                    <a:pt x="377028" y="899039"/>
                  </a:cubicBezTo>
                  <a:lnTo>
                    <a:pt x="372694" y="886038"/>
                  </a:lnTo>
                  <a:cubicBezTo>
                    <a:pt x="374139" y="881704"/>
                    <a:pt x="374174" y="876604"/>
                    <a:pt x="377028" y="873037"/>
                  </a:cubicBezTo>
                  <a:cubicBezTo>
                    <a:pt x="380282" y="868970"/>
                    <a:pt x="385370" y="866699"/>
                    <a:pt x="390029" y="864370"/>
                  </a:cubicBezTo>
                  <a:cubicBezTo>
                    <a:pt x="402129" y="858321"/>
                    <a:pt x="422191" y="857299"/>
                    <a:pt x="433365" y="855703"/>
                  </a:cubicBezTo>
                  <a:cubicBezTo>
                    <a:pt x="461171" y="827900"/>
                    <a:pt x="426123" y="866767"/>
                    <a:pt x="446366" y="777697"/>
                  </a:cubicBezTo>
                  <a:cubicBezTo>
                    <a:pt x="451303" y="755973"/>
                    <a:pt x="460366" y="751446"/>
                    <a:pt x="476702" y="747362"/>
                  </a:cubicBezTo>
                  <a:cubicBezTo>
                    <a:pt x="483848" y="745576"/>
                    <a:pt x="491264" y="744966"/>
                    <a:pt x="498370" y="743028"/>
                  </a:cubicBezTo>
                  <a:cubicBezTo>
                    <a:pt x="507184" y="740624"/>
                    <a:pt x="515509" y="736577"/>
                    <a:pt x="524372" y="734361"/>
                  </a:cubicBezTo>
                  <a:lnTo>
                    <a:pt x="541707" y="730027"/>
                  </a:lnTo>
                  <a:cubicBezTo>
                    <a:pt x="578957" y="705193"/>
                    <a:pt x="531830" y="734965"/>
                    <a:pt x="567708" y="717026"/>
                  </a:cubicBezTo>
                  <a:cubicBezTo>
                    <a:pt x="601312" y="700224"/>
                    <a:pt x="561031" y="714919"/>
                    <a:pt x="593710" y="704025"/>
                  </a:cubicBezTo>
                  <a:cubicBezTo>
                    <a:pt x="596599" y="701136"/>
                    <a:pt x="599926" y="698627"/>
                    <a:pt x="602378" y="695358"/>
                  </a:cubicBezTo>
                  <a:cubicBezTo>
                    <a:pt x="608628" y="687025"/>
                    <a:pt x="611045" y="675134"/>
                    <a:pt x="619712" y="669356"/>
                  </a:cubicBezTo>
                  <a:cubicBezTo>
                    <a:pt x="624046" y="666467"/>
                    <a:pt x="628141" y="663183"/>
                    <a:pt x="632713" y="660689"/>
                  </a:cubicBezTo>
                  <a:cubicBezTo>
                    <a:pt x="644056" y="654502"/>
                    <a:pt x="658245" y="652490"/>
                    <a:pt x="667382" y="643354"/>
                  </a:cubicBezTo>
                  <a:lnTo>
                    <a:pt x="676050" y="634687"/>
                  </a:lnTo>
                  <a:cubicBezTo>
                    <a:pt x="677494" y="630353"/>
                    <a:pt x="680383" y="626254"/>
                    <a:pt x="680383" y="621686"/>
                  </a:cubicBezTo>
                  <a:cubicBezTo>
                    <a:pt x="680383" y="573736"/>
                    <a:pt x="665286" y="596402"/>
                    <a:pt x="611045" y="600018"/>
                  </a:cubicBezTo>
                  <a:cubicBezTo>
                    <a:pt x="587207" y="607963"/>
                    <a:pt x="608567" y="599577"/>
                    <a:pt x="585043" y="613019"/>
                  </a:cubicBezTo>
                  <a:cubicBezTo>
                    <a:pt x="579434" y="616224"/>
                    <a:pt x="573355" y="618549"/>
                    <a:pt x="567708" y="621686"/>
                  </a:cubicBezTo>
                  <a:cubicBezTo>
                    <a:pt x="537005" y="638743"/>
                    <a:pt x="556807" y="631099"/>
                    <a:pt x="533039" y="639020"/>
                  </a:cubicBezTo>
                  <a:cubicBezTo>
                    <a:pt x="524372" y="644798"/>
                    <a:pt x="516919" y="653061"/>
                    <a:pt x="507037" y="656355"/>
                  </a:cubicBezTo>
                  <a:cubicBezTo>
                    <a:pt x="502703" y="657800"/>
                    <a:pt x="498122" y="658646"/>
                    <a:pt x="494036" y="660689"/>
                  </a:cubicBezTo>
                  <a:cubicBezTo>
                    <a:pt x="489378" y="663018"/>
                    <a:pt x="485976" y="667709"/>
                    <a:pt x="481035" y="669356"/>
                  </a:cubicBezTo>
                  <a:cubicBezTo>
                    <a:pt x="472699" y="672135"/>
                    <a:pt x="463701" y="672245"/>
                    <a:pt x="455034" y="673690"/>
                  </a:cubicBezTo>
                  <a:cubicBezTo>
                    <a:pt x="385647" y="667382"/>
                    <a:pt x="417323" y="684940"/>
                    <a:pt x="403030" y="656355"/>
                  </a:cubicBezTo>
                  <a:cubicBezTo>
                    <a:pt x="400701" y="651696"/>
                    <a:pt x="397251" y="647688"/>
                    <a:pt x="394362" y="643354"/>
                  </a:cubicBezTo>
                  <a:cubicBezTo>
                    <a:pt x="392918" y="639020"/>
                    <a:pt x="390029" y="634921"/>
                    <a:pt x="390029" y="630353"/>
                  </a:cubicBezTo>
                  <a:cubicBezTo>
                    <a:pt x="390029" y="615836"/>
                    <a:pt x="388970" y="600496"/>
                    <a:pt x="394362" y="587017"/>
                  </a:cubicBezTo>
                  <a:cubicBezTo>
                    <a:pt x="398156" y="577533"/>
                    <a:pt x="407532" y="571014"/>
                    <a:pt x="416031" y="565348"/>
                  </a:cubicBezTo>
                  <a:lnTo>
                    <a:pt x="442033" y="548014"/>
                  </a:lnTo>
                  <a:cubicBezTo>
                    <a:pt x="446367" y="545125"/>
                    <a:pt x="450093" y="540994"/>
                    <a:pt x="455034" y="539347"/>
                  </a:cubicBezTo>
                  <a:cubicBezTo>
                    <a:pt x="485525" y="529182"/>
                    <a:pt x="447879" y="542413"/>
                    <a:pt x="485369" y="526346"/>
                  </a:cubicBezTo>
                  <a:cubicBezTo>
                    <a:pt x="489568" y="524547"/>
                    <a:pt x="494377" y="524231"/>
                    <a:pt x="498370" y="522012"/>
                  </a:cubicBezTo>
                  <a:cubicBezTo>
                    <a:pt x="507476" y="516953"/>
                    <a:pt x="517006" y="512043"/>
                    <a:pt x="524372" y="504677"/>
                  </a:cubicBezTo>
                  <a:cubicBezTo>
                    <a:pt x="541056" y="487993"/>
                    <a:pt x="532274" y="495076"/>
                    <a:pt x="550374" y="483009"/>
                  </a:cubicBezTo>
                  <a:cubicBezTo>
                    <a:pt x="551818" y="478675"/>
                    <a:pt x="552357" y="473925"/>
                    <a:pt x="554707" y="470008"/>
                  </a:cubicBezTo>
                  <a:cubicBezTo>
                    <a:pt x="556809" y="466504"/>
                    <a:pt x="560184" y="463893"/>
                    <a:pt x="563375" y="461341"/>
                  </a:cubicBezTo>
                  <a:cubicBezTo>
                    <a:pt x="590824" y="439383"/>
                    <a:pt x="599610" y="451307"/>
                    <a:pt x="650048" y="448340"/>
                  </a:cubicBezTo>
                  <a:cubicBezTo>
                    <a:pt x="658715" y="446895"/>
                    <a:pt x="667714" y="446785"/>
                    <a:pt x="676050" y="444006"/>
                  </a:cubicBezTo>
                  <a:cubicBezTo>
                    <a:pt x="680991" y="442359"/>
                    <a:pt x="684393" y="437668"/>
                    <a:pt x="689051" y="435339"/>
                  </a:cubicBezTo>
                  <a:cubicBezTo>
                    <a:pt x="693137" y="433296"/>
                    <a:pt x="697718" y="432450"/>
                    <a:pt x="702052" y="431005"/>
                  </a:cubicBezTo>
                  <a:cubicBezTo>
                    <a:pt x="699163" y="428116"/>
                    <a:pt x="696575" y="424890"/>
                    <a:pt x="693384" y="422338"/>
                  </a:cubicBezTo>
                  <a:cubicBezTo>
                    <a:pt x="671020" y="404448"/>
                    <a:pt x="668504" y="412681"/>
                    <a:pt x="628379" y="409337"/>
                  </a:cubicBezTo>
                  <a:cubicBezTo>
                    <a:pt x="628232" y="409300"/>
                    <a:pt x="600115" y="402740"/>
                    <a:pt x="598044" y="400670"/>
                  </a:cubicBezTo>
                  <a:cubicBezTo>
                    <a:pt x="594814" y="397440"/>
                    <a:pt x="595753" y="391755"/>
                    <a:pt x="593710" y="387669"/>
                  </a:cubicBezTo>
                  <a:cubicBezTo>
                    <a:pt x="591381" y="383011"/>
                    <a:pt x="587932" y="379002"/>
                    <a:pt x="585043" y="374668"/>
                  </a:cubicBezTo>
                  <a:cubicBezTo>
                    <a:pt x="583598" y="364556"/>
                    <a:pt x="587090" y="352308"/>
                    <a:pt x="580709" y="344332"/>
                  </a:cubicBezTo>
                  <a:cubicBezTo>
                    <a:pt x="577455" y="340265"/>
                    <a:pt x="571709" y="349666"/>
                    <a:pt x="567708" y="353000"/>
                  </a:cubicBezTo>
                  <a:cubicBezTo>
                    <a:pt x="563000" y="356924"/>
                    <a:pt x="560629" y="364422"/>
                    <a:pt x="554707" y="366001"/>
                  </a:cubicBezTo>
                  <a:cubicBezTo>
                    <a:pt x="537900" y="370483"/>
                    <a:pt x="520038" y="368890"/>
                    <a:pt x="502704" y="370334"/>
                  </a:cubicBezTo>
                  <a:cubicBezTo>
                    <a:pt x="500037" y="371223"/>
                    <a:pt x="476480" y="375224"/>
                    <a:pt x="485369" y="387669"/>
                  </a:cubicBezTo>
                  <a:cubicBezTo>
                    <a:pt x="491424" y="396145"/>
                    <a:pt x="502704" y="399225"/>
                    <a:pt x="511371" y="405003"/>
                  </a:cubicBezTo>
                  <a:lnTo>
                    <a:pt x="524372" y="413671"/>
                  </a:lnTo>
                  <a:cubicBezTo>
                    <a:pt x="525817" y="418005"/>
                    <a:pt x="528706" y="422104"/>
                    <a:pt x="528706" y="426672"/>
                  </a:cubicBezTo>
                  <a:cubicBezTo>
                    <a:pt x="528706" y="439073"/>
                    <a:pt x="524671" y="452375"/>
                    <a:pt x="515705" y="461341"/>
                  </a:cubicBezTo>
                  <a:cubicBezTo>
                    <a:pt x="512022" y="465024"/>
                    <a:pt x="506658" y="466618"/>
                    <a:pt x="502704" y="470008"/>
                  </a:cubicBezTo>
                  <a:cubicBezTo>
                    <a:pt x="496499" y="475326"/>
                    <a:pt x="492299" y="483012"/>
                    <a:pt x="485369" y="487343"/>
                  </a:cubicBezTo>
                  <a:cubicBezTo>
                    <a:pt x="480318" y="490500"/>
                    <a:pt x="473739" y="489965"/>
                    <a:pt x="468034" y="491676"/>
                  </a:cubicBezTo>
                  <a:cubicBezTo>
                    <a:pt x="459283" y="494301"/>
                    <a:pt x="450700" y="497455"/>
                    <a:pt x="442033" y="500344"/>
                  </a:cubicBezTo>
                  <a:lnTo>
                    <a:pt x="416031" y="509011"/>
                  </a:lnTo>
                  <a:cubicBezTo>
                    <a:pt x="411697" y="510456"/>
                    <a:pt x="407462" y="512237"/>
                    <a:pt x="403030" y="513345"/>
                  </a:cubicBezTo>
                  <a:cubicBezTo>
                    <a:pt x="391474" y="516234"/>
                    <a:pt x="379421" y="517588"/>
                    <a:pt x="368361" y="522012"/>
                  </a:cubicBezTo>
                  <a:cubicBezTo>
                    <a:pt x="361138" y="524901"/>
                    <a:pt x="353976" y="527948"/>
                    <a:pt x="346692" y="530679"/>
                  </a:cubicBezTo>
                  <a:cubicBezTo>
                    <a:pt x="342415" y="532283"/>
                    <a:pt x="337684" y="532795"/>
                    <a:pt x="333691" y="535013"/>
                  </a:cubicBezTo>
                  <a:cubicBezTo>
                    <a:pt x="288987" y="559848"/>
                    <a:pt x="324106" y="546874"/>
                    <a:pt x="294688" y="556681"/>
                  </a:cubicBezTo>
                  <a:cubicBezTo>
                    <a:pt x="283453" y="522972"/>
                    <a:pt x="287938" y="541842"/>
                    <a:pt x="294688" y="474342"/>
                  </a:cubicBezTo>
                  <a:cubicBezTo>
                    <a:pt x="296056" y="460665"/>
                    <a:pt x="299417" y="454346"/>
                    <a:pt x="307689" y="444006"/>
                  </a:cubicBezTo>
                  <a:cubicBezTo>
                    <a:pt x="310241" y="440815"/>
                    <a:pt x="313905" y="438608"/>
                    <a:pt x="316357" y="435339"/>
                  </a:cubicBezTo>
                  <a:cubicBezTo>
                    <a:pt x="322607" y="427006"/>
                    <a:pt x="327913" y="418004"/>
                    <a:pt x="333691" y="409337"/>
                  </a:cubicBezTo>
                  <a:lnTo>
                    <a:pt x="342359" y="396336"/>
                  </a:lnTo>
                  <a:cubicBezTo>
                    <a:pt x="340914" y="390558"/>
                    <a:pt x="339661" y="384728"/>
                    <a:pt x="338025" y="379001"/>
                  </a:cubicBezTo>
                  <a:cubicBezTo>
                    <a:pt x="336770" y="374609"/>
                    <a:pt x="333691" y="370569"/>
                    <a:pt x="333691" y="366001"/>
                  </a:cubicBezTo>
                  <a:cubicBezTo>
                    <a:pt x="333691" y="354354"/>
                    <a:pt x="333700" y="342145"/>
                    <a:pt x="338025" y="331331"/>
                  </a:cubicBezTo>
                  <a:cubicBezTo>
                    <a:pt x="339959" y="326495"/>
                    <a:pt x="346692" y="325553"/>
                    <a:pt x="351026" y="322664"/>
                  </a:cubicBezTo>
                  <a:cubicBezTo>
                    <a:pt x="357528" y="312910"/>
                    <a:pt x="366518" y="297583"/>
                    <a:pt x="377028" y="292328"/>
                  </a:cubicBezTo>
                  <a:cubicBezTo>
                    <a:pt x="399020" y="281332"/>
                    <a:pt x="388987" y="287244"/>
                    <a:pt x="407363" y="274994"/>
                  </a:cubicBezTo>
                  <a:lnTo>
                    <a:pt x="398696" y="248992"/>
                  </a:lnTo>
                  <a:lnTo>
                    <a:pt x="394362" y="235991"/>
                  </a:lnTo>
                  <a:cubicBezTo>
                    <a:pt x="395807" y="201322"/>
                    <a:pt x="396308" y="166600"/>
                    <a:pt x="398696" y="131983"/>
                  </a:cubicBezTo>
                  <a:cubicBezTo>
                    <a:pt x="399490" y="120472"/>
                    <a:pt x="402170" y="105650"/>
                    <a:pt x="411697" y="97314"/>
                  </a:cubicBezTo>
                  <a:cubicBezTo>
                    <a:pt x="419536" y="90455"/>
                    <a:pt x="430334" y="87346"/>
                    <a:pt x="437699" y="79980"/>
                  </a:cubicBezTo>
                  <a:cubicBezTo>
                    <a:pt x="449596" y="68082"/>
                    <a:pt x="442490" y="72604"/>
                    <a:pt x="459367" y="66979"/>
                  </a:cubicBezTo>
                  <a:cubicBezTo>
                    <a:pt x="463140" y="63206"/>
                    <a:pt x="482366" y="49644"/>
                    <a:pt x="455034" y="49644"/>
                  </a:cubicBezTo>
                  <a:cubicBezTo>
                    <a:pt x="448574" y="49644"/>
                    <a:pt x="443477" y="55422"/>
                    <a:pt x="437699" y="58311"/>
                  </a:cubicBezTo>
                  <a:lnTo>
                    <a:pt x="407363" y="88647"/>
                  </a:lnTo>
                  <a:cubicBezTo>
                    <a:pt x="403029" y="92981"/>
                    <a:pt x="400176" y="99710"/>
                    <a:pt x="394362" y="101648"/>
                  </a:cubicBezTo>
                  <a:lnTo>
                    <a:pt x="368361" y="110315"/>
                  </a:lnTo>
                  <a:cubicBezTo>
                    <a:pt x="359694" y="108871"/>
                    <a:pt x="350883" y="108113"/>
                    <a:pt x="342359" y="105982"/>
                  </a:cubicBezTo>
                  <a:cubicBezTo>
                    <a:pt x="333496" y="103766"/>
                    <a:pt x="316357" y="97314"/>
                    <a:pt x="316357" y="97314"/>
                  </a:cubicBezTo>
                  <a:cubicBezTo>
                    <a:pt x="301911" y="98759"/>
                    <a:pt x="286286" y="95752"/>
                    <a:pt x="273020" y="101648"/>
                  </a:cubicBezTo>
                  <a:cubicBezTo>
                    <a:pt x="268846" y="103503"/>
                    <a:pt x="274500" y="111082"/>
                    <a:pt x="277354" y="114649"/>
                  </a:cubicBezTo>
                  <a:cubicBezTo>
                    <a:pt x="280608" y="118716"/>
                    <a:pt x="286117" y="120289"/>
                    <a:pt x="290355" y="123316"/>
                  </a:cubicBezTo>
                  <a:cubicBezTo>
                    <a:pt x="296232" y="127514"/>
                    <a:pt x="301418" y="132733"/>
                    <a:pt x="307689" y="136317"/>
                  </a:cubicBezTo>
                  <a:cubicBezTo>
                    <a:pt x="311655" y="138583"/>
                    <a:pt x="316604" y="138608"/>
                    <a:pt x="320690" y="140651"/>
                  </a:cubicBezTo>
                  <a:cubicBezTo>
                    <a:pt x="331623" y="146118"/>
                    <a:pt x="334297" y="149924"/>
                    <a:pt x="342359" y="157985"/>
                  </a:cubicBezTo>
                  <a:cubicBezTo>
                    <a:pt x="345248" y="166652"/>
                    <a:pt x="351785" y="174882"/>
                    <a:pt x="351026" y="183987"/>
                  </a:cubicBezTo>
                  <a:cubicBezTo>
                    <a:pt x="349581" y="201322"/>
                    <a:pt x="348849" y="218731"/>
                    <a:pt x="346692" y="235991"/>
                  </a:cubicBezTo>
                  <a:cubicBezTo>
                    <a:pt x="345953" y="241901"/>
                    <a:pt x="345023" y="247999"/>
                    <a:pt x="342359" y="253326"/>
                  </a:cubicBezTo>
                  <a:cubicBezTo>
                    <a:pt x="337701" y="262643"/>
                    <a:pt x="330802" y="270661"/>
                    <a:pt x="325024" y="279328"/>
                  </a:cubicBezTo>
                  <a:cubicBezTo>
                    <a:pt x="322135" y="283661"/>
                    <a:pt x="320040" y="288645"/>
                    <a:pt x="316357" y="292328"/>
                  </a:cubicBezTo>
                  <a:lnTo>
                    <a:pt x="294688" y="313997"/>
                  </a:lnTo>
                  <a:cubicBezTo>
                    <a:pt x="290355" y="318331"/>
                    <a:pt x="287502" y="325060"/>
                    <a:pt x="281688" y="326998"/>
                  </a:cubicBezTo>
                  <a:lnTo>
                    <a:pt x="255686" y="335665"/>
                  </a:lnTo>
                  <a:cubicBezTo>
                    <a:pt x="251352" y="332776"/>
                    <a:pt x="245446" y="331415"/>
                    <a:pt x="242685" y="326998"/>
                  </a:cubicBezTo>
                  <a:cubicBezTo>
                    <a:pt x="237843" y="319251"/>
                    <a:pt x="236233" y="309860"/>
                    <a:pt x="234017" y="300996"/>
                  </a:cubicBezTo>
                  <a:cubicBezTo>
                    <a:pt x="228576" y="279229"/>
                    <a:pt x="231568" y="289311"/>
                    <a:pt x="225350" y="270660"/>
                  </a:cubicBezTo>
                  <a:cubicBezTo>
                    <a:pt x="222374" y="231978"/>
                    <a:pt x="230977" y="223676"/>
                    <a:pt x="212349" y="201322"/>
                  </a:cubicBezTo>
                  <a:cubicBezTo>
                    <a:pt x="208426" y="196614"/>
                    <a:pt x="203111" y="193159"/>
                    <a:pt x="199348" y="188321"/>
                  </a:cubicBezTo>
                  <a:cubicBezTo>
                    <a:pt x="192953" y="180098"/>
                    <a:pt x="189380" y="169685"/>
                    <a:pt x="182014" y="162319"/>
                  </a:cubicBezTo>
                  <a:lnTo>
                    <a:pt x="164679" y="144984"/>
                  </a:lnTo>
                  <a:cubicBezTo>
                    <a:pt x="163234" y="140650"/>
                    <a:pt x="162388" y="136069"/>
                    <a:pt x="160345" y="131983"/>
                  </a:cubicBezTo>
                  <a:cubicBezTo>
                    <a:pt x="154879" y="121052"/>
                    <a:pt x="151071" y="118376"/>
                    <a:pt x="143011" y="110315"/>
                  </a:cubicBezTo>
                  <a:cubicBezTo>
                    <a:pt x="132696" y="79372"/>
                    <a:pt x="139411" y="91915"/>
                    <a:pt x="125676" y="71312"/>
                  </a:cubicBezTo>
                  <a:cubicBezTo>
                    <a:pt x="118151" y="48733"/>
                    <a:pt x="126273" y="66641"/>
                    <a:pt x="112675" y="49644"/>
                  </a:cubicBezTo>
                  <a:cubicBezTo>
                    <a:pt x="109421" y="45577"/>
                    <a:pt x="87395" y="8474"/>
                    <a:pt x="78006" y="1974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Gruppo 39">
            <a:extLst>
              <a:ext uri="{FF2B5EF4-FFF2-40B4-BE49-F238E27FC236}">
                <a16:creationId xmlns:a16="http://schemas.microsoft.com/office/drawing/2014/main" id="{C1526A13-5C44-E646-AF97-EDABA384D206}"/>
              </a:ext>
            </a:extLst>
          </p:cNvPr>
          <p:cNvGrpSpPr/>
          <p:nvPr/>
        </p:nvGrpSpPr>
        <p:grpSpPr>
          <a:xfrm>
            <a:off x="10717352" y="3492347"/>
            <a:ext cx="1299600" cy="1332000"/>
            <a:chOff x="1576809" y="3711388"/>
            <a:chExt cx="2449625" cy="2706486"/>
          </a:xfrm>
        </p:grpSpPr>
        <p:pic>
          <p:nvPicPr>
            <p:cNvPr id="49" name="Immagine 34">
              <a:extLst>
                <a:ext uri="{FF2B5EF4-FFF2-40B4-BE49-F238E27FC236}">
                  <a16:creationId xmlns:a16="http://schemas.microsoft.com/office/drawing/2014/main" id="{014B6067-7663-DB4D-A19A-0515CD4752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59" t="21893" r="20940" b="22241"/>
            <a:stretch/>
          </p:blipFill>
          <p:spPr>
            <a:xfrm>
              <a:off x="1576809" y="3711388"/>
              <a:ext cx="2449625" cy="2706486"/>
            </a:xfrm>
            <a:prstGeom prst="rect">
              <a:avLst/>
            </a:prstGeom>
          </p:spPr>
        </p:pic>
        <p:sp>
          <p:nvSpPr>
            <p:cNvPr id="50" name="Figura a mano libera 36">
              <a:extLst>
                <a:ext uri="{FF2B5EF4-FFF2-40B4-BE49-F238E27FC236}">
                  <a16:creationId xmlns:a16="http://schemas.microsoft.com/office/drawing/2014/main" id="{CEF3EDB3-7C10-DA45-B68F-BB4C53E0062E}"/>
                </a:ext>
              </a:extLst>
            </p:cNvPr>
            <p:cNvSpPr/>
            <p:nvPr/>
          </p:nvSpPr>
          <p:spPr>
            <a:xfrm>
              <a:off x="2647842" y="5131041"/>
              <a:ext cx="364841" cy="251351"/>
            </a:xfrm>
            <a:custGeom>
              <a:avLst/>
              <a:gdLst>
                <a:gd name="connsiteX0" fmla="*/ 182031 w 364841"/>
                <a:gd name="connsiteY0" fmla="*/ 69338 h 251351"/>
                <a:gd name="connsiteX1" fmla="*/ 173364 w 364841"/>
                <a:gd name="connsiteY1" fmla="*/ 47670 h 251351"/>
                <a:gd name="connsiteX2" fmla="*/ 160363 w 364841"/>
                <a:gd name="connsiteY2" fmla="*/ 21668 h 251351"/>
                <a:gd name="connsiteX3" fmla="*/ 143028 w 364841"/>
                <a:gd name="connsiteY3" fmla="*/ 4333 h 251351"/>
                <a:gd name="connsiteX4" fmla="*/ 130027 w 364841"/>
                <a:gd name="connsiteY4" fmla="*/ 0 h 251351"/>
                <a:gd name="connsiteX5" fmla="*/ 108359 w 364841"/>
                <a:gd name="connsiteY5" fmla="*/ 26002 h 251351"/>
                <a:gd name="connsiteX6" fmla="*/ 104025 w 364841"/>
                <a:gd name="connsiteY6" fmla="*/ 39003 h 251351"/>
                <a:gd name="connsiteX7" fmla="*/ 99692 w 364841"/>
                <a:gd name="connsiteY7" fmla="*/ 69338 h 251351"/>
                <a:gd name="connsiteX8" fmla="*/ 95358 w 364841"/>
                <a:gd name="connsiteY8" fmla="*/ 82339 h 251351"/>
                <a:gd name="connsiteX9" fmla="*/ 91024 w 364841"/>
                <a:gd name="connsiteY9" fmla="*/ 117008 h 251351"/>
                <a:gd name="connsiteX10" fmla="*/ 73690 w 364841"/>
                <a:gd name="connsiteY10" fmla="*/ 143010 h 251351"/>
                <a:gd name="connsiteX11" fmla="*/ 4351 w 364841"/>
                <a:gd name="connsiteY11" fmla="*/ 151677 h 251351"/>
                <a:gd name="connsiteX12" fmla="*/ 18 w 364841"/>
                <a:gd name="connsiteY12" fmla="*/ 164678 h 251351"/>
                <a:gd name="connsiteX13" fmla="*/ 4351 w 364841"/>
                <a:gd name="connsiteY13" fmla="*/ 199348 h 251351"/>
                <a:gd name="connsiteX14" fmla="*/ 39021 w 364841"/>
                <a:gd name="connsiteY14" fmla="*/ 225350 h 251351"/>
                <a:gd name="connsiteX15" fmla="*/ 52022 w 364841"/>
                <a:gd name="connsiteY15" fmla="*/ 234017 h 251351"/>
                <a:gd name="connsiteX16" fmla="*/ 104025 w 364841"/>
                <a:gd name="connsiteY16" fmla="*/ 242684 h 251351"/>
                <a:gd name="connsiteX17" fmla="*/ 173364 w 364841"/>
                <a:gd name="connsiteY17" fmla="*/ 234017 h 251351"/>
                <a:gd name="connsiteX18" fmla="*/ 186365 w 364841"/>
                <a:gd name="connsiteY18" fmla="*/ 225350 h 251351"/>
                <a:gd name="connsiteX19" fmla="*/ 195032 w 364841"/>
                <a:gd name="connsiteY19" fmla="*/ 216682 h 251351"/>
                <a:gd name="connsiteX20" fmla="*/ 216700 w 364841"/>
                <a:gd name="connsiteY20" fmla="*/ 221016 h 251351"/>
                <a:gd name="connsiteX21" fmla="*/ 225367 w 364841"/>
                <a:gd name="connsiteY21" fmla="*/ 234017 h 251351"/>
                <a:gd name="connsiteX22" fmla="*/ 247036 w 364841"/>
                <a:gd name="connsiteY22" fmla="*/ 251351 h 251351"/>
                <a:gd name="connsiteX23" fmla="*/ 333709 w 364841"/>
                <a:gd name="connsiteY23" fmla="*/ 238350 h 251351"/>
                <a:gd name="connsiteX24" fmla="*/ 346710 w 364841"/>
                <a:gd name="connsiteY24" fmla="*/ 229683 h 251351"/>
                <a:gd name="connsiteX25" fmla="*/ 359711 w 364841"/>
                <a:gd name="connsiteY25" fmla="*/ 177679 h 251351"/>
                <a:gd name="connsiteX26" fmla="*/ 351043 w 364841"/>
                <a:gd name="connsiteY26" fmla="*/ 169012 h 251351"/>
                <a:gd name="connsiteX27" fmla="*/ 342376 w 364841"/>
                <a:gd name="connsiteY27" fmla="*/ 156011 h 251351"/>
                <a:gd name="connsiteX28" fmla="*/ 307707 w 364841"/>
                <a:gd name="connsiteY28" fmla="*/ 151677 h 251351"/>
                <a:gd name="connsiteX29" fmla="*/ 294706 w 364841"/>
                <a:gd name="connsiteY29" fmla="*/ 143010 h 251351"/>
                <a:gd name="connsiteX30" fmla="*/ 281705 w 364841"/>
                <a:gd name="connsiteY30" fmla="*/ 117008 h 251351"/>
                <a:gd name="connsiteX31" fmla="*/ 290372 w 364841"/>
                <a:gd name="connsiteY31" fmla="*/ 65004 h 251351"/>
                <a:gd name="connsiteX32" fmla="*/ 294706 w 364841"/>
                <a:gd name="connsiteY32" fmla="*/ 52004 h 251351"/>
                <a:gd name="connsiteX33" fmla="*/ 277371 w 364841"/>
                <a:gd name="connsiteY33" fmla="*/ 21668 h 251351"/>
                <a:gd name="connsiteX34" fmla="*/ 251369 w 364841"/>
                <a:gd name="connsiteY34" fmla="*/ 13001 h 251351"/>
                <a:gd name="connsiteX35" fmla="*/ 212367 w 364841"/>
                <a:gd name="connsiteY35" fmla="*/ 21668 h 251351"/>
                <a:gd name="connsiteX36" fmla="*/ 203699 w 364841"/>
                <a:gd name="connsiteY36" fmla="*/ 30335 h 251351"/>
                <a:gd name="connsiteX37" fmla="*/ 182031 w 364841"/>
                <a:gd name="connsiteY37" fmla="*/ 69338 h 2513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</a:cxnLst>
              <a:rect l="l" t="t" r="r" b="b"/>
              <a:pathLst>
                <a:path w="364841" h="251351">
                  <a:moveTo>
                    <a:pt x="182031" y="69338"/>
                  </a:moveTo>
                  <a:cubicBezTo>
                    <a:pt x="176975" y="72227"/>
                    <a:pt x="176095" y="54954"/>
                    <a:pt x="173364" y="47670"/>
                  </a:cubicBezTo>
                  <a:cubicBezTo>
                    <a:pt x="168238" y="34001"/>
                    <a:pt x="170589" y="33598"/>
                    <a:pt x="160363" y="21668"/>
                  </a:cubicBezTo>
                  <a:cubicBezTo>
                    <a:pt x="155045" y="15463"/>
                    <a:pt x="150781" y="6917"/>
                    <a:pt x="143028" y="4333"/>
                  </a:cubicBezTo>
                  <a:lnTo>
                    <a:pt x="130027" y="0"/>
                  </a:lnTo>
                  <a:cubicBezTo>
                    <a:pt x="120442" y="9585"/>
                    <a:pt x="114393" y="13934"/>
                    <a:pt x="108359" y="26002"/>
                  </a:cubicBezTo>
                  <a:cubicBezTo>
                    <a:pt x="106316" y="30088"/>
                    <a:pt x="105470" y="34669"/>
                    <a:pt x="104025" y="39003"/>
                  </a:cubicBezTo>
                  <a:cubicBezTo>
                    <a:pt x="102581" y="49115"/>
                    <a:pt x="101695" y="59322"/>
                    <a:pt x="99692" y="69338"/>
                  </a:cubicBezTo>
                  <a:cubicBezTo>
                    <a:pt x="98796" y="73817"/>
                    <a:pt x="96175" y="77845"/>
                    <a:pt x="95358" y="82339"/>
                  </a:cubicBezTo>
                  <a:cubicBezTo>
                    <a:pt x="93274" y="93797"/>
                    <a:pt x="94941" y="106040"/>
                    <a:pt x="91024" y="117008"/>
                  </a:cubicBezTo>
                  <a:cubicBezTo>
                    <a:pt x="87521" y="126818"/>
                    <a:pt x="83572" y="139716"/>
                    <a:pt x="73690" y="143010"/>
                  </a:cubicBezTo>
                  <a:cubicBezTo>
                    <a:pt x="42821" y="153300"/>
                    <a:pt x="65244" y="146994"/>
                    <a:pt x="4351" y="151677"/>
                  </a:cubicBezTo>
                  <a:cubicBezTo>
                    <a:pt x="2907" y="156011"/>
                    <a:pt x="18" y="160110"/>
                    <a:pt x="18" y="164678"/>
                  </a:cubicBezTo>
                  <a:cubicBezTo>
                    <a:pt x="18" y="176325"/>
                    <a:pt x="-530" y="188773"/>
                    <a:pt x="4351" y="199348"/>
                  </a:cubicBezTo>
                  <a:cubicBezTo>
                    <a:pt x="16893" y="226523"/>
                    <a:pt x="21856" y="216767"/>
                    <a:pt x="39021" y="225350"/>
                  </a:cubicBezTo>
                  <a:cubicBezTo>
                    <a:pt x="43679" y="227679"/>
                    <a:pt x="47145" y="232188"/>
                    <a:pt x="52022" y="234017"/>
                  </a:cubicBezTo>
                  <a:cubicBezTo>
                    <a:pt x="59817" y="236940"/>
                    <a:pt x="99527" y="242041"/>
                    <a:pt x="104025" y="242684"/>
                  </a:cubicBezTo>
                  <a:cubicBezTo>
                    <a:pt x="114767" y="241858"/>
                    <a:pt x="154657" y="243370"/>
                    <a:pt x="173364" y="234017"/>
                  </a:cubicBezTo>
                  <a:cubicBezTo>
                    <a:pt x="178023" y="231688"/>
                    <a:pt x="182298" y="228604"/>
                    <a:pt x="186365" y="225350"/>
                  </a:cubicBezTo>
                  <a:cubicBezTo>
                    <a:pt x="189556" y="222798"/>
                    <a:pt x="192143" y="219571"/>
                    <a:pt x="195032" y="216682"/>
                  </a:cubicBezTo>
                  <a:cubicBezTo>
                    <a:pt x="202255" y="218127"/>
                    <a:pt x="210305" y="217361"/>
                    <a:pt x="216700" y="221016"/>
                  </a:cubicBezTo>
                  <a:cubicBezTo>
                    <a:pt x="221222" y="223600"/>
                    <a:pt x="222113" y="229950"/>
                    <a:pt x="225367" y="234017"/>
                  </a:cubicBezTo>
                  <a:cubicBezTo>
                    <a:pt x="232423" y="242837"/>
                    <a:pt x="237385" y="244917"/>
                    <a:pt x="247036" y="251351"/>
                  </a:cubicBezTo>
                  <a:cubicBezTo>
                    <a:pt x="260609" y="250382"/>
                    <a:pt x="313802" y="251621"/>
                    <a:pt x="333709" y="238350"/>
                  </a:cubicBezTo>
                  <a:lnTo>
                    <a:pt x="346710" y="229683"/>
                  </a:lnTo>
                  <a:cubicBezTo>
                    <a:pt x="363183" y="204972"/>
                    <a:pt x="370594" y="206699"/>
                    <a:pt x="359711" y="177679"/>
                  </a:cubicBezTo>
                  <a:cubicBezTo>
                    <a:pt x="358276" y="173853"/>
                    <a:pt x="353595" y="172203"/>
                    <a:pt x="351043" y="169012"/>
                  </a:cubicBezTo>
                  <a:cubicBezTo>
                    <a:pt x="347789" y="164945"/>
                    <a:pt x="347212" y="157945"/>
                    <a:pt x="342376" y="156011"/>
                  </a:cubicBezTo>
                  <a:cubicBezTo>
                    <a:pt x="331563" y="151686"/>
                    <a:pt x="319263" y="153122"/>
                    <a:pt x="307707" y="151677"/>
                  </a:cubicBezTo>
                  <a:cubicBezTo>
                    <a:pt x="303373" y="148788"/>
                    <a:pt x="298389" y="146693"/>
                    <a:pt x="294706" y="143010"/>
                  </a:cubicBezTo>
                  <a:cubicBezTo>
                    <a:pt x="286306" y="134610"/>
                    <a:pt x="285230" y="127581"/>
                    <a:pt x="281705" y="117008"/>
                  </a:cubicBezTo>
                  <a:cubicBezTo>
                    <a:pt x="284149" y="99901"/>
                    <a:pt x="286150" y="81891"/>
                    <a:pt x="290372" y="65004"/>
                  </a:cubicBezTo>
                  <a:cubicBezTo>
                    <a:pt x="291480" y="60573"/>
                    <a:pt x="293261" y="56337"/>
                    <a:pt x="294706" y="52004"/>
                  </a:cubicBezTo>
                  <a:cubicBezTo>
                    <a:pt x="290670" y="31826"/>
                    <a:pt x="295568" y="29755"/>
                    <a:pt x="277371" y="21668"/>
                  </a:cubicBezTo>
                  <a:cubicBezTo>
                    <a:pt x="269022" y="17958"/>
                    <a:pt x="251369" y="13001"/>
                    <a:pt x="251369" y="13001"/>
                  </a:cubicBezTo>
                  <a:cubicBezTo>
                    <a:pt x="246112" y="13877"/>
                    <a:pt x="220576" y="16742"/>
                    <a:pt x="212367" y="21668"/>
                  </a:cubicBezTo>
                  <a:cubicBezTo>
                    <a:pt x="208863" y="23770"/>
                    <a:pt x="206588" y="27446"/>
                    <a:pt x="203699" y="30335"/>
                  </a:cubicBezTo>
                  <a:cubicBezTo>
                    <a:pt x="198909" y="44707"/>
                    <a:pt x="187087" y="66449"/>
                    <a:pt x="182031" y="69338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Figura a mano libera 37">
              <a:extLst>
                <a:ext uri="{FF2B5EF4-FFF2-40B4-BE49-F238E27FC236}">
                  <a16:creationId xmlns:a16="http://schemas.microsoft.com/office/drawing/2014/main" id="{D29EBB3D-E3F9-BB4D-86EF-323A31CFEA2D}"/>
                </a:ext>
              </a:extLst>
            </p:cNvPr>
            <p:cNvSpPr/>
            <p:nvPr/>
          </p:nvSpPr>
          <p:spPr>
            <a:xfrm>
              <a:off x="2984222" y="5329848"/>
              <a:ext cx="326860" cy="416571"/>
            </a:xfrm>
            <a:custGeom>
              <a:avLst/>
              <a:gdLst>
                <a:gd name="connsiteX0" fmla="*/ 75334 w 326860"/>
                <a:gd name="connsiteY0" fmla="*/ 541 h 416571"/>
                <a:gd name="connsiteX1" fmla="*/ 97003 w 326860"/>
                <a:gd name="connsiteY1" fmla="*/ 9208 h 416571"/>
                <a:gd name="connsiteX2" fmla="*/ 214011 w 326860"/>
                <a:gd name="connsiteY2" fmla="*/ 17875 h 416571"/>
                <a:gd name="connsiteX3" fmla="*/ 240013 w 326860"/>
                <a:gd name="connsiteY3" fmla="*/ 26543 h 416571"/>
                <a:gd name="connsiteX4" fmla="*/ 266015 w 326860"/>
                <a:gd name="connsiteY4" fmla="*/ 39543 h 416571"/>
                <a:gd name="connsiteX5" fmla="*/ 305018 w 326860"/>
                <a:gd name="connsiteY5" fmla="*/ 69879 h 416571"/>
                <a:gd name="connsiteX6" fmla="*/ 313685 w 326860"/>
                <a:gd name="connsiteY6" fmla="*/ 82880 h 416571"/>
                <a:gd name="connsiteX7" fmla="*/ 322352 w 326860"/>
                <a:gd name="connsiteY7" fmla="*/ 108882 h 416571"/>
                <a:gd name="connsiteX8" fmla="*/ 326686 w 326860"/>
                <a:gd name="connsiteY8" fmla="*/ 121883 h 416571"/>
                <a:gd name="connsiteX9" fmla="*/ 322352 w 326860"/>
                <a:gd name="connsiteY9" fmla="*/ 147885 h 416571"/>
                <a:gd name="connsiteX10" fmla="*/ 287683 w 326860"/>
                <a:gd name="connsiteY10" fmla="*/ 143551 h 416571"/>
                <a:gd name="connsiteX11" fmla="*/ 270349 w 326860"/>
                <a:gd name="connsiteY11" fmla="*/ 147885 h 416571"/>
                <a:gd name="connsiteX12" fmla="*/ 257348 w 326860"/>
                <a:gd name="connsiteY12" fmla="*/ 173887 h 416571"/>
                <a:gd name="connsiteX13" fmla="*/ 253014 w 326860"/>
                <a:gd name="connsiteY13" fmla="*/ 186888 h 416571"/>
                <a:gd name="connsiteX14" fmla="*/ 248680 w 326860"/>
                <a:gd name="connsiteY14" fmla="*/ 256226 h 416571"/>
                <a:gd name="connsiteX15" fmla="*/ 222678 w 326860"/>
                <a:gd name="connsiteY15" fmla="*/ 264893 h 416571"/>
                <a:gd name="connsiteX16" fmla="*/ 196677 w 326860"/>
                <a:gd name="connsiteY16" fmla="*/ 260560 h 416571"/>
                <a:gd name="connsiteX17" fmla="*/ 170675 w 326860"/>
                <a:gd name="connsiteY17" fmla="*/ 251892 h 416571"/>
                <a:gd name="connsiteX18" fmla="*/ 157674 w 326860"/>
                <a:gd name="connsiteY18" fmla="*/ 256226 h 416571"/>
                <a:gd name="connsiteX19" fmla="*/ 131672 w 326860"/>
                <a:gd name="connsiteY19" fmla="*/ 286561 h 416571"/>
                <a:gd name="connsiteX20" fmla="*/ 114337 w 326860"/>
                <a:gd name="connsiteY20" fmla="*/ 308230 h 416571"/>
                <a:gd name="connsiteX21" fmla="*/ 105670 w 326860"/>
                <a:gd name="connsiteY21" fmla="*/ 334232 h 416571"/>
                <a:gd name="connsiteX22" fmla="*/ 101336 w 326860"/>
                <a:gd name="connsiteY22" fmla="*/ 347233 h 416571"/>
                <a:gd name="connsiteX23" fmla="*/ 79668 w 326860"/>
                <a:gd name="connsiteY23" fmla="*/ 377568 h 416571"/>
                <a:gd name="connsiteX24" fmla="*/ 71001 w 326860"/>
                <a:gd name="connsiteY24" fmla="*/ 390569 h 416571"/>
                <a:gd name="connsiteX25" fmla="*/ 49333 w 326860"/>
                <a:gd name="connsiteY25" fmla="*/ 407904 h 416571"/>
                <a:gd name="connsiteX26" fmla="*/ 14663 w 326860"/>
                <a:gd name="connsiteY26" fmla="*/ 416571 h 416571"/>
                <a:gd name="connsiteX27" fmla="*/ 1662 w 326860"/>
                <a:gd name="connsiteY27" fmla="*/ 403570 h 416571"/>
                <a:gd name="connsiteX28" fmla="*/ 14663 w 326860"/>
                <a:gd name="connsiteY28" fmla="*/ 360234 h 416571"/>
                <a:gd name="connsiteX29" fmla="*/ 18997 w 326860"/>
                <a:gd name="connsiteY29" fmla="*/ 347233 h 416571"/>
                <a:gd name="connsiteX30" fmla="*/ 27664 w 326860"/>
                <a:gd name="connsiteY30" fmla="*/ 334232 h 416571"/>
                <a:gd name="connsiteX31" fmla="*/ 36332 w 326860"/>
                <a:gd name="connsiteY31" fmla="*/ 308230 h 416571"/>
                <a:gd name="connsiteX32" fmla="*/ 40665 w 326860"/>
                <a:gd name="connsiteY32" fmla="*/ 282228 h 416571"/>
                <a:gd name="connsiteX33" fmla="*/ 44999 w 326860"/>
                <a:gd name="connsiteY33" fmla="*/ 269227 h 416571"/>
                <a:gd name="connsiteX34" fmla="*/ 71001 w 326860"/>
                <a:gd name="connsiteY34" fmla="*/ 260560 h 416571"/>
                <a:gd name="connsiteX35" fmla="*/ 97003 w 326860"/>
                <a:gd name="connsiteY35" fmla="*/ 243225 h 416571"/>
                <a:gd name="connsiteX36" fmla="*/ 110004 w 326860"/>
                <a:gd name="connsiteY36" fmla="*/ 217223 h 416571"/>
                <a:gd name="connsiteX37" fmla="*/ 118671 w 326860"/>
                <a:gd name="connsiteY37" fmla="*/ 204222 h 416571"/>
                <a:gd name="connsiteX38" fmla="*/ 114337 w 326860"/>
                <a:gd name="connsiteY38" fmla="*/ 178220 h 416571"/>
                <a:gd name="connsiteX39" fmla="*/ 88335 w 326860"/>
                <a:gd name="connsiteY39" fmla="*/ 160886 h 416571"/>
                <a:gd name="connsiteX40" fmla="*/ 66667 w 326860"/>
                <a:gd name="connsiteY40" fmla="*/ 143551 h 416571"/>
                <a:gd name="connsiteX41" fmla="*/ 58000 w 326860"/>
                <a:gd name="connsiteY41" fmla="*/ 117549 h 416571"/>
                <a:gd name="connsiteX42" fmla="*/ 53666 w 326860"/>
                <a:gd name="connsiteY42" fmla="*/ 104548 h 416571"/>
                <a:gd name="connsiteX43" fmla="*/ 49333 w 326860"/>
                <a:gd name="connsiteY43" fmla="*/ 82880 h 416571"/>
                <a:gd name="connsiteX44" fmla="*/ 53666 w 326860"/>
                <a:gd name="connsiteY44" fmla="*/ 26543 h 416571"/>
                <a:gd name="connsiteX45" fmla="*/ 75334 w 326860"/>
                <a:gd name="connsiteY45" fmla="*/ 541 h 4165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</a:cxnLst>
              <a:rect l="l" t="t" r="r" b="b"/>
              <a:pathLst>
                <a:path w="326860" h="416571">
                  <a:moveTo>
                    <a:pt x="75334" y="541"/>
                  </a:moveTo>
                  <a:cubicBezTo>
                    <a:pt x="82557" y="-2348"/>
                    <a:pt x="89498" y="7161"/>
                    <a:pt x="97003" y="9208"/>
                  </a:cubicBezTo>
                  <a:cubicBezTo>
                    <a:pt x="126601" y="17280"/>
                    <a:pt x="205337" y="17462"/>
                    <a:pt x="214011" y="17875"/>
                  </a:cubicBezTo>
                  <a:cubicBezTo>
                    <a:pt x="222678" y="20764"/>
                    <a:pt x="232411" y="21475"/>
                    <a:pt x="240013" y="26543"/>
                  </a:cubicBezTo>
                  <a:cubicBezTo>
                    <a:pt x="256815" y="37744"/>
                    <a:pt x="248073" y="33563"/>
                    <a:pt x="266015" y="39543"/>
                  </a:cubicBezTo>
                  <a:cubicBezTo>
                    <a:pt x="284134" y="51622"/>
                    <a:pt x="292289" y="54604"/>
                    <a:pt x="305018" y="69879"/>
                  </a:cubicBezTo>
                  <a:cubicBezTo>
                    <a:pt x="308352" y="73880"/>
                    <a:pt x="311570" y="78121"/>
                    <a:pt x="313685" y="82880"/>
                  </a:cubicBezTo>
                  <a:cubicBezTo>
                    <a:pt x="317395" y="91229"/>
                    <a:pt x="319463" y="100215"/>
                    <a:pt x="322352" y="108882"/>
                  </a:cubicBezTo>
                  <a:lnTo>
                    <a:pt x="326686" y="121883"/>
                  </a:lnTo>
                  <a:cubicBezTo>
                    <a:pt x="325241" y="130550"/>
                    <a:pt x="330033" y="143618"/>
                    <a:pt x="322352" y="147885"/>
                  </a:cubicBezTo>
                  <a:cubicBezTo>
                    <a:pt x="312171" y="153541"/>
                    <a:pt x="299329" y="143551"/>
                    <a:pt x="287683" y="143551"/>
                  </a:cubicBezTo>
                  <a:cubicBezTo>
                    <a:pt x="281727" y="143551"/>
                    <a:pt x="276127" y="146440"/>
                    <a:pt x="270349" y="147885"/>
                  </a:cubicBezTo>
                  <a:cubicBezTo>
                    <a:pt x="259455" y="180564"/>
                    <a:pt x="274150" y="140283"/>
                    <a:pt x="257348" y="173887"/>
                  </a:cubicBezTo>
                  <a:cubicBezTo>
                    <a:pt x="255305" y="177973"/>
                    <a:pt x="254459" y="182554"/>
                    <a:pt x="253014" y="186888"/>
                  </a:cubicBezTo>
                  <a:cubicBezTo>
                    <a:pt x="251569" y="210001"/>
                    <a:pt x="257074" y="234643"/>
                    <a:pt x="248680" y="256226"/>
                  </a:cubicBezTo>
                  <a:cubicBezTo>
                    <a:pt x="245369" y="264741"/>
                    <a:pt x="222678" y="264893"/>
                    <a:pt x="222678" y="264893"/>
                  </a:cubicBezTo>
                  <a:cubicBezTo>
                    <a:pt x="214011" y="263449"/>
                    <a:pt x="205201" y="262691"/>
                    <a:pt x="196677" y="260560"/>
                  </a:cubicBezTo>
                  <a:cubicBezTo>
                    <a:pt x="187814" y="258344"/>
                    <a:pt x="170675" y="251892"/>
                    <a:pt x="170675" y="251892"/>
                  </a:cubicBezTo>
                  <a:cubicBezTo>
                    <a:pt x="166341" y="253337"/>
                    <a:pt x="161391" y="253571"/>
                    <a:pt x="157674" y="256226"/>
                  </a:cubicBezTo>
                  <a:cubicBezTo>
                    <a:pt x="138203" y="270134"/>
                    <a:pt x="143886" y="271293"/>
                    <a:pt x="131672" y="286561"/>
                  </a:cubicBezTo>
                  <a:cubicBezTo>
                    <a:pt x="106970" y="317440"/>
                    <a:pt x="141018" y="268211"/>
                    <a:pt x="114337" y="308230"/>
                  </a:cubicBezTo>
                  <a:lnTo>
                    <a:pt x="105670" y="334232"/>
                  </a:lnTo>
                  <a:cubicBezTo>
                    <a:pt x="104225" y="338566"/>
                    <a:pt x="103870" y="343432"/>
                    <a:pt x="101336" y="347233"/>
                  </a:cubicBezTo>
                  <a:cubicBezTo>
                    <a:pt x="80910" y="377872"/>
                    <a:pt x="106544" y="339941"/>
                    <a:pt x="79668" y="377568"/>
                  </a:cubicBezTo>
                  <a:cubicBezTo>
                    <a:pt x="76641" y="381806"/>
                    <a:pt x="74255" y="386502"/>
                    <a:pt x="71001" y="390569"/>
                  </a:cubicBezTo>
                  <a:cubicBezTo>
                    <a:pt x="65629" y="397284"/>
                    <a:pt x="56836" y="404152"/>
                    <a:pt x="49333" y="407904"/>
                  </a:cubicBezTo>
                  <a:cubicBezTo>
                    <a:pt x="40453" y="412344"/>
                    <a:pt x="22897" y="414924"/>
                    <a:pt x="14663" y="416571"/>
                  </a:cubicBezTo>
                  <a:cubicBezTo>
                    <a:pt x="10329" y="412237"/>
                    <a:pt x="2864" y="409580"/>
                    <a:pt x="1662" y="403570"/>
                  </a:cubicBezTo>
                  <a:cubicBezTo>
                    <a:pt x="-3967" y="375422"/>
                    <a:pt x="5785" y="377989"/>
                    <a:pt x="14663" y="360234"/>
                  </a:cubicBezTo>
                  <a:cubicBezTo>
                    <a:pt x="16706" y="356148"/>
                    <a:pt x="16954" y="351319"/>
                    <a:pt x="18997" y="347233"/>
                  </a:cubicBezTo>
                  <a:cubicBezTo>
                    <a:pt x="21326" y="342575"/>
                    <a:pt x="25549" y="338991"/>
                    <a:pt x="27664" y="334232"/>
                  </a:cubicBezTo>
                  <a:cubicBezTo>
                    <a:pt x="31375" y="325883"/>
                    <a:pt x="36332" y="308230"/>
                    <a:pt x="36332" y="308230"/>
                  </a:cubicBezTo>
                  <a:cubicBezTo>
                    <a:pt x="37776" y="299563"/>
                    <a:pt x="38759" y="290806"/>
                    <a:pt x="40665" y="282228"/>
                  </a:cubicBezTo>
                  <a:cubicBezTo>
                    <a:pt x="41656" y="277769"/>
                    <a:pt x="41282" y="271882"/>
                    <a:pt x="44999" y="269227"/>
                  </a:cubicBezTo>
                  <a:cubicBezTo>
                    <a:pt x="52433" y="263917"/>
                    <a:pt x="71001" y="260560"/>
                    <a:pt x="71001" y="260560"/>
                  </a:cubicBezTo>
                  <a:cubicBezTo>
                    <a:pt x="79668" y="254782"/>
                    <a:pt x="91225" y="251892"/>
                    <a:pt x="97003" y="243225"/>
                  </a:cubicBezTo>
                  <a:cubicBezTo>
                    <a:pt x="121841" y="205966"/>
                    <a:pt x="92062" y="253107"/>
                    <a:pt x="110004" y="217223"/>
                  </a:cubicBezTo>
                  <a:cubicBezTo>
                    <a:pt x="112333" y="212565"/>
                    <a:pt x="115782" y="208556"/>
                    <a:pt x="118671" y="204222"/>
                  </a:cubicBezTo>
                  <a:cubicBezTo>
                    <a:pt x="117226" y="195555"/>
                    <a:pt x="119376" y="185418"/>
                    <a:pt x="114337" y="178220"/>
                  </a:cubicBezTo>
                  <a:cubicBezTo>
                    <a:pt x="108363" y="169686"/>
                    <a:pt x="95700" y="168252"/>
                    <a:pt x="88335" y="160886"/>
                  </a:cubicBezTo>
                  <a:cubicBezTo>
                    <a:pt x="75985" y="148535"/>
                    <a:pt x="83068" y="154484"/>
                    <a:pt x="66667" y="143551"/>
                  </a:cubicBezTo>
                  <a:lnTo>
                    <a:pt x="58000" y="117549"/>
                  </a:lnTo>
                  <a:cubicBezTo>
                    <a:pt x="56555" y="113215"/>
                    <a:pt x="54562" y="109027"/>
                    <a:pt x="53666" y="104548"/>
                  </a:cubicBezTo>
                  <a:lnTo>
                    <a:pt x="49333" y="82880"/>
                  </a:lnTo>
                  <a:cubicBezTo>
                    <a:pt x="50777" y="64101"/>
                    <a:pt x="49973" y="45012"/>
                    <a:pt x="53666" y="26543"/>
                  </a:cubicBezTo>
                  <a:cubicBezTo>
                    <a:pt x="54467" y="22536"/>
                    <a:pt x="68111" y="3430"/>
                    <a:pt x="75334" y="541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Figura a mano libera 38">
              <a:extLst>
                <a:ext uri="{FF2B5EF4-FFF2-40B4-BE49-F238E27FC236}">
                  <a16:creationId xmlns:a16="http://schemas.microsoft.com/office/drawing/2014/main" id="{CF8390D3-CACA-1946-AB3A-4A8A6CD90ADF}"/>
                </a:ext>
              </a:extLst>
            </p:cNvPr>
            <p:cNvSpPr/>
            <p:nvPr/>
          </p:nvSpPr>
          <p:spPr>
            <a:xfrm>
              <a:off x="2344504" y="5334136"/>
              <a:ext cx="404423" cy="429618"/>
            </a:xfrm>
            <a:custGeom>
              <a:avLst/>
              <a:gdLst>
                <a:gd name="connsiteX0" fmla="*/ 229684 w 404423"/>
                <a:gd name="connsiteY0" fmla="*/ 586 h 429618"/>
                <a:gd name="connsiteX1" fmla="*/ 134343 w 404423"/>
                <a:gd name="connsiteY1" fmla="*/ 4920 h 429618"/>
                <a:gd name="connsiteX2" fmla="*/ 99674 w 404423"/>
                <a:gd name="connsiteY2" fmla="*/ 9254 h 429618"/>
                <a:gd name="connsiteX3" fmla="*/ 73672 w 404423"/>
                <a:gd name="connsiteY3" fmla="*/ 17921 h 429618"/>
                <a:gd name="connsiteX4" fmla="*/ 60671 w 404423"/>
                <a:gd name="connsiteY4" fmla="*/ 30922 h 429618"/>
                <a:gd name="connsiteX5" fmla="*/ 26002 w 404423"/>
                <a:gd name="connsiteY5" fmla="*/ 56924 h 429618"/>
                <a:gd name="connsiteX6" fmla="*/ 8668 w 404423"/>
                <a:gd name="connsiteY6" fmla="*/ 82926 h 429618"/>
                <a:gd name="connsiteX7" fmla="*/ 0 w 404423"/>
                <a:gd name="connsiteY7" fmla="*/ 108928 h 429618"/>
                <a:gd name="connsiteX8" fmla="*/ 13001 w 404423"/>
                <a:gd name="connsiteY8" fmla="*/ 156598 h 429618"/>
                <a:gd name="connsiteX9" fmla="*/ 26002 w 404423"/>
                <a:gd name="connsiteY9" fmla="*/ 160931 h 429618"/>
                <a:gd name="connsiteX10" fmla="*/ 43337 w 404423"/>
                <a:gd name="connsiteY10" fmla="*/ 178266 h 429618"/>
                <a:gd name="connsiteX11" fmla="*/ 56338 w 404423"/>
                <a:gd name="connsiteY11" fmla="*/ 208601 h 429618"/>
                <a:gd name="connsiteX12" fmla="*/ 60671 w 404423"/>
                <a:gd name="connsiteY12" fmla="*/ 221602 h 429618"/>
                <a:gd name="connsiteX13" fmla="*/ 73672 w 404423"/>
                <a:gd name="connsiteY13" fmla="*/ 230270 h 429618"/>
                <a:gd name="connsiteX14" fmla="*/ 95341 w 404423"/>
                <a:gd name="connsiteY14" fmla="*/ 251938 h 429618"/>
                <a:gd name="connsiteX15" fmla="*/ 108341 w 404423"/>
                <a:gd name="connsiteY15" fmla="*/ 260605 h 429618"/>
                <a:gd name="connsiteX16" fmla="*/ 117009 w 404423"/>
                <a:gd name="connsiteY16" fmla="*/ 269273 h 429618"/>
                <a:gd name="connsiteX17" fmla="*/ 130010 w 404423"/>
                <a:gd name="connsiteY17" fmla="*/ 273606 h 429618"/>
                <a:gd name="connsiteX18" fmla="*/ 143011 w 404423"/>
                <a:gd name="connsiteY18" fmla="*/ 286607 h 429618"/>
                <a:gd name="connsiteX19" fmla="*/ 151678 w 404423"/>
                <a:gd name="connsiteY19" fmla="*/ 299608 h 429618"/>
                <a:gd name="connsiteX20" fmla="*/ 164679 w 404423"/>
                <a:gd name="connsiteY20" fmla="*/ 308275 h 429618"/>
                <a:gd name="connsiteX21" fmla="*/ 182014 w 404423"/>
                <a:gd name="connsiteY21" fmla="*/ 325610 h 429618"/>
                <a:gd name="connsiteX22" fmla="*/ 195014 w 404423"/>
                <a:gd name="connsiteY22" fmla="*/ 364613 h 429618"/>
                <a:gd name="connsiteX23" fmla="*/ 225350 w 404423"/>
                <a:gd name="connsiteY23" fmla="*/ 368946 h 429618"/>
                <a:gd name="connsiteX24" fmla="*/ 277354 w 404423"/>
                <a:gd name="connsiteY24" fmla="*/ 386281 h 429618"/>
                <a:gd name="connsiteX25" fmla="*/ 290355 w 404423"/>
                <a:gd name="connsiteY25" fmla="*/ 390615 h 429618"/>
                <a:gd name="connsiteX26" fmla="*/ 303356 w 404423"/>
                <a:gd name="connsiteY26" fmla="*/ 399282 h 429618"/>
                <a:gd name="connsiteX27" fmla="*/ 316357 w 404423"/>
                <a:gd name="connsiteY27" fmla="*/ 403616 h 429618"/>
                <a:gd name="connsiteX28" fmla="*/ 355360 w 404423"/>
                <a:gd name="connsiteY28" fmla="*/ 425284 h 429618"/>
                <a:gd name="connsiteX29" fmla="*/ 381361 w 404423"/>
                <a:gd name="connsiteY29" fmla="*/ 429618 h 429618"/>
                <a:gd name="connsiteX30" fmla="*/ 403030 w 404423"/>
                <a:gd name="connsiteY30" fmla="*/ 425284 h 429618"/>
                <a:gd name="connsiteX31" fmla="*/ 398696 w 404423"/>
                <a:gd name="connsiteY31" fmla="*/ 399282 h 429618"/>
                <a:gd name="connsiteX32" fmla="*/ 385695 w 404423"/>
                <a:gd name="connsiteY32" fmla="*/ 351612 h 429618"/>
                <a:gd name="connsiteX33" fmla="*/ 381361 w 404423"/>
                <a:gd name="connsiteY33" fmla="*/ 338611 h 429618"/>
                <a:gd name="connsiteX34" fmla="*/ 368360 w 404423"/>
                <a:gd name="connsiteY34" fmla="*/ 321276 h 429618"/>
                <a:gd name="connsiteX35" fmla="*/ 355360 w 404423"/>
                <a:gd name="connsiteY35" fmla="*/ 295274 h 429618"/>
                <a:gd name="connsiteX36" fmla="*/ 346692 w 404423"/>
                <a:gd name="connsiteY36" fmla="*/ 269273 h 429618"/>
                <a:gd name="connsiteX37" fmla="*/ 338025 w 404423"/>
                <a:gd name="connsiteY37" fmla="*/ 234603 h 429618"/>
                <a:gd name="connsiteX38" fmla="*/ 333691 w 404423"/>
                <a:gd name="connsiteY38" fmla="*/ 204268 h 429618"/>
                <a:gd name="connsiteX39" fmla="*/ 299022 w 404423"/>
                <a:gd name="connsiteY39" fmla="*/ 199934 h 429618"/>
                <a:gd name="connsiteX40" fmla="*/ 286021 w 404423"/>
                <a:gd name="connsiteY40" fmla="*/ 186933 h 429618"/>
                <a:gd name="connsiteX41" fmla="*/ 303356 w 404423"/>
                <a:gd name="connsiteY41" fmla="*/ 143597 h 429618"/>
                <a:gd name="connsiteX42" fmla="*/ 307689 w 404423"/>
                <a:gd name="connsiteY42" fmla="*/ 126262 h 429618"/>
                <a:gd name="connsiteX43" fmla="*/ 303356 w 404423"/>
                <a:gd name="connsiteY43" fmla="*/ 104594 h 429618"/>
                <a:gd name="connsiteX44" fmla="*/ 299022 w 404423"/>
                <a:gd name="connsiteY44" fmla="*/ 78592 h 429618"/>
                <a:gd name="connsiteX45" fmla="*/ 294688 w 404423"/>
                <a:gd name="connsiteY45" fmla="*/ 65591 h 429618"/>
                <a:gd name="connsiteX46" fmla="*/ 290355 w 404423"/>
                <a:gd name="connsiteY46" fmla="*/ 43923 h 429618"/>
                <a:gd name="connsiteX47" fmla="*/ 277354 w 404423"/>
                <a:gd name="connsiteY47" fmla="*/ 17921 h 429618"/>
                <a:gd name="connsiteX48" fmla="*/ 229684 w 404423"/>
                <a:gd name="connsiteY48" fmla="*/ 586 h 4296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</a:cxnLst>
              <a:rect l="l" t="t" r="r" b="b"/>
              <a:pathLst>
                <a:path w="404423" h="429618">
                  <a:moveTo>
                    <a:pt x="229684" y="586"/>
                  </a:moveTo>
                  <a:cubicBezTo>
                    <a:pt x="205849" y="-1581"/>
                    <a:pt x="166086" y="2804"/>
                    <a:pt x="134343" y="4920"/>
                  </a:cubicBezTo>
                  <a:cubicBezTo>
                    <a:pt x="122723" y="5695"/>
                    <a:pt x="111062" y="6814"/>
                    <a:pt x="99674" y="9254"/>
                  </a:cubicBezTo>
                  <a:cubicBezTo>
                    <a:pt x="90741" y="11168"/>
                    <a:pt x="73672" y="17921"/>
                    <a:pt x="73672" y="17921"/>
                  </a:cubicBezTo>
                  <a:cubicBezTo>
                    <a:pt x="69338" y="22255"/>
                    <a:pt x="65509" y="27159"/>
                    <a:pt x="60671" y="30922"/>
                  </a:cubicBezTo>
                  <a:cubicBezTo>
                    <a:pt x="49906" y="39294"/>
                    <a:pt x="34724" y="45294"/>
                    <a:pt x="26002" y="56924"/>
                  </a:cubicBezTo>
                  <a:cubicBezTo>
                    <a:pt x="19752" y="65258"/>
                    <a:pt x="11962" y="73044"/>
                    <a:pt x="8668" y="82926"/>
                  </a:cubicBezTo>
                  <a:lnTo>
                    <a:pt x="0" y="108928"/>
                  </a:lnTo>
                  <a:cubicBezTo>
                    <a:pt x="1691" y="122454"/>
                    <a:pt x="-655" y="145673"/>
                    <a:pt x="13001" y="156598"/>
                  </a:cubicBezTo>
                  <a:cubicBezTo>
                    <a:pt x="16568" y="159452"/>
                    <a:pt x="21668" y="159487"/>
                    <a:pt x="26002" y="160931"/>
                  </a:cubicBezTo>
                  <a:cubicBezTo>
                    <a:pt x="31780" y="166709"/>
                    <a:pt x="40753" y="170513"/>
                    <a:pt x="43337" y="178266"/>
                  </a:cubicBezTo>
                  <a:cubicBezTo>
                    <a:pt x="53499" y="208756"/>
                    <a:pt x="40273" y="171116"/>
                    <a:pt x="56338" y="208601"/>
                  </a:cubicBezTo>
                  <a:cubicBezTo>
                    <a:pt x="58137" y="212800"/>
                    <a:pt x="57818" y="218035"/>
                    <a:pt x="60671" y="221602"/>
                  </a:cubicBezTo>
                  <a:cubicBezTo>
                    <a:pt x="63925" y="225669"/>
                    <a:pt x="69752" y="226840"/>
                    <a:pt x="73672" y="230270"/>
                  </a:cubicBezTo>
                  <a:cubicBezTo>
                    <a:pt x="81359" y="236996"/>
                    <a:pt x="86842" y="246272"/>
                    <a:pt x="95341" y="251938"/>
                  </a:cubicBezTo>
                  <a:cubicBezTo>
                    <a:pt x="99674" y="254827"/>
                    <a:pt x="104274" y="257351"/>
                    <a:pt x="108341" y="260605"/>
                  </a:cubicBezTo>
                  <a:cubicBezTo>
                    <a:pt x="111532" y="263158"/>
                    <a:pt x="113505" y="267171"/>
                    <a:pt x="117009" y="269273"/>
                  </a:cubicBezTo>
                  <a:cubicBezTo>
                    <a:pt x="120926" y="271623"/>
                    <a:pt x="125676" y="272162"/>
                    <a:pt x="130010" y="273606"/>
                  </a:cubicBezTo>
                  <a:cubicBezTo>
                    <a:pt x="134344" y="277940"/>
                    <a:pt x="139088" y="281899"/>
                    <a:pt x="143011" y="286607"/>
                  </a:cubicBezTo>
                  <a:cubicBezTo>
                    <a:pt x="146345" y="290608"/>
                    <a:pt x="147995" y="295925"/>
                    <a:pt x="151678" y="299608"/>
                  </a:cubicBezTo>
                  <a:cubicBezTo>
                    <a:pt x="155361" y="303291"/>
                    <a:pt x="160725" y="304885"/>
                    <a:pt x="164679" y="308275"/>
                  </a:cubicBezTo>
                  <a:cubicBezTo>
                    <a:pt x="170884" y="313593"/>
                    <a:pt x="182014" y="325610"/>
                    <a:pt x="182014" y="325610"/>
                  </a:cubicBezTo>
                  <a:cubicBezTo>
                    <a:pt x="182863" y="330705"/>
                    <a:pt x="184046" y="359738"/>
                    <a:pt x="195014" y="364613"/>
                  </a:cubicBezTo>
                  <a:cubicBezTo>
                    <a:pt x="204348" y="368761"/>
                    <a:pt x="215238" y="367502"/>
                    <a:pt x="225350" y="368946"/>
                  </a:cubicBezTo>
                  <a:lnTo>
                    <a:pt x="277354" y="386281"/>
                  </a:lnTo>
                  <a:cubicBezTo>
                    <a:pt x="281688" y="387726"/>
                    <a:pt x="286554" y="388081"/>
                    <a:pt x="290355" y="390615"/>
                  </a:cubicBezTo>
                  <a:cubicBezTo>
                    <a:pt x="294689" y="393504"/>
                    <a:pt x="298698" y="396953"/>
                    <a:pt x="303356" y="399282"/>
                  </a:cubicBezTo>
                  <a:cubicBezTo>
                    <a:pt x="307442" y="401325"/>
                    <a:pt x="312364" y="401398"/>
                    <a:pt x="316357" y="403616"/>
                  </a:cubicBezTo>
                  <a:cubicBezTo>
                    <a:pt x="338698" y="416028"/>
                    <a:pt x="335749" y="420926"/>
                    <a:pt x="355360" y="425284"/>
                  </a:cubicBezTo>
                  <a:cubicBezTo>
                    <a:pt x="363937" y="427190"/>
                    <a:pt x="372694" y="428173"/>
                    <a:pt x="381361" y="429618"/>
                  </a:cubicBezTo>
                  <a:cubicBezTo>
                    <a:pt x="388584" y="428173"/>
                    <a:pt x="399375" y="431680"/>
                    <a:pt x="403030" y="425284"/>
                  </a:cubicBezTo>
                  <a:cubicBezTo>
                    <a:pt x="407390" y="417655"/>
                    <a:pt x="400268" y="407927"/>
                    <a:pt x="398696" y="399282"/>
                  </a:cubicBezTo>
                  <a:cubicBezTo>
                    <a:pt x="393796" y="372334"/>
                    <a:pt x="395171" y="380039"/>
                    <a:pt x="385695" y="351612"/>
                  </a:cubicBezTo>
                  <a:cubicBezTo>
                    <a:pt x="384250" y="347278"/>
                    <a:pt x="384102" y="342266"/>
                    <a:pt x="381361" y="338611"/>
                  </a:cubicBezTo>
                  <a:lnTo>
                    <a:pt x="368360" y="321276"/>
                  </a:lnTo>
                  <a:cubicBezTo>
                    <a:pt x="352566" y="273886"/>
                    <a:pt x="377751" y="345651"/>
                    <a:pt x="355360" y="295274"/>
                  </a:cubicBezTo>
                  <a:cubicBezTo>
                    <a:pt x="351649" y="286926"/>
                    <a:pt x="349581" y="277940"/>
                    <a:pt x="346692" y="269273"/>
                  </a:cubicBezTo>
                  <a:cubicBezTo>
                    <a:pt x="341112" y="252534"/>
                    <a:pt x="341510" y="255510"/>
                    <a:pt x="338025" y="234603"/>
                  </a:cubicBezTo>
                  <a:cubicBezTo>
                    <a:pt x="336346" y="224528"/>
                    <a:pt x="341325" y="211054"/>
                    <a:pt x="333691" y="204268"/>
                  </a:cubicBezTo>
                  <a:cubicBezTo>
                    <a:pt x="324986" y="196531"/>
                    <a:pt x="310578" y="201379"/>
                    <a:pt x="299022" y="199934"/>
                  </a:cubicBezTo>
                  <a:cubicBezTo>
                    <a:pt x="294688" y="195600"/>
                    <a:pt x="287117" y="192963"/>
                    <a:pt x="286021" y="186933"/>
                  </a:cubicBezTo>
                  <a:cubicBezTo>
                    <a:pt x="280099" y="154363"/>
                    <a:pt x="285540" y="155474"/>
                    <a:pt x="303356" y="143597"/>
                  </a:cubicBezTo>
                  <a:cubicBezTo>
                    <a:pt x="304800" y="137819"/>
                    <a:pt x="307689" y="132218"/>
                    <a:pt x="307689" y="126262"/>
                  </a:cubicBezTo>
                  <a:cubicBezTo>
                    <a:pt x="307689" y="118896"/>
                    <a:pt x="304674" y="111841"/>
                    <a:pt x="303356" y="104594"/>
                  </a:cubicBezTo>
                  <a:cubicBezTo>
                    <a:pt x="301784" y="95949"/>
                    <a:pt x="300928" y="87170"/>
                    <a:pt x="299022" y="78592"/>
                  </a:cubicBezTo>
                  <a:cubicBezTo>
                    <a:pt x="298031" y="74133"/>
                    <a:pt x="295796" y="70023"/>
                    <a:pt x="294688" y="65591"/>
                  </a:cubicBezTo>
                  <a:cubicBezTo>
                    <a:pt x="292902" y="58445"/>
                    <a:pt x="292141" y="51069"/>
                    <a:pt x="290355" y="43923"/>
                  </a:cubicBezTo>
                  <a:cubicBezTo>
                    <a:pt x="287563" y="32756"/>
                    <a:pt x="284918" y="26998"/>
                    <a:pt x="277354" y="17921"/>
                  </a:cubicBezTo>
                  <a:cubicBezTo>
                    <a:pt x="273431" y="13213"/>
                    <a:pt x="253519" y="2753"/>
                    <a:pt x="229684" y="586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C3347F20-153B-404F-8355-6BC43C1B578C}"/>
              </a:ext>
            </a:extLst>
          </p:cNvPr>
          <p:cNvSpPr txBox="1"/>
          <p:nvPr/>
        </p:nvSpPr>
        <p:spPr>
          <a:xfrm>
            <a:off x="10661454" y="4874426"/>
            <a:ext cx="1460656" cy="75251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CH" sz="2000" b="1" dirty="0">
                <a:solidFill>
                  <a:srgbClr val="FF0000"/>
                </a:solidFill>
              </a:rPr>
              <a:t>Brainstem-</a:t>
            </a:r>
          </a:p>
          <a:p>
            <a:pPr algn="ctr">
              <a:lnSpc>
                <a:spcPct val="70000"/>
              </a:lnSpc>
            </a:pPr>
            <a:r>
              <a:rPr lang="en-CH" sz="2000" b="1" dirty="0">
                <a:solidFill>
                  <a:srgbClr val="FF0000"/>
                </a:solidFill>
              </a:rPr>
              <a:t>cerebellum</a:t>
            </a:r>
          </a:p>
          <a:p>
            <a:pPr algn="ctr">
              <a:lnSpc>
                <a:spcPct val="70000"/>
              </a:lnSpc>
            </a:pPr>
            <a:r>
              <a:rPr lang="en-CH" sz="2000" b="1" dirty="0">
                <a:solidFill>
                  <a:srgbClr val="FF0000"/>
                </a:solidFill>
              </a:rPr>
              <a:t>N</a:t>
            </a:r>
            <a:r>
              <a:rPr lang="en-US" sz="2000" b="1" dirty="0">
                <a:solidFill>
                  <a:srgbClr val="FF0000"/>
                </a:solidFill>
              </a:rPr>
              <a:t> </a:t>
            </a:r>
            <a:r>
              <a:rPr lang="en-CH" sz="2000" b="1" dirty="0">
                <a:solidFill>
                  <a:srgbClr val="FF0000"/>
                </a:solidFill>
              </a:rPr>
              <a:t>=</a:t>
            </a:r>
            <a:r>
              <a:rPr lang="en-US" sz="2000" b="1" dirty="0">
                <a:solidFill>
                  <a:srgbClr val="FF0000"/>
                </a:solidFill>
              </a:rPr>
              <a:t> </a:t>
            </a:r>
            <a:r>
              <a:rPr lang="en-CH" sz="2000" b="1" dirty="0">
                <a:solidFill>
                  <a:srgbClr val="FF0000"/>
                </a:solidFill>
              </a:rPr>
              <a:t>1 (1.9%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279CE5C-B52C-F545-A640-60286958A5E9}"/>
              </a:ext>
            </a:extLst>
          </p:cNvPr>
          <p:cNvSpPr txBox="1"/>
          <p:nvPr/>
        </p:nvSpPr>
        <p:spPr>
          <a:xfrm>
            <a:off x="7543412" y="5633341"/>
            <a:ext cx="20381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>
                <a:solidFill>
                  <a:schemeClr val="bg1"/>
                </a:solidFill>
              </a:rPr>
              <a:t>Orlando et al.</a:t>
            </a:r>
            <a:r>
              <a:rPr lang="en-US" dirty="0">
                <a:solidFill>
                  <a:schemeClr val="bg1"/>
                </a:solidFill>
              </a:rPr>
              <a:t> 2021</a:t>
            </a:r>
            <a:endParaRPr lang="en-CH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3</TotalTime>
  <Words>130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102</cp:revision>
  <dcterms:created xsi:type="dcterms:W3CDTF">2019-06-13T12:30:18Z</dcterms:created>
  <dcterms:modified xsi:type="dcterms:W3CDTF">2021-07-23T16:35:59Z</dcterms:modified>
</cp:coreProperties>
</file>